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3657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5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182" y="-7282"/>
      </p:cViewPr>
      <p:guideLst>
        <p:guide orient="horz" pos="115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Projects\Essentialome\documents\IX000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Projects\Essentialome\data\EMS%20analysis\h88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Projects\Essentialome\data\EMS%20analysis\h225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Projects\Essentialome\data\EMS%20analysis\h14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h706 (control)</a:t>
            </a:r>
            <a:endParaRPr 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CAGTG!$C$1</c:f>
              <c:strCache>
                <c:ptCount val="1"/>
                <c:pt idx="0">
                  <c:v>Average</c:v>
                </c:pt>
              </c:strCache>
            </c:strRef>
          </c:tx>
          <c:invertIfNegative val="0"/>
          <c:val>
            <c:numRef>
              <c:f>ACAGTG!$C$2:$C$1466</c:f>
              <c:numCache>
                <c:formatCode>General</c:formatCode>
                <c:ptCount val="1465"/>
                <c:pt idx="0">
                  <c:v>33.714285714285701</c:v>
                </c:pt>
                <c:pt idx="1">
                  <c:v>34.882860665844497</c:v>
                </c:pt>
                <c:pt idx="2">
                  <c:v>33.720930232558196</c:v>
                </c:pt>
                <c:pt idx="3">
                  <c:v>40.912500000000001</c:v>
                </c:pt>
                <c:pt idx="4">
                  <c:v>33.359781121750963</c:v>
                </c:pt>
                <c:pt idx="5">
                  <c:v>38.694138649211503</c:v>
                </c:pt>
                <c:pt idx="6">
                  <c:v>40.246575342465881</c:v>
                </c:pt>
                <c:pt idx="7">
                  <c:v>35.219481340923501</c:v>
                </c:pt>
                <c:pt idx="8">
                  <c:v>33.371862849063263</c:v>
                </c:pt>
                <c:pt idx="9">
                  <c:v>31.638144019282901</c:v>
                </c:pt>
                <c:pt idx="10">
                  <c:v>30.717469262295101</c:v>
                </c:pt>
                <c:pt idx="11">
                  <c:v>31.690242643262778</c:v>
                </c:pt>
                <c:pt idx="12">
                  <c:v>31.510440835266778</c:v>
                </c:pt>
                <c:pt idx="13">
                  <c:v>35.176419213973837</c:v>
                </c:pt>
                <c:pt idx="14">
                  <c:v>40.029591635431103</c:v>
                </c:pt>
                <c:pt idx="15">
                  <c:v>41.175411119812097</c:v>
                </c:pt>
                <c:pt idx="16">
                  <c:v>35.218838814453946</c:v>
                </c:pt>
                <c:pt idx="17">
                  <c:v>36.296296296296298</c:v>
                </c:pt>
                <c:pt idx="18">
                  <c:v>30.265793167992499</c:v>
                </c:pt>
                <c:pt idx="19">
                  <c:v>31.620737647877487</c:v>
                </c:pt>
                <c:pt idx="20">
                  <c:v>34.765784114053012</c:v>
                </c:pt>
                <c:pt idx="21">
                  <c:v>30.814964610717926</c:v>
                </c:pt>
                <c:pt idx="22">
                  <c:v>51.674484719260747</c:v>
                </c:pt>
                <c:pt idx="23">
                  <c:v>35.955835240274602</c:v>
                </c:pt>
                <c:pt idx="24">
                  <c:v>37.820395738204013</c:v>
                </c:pt>
                <c:pt idx="25">
                  <c:v>32.011893583724529</c:v>
                </c:pt>
                <c:pt idx="26">
                  <c:v>28.8594823032224</c:v>
                </c:pt>
                <c:pt idx="27">
                  <c:v>42.075144508670498</c:v>
                </c:pt>
                <c:pt idx="28">
                  <c:v>34.309812930751612</c:v>
                </c:pt>
                <c:pt idx="29">
                  <c:v>34.657881136950898</c:v>
                </c:pt>
                <c:pt idx="30">
                  <c:v>30.657507360156998</c:v>
                </c:pt>
                <c:pt idx="31">
                  <c:v>35.9859943977591</c:v>
                </c:pt>
                <c:pt idx="32">
                  <c:v>29.485209235209155</c:v>
                </c:pt>
                <c:pt idx="33">
                  <c:v>31.086175284195086</c:v>
                </c:pt>
                <c:pt idx="34">
                  <c:v>33.945924347362798</c:v>
                </c:pt>
                <c:pt idx="35">
                  <c:v>30.428705440900586</c:v>
                </c:pt>
                <c:pt idx="36">
                  <c:v>32.116940581542337</c:v>
                </c:pt>
                <c:pt idx="37">
                  <c:v>31.276638319159588</c:v>
                </c:pt>
                <c:pt idx="38">
                  <c:v>29.892665474060799</c:v>
                </c:pt>
                <c:pt idx="39">
                  <c:v>34.5047039291644</c:v>
                </c:pt>
                <c:pt idx="40">
                  <c:v>36.913402061855663</c:v>
                </c:pt>
                <c:pt idx="41">
                  <c:v>20.747591522158</c:v>
                </c:pt>
                <c:pt idx="42">
                  <c:v>32.140070921985846</c:v>
                </c:pt>
                <c:pt idx="43">
                  <c:v>35.7777777777778</c:v>
                </c:pt>
                <c:pt idx="44">
                  <c:v>33.663394109396897</c:v>
                </c:pt>
                <c:pt idx="45">
                  <c:v>34.477693891557998</c:v>
                </c:pt>
                <c:pt idx="46">
                  <c:v>34.067232170907936</c:v>
                </c:pt>
                <c:pt idx="47">
                  <c:v>33.749029395452006</c:v>
                </c:pt>
                <c:pt idx="48">
                  <c:v>32.377158034528613</c:v>
                </c:pt>
                <c:pt idx="49">
                  <c:v>30</c:v>
                </c:pt>
                <c:pt idx="50">
                  <c:v>32.039989264626897</c:v>
                </c:pt>
                <c:pt idx="51">
                  <c:v>30.9710144927536</c:v>
                </c:pt>
                <c:pt idx="52">
                  <c:v>35.981879606879595</c:v>
                </c:pt>
                <c:pt idx="53">
                  <c:v>37.113166485310039</c:v>
                </c:pt>
                <c:pt idx="54">
                  <c:v>30.681350954478717</c:v>
                </c:pt>
                <c:pt idx="55">
                  <c:v>36.580864197530865</c:v>
                </c:pt>
                <c:pt idx="56">
                  <c:v>35.758198198198237</c:v>
                </c:pt>
                <c:pt idx="57">
                  <c:v>33.969647696476997</c:v>
                </c:pt>
                <c:pt idx="58">
                  <c:v>38.648372996600337</c:v>
                </c:pt>
                <c:pt idx="59">
                  <c:v>28.256188118811917</c:v>
                </c:pt>
                <c:pt idx="60">
                  <c:v>29.266009852216687</c:v>
                </c:pt>
                <c:pt idx="61">
                  <c:v>33.077513430544911</c:v>
                </c:pt>
                <c:pt idx="62">
                  <c:v>31.981849120816801</c:v>
                </c:pt>
                <c:pt idx="63">
                  <c:v>31.593690248565959</c:v>
                </c:pt>
                <c:pt idx="64">
                  <c:v>39.240102171136698</c:v>
                </c:pt>
                <c:pt idx="65">
                  <c:v>33.4860668789809</c:v>
                </c:pt>
                <c:pt idx="66">
                  <c:v>32.678271812080503</c:v>
                </c:pt>
                <c:pt idx="67">
                  <c:v>30.777119585338777</c:v>
                </c:pt>
                <c:pt idx="68">
                  <c:v>22.016468435498634</c:v>
                </c:pt>
                <c:pt idx="69">
                  <c:v>31.050595238095202</c:v>
                </c:pt>
                <c:pt idx="70">
                  <c:v>33.369124622682165</c:v>
                </c:pt>
                <c:pt idx="71">
                  <c:v>35.0365974282888</c:v>
                </c:pt>
                <c:pt idx="72">
                  <c:v>33.543640897755594</c:v>
                </c:pt>
                <c:pt idx="73">
                  <c:v>30.737399193548399</c:v>
                </c:pt>
                <c:pt idx="74">
                  <c:v>34.762216624685145</c:v>
                </c:pt>
                <c:pt idx="75">
                  <c:v>34.519813519813447</c:v>
                </c:pt>
                <c:pt idx="76">
                  <c:v>36.185393258427013</c:v>
                </c:pt>
                <c:pt idx="77">
                  <c:v>32.640816326530611</c:v>
                </c:pt>
                <c:pt idx="78">
                  <c:v>31.910056214865687</c:v>
                </c:pt>
                <c:pt idx="79">
                  <c:v>37.822974860335201</c:v>
                </c:pt>
                <c:pt idx="80">
                  <c:v>22.330903790087518</c:v>
                </c:pt>
                <c:pt idx="81">
                  <c:v>30.961965134706801</c:v>
                </c:pt>
                <c:pt idx="82">
                  <c:v>30.515589697243588</c:v>
                </c:pt>
                <c:pt idx="83">
                  <c:v>33.773444753946038</c:v>
                </c:pt>
                <c:pt idx="84">
                  <c:v>24.554847841472</c:v>
                </c:pt>
                <c:pt idx="85">
                  <c:v>34.059215396003012</c:v>
                </c:pt>
                <c:pt idx="86">
                  <c:v>36.388610478359901</c:v>
                </c:pt>
                <c:pt idx="87">
                  <c:v>34.526315789473763</c:v>
                </c:pt>
                <c:pt idx="88">
                  <c:v>38.058823529411796</c:v>
                </c:pt>
                <c:pt idx="89">
                  <c:v>31.8671632526381</c:v>
                </c:pt>
                <c:pt idx="90">
                  <c:v>33.25089605734761</c:v>
                </c:pt>
                <c:pt idx="91">
                  <c:v>34.171792948237112</c:v>
                </c:pt>
                <c:pt idx="92">
                  <c:v>34.688461538461496</c:v>
                </c:pt>
                <c:pt idx="93">
                  <c:v>23.034920634920599</c:v>
                </c:pt>
                <c:pt idx="94">
                  <c:v>34.729665071770299</c:v>
                </c:pt>
                <c:pt idx="95">
                  <c:v>34.301845819761063</c:v>
                </c:pt>
                <c:pt idx="96">
                  <c:v>28.7180910099889</c:v>
                </c:pt>
                <c:pt idx="97">
                  <c:v>31.752372735116499</c:v>
                </c:pt>
                <c:pt idx="98">
                  <c:v>23.169952210274801</c:v>
                </c:pt>
                <c:pt idx="99">
                  <c:v>22.955394190871377</c:v>
                </c:pt>
                <c:pt idx="100">
                  <c:v>27.103518267929587</c:v>
                </c:pt>
                <c:pt idx="101">
                  <c:v>30.056524035921775</c:v>
                </c:pt>
                <c:pt idx="102">
                  <c:v>35.698518518518554</c:v>
                </c:pt>
                <c:pt idx="103">
                  <c:v>38.497854077253137</c:v>
                </c:pt>
                <c:pt idx="104">
                  <c:v>32.540816326530603</c:v>
                </c:pt>
                <c:pt idx="105">
                  <c:v>44.116702355460397</c:v>
                </c:pt>
                <c:pt idx="106">
                  <c:v>39.649043869516255</c:v>
                </c:pt>
                <c:pt idx="107">
                  <c:v>31.157303370786501</c:v>
                </c:pt>
                <c:pt idx="108">
                  <c:v>34.292652552926512</c:v>
                </c:pt>
                <c:pt idx="109">
                  <c:v>32.602496714848911</c:v>
                </c:pt>
                <c:pt idx="110">
                  <c:v>32.403437499999995</c:v>
                </c:pt>
                <c:pt idx="111">
                  <c:v>29.854861111111134</c:v>
                </c:pt>
                <c:pt idx="112">
                  <c:v>24.746056782334389</c:v>
                </c:pt>
                <c:pt idx="113">
                  <c:v>31.485928705440902</c:v>
                </c:pt>
                <c:pt idx="114">
                  <c:v>32.766135792120807</c:v>
                </c:pt>
                <c:pt idx="115">
                  <c:v>32.2696011004127</c:v>
                </c:pt>
                <c:pt idx="116">
                  <c:v>26.947513812154689</c:v>
                </c:pt>
                <c:pt idx="117">
                  <c:v>29.814502529511</c:v>
                </c:pt>
                <c:pt idx="118">
                  <c:v>34.510464058234739</c:v>
                </c:pt>
                <c:pt idx="119">
                  <c:v>37.479853479853439</c:v>
                </c:pt>
                <c:pt idx="120">
                  <c:v>32.668866886688697</c:v>
                </c:pt>
                <c:pt idx="121">
                  <c:v>33.946322067594394</c:v>
                </c:pt>
                <c:pt idx="122">
                  <c:v>31.822663723325977</c:v>
                </c:pt>
                <c:pt idx="123">
                  <c:v>32.799657534246563</c:v>
                </c:pt>
                <c:pt idx="124">
                  <c:v>37.326683291770564</c:v>
                </c:pt>
                <c:pt idx="125">
                  <c:v>33.661867847914394</c:v>
                </c:pt>
                <c:pt idx="126">
                  <c:v>35.271103896103945</c:v>
                </c:pt>
                <c:pt idx="127">
                  <c:v>29.4709915611814</c:v>
                </c:pt>
                <c:pt idx="128">
                  <c:v>30.492640692640673</c:v>
                </c:pt>
                <c:pt idx="129">
                  <c:v>28.16</c:v>
                </c:pt>
                <c:pt idx="130">
                  <c:v>29.475618904726176</c:v>
                </c:pt>
                <c:pt idx="131">
                  <c:v>25.7733516483516</c:v>
                </c:pt>
                <c:pt idx="132">
                  <c:v>24.391269199676618</c:v>
                </c:pt>
                <c:pt idx="133">
                  <c:v>33.410273972602653</c:v>
                </c:pt>
                <c:pt idx="134">
                  <c:v>28.591412742382289</c:v>
                </c:pt>
                <c:pt idx="135">
                  <c:v>35.157401623984995</c:v>
                </c:pt>
                <c:pt idx="136">
                  <c:v>31.293986636970978</c:v>
                </c:pt>
                <c:pt idx="137">
                  <c:v>30.736493936052899</c:v>
                </c:pt>
                <c:pt idx="138">
                  <c:v>31.588044184535359</c:v>
                </c:pt>
                <c:pt idx="139">
                  <c:v>33.996796338672837</c:v>
                </c:pt>
                <c:pt idx="140">
                  <c:v>32.754970760233896</c:v>
                </c:pt>
                <c:pt idx="141">
                  <c:v>30.518475750577405</c:v>
                </c:pt>
                <c:pt idx="142">
                  <c:v>33.489973262032095</c:v>
                </c:pt>
                <c:pt idx="143">
                  <c:v>33.8223017292785</c:v>
                </c:pt>
                <c:pt idx="144">
                  <c:v>32.095791001451403</c:v>
                </c:pt>
                <c:pt idx="145">
                  <c:v>33.3459539717892</c:v>
                </c:pt>
                <c:pt idx="146">
                  <c:v>24.214390602055801</c:v>
                </c:pt>
                <c:pt idx="147">
                  <c:v>31.252361673414299</c:v>
                </c:pt>
                <c:pt idx="148">
                  <c:v>35.69525801952588</c:v>
                </c:pt>
                <c:pt idx="149">
                  <c:v>30.909090909090899</c:v>
                </c:pt>
                <c:pt idx="150">
                  <c:v>34.742950819672103</c:v>
                </c:pt>
                <c:pt idx="151">
                  <c:v>32.364937388193198</c:v>
                </c:pt>
                <c:pt idx="152">
                  <c:v>30.69389509888223</c:v>
                </c:pt>
                <c:pt idx="153">
                  <c:v>29.176114236261402</c:v>
                </c:pt>
                <c:pt idx="154">
                  <c:v>30.976093294460586</c:v>
                </c:pt>
                <c:pt idx="155">
                  <c:v>28.738012508686602</c:v>
                </c:pt>
                <c:pt idx="156">
                  <c:v>32.711153479504297</c:v>
                </c:pt>
                <c:pt idx="157">
                  <c:v>34.511936339522499</c:v>
                </c:pt>
                <c:pt idx="158">
                  <c:v>38.156751163993796</c:v>
                </c:pt>
                <c:pt idx="159">
                  <c:v>34.158201984822</c:v>
                </c:pt>
                <c:pt idx="160">
                  <c:v>26.220410310362976</c:v>
                </c:pt>
                <c:pt idx="161">
                  <c:v>34.360897435897328</c:v>
                </c:pt>
                <c:pt idx="162">
                  <c:v>33.206185567010294</c:v>
                </c:pt>
                <c:pt idx="163">
                  <c:v>27.509852216748801</c:v>
                </c:pt>
                <c:pt idx="164">
                  <c:v>34.673410404624299</c:v>
                </c:pt>
                <c:pt idx="165">
                  <c:v>36.000465116279102</c:v>
                </c:pt>
                <c:pt idx="166">
                  <c:v>31.120817843866199</c:v>
                </c:pt>
                <c:pt idx="167">
                  <c:v>35.761805555555597</c:v>
                </c:pt>
                <c:pt idx="168">
                  <c:v>28.793658782083501</c:v>
                </c:pt>
                <c:pt idx="169">
                  <c:v>31.651063829787201</c:v>
                </c:pt>
                <c:pt idx="170">
                  <c:v>30.101587301587287</c:v>
                </c:pt>
                <c:pt idx="171">
                  <c:v>33.837962962962997</c:v>
                </c:pt>
                <c:pt idx="172">
                  <c:v>32.010926365795648</c:v>
                </c:pt>
                <c:pt idx="173">
                  <c:v>37.518326118326101</c:v>
                </c:pt>
                <c:pt idx="174">
                  <c:v>35.319775132275112</c:v>
                </c:pt>
                <c:pt idx="175">
                  <c:v>34.637822070977201</c:v>
                </c:pt>
                <c:pt idx="176">
                  <c:v>33.962546816479446</c:v>
                </c:pt>
                <c:pt idx="177">
                  <c:v>32.434760956175303</c:v>
                </c:pt>
                <c:pt idx="178">
                  <c:v>34.710508002783598</c:v>
                </c:pt>
                <c:pt idx="179">
                  <c:v>36.792586750788601</c:v>
                </c:pt>
                <c:pt idx="180">
                  <c:v>33.373584905660337</c:v>
                </c:pt>
                <c:pt idx="181">
                  <c:v>35.063636363636363</c:v>
                </c:pt>
                <c:pt idx="182">
                  <c:v>28.582882882882878</c:v>
                </c:pt>
                <c:pt idx="183">
                  <c:v>35.592592592592602</c:v>
                </c:pt>
                <c:pt idx="184">
                  <c:v>32.6334144363341</c:v>
                </c:pt>
                <c:pt idx="185">
                  <c:v>37.188127853881298</c:v>
                </c:pt>
                <c:pt idx="186">
                  <c:v>35.482539682539738</c:v>
                </c:pt>
                <c:pt idx="187">
                  <c:v>38.256916996047401</c:v>
                </c:pt>
                <c:pt idx="188">
                  <c:v>22.534516765286018</c:v>
                </c:pt>
                <c:pt idx="189">
                  <c:v>33.990066225165599</c:v>
                </c:pt>
                <c:pt idx="190">
                  <c:v>29.744094488188999</c:v>
                </c:pt>
                <c:pt idx="191">
                  <c:v>31.419889502762373</c:v>
                </c:pt>
                <c:pt idx="192">
                  <c:v>32.382309941520511</c:v>
                </c:pt>
                <c:pt idx="193">
                  <c:v>34.909751037344364</c:v>
                </c:pt>
                <c:pt idx="194">
                  <c:v>20.747720364741589</c:v>
                </c:pt>
                <c:pt idx="195">
                  <c:v>31.135696821515889</c:v>
                </c:pt>
                <c:pt idx="196">
                  <c:v>35.611168208290465</c:v>
                </c:pt>
                <c:pt idx="197">
                  <c:v>34.530163803435912</c:v>
                </c:pt>
                <c:pt idx="198">
                  <c:v>30.1119592875318</c:v>
                </c:pt>
                <c:pt idx="199">
                  <c:v>36.1542750929368</c:v>
                </c:pt>
                <c:pt idx="200">
                  <c:v>32.397254397254365</c:v>
                </c:pt>
                <c:pt idx="201">
                  <c:v>38.165307232191445</c:v>
                </c:pt>
                <c:pt idx="202">
                  <c:v>34.785644051130795</c:v>
                </c:pt>
                <c:pt idx="203">
                  <c:v>37.894062863795064</c:v>
                </c:pt>
                <c:pt idx="204">
                  <c:v>34.850961538461448</c:v>
                </c:pt>
                <c:pt idx="205">
                  <c:v>28.561837455830418</c:v>
                </c:pt>
                <c:pt idx="206">
                  <c:v>35.399022801302898</c:v>
                </c:pt>
                <c:pt idx="207">
                  <c:v>34.736842105263165</c:v>
                </c:pt>
                <c:pt idx="208">
                  <c:v>31.655430711610517</c:v>
                </c:pt>
                <c:pt idx="209">
                  <c:v>32.069620253164594</c:v>
                </c:pt>
                <c:pt idx="210">
                  <c:v>37.992395437262395</c:v>
                </c:pt>
                <c:pt idx="211">
                  <c:v>31.908965517241388</c:v>
                </c:pt>
                <c:pt idx="212">
                  <c:v>28.692307692307686</c:v>
                </c:pt>
                <c:pt idx="213">
                  <c:v>30.422954303931977</c:v>
                </c:pt>
                <c:pt idx="214">
                  <c:v>39.481252037821996</c:v>
                </c:pt>
                <c:pt idx="215">
                  <c:v>37.981976629035465</c:v>
                </c:pt>
                <c:pt idx="216">
                  <c:v>41.282336578581436</c:v>
                </c:pt>
                <c:pt idx="217">
                  <c:v>35.882096069868965</c:v>
                </c:pt>
                <c:pt idx="218">
                  <c:v>37.173874669020265</c:v>
                </c:pt>
                <c:pt idx="219">
                  <c:v>34.890086206896555</c:v>
                </c:pt>
                <c:pt idx="220">
                  <c:v>24.970149253731254</c:v>
                </c:pt>
                <c:pt idx="221">
                  <c:v>35.280971659918997</c:v>
                </c:pt>
                <c:pt idx="222">
                  <c:v>34.120473633484835</c:v>
                </c:pt>
                <c:pt idx="223">
                  <c:v>33.602123058777302</c:v>
                </c:pt>
                <c:pt idx="224">
                  <c:v>33.860092300218597</c:v>
                </c:pt>
                <c:pt idx="225">
                  <c:v>37.215710723192011</c:v>
                </c:pt>
                <c:pt idx="226">
                  <c:v>41.865163760102099</c:v>
                </c:pt>
                <c:pt idx="227">
                  <c:v>35.173860911270999</c:v>
                </c:pt>
                <c:pt idx="228">
                  <c:v>36.035867237687363</c:v>
                </c:pt>
                <c:pt idx="229">
                  <c:v>30.553884711779418</c:v>
                </c:pt>
                <c:pt idx="230">
                  <c:v>30.056730273336775</c:v>
                </c:pt>
                <c:pt idx="231">
                  <c:v>24.215272727272701</c:v>
                </c:pt>
                <c:pt idx="232">
                  <c:v>29.047381546134702</c:v>
                </c:pt>
                <c:pt idx="233">
                  <c:v>29.600706713780902</c:v>
                </c:pt>
                <c:pt idx="234">
                  <c:v>32.391937833900002</c:v>
                </c:pt>
                <c:pt idx="235">
                  <c:v>30.926678765880201</c:v>
                </c:pt>
                <c:pt idx="236">
                  <c:v>38.740963855421697</c:v>
                </c:pt>
                <c:pt idx="237">
                  <c:v>36.662714636140613</c:v>
                </c:pt>
                <c:pt idx="238">
                  <c:v>24.168103448275886</c:v>
                </c:pt>
                <c:pt idx="239">
                  <c:v>35.867608581894238</c:v>
                </c:pt>
                <c:pt idx="240">
                  <c:v>28.9270886075949</c:v>
                </c:pt>
                <c:pt idx="241">
                  <c:v>29.83220135837</c:v>
                </c:pt>
                <c:pt idx="242">
                  <c:v>30.386649874055362</c:v>
                </c:pt>
                <c:pt idx="243">
                  <c:v>41.285178236397755</c:v>
                </c:pt>
                <c:pt idx="244">
                  <c:v>34.049853372434001</c:v>
                </c:pt>
                <c:pt idx="245">
                  <c:v>36.364743250396963</c:v>
                </c:pt>
                <c:pt idx="246">
                  <c:v>38.441496920890565</c:v>
                </c:pt>
                <c:pt idx="247">
                  <c:v>38.094820717131498</c:v>
                </c:pt>
                <c:pt idx="248">
                  <c:v>32.450482478415339</c:v>
                </c:pt>
                <c:pt idx="249">
                  <c:v>35.138568129330302</c:v>
                </c:pt>
                <c:pt idx="250">
                  <c:v>37.499502487562197</c:v>
                </c:pt>
                <c:pt idx="251">
                  <c:v>34.462817551962964</c:v>
                </c:pt>
                <c:pt idx="252">
                  <c:v>35.756105503093494</c:v>
                </c:pt>
                <c:pt idx="253">
                  <c:v>31.603026257231889</c:v>
                </c:pt>
                <c:pt idx="254">
                  <c:v>30.225831399845287</c:v>
                </c:pt>
                <c:pt idx="255">
                  <c:v>35.263772954924981</c:v>
                </c:pt>
                <c:pt idx="256">
                  <c:v>40.118404118404101</c:v>
                </c:pt>
                <c:pt idx="257">
                  <c:v>34.302543507362763</c:v>
                </c:pt>
                <c:pt idx="258">
                  <c:v>37.033853176112594</c:v>
                </c:pt>
                <c:pt idx="259">
                  <c:v>28.198859005705</c:v>
                </c:pt>
                <c:pt idx="260">
                  <c:v>40.202441077441094</c:v>
                </c:pt>
                <c:pt idx="261">
                  <c:v>35.463494132985737</c:v>
                </c:pt>
                <c:pt idx="262">
                  <c:v>34.391764051196311</c:v>
                </c:pt>
                <c:pt idx="263">
                  <c:v>28.444748858447486</c:v>
                </c:pt>
                <c:pt idx="264">
                  <c:v>31.308923705722087</c:v>
                </c:pt>
                <c:pt idx="265">
                  <c:v>27.246445497630287</c:v>
                </c:pt>
                <c:pt idx="266">
                  <c:v>34.969052945563035</c:v>
                </c:pt>
                <c:pt idx="267">
                  <c:v>32.927860696517364</c:v>
                </c:pt>
                <c:pt idx="268">
                  <c:v>33.789995866060401</c:v>
                </c:pt>
                <c:pt idx="269">
                  <c:v>37.141965364478501</c:v>
                </c:pt>
                <c:pt idx="270">
                  <c:v>37.541388518024</c:v>
                </c:pt>
                <c:pt idx="271">
                  <c:v>38.526421136909512</c:v>
                </c:pt>
                <c:pt idx="272">
                  <c:v>36.881661891117396</c:v>
                </c:pt>
                <c:pt idx="273">
                  <c:v>30.431176470588188</c:v>
                </c:pt>
                <c:pt idx="274">
                  <c:v>36.649076517150398</c:v>
                </c:pt>
                <c:pt idx="275">
                  <c:v>37.720670391061503</c:v>
                </c:pt>
                <c:pt idx="276">
                  <c:v>34.828729281767998</c:v>
                </c:pt>
                <c:pt idx="277">
                  <c:v>28.970714900947478</c:v>
                </c:pt>
                <c:pt idx="278">
                  <c:v>29.492555454269187</c:v>
                </c:pt>
                <c:pt idx="279">
                  <c:v>34.934052757793765</c:v>
                </c:pt>
                <c:pt idx="280">
                  <c:v>32.455054868083096</c:v>
                </c:pt>
                <c:pt idx="281">
                  <c:v>34.448721716132802</c:v>
                </c:pt>
                <c:pt idx="282">
                  <c:v>32.977443609022536</c:v>
                </c:pt>
                <c:pt idx="283">
                  <c:v>31.535142469470799</c:v>
                </c:pt>
                <c:pt idx="284">
                  <c:v>33.595114345114347</c:v>
                </c:pt>
                <c:pt idx="285">
                  <c:v>35.260473588342364</c:v>
                </c:pt>
                <c:pt idx="286">
                  <c:v>38.164666666666612</c:v>
                </c:pt>
                <c:pt idx="287">
                  <c:v>28.193922651933686</c:v>
                </c:pt>
                <c:pt idx="288">
                  <c:v>34.134668237141703</c:v>
                </c:pt>
                <c:pt idx="289">
                  <c:v>29.950485436893199</c:v>
                </c:pt>
                <c:pt idx="290">
                  <c:v>32.682563906905862</c:v>
                </c:pt>
                <c:pt idx="291">
                  <c:v>31.041633306645277</c:v>
                </c:pt>
                <c:pt idx="292">
                  <c:v>32.859767025089539</c:v>
                </c:pt>
                <c:pt idx="293">
                  <c:v>35.372129849564502</c:v>
                </c:pt>
                <c:pt idx="294">
                  <c:v>32.446299387868663</c:v>
                </c:pt>
                <c:pt idx="295">
                  <c:v>33.646739130434845</c:v>
                </c:pt>
                <c:pt idx="296">
                  <c:v>30.675808720112535</c:v>
                </c:pt>
                <c:pt idx="297">
                  <c:v>26.554794520547887</c:v>
                </c:pt>
                <c:pt idx="298">
                  <c:v>34.954515919428211</c:v>
                </c:pt>
                <c:pt idx="299">
                  <c:v>38.435135135135162</c:v>
                </c:pt>
                <c:pt idx="300">
                  <c:v>30.571644042232286</c:v>
                </c:pt>
                <c:pt idx="301">
                  <c:v>36.384379785604864</c:v>
                </c:pt>
                <c:pt idx="302">
                  <c:v>35.682948230476754</c:v>
                </c:pt>
                <c:pt idx="303">
                  <c:v>40.308677098150802</c:v>
                </c:pt>
                <c:pt idx="304">
                  <c:v>31.222987413915899</c:v>
                </c:pt>
                <c:pt idx="305">
                  <c:v>30.166287015945286</c:v>
                </c:pt>
                <c:pt idx="306">
                  <c:v>33.013284132841264</c:v>
                </c:pt>
                <c:pt idx="307">
                  <c:v>31.775723472668776</c:v>
                </c:pt>
                <c:pt idx="308">
                  <c:v>34.557945041815998</c:v>
                </c:pt>
                <c:pt idx="309">
                  <c:v>32.951409978307964</c:v>
                </c:pt>
                <c:pt idx="310">
                  <c:v>36.616859623733653</c:v>
                </c:pt>
                <c:pt idx="311">
                  <c:v>32.636094674556198</c:v>
                </c:pt>
                <c:pt idx="312">
                  <c:v>33.245614035087698</c:v>
                </c:pt>
                <c:pt idx="313">
                  <c:v>39.497303128371136</c:v>
                </c:pt>
                <c:pt idx="314">
                  <c:v>37.758942065491198</c:v>
                </c:pt>
                <c:pt idx="315">
                  <c:v>35.786465177398163</c:v>
                </c:pt>
                <c:pt idx="316">
                  <c:v>35.451745379876797</c:v>
                </c:pt>
                <c:pt idx="317">
                  <c:v>39.137284701114439</c:v>
                </c:pt>
                <c:pt idx="318">
                  <c:v>34.863444392304096</c:v>
                </c:pt>
                <c:pt idx="319">
                  <c:v>33.978395061728399</c:v>
                </c:pt>
                <c:pt idx="320">
                  <c:v>26.747035573122481</c:v>
                </c:pt>
                <c:pt idx="321">
                  <c:v>34.137500000000003</c:v>
                </c:pt>
                <c:pt idx="322">
                  <c:v>34.159437280187596</c:v>
                </c:pt>
                <c:pt idx="323">
                  <c:v>39.181436811746138</c:v>
                </c:pt>
                <c:pt idx="324">
                  <c:v>34.299816625916911</c:v>
                </c:pt>
                <c:pt idx="325">
                  <c:v>37.508569739952698</c:v>
                </c:pt>
                <c:pt idx="326">
                  <c:v>35.075461151481264</c:v>
                </c:pt>
                <c:pt idx="327">
                  <c:v>35.713016437139011</c:v>
                </c:pt>
                <c:pt idx="328">
                  <c:v>31.429042904290402</c:v>
                </c:pt>
                <c:pt idx="329">
                  <c:v>32.898209236569336</c:v>
                </c:pt>
                <c:pt idx="330">
                  <c:v>32.904161412358064</c:v>
                </c:pt>
                <c:pt idx="331">
                  <c:v>36.307792207792147</c:v>
                </c:pt>
                <c:pt idx="332">
                  <c:v>34.478308823529446</c:v>
                </c:pt>
                <c:pt idx="333">
                  <c:v>38.112571022727302</c:v>
                </c:pt>
                <c:pt idx="334">
                  <c:v>32.643916913946597</c:v>
                </c:pt>
                <c:pt idx="335">
                  <c:v>35.816135084427813</c:v>
                </c:pt>
                <c:pt idx="336">
                  <c:v>34.821275189957099</c:v>
                </c:pt>
                <c:pt idx="337">
                  <c:v>37.542539436255502</c:v>
                </c:pt>
                <c:pt idx="338">
                  <c:v>40.440798858773199</c:v>
                </c:pt>
                <c:pt idx="339">
                  <c:v>31.088405153265189</c:v>
                </c:pt>
                <c:pt idx="340">
                  <c:v>32.749902912621437</c:v>
                </c:pt>
                <c:pt idx="341">
                  <c:v>34.901268115941974</c:v>
                </c:pt>
                <c:pt idx="342">
                  <c:v>34.826155297076411</c:v>
                </c:pt>
                <c:pt idx="343">
                  <c:v>36.771839292296264</c:v>
                </c:pt>
                <c:pt idx="344">
                  <c:v>33.870660960532547</c:v>
                </c:pt>
                <c:pt idx="345">
                  <c:v>35.437308868501503</c:v>
                </c:pt>
                <c:pt idx="346">
                  <c:v>36.669679752066095</c:v>
                </c:pt>
                <c:pt idx="347">
                  <c:v>33.398046875000006</c:v>
                </c:pt>
                <c:pt idx="348">
                  <c:v>33.295511221945155</c:v>
                </c:pt>
                <c:pt idx="349">
                  <c:v>34.9653483992467</c:v>
                </c:pt>
                <c:pt idx="350">
                  <c:v>35.003613369466997</c:v>
                </c:pt>
                <c:pt idx="351">
                  <c:v>37.583818232197302</c:v>
                </c:pt>
                <c:pt idx="352">
                  <c:v>36.823482428115</c:v>
                </c:pt>
                <c:pt idx="353">
                  <c:v>32.175344384777013</c:v>
                </c:pt>
                <c:pt idx="354">
                  <c:v>37.494395280236006</c:v>
                </c:pt>
                <c:pt idx="355">
                  <c:v>38.451400329489296</c:v>
                </c:pt>
                <c:pt idx="356">
                  <c:v>35.608092485549101</c:v>
                </c:pt>
                <c:pt idx="357">
                  <c:v>37.126715735030871</c:v>
                </c:pt>
                <c:pt idx="358">
                  <c:v>40.489614243323395</c:v>
                </c:pt>
                <c:pt idx="359">
                  <c:v>38.105958781362006</c:v>
                </c:pt>
                <c:pt idx="360">
                  <c:v>35.083426443202939</c:v>
                </c:pt>
                <c:pt idx="361">
                  <c:v>35.573117760617798</c:v>
                </c:pt>
                <c:pt idx="362">
                  <c:v>36.213544241225911</c:v>
                </c:pt>
                <c:pt idx="363">
                  <c:v>37.409046214355911</c:v>
                </c:pt>
                <c:pt idx="364">
                  <c:v>39.881040892193248</c:v>
                </c:pt>
                <c:pt idx="365">
                  <c:v>41.836908881199498</c:v>
                </c:pt>
                <c:pt idx="366">
                  <c:v>35.456840869054538</c:v>
                </c:pt>
                <c:pt idx="367">
                  <c:v>36.527956712187603</c:v>
                </c:pt>
                <c:pt idx="368">
                  <c:v>36.591343093571012</c:v>
                </c:pt>
                <c:pt idx="369">
                  <c:v>35.240313653136504</c:v>
                </c:pt>
                <c:pt idx="370">
                  <c:v>35.7097235462345</c:v>
                </c:pt>
                <c:pt idx="371">
                  <c:v>36.561454311454298</c:v>
                </c:pt>
                <c:pt idx="372">
                  <c:v>32.319444444444329</c:v>
                </c:pt>
                <c:pt idx="373">
                  <c:v>36.641426783479297</c:v>
                </c:pt>
                <c:pt idx="374">
                  <c:v>37.3852108372377</c:v>
                </c:pt>
                <c:pt idx="375">
                  <c:v>39.990441016728198</c:v>
                </c:pt>
                <c:pt idx="376">
                  <c:v>36.480883022303047</c:v>
                </c:pt>
                <c:pt idx="377">
                  <c:v>38.264494489698038</c:v>
                </c:pt>
                <c:pt idx="378">
                  <c:v>37.376436781609165</c:v>
                </c:pt>
                <c:pt idx="379">
                  <c:v>34.147082334132698</c:v>
                </c:pt>
                <c:pt idx="380">
                  <c:v>33.377981651375997</c:v>
                </c:pt>
                <c:pt idx="381">
                  <c:v>39.074177631578912</c:v>
                </c:pt>
                <c:pt idx="382">
                  <c:v>38.3482324745356</c:v>
                </c:pt>
                <c:pt idx="383">
                  <c:v>38.759381171823563</c:v>
                </c:pt>
                <c:pt idx="384">
                  <c:v>37.439588043205198</c:v>
                </c:pt>
                <c:pt idx="385">
                  <c:v>36.382222222222197</c:v>
                </c:pt>
                <c:pt idx="386">
                  <c:v>34.035971223021612</c:v>
                </c:pt>
                <c:pt idx="387">
                  <c:v>33.175579322638136</c:v>
                </c:pt>
                <c:pt idx="388">
                  <c:v>34.951105442176903</c:v>
                </c:pt>
                <c:pt idx="389">
                  <c:v>31.634710743801701</c:v>
                </c:pt>
                <c:pt idx="390">
                  <c:v>37.897989417989365</c:v>
                </c:pt>
                <c:pt idx="391">
                  <c:v>36.696078431372499</c:v>
                </c:pt>
                <c:pt idx="392">
                  <c:v>37.695364238410612</c:v>
                </c:pt>
                <c:pt idx="393">
                  <c:v>37.456832087015563</c:v>
                </c:pt>
                <c:pt idx="394">
                  <c:v>37.912556764177836</c:v>
                </c:pt>
                <c:pt idx="395">
                  <c:v>36.686873290793095</c:v>
                </c:pt>
                <c:pt idx="396">
                  <c:v>36.105422446406102</c:v>
                </c:pt>
                <c:pt idx="397">
                  <c:v>38.101315789473738</c:v>
                </c:pt>
                <c:pt idx="398">
                  <c:v>36.930867459268896</c:v>
                </c:pt>
                <c:pt idx="399">
                  <c:v>38.8888888888889</c:v>
                </c:pt>
                <c:pt idx="400">
                  <c:v>34.260000000000012</c:v>
                </c:pt>
                <c:pt idx="401">
                  <c:v>36.445093693330563</c:v>
                </c:pt>
                <c:pt idx="402">
                  <c:v>37.865353911655113</c:v>
                </c:pt>
                <c:pt idx="403">
                  <c:v>35.639874739039698</c:v>
                </c:pt>
                <c:pt idx="404">
                  <c:v>37.224467504096047</c:v>
                </c:pt>
                <c:pt idx="405">
                  <c:v>37.501332825590303</c:v>
                </c:pt>
                <c:pt idx="406">
                  <c:v>36.241696474195194</c:v>
                </c:pt>
                <c:pt idx="407">
                  <c:v>32.051126516464464</c:v>
                </c:pt>
                <c:pt idx="408">
                  <c:v>40.692958447375062</c:v>
                </c:pt>
                <c:pt idx="409">
                  <c:v>36.911130039750098</c:v>
                </c:pt>
                <c:pt idx="410">
                  <c:v>36.547619047619094</c:v>
                </c:pt>
                <c:pt idx="411">
                  <c:v>36.146685878962494</c:v>
                </c:pt>
                <c:pt idx="412">
                  <c:v>39.163147310206099</c:v>
                </c:pt>
                <c:pt idx="413">
                  <c:v>37.9600934397508</c:v>
                </c:pt>
                <c:pt idx="414">
                  <c:v>34.85404704574912</c:v>
                </c:pt>
                <c:pt idx="415">
                  <c:v>38.444776119402995</c:v>
                </c:pt>
                <c:pt idx="416">
                  <c:v>33.42</c:v>
                </c:pt>
                <c:pt idx="417">
                  <c:v>34.837315709201803</c:v>
                </c:pt>
                <c:pt idx="418">
                  <c:v>36.518111518111503</c:v>
                </c:pt>
                <c:pt idx="419">
                  <c:v>38.415563506261194</c:v>
                </c:pt>
                <c:pt idx="420">
                  <c:v>65.805458584576229</c:v>
                </c:pt>
                <c:pt idx="421">
                  <c:v>63.564891655140528</c:v>
                </c:pt>
                <c:pt idx="422">
                  <c:v>39.403369672943455</c:v>
                </c:pt>
                <c:pt idx="423">
                  <c:v>34.851023322227448</c:v>
                </c:pt>
                <c:pt idx="424">
                  <c:v>39.119075336770337</c:v>
                </c:pt>
                <c:pt idx="425">
                  <c:v>38.739463601532563</c:v>
                </c:pt>
                <c:pt idx="426">
                  <c:v>34.743809523809496</c:v>
                </c:pt>
                <c:pt idx="427">
                  <c:v>42.324530516431913</c:v>
                </c:pt>
                <c:pt idx="428">
                  <c:v>35.451026119402947</c:v>
                </c:pt>
                <c:pt idx="429">
                  <c:v>37.999165275459113</c:v>
                </c:pt>
                <c:pt idx="430">
                  <c:v>36.9930690324369</c:v>
                </c:pt>
                <c:pt idx="431">
                  <c:v>35.433511385999402</c:v>
                </c:pt>
                <c:pt idx="432">
                  <c:v>35.304134697357163</c:v>
                </c:pt>
                <c:pt idx="433">
                  <c:v>27.884371029224901</c:v>
                </c:pt>
                <c:pt idx="434">
                  <c:v>37.201030927835035</c:v>
                </c:pt>
                <c:pt idx="435">
                  <c:v>35.500879352796247</c:v>
                </c:pt>
                <c:pt idx="436">
                  <c:v>37.369220821209197</c:v>
                </c:pt>
                <c:pt idx="437">
                  <c:v>32.678513731825547</c:v>
                </c:pt>
                <c:pt idx="438">
                  <c:v>35.180200222469402</c:v>
                </c:pt>
                <c:pt idx="439">
                  <c:v>39.926866990720299</c:v>
                </c:pt>
                <c:pt idx="440">
                  <c:v>36.824693482469264</c:v>
                </c:pt>
                <c:pt idx="441">
                  <c:v>37.777667493796393</c:v>
                </c:pt>
                <c:pt idx="442">
                  <c:v>37.042281879194547</c:v>
                </c:pt>
                <c:pt idx="443">
                  <c:v>32.381818181818147</c:v>
                </c:pt>
                <c:pt idx="444">
                  <c:v>37.107666098807464</c:v>
                </c:pt>
                <c:pt idx="445">
                  <c:v>37.226465661641463</c:v>
                </c:pt>
                <c:pt idx="446">
                  <c:v>39.479377839916097</c:v>
                </c:pt>
                <c:pt idx="447">
                  <c:v>36.190031152647997</c:v>
                </c:pt>
                <c:pt idx="448">
                  <c:v>35.749819754866564</c:v>
                </c:pt>
                <c:pt idx="449">
                  <c:v>34.303831807392228</c:v>
                </c:pt>
                <c:pt idx="450">
                  <c:v>39.251469627694227</c:v>
                </c:pt>
                <c:pt idx="451">
                  <c:v>37.313375350140099</c:v>
                </c:pt>
                <c:pt idx="452">
                  <c:v>34.237095996140937</c:v>
                </c:pt>
                <c:pt idx="453">
                  <c:v>34.854999127551899</c:v>
                </c:pt>
                <c:pt idx="454">
                  <c:v>34.853736089030164</c:v>
                </c:pt>
                <c:pt idx="455">
                  <c:v>38.164644351464347</c:v>
                </c:pt>
                <c:pt idx="456">
                  <c:v>39.630617689308394</c:v>
                </c:pt>
                <c:pt idx="457">
                  <c:v>39.031050734682594</c:v>
                </c:pt>
                <c:pt idx="458">
                  <c:v>40.602749140893501</c:v>
                </c:pt>
                <c:pt idx="459">
                  <c:v>39.164141414141397</c:v>
                </c:pt>
                <c:pt idx="460">
                  <c:v>32.549117549117497</c:v>
                </c:pt>
                <c:pt idx="461">
                  <c:v>36.213939393939413</c:v>
                </c:pt>
                <c:pt idx="462">
                  <c:v>42.0416666666666</c:v>
                </c:pt>
                <c:pt idx="463">
                  <c:v>37.530150753768801</c:v>
                </c:pt>
                <c:pt idx="464">
                  <c:v>38.532296392309412</c:v>
                </c:pt>
                <c:pt idx="465">
                  <c:v>34.363451776649647</c:v>
                </c:pt>
                <c:pt idx="466">
                  <c:v>35.957120980091901</c:v>
                </c:pt>
                <c:pt idx="467">
                  <c:v>35.788129496402902</c:v>
                </c:pt>
                <c:pt idx="468">
                  <c:v>40.798029556650199</c:v>
                </c:pt>
                <c:pt idx="469">
                  <c:v>33.667128987517302</c:v>
                </c:pt>
                <c:pt idx="470">
                  <c:v>38.176589303733564</c:v>
                </c:pt>
                <c:pt idx="471">
                  <c:v>34.397359320968235</c:v>
                </c:pt>
                <c:pt idx="472">
                  <c:v>35.030248033877811</c:v>
                </c:pt>
                <c:pt idx="473">
                  <c:v>38.764814814814812</c:v>
                </c:pt>
                <c:pt idx="474">
                  <c:v>36.535070140280602</c:v>
                </c:pt>
                <c:pt idx="475">
                  <c:v>37.687584956955099</c:v>
                </c:pt>
                <c:pt idx="476">
                  <c:v>36.658369266954111</c:v>
                </c:pt>
                <c:pt idx="477">
                  <c:v>36.993680884676095</c:v>
                </c:pt>
                <c:pt idx="478">
                  <c:v>40.520050125313297</c:v>
                </c:pt>
                <c:pt idx="479">
                  <c:v>38.443995963673096</c:v>
                </c:pt>
                <c:pt idx="480">
                  <c:v>37.264868603042864</c:v>
                </c:pt>
                <c:pt idx="481">
                  <c:v>37.128642688369737</c:v>
                </c:pt>
                <c:pt idx="482">
                  <c:v>37.030731190392096</c:v>
                </c:pt>
                <c:pt idx="483">
                  <c:v>38.160322108345511</c:v>
                </c:pt>
                <c:pt idx="484">
                  <c:v>37.431495167708896</c:v>
                </c:pt>
                <c:pt idx="485">
                  <c:v>33.358203799654547</c:v>
                </c:pt>
                <c:pt idx="486">
                  <c:v>38.360959651035998</c:v>
                </c:pt>
                <c:pt idx="487">
                  <c:v>38.149311683727497</c:v>
                </c:pt>
                <c:pt idx="488">
                  <c:v>34.001766784452265</c:v>
                </c:pt>
                <c:pt idx="489">
                  <c:v>36.951818181818147</c:v>
                </c:pt>
                <c:pt idx="490">
                  <c:v>37.229789318961338</c:v>
                </c:pt>
                <c:pt idx="491">
                  <c:v>39.019954940457012</c:v>
                </c:pt>
                <c:pt idx="492">
                  <c:v>37.724413004214298</c:v>
                </c:pt>
                <c:pt idx="493">
                  <c:v>39.485851019558901</c:v>
                </c:pt>
                <c:pt idx="494">
                  <c:v>36.574552683896563</c:v>
                </c:pt>
                <c:pt idx="495">
                  <c:v>37.093406593406563</c:v>
                </c:pt>
                <c:pt idx="496">
                  <c:v>38.635939741750413</c:v>
                </c:pt>
                <c:pt idx="497">
                  <c:v>39.043434343434299</c:v>
                </c:pt>
                <c:pt idx="498">
                  <c:v>39.330399798843395</c:v>
                </c:pt>
                <c:pt idx="499">
                  <c:v>37.976142697881812</c:v>
                </c:pt>
                <c:pt idx="500">
                  <c:v>38.110581506196347</c:v>
                </c:pt>
                <c:pt idx="501">
                  <c:v>40.235847350334595</c:v>
                </c:pt>
                <c:pt idx="502">
                  <c:v>37.856474258970394</c:v>
                </c:pt>
                <c:pt idx="503">
                  <c:v>37.608944050433394</c:v>
                </c:pt>
                <c:pt idx="504">
                  <c:v>36.849371373307463</c:v>
                </c:pt>
                <c:pt idx="505">
                  <c:v>38.6248331108144</c:v>
                </c:pt>
                <c:pt idx="506">
                  <c:v>37.602618657937803</c:v>
                </c:pt>
                <c:pt idx="507">
                  <c:v>36.129710780017511</c:v>
                </c:pt>
                <c:pt idx="508">
                  <c:v>35.506154178363197</c:v>
                </c:pt>
                <c:pt idx="509">
                  <c:v>39.481735159817347</c:v>
                </c:pt>
                <c:pt idx="510">
                  <c:v>41.039909067946446</c:v>
                </c:pt>
                <c:pt idx="511">
                  <c:v>38.193387842161435</c:v>
                </c:pt>
                <c:pt idx="512">
                  <c:v>36.678351391544503</c:v>
                </c:pt>
                <c:pt idx="513">
                  <c:v>38.9200472627018</c:v>
                </c:pt>
                <c:pt idx="514">
                  <c:v>37.116593337523611</c:v>
                </c:pt>
                <c:pt idx="515">
                  <c:v>35.907753254103</c:v>
                </c:pt>
                <c:pt idx="516">
                  <c:v>42.396396396396398</c:v>
                </c:pt>
                <c:pt idx="517">
                  <c:v>30.958333333333254</c:v>
                </c:pt>
                <c:pt idx="518">
                  <c:v>35.446674537583547</c:v>
                </c:pt>
                <c:pt idx="519">
                  <c:v>37.845814977973596</c:v>
                </c:pt>
                <c:pt idx="520">
                  <c:v>36.374623871614737</c:v>
                </c:pt>
                <c:pt idx="521">
                  <c:v>39.559767971825195</c:v>
                </c:pt>
                <c:pt idx="522">
                  <c:v>39.276794493608648</c:v>
                </c:pt>
                <c:pt idx="523">
                  <c:v>36.207307979120102</c:v>
                </c:pt>
                <c:pt idx="524">
                  <c:v>30.793859649122787</c:v>
                </c:pt>
                <c:pt idx="525">
                  <c:v>35.315428571428548</c:v>
                </c:pt>
                <c:pt idx="526">
                  <c:v>37.329805249788301</c:v>
                </c:pt>
                <c:pt idx="527">
                  <c:v>39.566225165562898</c:v>
                </c:pt>
                <c:pt idx="528">
                  <c:v>39.090558194774346</c:v>
                </c:pt>
                <c:pt idx="529">
                  <c:v>39.138496677740896</c:v>
                </c:pt>
                <c:pt idx="530">
                  <c:v>38.743670223896196</c:v>
                </c:pt>
                <c:pt idx="531">
                  <c:v>40.621118012422436</c:v>
                </c:pt>
                <c:pt idx="532">
                  <c:v>38.038618809632005</c:v>
                </c:pt>
                <c:pt idx="533">
                  <c:v>41.057412167951995</c:v>
                </c:pt>
                <c:pt idx="534">
                  <c:v>39.402822480812063</c:v>
                </c:pt>
                <c:pt idx="535">
                  <c:v>36.267460178540198</c:v>
                </c:pt>
                <c:pt idx="536">
                  <c:v>38.319320712694896</c:v>
                </c:pt>
                <c:pt idx="537">
                  <c:v>36.940350877192998</c:v>
                </c:pt>
                <c:pt idx="538">
                  <c:v>38.837434750186347</c:v>
                </c:pt>
                <c:pt idx="539">
                  <c:v>36.693469164999101</c:v>
                </c:pt>
                <c:pt idx="540">
                  <c:v>39.5805384978744</c:v>
                </c:pt>
                <c:pt idx="541">
                  <c:v>37.514107514107494</c:v>
                </c:pt>
                <c:pt idx="542">
                  <c:v>38.596765779864398</c:v>
                </c:pt>
                <c:pt idx="543">
                  <c:v>38.375207609844438</c:v>
                </c:pt>
                <c:pt idx="544">
                  <c:v>38.135679504205399</c:v>
                </c:pt>
                <c:pt idx="545">
                  <c:v>38.0582908885116</c:v>
                </c:pt>
                <c:pt idx="546">
                  <c:v>36.533655006031402</c:v>
                </c:pt>
                <c:pt idx="547">
                  <c:v>34.5027947830716</c:v>
                </c:pt>
                <c:pt idx="548">
                  <c:v>39.782128514056211</c:v>
                </c:pt>
                <c:pt idx="549">
                  <c:v>38.5</c:v>
                </c:pt>
                <c:pt idx="550">
                  <c:v>38.415282392026597</c:v>
                </c:pt>
                <c:pt idx="551">
                  <c:v>40.279061745429502</c:v>
                </c:pt>
                <c:pt idx="552">
                  <c:v>35.852023121387248</c:v>
                </c:pt>
                <c:pt idx="553">
                  <c:v>39.665283842794835</c:v>
                </c:pt>
                <c:pt idx="554">
                  <c:v>35.127625201938599</c:v>
                </c:pt>
                <c:pt idx="555">
                  <c:v>35.118460613349363</c:v>
                </c:pt>
                <c:pt idx="556">
                  <c:v>34.080278128950745</c:v>
                </c:pt>
                <c:pt idx="557">
                  <c:v>38.321248600223996</c:v>
                </c:pt>
                <c:pt idx="558">
                  <c:v>38.149677166894897</c:v>
                </c:pt>
                <c:pt idx="559">
                  <c:v>39.209064073623864</c:v>
                </c:pt>
                <c:pt idx="560">
                  <c:v>39.589558232931772</c:v>
                </c:pt>
                <c:pt idx="561">
                  <c:v>39.690324858757101</c:v>
                </c:pt>
                <c:pt idx="562">
                  <c:v>39.241971207087495</c:v>
                </c:pt>
                <c:pt idx="563">
                  <c:v>39.5585146286572</c:v>
                </c:pt>
                <c:pt idx="564">
                  <c:v>37.131871035940797</c:v>
                </c:pt>
                <c:pt idx="565">
                  <c:v>38.885150291610564</c:v>
                </c:pt>
                <c:pt idx="566">
                  <c:v>44.921397379912648</c:v>
                </c:pt>
                <c:pt idx="567">
                  <c:v>41.007351439656894</c:v>
                </c:pt>
                <c:pt idx="568">
                  <c:v>37.4202669079394</c:v>
                </c:pt>
                <c:pt idx="569">
                  <c:v>38.032177531206663</c:v>
                </c:pt>
                <c:pt idx="570">
                  <c:v>42.4613583138173</c:v>
                </c:pt>
                <c:pt idx="571">
                  <c:v>42.456865747830463</c:v>
                </c:pt>
                <c:pt idx="572">
                  <c:v>43.157939548744096</c:v>
                </c:pt>
                <c:pt idx="573">
                  <c:v>39.811230585424063</c:v>
                </c:pt>
                <c:pt idx="574">
                  <c:v>38.559472628260195</c:v>
                </c:pt>
                <c:pt idx="575">
                  <c:v>38.463029432878699</c:v>
                </c:pt>
                <c:pt idx="576">
                  <c:v>36.700448430493296</c:v>
                </c:pt>
                <c:pt idx="577">
                  <c:v>38.276304888152403</c:v>
                </c:pt>
                <c:pt idx="578">
                  <c:v>37.305495689655196</c:v>
                </c:pt>
                <c:pt idx="579">
                  <c:v>37.128470425935511</c:v>
                </c:pt>
                <c:pt idx="580">
                  <c:v>36.953723404255264</c:v>
                </c:pt>
                <c:pt idx="581">
                  <c:v>35.828632251197398</c:v>
                </c:pt>
                <c:pt idx="582">
                  <c:v>38.423155737704946</c:v>
                </c:pt>
                <c:pt idx="583">
                  <c:v>39.204051012753197</c:v>
                </c:pt>
                <c:pt idx="584">
                  <c:v>35.153190559440539</c:v>
                </c:pt>
                <c:pt idx="585">
                  <c:v>37.057538994800737</c:v>
                </c:pt>
                <c:pt idx="586">
                  <c:v>42.2526051024075</c:v>
                </c:pt>
                <c:pt idx="587">
                  <c:v>34.252229753835195</c:v>
                </c:pt>
                <c:pt idx="588">
                  <c:v>37.248971193415599</c:v>
                </c:pt>
                <c:pt idx="589">
                  <c:v>39.271729957805903</c:v>
                </c:pt>
                <c:pt idx="590">
                  <c:v>37.087212413055099</c:v>
                </c:pt>
                <c:pt idx="591">
                  <c:v>39.274675520676098</c:v>
                </c:pt>
                <c:pt idx="592">
                  <c:v>41.554905490549096</c:v>
                </c:pt>
                <c:pt idx="593">
                  <c:v>36.121242484969912</c:v>
                </c:pt>
                <c:pt idx="594">
                  <c:v>40.952738990333003</c:v>
                </c:pt>
                <c:pt idx="595">
                  <c:v>39.933453237410099</c:v>
                </c:pt>
                <c:pt idx="596">
                  <c:v>40.158109788594835</c:v>
                </c:pt>
                <c:pt idx="597">
                  <c:v>42.291728212703113</c:v>
                </c:pt>
                <c:pt idx="598">
                  <c:v>39.794967564379803</c:v>
                </c:pt>
                <c:pt idx="599">
                  <c:v>37.468203497615264</c:v>
                </c:pt>
                <c:pt idx="600">
                  <c:v>37.085298742138413</c:v>
                </c:pt>
                <c:pt idx="601">
                  <c:v>35.885565052231655</c:v>
                </c:pt>
                <c:pt idx="602">
                  <c:v>40.409842154131802</c:v>
                </c:pt>
                <c:pt idx="603">
                  <c:v>38.168143603726399</c:v>
                </c:pt>
                <c:pt idx="604">
                  <c:v>39.317695961995163</c:v>
                </c:pt>
                <c:pt idx="605">
                  <c:v>34.687163720215196</c:v>
                </c:pt>
                <c:pt idx="606">
                  <c:v>35.434611602753165</c:v>
                </c:pt>
                <c:pt idx="607">
                  <c:v>39.341403699673528</c:v>
                </c:pt>
                <c:pt idx="608">
                  <c:v>39.684481280365794</c:v>
                </c:pt>
                <c:pt idx="609">
                  <c:v>36.391287660717609</c:v>
                </c:pt>
                <c:pt idx="610">
                  <c:v>43.036800000000007</c:v>
                </c:pt>
                <c:pt idx="611">
                  <c:v>35.403100775193799</c:v>
                </c:pt>
                <c:pt idx="612">
                  <c:v>37.434162062615094</c:v>
                </c:pt>
                <c:pt idx="613">
                  <c:v>38.159866017052337</c:v>
                </c:pt>
                <c:pt idx="614">
                  <c:v>38.388253409590895</c:v>
                </c:pt>
                <c:pt idx="615">
                  <c:v>37.414634146341463</c:v>
                </c:pt>
                <c:pt idx="616">
                  <c:v>37.658251900108603</c:v>
                </c:pt>
                <c:pt idx="617">
                  <c:v>56.0322580645161</c:v>
                </c:pt>
                <c:pt idx="618">
                  <c:v>39.396974063400563</c:v>
                </c:pt>
                <c:pt idx="619">
                  <c:v>37.065203761755498</c:v>
                </c:pt>
                <c:pt idx="620">
                  <c:v>38.857918930213096</c:v>
                </c:pt>
                <c:pt idx="621">
                  <c:v>38.092463923035837</c:v>
                </c:pt>
                <c:pt idx="622">
                  <c:v>36.518597997138812</c:v>
                </c:pt>
                <c:pt idx="623">
                  <c:v>40.979457364341094</c:v>
                </c:pt>
                <c:pt idx="624">
                  <c:v>38.540873663222747</c:v>
                </c:pt>
                <c:pt idx="625">
                  <c:v>38.371522769420999</c:v>
                </c:pt>
                <c:pt idx="626">
                  <c:v>39.561394101876701</c:v>
                </c:pt>
                <c:pt idx="627">
                  <c:v>38.560024625487394</c:v>
                </c:pt>
                <c:pt idx="628">
                  <c:v>40.783199721157203</c:v>
                </c:pt>
                <c:pt idx="629">
                  <c:v>37.046272991287495</c:v>
                </c:pt>
                <c:pt idx="630">
                  <c:v>38.643276661514648</c:v>
                </c:pt>
                <c:pt idx="631">
                  <c:v>37.488430268918101</c:v>
                </c:pt>
                <c:pt idx="632">
                  <c:v>38.387495320104811</c:v>
                </c:pt>
                <c:pt idx="633">
                  <c:v>40.580109289617454</c:v>
                </c:pt>
                <c:pt idx="634">
                  <c:v>38.732614107883812</c:v>
                </c:pt>
                <c:pt idx="635">
                  <c:v>34.573979591836647</c:v>
                </c:pt>
                <c:pt idx="636">
                  <c:v>37.168115942029132</c:v>
                </c:pt>
                <c:pt idx="637">
                  <c:v>39.091682070240239</c:v>
                </c:pt>
                <c:pt idx="638">
                  <c:v>39.826022852930301</c:v>
                </c:pt>
                <c:pt idx="639">
                  <c:v>39.166462668298664</c:v>
                </c:pt>
                <c:pt idx="640">
                  <c:v>37.674509803921602</c:v>
                </c:pt>
                <c:pt idx="641">
                  <c:v>42.235164835164845</c:v>
                </c:pt>
                <c:pt idx="642">
                  <c:v>40.040790312300835</c:v>
                </c:pt>
                <c:pt idx="643">
                  <c:v>38.787156570671996</c:v>
                </c:pt>
                <c:pt idx="644">
                  <c:v>39.812381951731346</c:v>
                </c:pt>
                <c:pt idx="645">
                  <c:v>37.036290322580612</c:v>
                </c:pt>
                <c:pt idx="646">
                  <c:v>41.547851002865265</c:v>
                </c:pt>
                <c:pt idx="647">
                  <c:v>27.970731707317089</c:v>
                </c:pt>
                <c:pt idx="648">
                  <c:v>40.955433455433429</c:v>
                </c:pt>
                <c:pt idx="649">
                  <c:v>39.839840637450195</c:v>
                </c:pt>
                <c:pt idx="650">
                  <c:v>38.655603448275912</c:v>
                </c:pt>
                <c:pt idx="651">
                  <c:v>39.1682219419924</c:v>
                </c:pt>
                <c:pt idx="652">
                  <c:v>37.950327387672147</c:v>
                </c:pt>
                <c:pt idx="653">
                  <c:v>36.955345316934746</c:v>
                </c:pt>
                <c:pt idx="654">
                  <c:v>35.670793214122035</c:v>
                </c:pt>
                <c:pt idx="655">
                  <c:v>37.948781495249847</c:v>
                </c:pt>
                <c:pt idx="656">
                  <c:v>39.369417108251298</c:v>
                </c:pt>
                <c:pt idx="657">
                  <c:v>35.020083682008398</c:v>
                </c:pt>
                <c:pt idx="658">
                  <c:v>36.451086956521664</c:v>
                </c:pt>
                <c:pt idx="659">
                  <c:v>39.320261437908464</c:v>
                </c:pt>
                <c:pt idx="660">
                  <c:v>42.126568466994001</c:v>
                </c:pt>
                <c:pt idx="661">
                  <c:v>37.071406102548004</c:v>
                </c:pt>
                <c:pt idx="662">
                  <c:v>38.037642306279835</c:v>
                </c:pt>
                <c:pt idx="663">
                  <c:v>37.908110350549762</c:v>
                </c:pt>
                <c:pt idx="664">
                  <c:v>42.704402515723295</c:v>
                </c:pt>
                <c:pt idx="665">
                  <c:v>37.746324589218794</c:v>
                </c:pt>
                <c:pt idx="666">
                  <c:v>37.166049382716004</c:v>
                </c:pt>
                <c:pt idx="667">
                  <c:v>38.687339825730398</c:v>
                </c:pt>
                <c:pt idx="668">
                  <c:v>36.638988488393998</c:v>
                </c:pt>
                <c:pt idx="669">
                  <c:v>35.993001930501954</c:v>
                </c:pt>
                <c:pt idx="670">
                  <c:v>38.587920261826795</c:v>
                </c:pt>
                <c:pt idx="671">
                  <c:v>36.4702251270879</c:v>
                </c:pt>
                <c:pt idx="672">
                  <c:v>39.438965724594112</c:v>
                </c:pt>
                <c:pt idx="673">
                  <c:v>39.277685492801801</c:v>
                </c:pt>
                <c:pt idx="674">
                  <c:v>34.5580182529335</c:v>
                </c:pt>
                <c:pt idx="675">
                  <c:v>37.327573794096494</c:v>
                </c:pt>
                <c:pt idx="676">
                  <c:v>39.348130841121545</c:v>
                </c:pt>
                <c:pt idx="677">
                  <c:v>38.182052604435313</c:v>
                </c:pt>
                <c:pt idx="678">
                  <c:v>34.856070087609439</c:v>
                </c:pt>
                <c:pt idx="679">
                  <c:v>38.303129829984499</c:v>
                </c:pt>
                <c:pt idx="680">
                  <c:v>35.081771720613247</c:v>
                </c:pt>
                <c:pt idx="681">
                  <c:v>35.986842105263129</c:v>
                </c:pt>
                <c:pt idx="682">
                  <c:v>36.038443723946294</c:v>
                </c:pt>
                <c:pt idx="683">
                  <c:v>40.050474254742412</c:v>
                </c:pt>
                <c:pt idx="684">
                  <c:v>38.649097815764463</c:v>
                </c:pt>
                <c:pt idx="685">
                  <c:v>41.816283924843347</c:v>
                </c:pt>
                <c:pt idx="686">
                  <c:v>37.934449093444847</c:v>
                </c:pt>
                <c:pt idx="687">
                  <c:v>41.939172749391737</c:v>
                </c:pt>
                <c:pt idx="688">
                  <c:v>37.905000000000001</c:v>
                </c:pt>
                <c:pt idx="689">
                  <c:v>39.901245551601328</c:v>
                </c:pt>
                <c:pt idx="690">
                  <c:v>37.390047074646837</c:v>
                </c:pt>
                <c:pt idx="691">
                  <c:v>37.252864375166439</c:v>
                </c:pt>
                <c:pt idx="692">
                  <c:v>35.1533333333333</c:v>
                </c:pt>
                <c:pt idx="693">
                  <c:v>37.748543463062163</c:v>
                </c:pt>
                <c:pt idx="694">
                  <c:v>38.850699844479003</c:v>
                </c:pt>
                <c:pt idx="695">
                  <c:v>37.103174603174601</c:v>
                </c:pt>
                <c:pt idx="696">
                  <c:v>40.947720011617747</c:v>
                </c:pt>
                <c:pt idx="697">
                  <c:v>36.953864589574529</c:v>
                </c:pt>
                <c:pt idx="698">
                  <c:v>39.160801144492098</c:v>
                </c:pt>
                <c:pt idx="699">
                  <c:v>40.635902168897111</c:v>
                </c:pt>
                <c:pt idx="700">
                  <c:v>38.473913905971045</c:v>
                </c:pt>
                <c:pt idx="701">
                  <c:v>38.259545674238801</c:v>
                </c:pt>
                <c:pt idx="702">
                  <c:v>33.489787902592248</c:v>
                </c:pt>
                <c:pt idx="703">
                  <c:v>28.405664906384978</c:v>
                </c:pt>
                <c:pt idx="704">
                  <c:v>26.637120054338617</c:v>
                </c:pt>
                <c:pt idx="705">
                  <c:v>29.200837915684701</c:v>
                </c:pt>
                <c:pt idx="706">
                  <c:v>27.745238095238086</c:v>
                </c:pt>
                <c:pt idx="707">
                  <c:v>28.725858867223799</c:v>
                </c:pt>
                <c:pt idx="708">
                  <c:v>27.955637307941959</c:v>
                </c:pt>
                <c:pt idx="709">
                  <c:v>29.297499066815988</c:v>
                </c:pt>
                <c:pt idx="710">
                  <c:v>28.736040609137078</c:v>
                </c:pt>
                <c:pt idx="711">
                  <c:v>26.774647887323859</c:v>
                </c:pt>
                <c:pt idx="712">
                  <c:v>27.043596730245177</c:v>
                </c:pt>
                <c:pt idx="713">
                  <c:v>31.084012417539789</c:v>
                </c:pt>
                <c:pt idx="714">
                  <c:v>27.629839471199187</c:v>
                </c:pt>
                <c:pt idx="715">
                  <c:v>23.067695961995199</c:v>
                </c:pt>
                <c:pt idx="716">
                  <c:v>26.1196868008949</c:v>
                </c:pt>
                <c:pt idx="717">
                  <c:v>28.566957414058535</c:v>
                </c:pt>
                <c:pt idx="718">
                  <c:v>26.155133295518986</c:v>
                </c:pt>
                <c:pt idx="719">
                  <c:v>27.892134831460677</c:v>
                </c:pt>
                <c:pt idx="720">
                  <c:v>28.007994186046535</c:v>
                </c:pt>
                <c:pt idx="721">
                  <c:v>28.776022681247486</c:v>
                </c:pt>
                <c:pt idx="722">
                  <c:v>29.819981834695717</c:v>
                </c:pt>
                <c:pt idx="723">
                  <c:v>28.527552674230087</c:v>
                </c:pt>
                <c:pt idx="724">
                  <c:v>26.7062937062937</c:v>
                </c:pt>
                <c:pt idx="725">
                  <c:v>28.587456174522789</c:v>
                </c:pt>
                <c:pt idx="726">
                  <c:v>31.081851214381299</c:v>
                </c:pt>
                <c:pt idx="727">
                  <c:v>29.497528830312977</c:v>
                </c:pt>
                <c:pt idx="728">
                  <c:v>32.619990342829645</c:v>
                </c:pt>
                <c:pt idx="729">
                  <c:v>28.822580645161263</c:v>
                </c:pt>
                <c:pt idx="730">
                  <c:v>27.006092916983977</c:v>
                </c:pt>
                <c:pt idx="731">
                  <c:v>23.956956187547988</c:v>
                </c:pt>
                <c:pt idx="732">
                  <c:v>30.464207769532987</c:v>
                </c:pt>
                <c:pt idx="733">
                  <c:v>30.462710831131837</c:v>
                </c:pt>
                <c:pt idx="734">
                  <c:v>30.066689822855189</c:v>
                </c:pt>
                <c:pt idx="735">
                  <c:v>27.2571015017188</c:v>
                </c:pt>
                <c:pt idx="736">
                  <c:v>29.066950699939099</c:v>
                </c:pt>
                <c:pt idx="737">
                  <c:v>28.058099062918288</c:v>
                </c:pt>
                <c:pt idx="738">
                  <c:v>27.749906402096617</c:v>
                </c:pt>
                <c:pt idx="739">
                  <c:v>29.482379644009075</c:v>
                </c:pt>
                <c:pt idx="740">
                  <c:v>27.5679437294223</c:v>
                </c:pt>
                <c:pt idx="741">
                  <c:v>28.5710594315245</c:v>
                </c:pt>
                <c:pt idx="742">
                  <c:v>29.505197132616505</c:v>
                </c:pt>
                <c:pt idx="743">
                  <c:v>32.515923566879003</c:v>
                </c:pt>
                <c:pt idx="744">
                  <c:v>27.749885896850817</c:v>
                </c:pt>
                <c:pt idx="745">
                  <c:v>28.601629696695287</c:v>
                </c:pt>
                <c:pt idx="746">
                  <c:v>28.407275711159716</c:v>
                </c:pt>
                <c:pt idx="747">
                  <c:v>25.688701923076888</c:v>
                </c:pt>
                <c:pt idx="748">
                  <c:v>27.0949494949495</c:v>
                </c:pt>
                <c:pt idx="749">
                  <c:v>31.075544527157376</c:v>
                </c:pt>
                <c:pt idx="750">
                  <c:v>27.208333333333254</c:v>
                </c:pt>
                <c:pt idx="751">
                  <c:v>30.227917620137287</c:v>
                </c:pt>
                <c:pt idx="752">
                  <c:v>27.652467054857517</c:v>
                </c:pt>
                <c:pt idx="753">
                  <c:v>26.838789158746899</c:v>
                </c:pt>
                <c:pt idx="754">
                  <c:v>14.0294117647059</c:v>
                </c:pt>
                <c:pt idx="755">
                  <c:v>26.894026974951789</c:v>
                </c:pt>
                <c:pt idx="756">
                  <c:v>27.584886392647405</c:v>
                </c:pt>
                <c:pt idx="757">
                  <c:v>28.666993913214217</c:v>
                </c:pt>
                <c:pt idx="758">
                  <c:v>28.195396145610299</c:v>
                </c:pt>
                <c:pt idx="759">
                  <c:v>27.093063583814999</c:v>
                </c:pt>
                <c:pt idx="760">
                  <c:v>26.618131359852018</c:v>
                </c:pt>
                <c:pt idx="761">
                  <c:v>26.050505050505102</c:v>
                </c:pt>
                <c:pt idx="762">
                  <c:v>27.993771087464289</c:v>
                </c:pt>
                <c:pt idx="763">
                  <c:v>29.004158004158018</c:v>
                </c:pt>
                <c:pt idx="764">
                  <c:v>30.873995771670216</c:v>
                </c:pt>
                <c:pt idx="765">
                  <c:v>25.757223113964699</c:v>
                </c:pt>
                <c:pt idx="766">
                  <c:v>26.146541137945089</c:v>
                </c:pt>
                <c:pt idx="767">
                  <c:v>28.589179210451586</c:v>
                </c:pt>
                <c:pt idx="768">
                  <c:v>29.8914535246413</c:v>
                </c:pt>
                <c:pt idx="769">
                  <c:v>27.326310102647199</c:v>
                </c:pt>
                <c:pt idx="770">
                  <c:v>29.014398354473801</c:v>
                </c:pt>
                <c:pt idx="771">
                  <c:v>31.409332153914189</c:v>
                </c:pt>
                <c:pt idx="772">
                  <c:v>27.963677639046502</c:v>
                </c:pt>
                <c:pt idx="773">
                  <c:v>29.598591549295787</c:v>
                </c:pt>
                <c:pt idx="774">
                  <c:v>26.183911019141199</c:v>
                </c:pt>
                <c:pt idx="775">
                  <c:v>28.432405891980402</c:v>
                </c:pt>
                <c:pt idx="776">
                  <c:v>25.828105906313599</c:v>
                </c:pt>
                <c:pt idx="777">
                  <c:v>27.1312404621757</c:v>
                </c:pt>
                <c:pt idx="778">
                  <c:v>28.069604086845487</c:v>
                </c:pt>
                <c:pt idx="779">
                  <c:v>28.636690647481988</c:v>
                </c:pt>
                <c:pt idx="780">
                  <c:v>26.496688741721876</c:v>
                </c:pt>
                <c:pt idx="781">
                  <c:v>31.492446605313358</c:v>
                </c:pt>
                <c:pt idx="782">
                  <c:v>29.156998090762201</c:v>
                </c:pt>
                <c:pt idx="783">
                  <c:v>29.280413159908189</c:v>
                </c:pt>
                <c:pt idx="784">
                  <c:v>28.383658135712601</c:v>
                </c:pt>
                <c:pt idx="785">
                  <c:v>29.253556910569078</c:v>
                </c:pt>
                <c:pt idx="786">
                  <c:v>25.120718887758599</c:v>
                </c:pt>
                <c:pt idx="787">
                  <c:v>29.224466891133577</c:v>
                </c:pt>
                <c:pt idx="788">
                  <c:v>25.127567567567599</c:v>
                </c:pt>
                <c:pt idx="789">
                  <c:v>29.129452054794498</c:v>
                </c:pt>
                <c:pt idx="790">
                  <c:v>30.2172719935432</c:v>
                </c:pt>
                <c:pt idx="791">
                  <c:v>26.087947882736177</c:v>
                </c:pt>
                <c:pt idx="792">
                  <c:v>33.332313965341498</c:v>
                </c:pt>
                <c:pt idx="793">
                  <c:v>23.357983193277317</c:v>
                </c:pt>
                <c:pt idx="794">
                  <c:v>27.9128882541949</c:v>
                </c:pt>
                <c:pt idx="795">
                  <c:v>27.522797131147478</c:v>
                </c:pt>
                <c:pt idx="796">
                  <c:v>26.598630136986277</c:v>
                </c:pt>
                <c:pt idx="797">
                  <c:v>27.383838383838388</c:v>
                </c:pt>
                <c:pt idx="798">
                  <c:v>25.406385616862988</c:v>
                </c:pt>
                <c:pt idx="799">
                  <c:v>27.992383853769962</c:v>
                </c:pt>
                <c:pt idx="800">
                  <c:v>27.266846361185976</c:v>
                </c:pt>
                <c:pt idx="801">
                  <c:v>29.202113606340777</c:v>
                </c:pt>
                <c:pt idx="802">
                  <c:v>28.162582781456987</c:v>
                </c:pt>
                <c:pt idx="803">
                  <c:v>27.104734848484799</c:v>
                </c:pt>
                <c:pt idx="804">
                  <c:v>31.707492795388987</c:v>
                </c:pt>
                <c:pt idx="805">
                  <c:v>28.6152524905531</c:v>
                </c:pt>
                <c:pt idx="806">
                  <c:v>28.714027149321289</c:v>
                </c:pt>
                <c:pt idx="807">
                  <c:v>27.015934706568199</c:v>
                </c:pt>
                <c:pt idx="808">
                  <c:v>27.173016584491286</c:v>
                </c:pt>
                <c:pt idx="809">
                  <c:v>31.727019498607188</c:v>
                </c:pt>
                <c:pt idx="810">
                  <c:v>28.494170740880001</c:v>
                </c:pt>
                <c:pt idx="811">
                  <c:v>25.712922173274599</c:v>
                </c:pt>
                <c:pt idx="812">
                  <c:v>27.731758530183686</c:v>
                </c:pt>
                <c:pt idx="813">
                  <c:v>26.685169124024299</c:v>
                </c:pt>
                <c:pt idx="814">
                  <c:v>28.522511097019699</c:v>
                </c:pt>
                <c:pt idx="815">
                  <c:v>26.732965009208126</c:v>
                </c:pt>
                <c:pt idx="816">
                  <c:v>28.206040992448788</c:v>
                </c:pt>
                <c:pt idx="817">
                  <c:v>27.479095270733364</c:v>
                </c:pt>
                <c:pt idx="818">
                  <c:v>28.0894257257894</c:v>
                </c:pt>
                <c:pt idx="819">
                  <c:v>33.244224422442137</c:v>
                </c:pt>
                <c:pt idx="820">
                  <c:v>28.039748953974886</c:v>
                </c:pt>
                <c:pt idx="821">
                  <c:v>30.249028611798</c:v>
                </c:pt>
                <c:pt idx="822">
                  <c:v>29.005320328086899</c:v>
                </c:pt>
                <c:pt idx="823">
                  <c:v>25.634672418441617</c:v>
                </c:pt>
                <c:pt idx="824">
                  <c:v>27.947368421052634</c:v>
                </c:pt>
                <c:pt idx="825">
                  <c:v>26.899594320486798</c:v>
                </c:pt>
                <c:pt idx="826">
                  <c:v>28.294708220037599</c:v>
                </c:pt>
                <c:pt idx="827">
                  <c:v>28.855584415584399</c:v>
                </c:pt>
                <c:pt idx="828">
                  <c:v>29.913913043478299</c:v>
                </c:pt>
                <c:pt idx="829">
                  <c:v>28.483375959079289</c:v>
                </c:pt>
                <c:pt idx="830">
                  <c:v>25.4174603174603</c:v>
                </c:pt>
                <c:pt idx="831">
                  <c:v>28.000582580833075</c:v>
                </c:pt>
                <c:pt idx="832">
                  <c:v>27.953819840364876</c:v>
                </c:pt>
                <c:pt idx="833">
                  <c:v>28.725753871230577</c:v>
                </c:pt>
                <c:pt idx="834">
                  <c:v>26.956933483652801</c:v>
                </c:pt>
                <c:pt idx="835">
                  <c:v>26.728012201321754</c:v>
                </c:pt>
                <c:pt idx="836">
                  <c:v>28.923329083955576</c:v>
                </c:pt>
                <c:pt idx="837">
                  <c:v>30.7781559405941</c:v>
                </c:pt>
                <c:pt idx="838">
                  <c:v>26.454782382069276</c:v>
                </c:pt>
                <c:pt idx="839">
                  <c:v>27.391226499552399</c:v>
                </c:pt>
                <c:pt idx="840">
                  <c:v>30.596289062499999</c:v>
                </c:pt>
                <c:pt idx="841">
                  <c:v>28.446388682055087</c:v>
                </c:pt>
                <c:pt idx="842">
                  <c:v>28.663416898792889</c:v>
                </c:pt>
                <c:pt idx="843">
                  <c:v>28.418347556245177</c:v>
                </c:pt>
                <c:pt idx="844">
                  <c:v>26.693815635939288</c:v>
                </c:pt>
                <c:pt idx="845">
                  <c:v>27.440318302387276</c:v>
                </c:pt>
                <c:pt idx="846">
                  <c:v>26.398788310762686</c:v>
                </c:pt>
                <c:pt idx="847">
                  <c:v>28.526956521739088</c:v>
                </c:pt>
                <c:pt idx="848">
                  <c:v>28.010281385281399</c:v>
                </c:pt>
                <c:pt idx="849">
                  <c:v>29.787536595566664</c:v>
                </c:pt>
                <c:pt idx="850">
                  <c:v>28.508871989860605</c:v>
                </c:pt>
                <c:pt idx="851">
                  <c:v>27.104236970378686</c:v>
                </c:pt>
                <c:pt idx="852">
                  <c:v>28.733333333333263</c:v>
                </c:pt>
                <c:pt idx="853">
                  <c:v>28.225545171339576</c:v>
                </c:pt>
                <c:pt idx="854">
                  <c:v>28.488714425907776</c:v>
                </c:pt>
                <c:pt idx="855">
                  <c:v>27.968386444107164</c:v>
                </c:pt>
                <c:pt idx="856">
                  <c:v>28.410770031217499</c:v>
                </c:pt>
                <c:pt idx="857">
                  <c:v>27.658131116771699</c:v>
                </c:pt>
                <c:pt idx="858">
                  <c:v>30.931034482758601</c:v>
                </c:pt>
                <c:pt idx="859">
                  <c:v>26.735058533579789</c:v>
                </c:pt>
                <c:pt idx="860">
                  <c:v>25.170818505338101</c:v>
                </c:pt>
                <c:pt idx="861">
                  <c:v>28.791276547156887</c:v>
                </c:pt>
                <c:pt idx="862">
                  <c:v>30.115947015310518</c:v>
                </c:pt>
                <c:pt idx="863">
                  <c:v>29.429026651216699</c:v>
                </c:pt>
                <c:pt idx="864">
                  <c:v>29.408437730287371</c:v>
                </c:pt>
                <c:pt idx="865">
                  <c:v>29.824838898652626</c:v>
                </c:pt>
                <c:pt idx="866">
                  <c:v>30.171911880409105</c:v>
                </c:pt>
                <c:pt idx="867">
                  <c:v>28.448532144184259</c:v>
                </c:pt>
                <c:pt idx="868">
                  <c:v>27.753971486761699</c:v>
                </c:pt>
                <c:pt idx="869">
                  <c:v>29.0208691382274</c:v>
                </c:pt>
                <c:pt idx="870">
                  <c:v>28.093055080396901</c:v>
                </c:pt>
                <c:pt idx="871">
                  <c:v>27.424339987121662</c:v>
                </c:pt>
                <c:pt idx="872">
                  <c:v>27.733114919354801</c:v>
                </c:pt>
                <c:pt idx="873">
                  <c:v>27.133474576271187</c:v>
                </c:pt>
                <c:pt idx="874">
                  <c:v>28.2775532201563</c:v>
                </c:pt>
                <c:pt idx="875">
                  <c:v>28.327777777777786</c:v>
                </c:pt>
                <c:pt idx="876">
                  <c:v>29.942528735632177</c:v>
                </c:pt>
                <c:pt idx="877">
                  <c:v>30.350364963503701</c:v>
                </c:pt>
                <c:pt idx="878">
                  <c:v>28.054478976234005</c:v>
                </c:pt>
                <c:pt idx="879">
                  <c:v>31.366233766233787</c:v>
                </c:pt>
                <c:pt idx="880">
                  <c:v>29.457812499999999</c:v>
                </c:pt>
                <c:pt idx="881">
                  <c:v>29.382617382617376</c:v>
                </c:pt>
                <c:pt idx="882">
                  <c:v>23.439024390243887</c:v>
                </c:pt>
                <c:pt idx="883">
                  <c:v>29.933127572016499</c:v>
                </c:pt>
                <c:pt idx="884">
                  <c:v>25.942028985507175</c:v>
                </c:pt>
                <c:pt idx="885">
                  <c:v>29.047197640118</c:v>
                </c:pt>
                <c:pt idx="886">
                  <c:v>27.783716594157863</c:v>
                </c:pt>
                <c:pt idx="887">
                  <c:v>28.512210394489699</c:v>
                </c:pt>
                <c:pt idx="888">
                  <c:v>28.359927140255017</c:v>
                </c:pt>
                <c:pt idx="889">
                  <c:v>29.057240011334699</c:v>
                </c:pt>
                <c:pt idx="890">
                  <c:v>28.055108359133087</c:v>
                </c:pt>
                <c:pt idx="891">
                  <c:v>27.905591200733259</c:v>
                </c:pt>
                <c:pt idx="892">
                  <c:v>25.522242535039563</c:v>
                </c:pt>
                <c:pt idx="893">
                  <c:v>25.675141242937876</c:v>
                </c:pt>
                <c:pt idx="894">
                  <c:v>28.299035369774899</c:v>
                </c:pt>
                <c:pt idx="895">
                  <c:v>28.203448275862076</c:v>
                </c:pt>
                <c:pt idx="896">
                  <c:v>28.263661971830977</c:v>
                </c:pt>
                <c:pt idx="897">
                  <c:v>25.604587781058431</c:v>
                </c:pt>
                <c:pt idx="898">
                  <c:v>28.665569724393286</c:v>
                </c:pt>
                <c:pt idx="899">
                  <c:v>27.221184461897717</c:v>
                </c:pt>
                <c:pt idx="900">
                  <c:v>28.682985279014005</c:v>
                </c:pt>
                <c:pt idx="901">
                  <c:v>27.443193449334689</c:v>
                </c:pt>
                <c:pt idx="902">
                  <c:v>27.141315414375899</c:v>
                </c:pt>
                <c:pt idx="903">
                  <c:v>29.311621966794434</c:v>
                </c:pt>
                <c:pt idx="904">
                  <c:v>25.086220169360978</c:v>
                </c:pt>
                <c:pt idx="905">
                  <c:v>26.863849765258198</c:v>
                </c:pt>
                <c:pt idx="906">
                  <c:v>28.752930232558089</c:v>
                </c:pt>
                <c:pt idx="907">
                  <c:v>26.270136778115489</c:v>
                </c:pt>
                <c:pt idx="908">
                  <c:v>28.451097804391189</c:v>
                </c:pt>
                <c:pt idx="909">
                  <c:v>27.142699115044199</c:v>
                </c:pt>
                <c:pt idx="910">
                  <c:v>27.961582437685777</c:v>
                </c:pt>
                <c:pt idx="911">
                  <c:v>25.187713310580186</c:v>
                </c:pt>
                <c:pt idx="912">
                  <c:v>22.552127659574499</c:v>
                </c:pt>
                <c:pt idx="913">
                  <c:v>29.489925158318901</c:v>
                </c:pt>
                <c:pt idx="914">
                  <c:v>30.210252600297199</c:v>
                </c:pt>
                <c:pt idx="915">
                  <c:v>29.224354418384301</c:v>
                </c:pt>
                <c:pt idx="916">
                  <c:v>27.693017127799717</c:v>
                </c:pt>
                <c:pt idx="917">
                  <c:v>27.719982078853</c:v>
                </c:pt>
                <c:pt idx="918">
                  <c:v>27.733885819521188</c:v>
                </c:pt>
                <c:pt idx="919">
                  <c:v>30.415499533146576</c:v>
                </c:pt>
                <c:pt idx="920">
                  <c:v>31.095823095823089</c:v>
                </c:pt>
                <c:pt idx="921">
                  <c:v>28.060369096027486</c:v>
                </c:pt>
                <c:pt idx="922">
                  <c:v>27.927088249174087</c:v>
                </c:pt>
                <c:pt idx="923">
                  <c:v>31.840127388534977</c:v>
                </c:pt>
                <c:pt idx="924">
                  <c:v>29.494328358209</c:v>
                </c:pt>
                <c:pt idx="925">
                  <c:v>26.834341213120787</c:v>
                </c:pt>
                <c:pt idx="926">
                  <c:v>28.082578397212501</c:v>
                </c:pt>
                <c:pt idx="927">
                  <c:v>29.048747763863979</c:v>
                </c:pt>
                <c:pt idx="928">
                  <c:v>25.423469387755077</c:v>
                </c:pt>
                <c:pt idx="929">
                  <c:v>24.342507645259889</c:v>
                </c:pt>
                <c:pt idx="930">
                  <c:v>26.961180124223599</c:v>
                </c:pt>
                <c:pt idx="931">
                  <c:v>27.863489499192202</c:v>
                </c:pt>
                <c:pt idx="932">
                  <c:v>29.372696245733763</c:v>
                </c:pt>
                <c:pt idx="933">
                  <c:v>27.365100671140876</c:v>
                </c:pt>
                <c:pt idx="934">
                  <c:v>26.233406272793577</c:v>
                </c:pt>
                <c:pt idx="935">
                  <c:v>27.642736486486488</c:v>
                </c:pt>
                <c:pt idx="936">
                  <c:v>27.4860619782086</c:v>
                </c:pt>
                <c:pt idx="937">
                  <c:v>25.658195679796705</c:v>
                </c:pt>
                <c:pt idx="938">
                  <c:v>29.056693663649401</c:v>
                </c:pt>
                <c:pt idx="939">
                  <c:v>28.9691056910569</c:v>
                </c:pt>
                <c:pt idx="940">
                  <c:v>29.097971514889917</c:v>
                </c:pt>
                <c:pt idx="941">
                  <c:v>26.585487387106777</c:v>
                </c:pt>
                <c:pt idx="942">
                  <c:v>28.143648960738989</c:v>
                </c:pt>
                <c:pt idx="943">
                  <c:v>26.8815572418344</c:v>
                </c:pt>
                <c:pt idx="944">
                  <c:v>28.641774891774887</c:v>
                </c:pt>
                <c:pt idx="945">
                  <c:v>26.885580603998289</c:v>
                </c:pt>
                <c:pt idx="946">
                  <c:v>25.988868832731576</c:v>
                </c:pt>
                <c:pt idx="947">
                  <c:v>27.746533555185763</c:v>
                </c:pt>
                <c:pt idx="948">
                  <c:v>29.755545286506489</c:v>
                </c:pt>
                <c:pt idx="949">
                  <c:v>28.701298701298718</c:v>
                </c:pt>
                <c:pt idx="950">
                  <c:v>27.135041802980702</c:v>
                </c:pt>
                <c:pt idx="951">
                  <c:v>24.5976401179941</c:v>
                </c:pt>
                <c:pt idx="952">
                  <c:v>28.194346289752687</c:v>
                </c:pt>
                <c:pt idx="953">
                  <c:v>30.3136752136752</c:v>
                </c:pt>
                <c:pt idx="954">
                  <c:v>25.571428571428587</c:v>
                </c:pt>
                <c:pt idx="955">
                  <c:v>32.422000000000011</c:v>
                </c:pt>
                <c:pt idx="956">
                  <c:v>28.315388280133376</c:v>
                </c:pt>
                <c:pt idx="957">
                  <c:v>27.6514285714286</c:v>
                </c:pt>
                <c:pt idx="958">
                  <c:v>26.574896694214917</c:v>
                </c:pt>
                <c:pt idx="959">
                  <c:v>28.769133459835487</c:v>
                </c:pt>
                <c:pt idx="960">
                  <c:v>29.575034578146589</c:v>
                </c:pt>
                <c:pt idx="961">
                  <c:v>27.721177944862202</c:v>
                </c:pt>
                <c:pt idx="962">
                  <c:v>28.011009174311887</c:v>
                </c:pt>
                <c:pt idx="963">
                  <c:v>28.580110497237602</c:v>
                </c:pt>
                <c:pt idx="964">
                  <c:v>29.695914577530189</c:v>
                </c:pt>
                <c:pt idx="965">
                  <c:v>25.950435979807278</c:v>
                </c:pt>
                <c:pt idx="966">
                  <c:v>26.693877551020417</c:v>
                </c:pt>
                <c:pt idx="967">
                  <c:v>27.893149085247178</c:v>
                </c:pt>
                <c:pt idx="968">
                  <c:v>27.358941252420902</c:v>
                </c:pt>
                <c:pt idx="969">
                  <c:v>26.795204147764089</c:v>
                </c:pt>
                <c:pt idx="970">
                  <c:v>26.691421642922087</c:v>
                </c:pt>
                <c:pt idx="971">
                  <c:v>29.753908219868901</c:v>
                </c:pt>
                <c:pt idx="972">
                  <c:v>26.829741379310278</c:v>
                </c:pt>
                <c:pt idx="973">
                  <c:v>30.618300653594801</c:v>
                </c:pt>
                <c:pt idx="974">
                  <c:v>28.867834394904516</c:v>
                </c:pt>
                <c:pt idx="975">
                  <c:v>28.138714733542287</c:v>
                </c:pt>
                <c:pt idx="976">
                  <c:v>29.176580504515702</c:v>
                </c:pt>
                <c:pt idx="977">
                  <c:v>21.787037037036978</c:v>
                </c:pt>
                <c:pt idx="978">
                  <c:v>29.642745098039189</c:v>
                </c:pt>
                <c:pt idx="979">
                  <c:v>28.007197815835202</c:v>
                </c:pt>
                <c:pt idx="980">
                  <c:v>26.196581196581199</c:v>
                </c:pt>
                <c:pt idx="981">
                  <c:v>29.460176991150377</c:v>
                </c:pt>
                <c:pt idx="982">
                  <c:v>29.069203382287487</c:v>
                </c:pt>
                <c:pt idx="983">
                  <c:v>25.886195995784988</c:v>
                </c:pt>
                <c:pt idx="984">
                  <c:v>28.475833333333259</c:v>
                </c:pt>
                <c:pt idx="985">
                  <c:v>28.162534435261676</c:v>
                </c:pt>
                <c:pt idx="986">
                  <c:v>27.152871287128701</c:v>
                </c:pt>
                <c:pt idx="987">
                  <c:v>28.373045420699917</c:v>
                </c:pt>
                <c:pt idx="988">
                  <c:v>29.4969377581541</c:v>
                </c:pt>
                <c:pt idx="989">
                  <c:v>28.005491272798587</c:v>
                </c:pt>
                <c:pt idx="990">
                  <c:v>27.777777777777789</c:v>
                </c:pt>
                <c:pt idx="991">
                  <c:v>29.959429824561361</c:v>
                </c:pt>
                <c:pt idx="992">
                  <c:v>21.821882951653901</c:v>
                </c:pt>
                <c:pt idx="993">
                  <c:v>24.808383233532876</c:v>
                </c:pt>
                <c:pt idx="994">
                  <c:v>27.118544600938989</c:v>
                </c:pt>
                <c:pt idx="995">
                  <c:v>54.605711147721046</c:v>
                </c:pt>
                <c:pt idx="996">
                  <c:v>83.395585099711482</c:v>
                </c:pt>
                <c:pt idx="997">
                  <c:v>30.1732016054338</c:v>
                </c:pt>
                <c:pt idx="998">
                  <c:v>28.7089910775566</c:v>
                </c:pt>
                <c:pt idx="999">
                  <c:v>25.605633802816889</c:v>
                </c:pt>
                <c:pt idx="1000">
                  <c:v>27.101670814077501</c:v>
                </c:pt>
                <c:pt idx="1001">
                  <c:v>27.517709766162302</c:v>
                </c:pt>
                <c:pt idx="1002">
                  <c:v>29.173652694610801</c:v>
                </c:pt>
                <c:pt idx="1003">
                  <c:v>28.132198952879605</c:v>
                </c:pt>
                <c:pt idx="1004">
                  <c:v>24.819444444444418</c:v>
                </c:pt>
                <c:pt idx="1005">
                  <c:v>28.285442073170653</c:v>
                </c:pt>
                <c:pt idx="1006">
                  <c:v>29.274769585253502</c:v>
                </c:pt>
                <c:pt idx="1007">
                  <c:v>30.479701739850899</c:v>
                </c:pt>
                <c:pt idx="1008">
                  <c:v>26.576540755467189</c:v>
                </c:pt>
                <c:pt idx="1009">
                  <c:v>25.452190006168976</c:v>
                </c:pt>
                <c:pt idx="1010">
                  <c:v>26.585473220836374</c:v>
                </c:pt>
                <c:pt idx="1011">
                  <c:v>26.330140615447299</c:v>
                </c:pt>
                <c:pt idx="1012">
                  <c:v>28.834305960817034</c:v>
                </c:pt>
                <c:pt idx="1013">
                  <c:v>27.271172298706688</c:v>
                </c:pt>
                <c:pt idx="1014">
                  <c:v>29.638132295719789</c:v>
                </c:pt>
                <c:pt idx="1015">
                  <c:v>28.820151451409298</c:v>
                </c:pt>
                <c:pt idx="1016">
                  <c:v>29.953850142597901</c:v>
                </c:pt>
                <c:pt idx="1017">
                  <c:v>26.211255024564526</c:v>
                </c:pt>
                <c:pt idx="1018">
                  <c:v>28.935726210350577</c:v>
                </c:pt>
                <c:pt idx="1019">
                  <c:v>28.578235672891189</c:v>
                </c:pt>
                <c:pt idx="1020">
                  <c:v>29.191555903049316</c:v>
                </c:pt>
                <c:pt idx="1021">
                  <c:v>28.354886659234534</c:v>
                </c:pt>
                <c:pt idx="1022">
                  <c:v>27.319680577022186</c:v>
                </c:pt>
                <c:pt idx="1023">
                  <c:v>27.134570082449901</c:v>
                </c:pt>
                <c:pt idx="1024">
                  <c:v>28.9540621012335</c:v>
                </c:pt>
                <c:pt idx="1025">
                  <c:v>24.194153337010526</c:v>
                </c:pt>
                <c:pt idx="1026">
                  <c:v>29.546688899475889</c:v>
                </c:pt>
                <c:pt idx="1027">
                  <c:v>29.584202085004002</c:v>
                </c:pt>
                <c:pt idx="1028">
                  <c:v>31.3543336673347</c:v>
                </c:pt>
                <c:pt idx="1029">
                  <c:v>27.181167716084726</c:v>
                </c:pt>
                <c:pt idx="1030">
                  <c:v>28.471855313960617</c:v>
                </c:pt>
                <c:pt idx="1031">
                  <c:v>27.169162779278199</c:v>
                </c:pt>
                <c:pt idx="1032">
                  <c:v>24.869805002954518</c:v>
                </c:pt>
                <c:pt idx="1033">
                  <c:v>25.741029207232277</c:v>
                </c:pt>
                <c:pt idx="1034">
                  <c:v>29.900207900207889</c:v>
                </c:pt>
                <c:pt idx="1035">
                  <c:v>27.443729189789064</c:v>
                </c:pt>
                <c:pt idx="1036">
                  <c:v>26.027611044417799</c:v>
                </c:pt>
                <c:pt idx="1037">
                  <c:v>24.074969770253901</c:v>
                </c:pt>
                <c:pt idx="1038">
                  <c:v>29.279483037156702</c:v>
                </c:pt>
                <c:pt idx="1039">
                  <c:v>31.0087693656826</c:v>
                </c:pt>
                <c:pt idx="1040">
                  <c:v>27.753452115812905</c:v>
                </c:pt>
                <c:pt idx="1041">
                  <c:v>27.751677852348987</c:v>
                </c:pt>
                <c:pt idx="1042">
                  <c:v>19.865525672371575</c:v>
                </c:pt>
                <c:pt idx="1043">
                  <c:v>25.228522336769753</c:v>
                </c:pt>
                <c:pt idx="1044">
                  <c:v>22.345260514751978</c:v>
                </c:pt>
                <c:pt idx="1045">
                  <c:v>26.331258644536717</c:v>
                </c:pt>
                <c:pt idx="1046">
                  <c:v>27.980572998430077</c:v>
                </c:pt>
                <c:pt idx="1047">
                  <c:v>27.273796791443786</c:v>
                </c:pt>
                <c:pt idx="1048">
                  <c:v>27.127716482781686</c:v>
                </c:pt>
                <c:pt idx="1049">
                  <c:v>31.802583025830302</c:v>
                </c:pt>
                <c:pt idx="1050">
                  <c:v>28.864327485380102</c:v>
                </c:pt>
                <c:pt idx="1051">
                  <c:v>27.850063802637202</c:v>
                </c:pt>
                <c:pt idx="1052">
                  <c:v>23.271959459459534</c:v>
                </c:pt>
                <c:pt idx="1053">
                  <c:v>29.987654320987687</c:v>
                </c:pt>
                <c:pt idx="1054">
                  <c:v>26.429810725552105</c:v>
                </c:pt>
                <c:pt idx="1055">
                  <c:v>27.613421828908617</c:v>
                </c:pt>
                <c:pt idx="1056">
                  <c:v>27.3597056117755</c:v>
                </c:pt>
                <c:pt idx="1057">
                  <c:v>29.870930232558099</c:v>
                </c:pt>
                <c:pt idx="1058">
                  <c:v>29.473588342440799</c:v>
                </c:pt>
                <c:pt idx="1059">
                  <c:v>28.498926050935875</c:v>
                </c:pt>
                <c:pt idx="1060">
                  <c:v>24.179234338747086</c:v>
                </c:pt>
                <c:pt idx="1061">
                  <c:v>24.6010844306739</c:v>
                </c:pt>
                <c:pt idx="1062">
                  <c:v>22.583904109589</c:v>
                </c:pt>
                <c:pt idx="1063">
                  <c:v>19.017353579175687</c:v>
                </c:pt>
                <c:pt idx="1064">
                  <c:v>24.957219251336873</c:v>
                </c:pt>
                <c:pt idx="1065">
                  <c:v>18.008064516128989</c:v>
                </c:pt>
                <c:pt idx="1066">
                  <c:v>18.708860759493717</c:v>
                </c:pt>
                <c:pt idx="1067">
                  <c:v>26.793838862559188</c:v>
                </c:pt>
                <c:pt idx="1068">
                  <c:v>28.3589087809037</c:v>
                </c:pt>
                <c:pt idx="1069">
                  <c:v>22.170607324988399</c:v>
                </c:pt>
                <c:pt idx="1070">
                  <c:v>15.9244186046512</c:v>
                </c:pt>
                <c:pt idx="1071">
                  <c:v>17.274747474747489</c:v>
                </c:pt>
                <c:pt idx="1072">
                  <c:v>22.445910290237489</c:v>
                </c:pt>
                <c:pt idx="1073">
                  <c:v>22.874773960217016</c:v>
                </c:pt>
                <c:pt idx="1074">
                  <c:v>23.874115983026901</c:v>
                </c:pt>
                <c:pt idx="1075">
                  <c:v>25.629475147723287</c:v>
                </c:pt>
                <c:pt idx="1076">
                  <c:v>27.037783375314888</c:v>
                </c:pt>
                <c:pt idx="1077">
                  <c:v>29.710784313725487</c:v>
                </c:pt>
                <c:pt idx="1078">
                  <c:v>25.377439314612101</c:v>
                </c:pt>
                <c:pt idx="1079">
                  <c:v>24.569264069264101</c:v>
                </c:pt>
                <c:pt idx="1080">
                  <c:v>25.3186813186813</c:v>
                </c:pt>
                <c:pt idx="1081">
                  <c:v>21.3282674772036</c:v>
                </c:pt>
                <c:pt idx="1082">
                  <c:v>23.853439153439187</c:v>
                </c:pt>
                <c:pt idx="1083">
                  <c:v>22.376923076923077</c:v>
                </c:pt>
                <c:pt idx="1084">
                  <c:v>20.688513951979175</c:v>
                </c:pt>
                <c:pt idx="1085">
                  <c:v>20.6350261034646</c:v>
                </c:pt>
                <c:pt idx="1086">
                  <c:v>28.705025833724775</c:v>
                </c:pt>
                <c:pt idx="1087">
                  <c:v>27.523391812865487</c:v>
                </c:pt>
                <c:pt idx="1088">
                  <c:v>24.462279293739954</c:v>
                </c:pt>
                <c:pt idx="1089">
                  <c:v>26.949152542372875</c:v>
                </c:pt>
                <c:pt idx="1090">
                  <c:v>27.325652173912989</c:v>
                </c:pt>
                <c:pt idx="1091">
                  <c:v>27.571240105540902</c:v>
                </c:pt>
                <c:pt idx="1092">
                  <c:v>24.498361998361975</c:v>
                </c:pt>
                <c:pt idx="1093">
                  <c:v>30.594522632179476</c:v>
                </c:pt>
                <c:pt idx="1094">
                  <c:v>19.031430934656701</c:v>
                </c:pt>
                <c:pt idx="1095">
                  <c:v>14.834224598930501</c:v>
                </c:pt>
                <c:pt idx="1096">
                  <c:v>17.6559766763848</c:v>
                </c:pt>
                <c:pt idx="1097">
                  <c:v>27.682099890630678</c:v>
                </c:pt>
                <c:pt idx="1098">
                  <c:v>24.086345381526076</c:v>
                </c:pt>
                <c:pt idx="1099">
                  <c:v>21.347350230414701</c:v>
                </c:pt>
                <c:pt idx="1100">
                  <c:v>13.599019238023409</c:v>
                </c:pt>
                <c:pt idx="1101">
                  <c:v>19.708926875593477</c:v>
                </c:pt>
                <c:pt idx="1102">
                  <c:v>19.223016440314499</c:v>
                </c:pt>
                <c:pt idx="1103">
                  <c:v>24.289402581807259</c:v>
                </c:pt>
                <c:pt idx="1104">
                  <c:v>25.182040317654199</c:v>
                </c:pt>
                <c:pt idx="1105">
                  <c:v>26.7132701421801</c:v>
                </c:pt>
                <c:pt idx="1106">
                  <c:v>26.269547325102877</c:v>
                </c:pt>
                <c:pt idx="1107">
                  <c:v>29.841784989857999</c:v>
                </c:pt>
                <c:pt idx="1108">
                  <c:v>28.270209580838277</c:v>
                </c:pt>
                <c:pt idx="1109">
                  <c:v>29.098062475286699</c:v>
                </c:pt>
                <c:pt idx="1110">
                  <c:v>27.103695730175787</c:v>
                </c:pt>
                <c:pt idx="1111">
                  <c:v>23.241286863270787</c:v>
                </c:pt>
                <c:pt idx="1112">
                  <c:v>27.271878646441117</c:v>
                </c:pt>
                <c:pt idx="1113">
                  <c:v>27.474616292798089</c:v>
                </c:pt>
                <c:pt idx="1114">
                  <c:v>26.006690997566889</c:v>
                </c:pt>
                <c:pt idx="1115">
                  <c:v>20.177341303728987</c:v>
                </c:pt>
                <c:pt idx="1116">
                  <c:v>24.953084274543876</c:v>
                </c:pt>
                <c:pt idx="1117">
                  <c:v>28.139897395422317</c:v>
                </c:pt>
                <c:pt idx="1118">
                  <c:v>23.352169981916788</c:v>
                </c:pt>
                <c:pt idx="1119">
                  <c:v>28.957050452781399</c:v>
                </c:pt>
                <c:pt idx="1120">
                  <c:v>21.61985216473073</c:v>
                </c:pt>
                <c:pt idx="1121">
                  <c:v>27.979509469108987</c:v>
                </c:pt>
                <c:pt idx="1122">
                  <c:v>23.9265982636148</c:v>
                </c:pt>
                <c:pt idx="1123">
                  <c:v>18.831593597773089</c:v>
                </c:pt>
                <c:pt idx="1124">
                  <c:v>18.2048012003001</c:v>
                </c:pt>
                <c:pt idx="1125">
                  <c:v>30.727366787377086</c:v>
                </c:pt>
                <c:pt idx="1126">
                  <c:v>30.799531066822986</c:v>
                </c:pt>
                <c:pt idx="1127">
                  <c:v>30.482621288921045</c:v>
                </c:pt>
                <c:pt idx="1128">
                  <c:v>27.951394759087101</c:v>
                </c:pt>
                <c:pt idx="1129">
                  <c:v>27.355495978552302</c:v>
                </c:pt>
                <c:pt idx="1130">
                  <c:v>22.510786360473187</c:v>
                </c:pt>
                <c:pt idx="1131">
                  <c:v>25.726075504828799</c:v>
                </c:pt>
                <c:pt idx="1132">
                  <c:v>26.585074626865687</c:v>
                </c:pt>
                <c:pt idx="1133">
                  <c:v>29.000617665225374</c:v>
                </c:pt>
                <c:pt idx="1134">
                  <c:v>27.191511387163587</c:v>
                </c:pt>
                <c:pt idx="1135">
                  <c:v>27.329428989751086</c:v>
                </c:pt>
                <c:pt idx="1136">
                  <c:v>25.676835682726701</c:v>
                </c:pt>
                <c:pt idx="1137">
                  <c:v>27.152116082224889</c:v>
                </c:pt>
                <c:pt idx="1138">
                  <c:v>24.709153543307089</c:v>
                </c:pt>
                <c:pt idx="1139">
                  <c:v>22.660536564257889</c:v>
                </c:pt>
                <c:pt idx="1140">
                  <c:v>22.175606171932376</c:v>
                </c:pt>
                <c:pt idx="1141">
                  <c:v>23.115800865800917</c:v>
                </c:pt>
                <c:pt idx="1142">
                  <c:v>21.655813953488426</c:v>
                </c:pt>
                <c:pt idx="1143">
                  <c:v>26.768382352941163</c:v>
                </c:pt>
                <c:pt idx="1144">
                  <c:v>26.199143468950705</c:v>
                </c:pt>
                <c:pt idx="1145">
                  <c:v>28.536752136752099</c:v>
                </c:pt>
                <c:pt idx="1146">
                  <c:v>23.542832909245089</c:v>
                </c:pt>
                <c:pt idx="1147">
                  <c:v>21.567627494456801</c:v>
                </c:pt>
                <c:pt idx="1148">
                  <c:v>19.494618395303277</c:v>
                </c:pt>
                <c:pt idx="1149">
                  <c:v>22.400868306801701</c:v>
                </c:pt>
                <c:pt idx="1150">
                  <c:v>27.069987118935199</c:v>
                </c:pt>
                <c:pt idx="1151">
                  <c:v>24.528092783505176</c:v>
                </c:pt>
                <c:pt idx="1152">
                  <c:v>25.199841395717701</c:v>
                </c:pt>
                <c:pt idx="1153">
                  <c:v>24.683006535947676</c:v>
                </c:pt>
                <c:pt idx="1154">
                  <c:v>21.545569620253186</c:v>
                </c:pt>
                <c:pt idx="1155">
                  <c:v>25.039215686274517</c:v>
                </c:pt>
                <c:pt idx="1156">
                  <c:v>21.740157480314988</c:v>
                </c:pt>
                <c:pt idx="1157">
                  <c:v>23.820768662232101</c:v>
                </c:pt>
                <c:pt idx="1158">
                  <c:v>21.536376604850201</c:v>
                </c:pt>
                <c:pt idx="1159">
                  <c:v>27.784644194756599</c:v>
                </c:pt>
                <c:pt idx="1160">
                  <c:v>27.529828486204298</c:v>
                </c:pt>
                <c:pt idx="1161">
                  <c:v>28.621848739495817</c:v>
                </c:pt>
                <c:pt idx="1162">
                  <c:v>26.267068273092399</c:v>
                </c:pt>
                <c:pt idx="1163">
                  <c:v>31.604259850905187</c:v>
                </c:pt>
                <c:pt idx="1164">
                  <c:v>29.820622070728575</c:v>
                </c:pt>
                <c:pt idx="1165">
                  <c:v>30.8276699029126</c:v>
                </c:pt>
                <c:pt idx="1166">
                  <c:v>22.3770034843206</c:v>
                </c:pt>
                <c:pt idx="1167">
                  <c:v>22.035268185157999</c:v>
                </c:pt>
                <c:pt idx="1168">
                  <c:v>21.519575856443701</c:v>
                </c:pt>
                <c:pt idx="1169">
                  <c:v>26.576680672268889</c:v>
                </c:pt>
                <c:pt idx="1170">
                  <c:v>26.929597701149376</c:v>
                </c:pt>
                <c:pt idx="1171">
                  <c:v>29.798275215598</c:v>
                </c:pt>
                <c:pt idx="1172">
                  <c:v>26.930669800234973</c:v>
                </c:pt>
                <c:pt idx="1173">
                  <c:v>28.752890650809405</c:v>
                </c:pt>
                <c:pt idx="1174">
                  <c:v>28.815583218072799</c:v>
                </c:pt>
                <c:pt idx="1175">
                  <c:v>29.4989648033126</c:v>
                </c:pt>
                <c:pt idx="1176">
                  <c:v>27.948304800268478</c:v>
                </c:pt>
                <c:pt idx="1177">
                  <c:v>28.210631494804201</c:v>
                </c:pt>
                <c:pt idx="1178">
                  <c:v>24.953193350831089</c:v>
                </c:pt>
                <c:pt idx="1179">
                  <c:v>14.532646048110006</c:v>
                </c:pt>
                <c:pt idx="1180">
                  <c:v>22.306780464675199</c:v>
                </c:pt>
                <c:pt idx="1181">
                  <c:v>16.066666666666688</c:v>
                </c:pt>
                <c:pt idx="1182">
                  <c:v>22.263179403350989</c:v>
                </c:pt>
                <c:pt idx="1183">
                  <c:v>24.460037759597189</c:v>
                </c:pt>
                <c:pt idx="1184">
                  <c:v>29.796453900709189</c:v>
                </c:pt>
                <c:pt idx="1185">
                  <c:v>28.126004666839517</c:v>
                </c:pt>
                <c:pt idx="1186">
                  <c:v>30.915556612749789</c:v>
                </c:pt>
                <c:pt idx="1187">
                  <c:v>29.068235995232389</c:v>
                </c:pt>
                <c:pt idx="1188">
                  <c:v>28.442013643848487</c:v>
                </c:pt>
                <c:pt idx="1189">
                  <c:v>28.530479544838787</c:v>
                </c:pt>
                <c:pt idx="1190">
                  <c:v>27.3058266784975</c:v>
                </c:pt>
                <c:pt idx="1191">
                  <c:v>28.2783947009546</c:v>
                </c:pt>
                <c:pt idx="1192">
                  <c:v>28.864159891598899</c:v>
                </c:pt>
                <c:pt idx="1193">
                  <c:v>30.115264797507798</c:v>
                </c:pt>
                <c:pt idx="1194">
                  <c:v>27.2489770223481</c:v>
                </c:pt>
                <c:pt idx="1195">
                  <c:v>30.592393254395375</c:v>
                </c:pt>
                <c:pt idx="1196">
                  <c:v>29.246018671059886</c:v>
                </c:pt>
                <c:pt idx="1197">
                  <c:v>30.041984056687301</c:v>
                </c:pt>
                <c:pt idx="1198">
                  <c:v>28.140405942665787</c:v>
                </c:pt>
                <c:pt idx="1199">
                  <c:v>27.572351719362999</c:v>
                </c:pt>
                <c:pt idx="1200">
                  <c:v>29.271232204221864</c:v>
                </c:pt>
                <c:pt idx="1201">
                  <c:v>27.744912072712889</c:v>
                </c:pt>
                <c:pt idx="1202">
                  <c:v>29.982600732600677</c:v>
                </c:pt>
                <c:pt idx="1203">
                  <c:v>29.614862781375301</c:v>
                </c:pt>
                <c:pt idx="1204">
                  <c:v>28.917719468739886</c:v>
                </c:pt>
                <c:pt idx="1205">
                  <c:v>27.994390315913787</c:v>
                </c:pt>
                <c:pt idx="1206">
                  <c:v>28.642221687905689</c:v>
                </c:pt>
                <c:pt idx="1207">
                  <c:v>28.209663250365963</c:v>
                </c:pt>
                <c:pt idx="1208">
                  <c:v>26.024944320712716</c:v>
                </c:pt>
                <c:pt idx="1209">
                  <c:v>27.045019157088099</c:v>
                </c:pt>
                <c:pt idx="1210">
                  <c:v>16.639060568603217</c:v>
                </c:pt>
                <c:pt idx="1211">
                  <c:v>21.178135239797378</c:v>
                </c:pt>
                <c:pt idx="1212">
                  <c:v>23.111601235112516</c:v>
                </c:pt>
                <c:pt idx="1213">
                  <c:v>17.366281986954299</c:v>
                </c:pt>
                <c:pt idx="1214">
                  <c:v>23.895657418576601</c:v>
                </c:pt>
                <c:pt idx="1215">
                  <c:v>23.372022160664802</c:v>
                </c:pt>
                <c:pt idx="1216">
                  <c:v>26.820627802690588</c:v>
                </c:pt>
                <c:pt idx="1217">
                  <c:v>24.080792203709464</c:v>
                </c:pt>
                <c:pt idx="1218">
                  <c:v>26.984413054067176</c:v>
                </c:pt>
                <c:pt idx="1219">
                  <c:v>26.759641255605374</c:v>
                </c:pt>
                <c:pt idx="1220">
                  <c:v>24.528773072746976</c:v>
                </c:pt>
                <c:pt idx="1221">
                  <c:v>22.338061465721001</c:v>
                </c:pt>
                <c:pt idx="1222">
                  <c:v>25.679684418146017</c:v>
                </c:pt>
                <c:pt idx="1223">
                  <c:v>27.801090792428617</c:v>
                </c:pt>
                <c:pt idx="1224">
                  <c:v>24.920579420579376</c:v>
                </c:pt>
                <c:pt idx="1225">
                  <c:v>22.343118249792287</c:v>
                </c:pt>
                <c:pt idx="1226">
                  <c:v>22.347509113001188</c:v>
                </c:pt>
                <c:pt idx="1227">
                  <c:v>18.409126671911864</c:v>
                </c:pt>
                <c:pt idx="1228">
                  <c:v>28.168843000303681</c:v>
                </c:pt>
                <c:pt idx="1229">
                  <c:v>31.088838268792699</c:v>
                </c:pt>
                <c:pt idx="1230">
                  <c:v>26.743158366980701</c:v>
                </c:pt>
                <c:pt idx="1231">
                  <c:v>28.788693234476362</c:v>
                </c:pt>
                <c:pt idx="1232">
                  <c:v>27.216174661746617</c:v>
                </c:pt>
                <c:pt idx="1233">
                  <c:v>18.694638694638705</c:v>
                </c:pt>
                <c:pt idx="1234">
                  <c:v>20.007490636704102</c:v>
                </c:pt>
                <c:pt idx="1235">
                  <c:v>31.3213773314204</c:v>
                </c:pt>
                <c:pt idx="1236">
                  <c:v>25.501960784313717</c:v>
                </c:pt>
                <c:pt idx="1237">
                  <c:v>26.491772151898701</c:v>
                </c:pt>
                <c:pt idx="1238">
                  <c:v>26.329497274379175</c:v>
                </c:pt>
                <c:pt idx="1239">
                  <c:v>21.896737302388189</c:v>
                </c:pt>
                <c:pt idx="1240">
                  <c:v>19.818596928186</c:v>
                </c:pt>
                <c:pt idx="1241">
                  <c:v>25.896722325293787</c:v>
                </c:pt>
                <c:pt idx="1242">
                  <c:v>19.845122859270276</c:v>
                </c:pt>
                <c:pt idx="1243">
                  <c:v>27.690804897108617</c:v>
                </c:pt>
                <c:pt idx="1244">
                  <c:v>26.018343195266286</c:v>
                </c:pt>
                <c:pt idx="1245">
                  <c:v>23.683673469387799</c:v>
                </c:pt>
                <c:pt idx="1246">
                  <c:v>25.547135884921676</c:v>
                </c:pt>
                <c:pt idx="1247">
                  <c:v>22.422924901185777</c:v>
                </c:pt>
                <c:pt idx="1248">
                  <c:v>24.081025338833189</c:v>
                </c:pt>
                <c:pt idx="1249">
                  <c:v>25.852397260274</c:v>
                </c:pt>
                <c:pt idx="1250">
                  <c:v>23.8049199084668</c:v>
                </c:pt>
                <c:pt idx="1251">
                  <c:v>25.4316666666667</c:v>
                </c:pt>
                <c:pt idx="1252">
                  <c:v>29.1986666666667</c:v>
                </c:pt>
                <c:pt idx="1253">
                  <c:v>29.282924107142886</c:v>
                </c:pt>
                <c:pt idx="1254">
                  <c:v>28.987391304347781</c:v>
                </c:pt>
                <c:pt idx="1255">
                  <c:v>28.162615413604701</c:v>
                </c:pt>
                <c:pt idx="1256">
                  <c:v>22.480521936459876</c:v>
                </c:pt>
                <c:pt idx="1257">
                  <c:v>24.012241054613899</c:v>
                </c:pt>
                <c:pt idx="1258">
                  <c:v>19.6479049405879</c:v>
                </c:pt>
                <c:pt idx="1259">
                  <c:v>23.118169398907099</c:v>
                </c:pt>
                <c:pt idx="1260">
                  <c:v>24.986394557823076</c:v>
                </c:pt>
                <c:pt idx="1261">
                  <c:v>26.098598858328977</c:v>
                </c:pt>
                <c:pt idx="1262">
                  <c:v>26.212989493791799</c:v>
                </c:pt>
                <c:pt idx="1263">
                  <c:v>25.2843137254902</c:v>
                </c:pt>
                <c:pt idx="1264">
                  <c:v>19.2761904761905</c:v>
                </c:pt>
                <c:pt idx="1265">
                  <c:v>26.286835222319102</c:v>
                </c:pt>
                <c:pt idx="1266">
                  <c:v>27.39786856127893</c:v>
                </c:pt>
                <c:pt idx="1267">
                  <c:v>30.134090909090919</c:v>
                </c:pt>
                <c:pt idx="1268">
                  <c:v>27.499052312357787</c:v>
                </c:pt>
                <c:pt idx="1269">
                  <c:v>26.246402389356486</c:v>
                </c:pt>
                <c:pt idx="1270">
                  <c:v>27.269343780607176</c:v>
                </c:pt>
                <c:pt idx="1271">
                  <c:v>28.260009647853376</c:v>
                </c:pt>
                <c:pt idx="1272">
                  <c:v>30.091872791519418</c:v>
                </c:pt>
                <c:pt idx="1273">
                  <c:v>29.706043121773487</c:v>
                </c:pt>
                <c:pt idx="1274">
                  <c:v>29.031827515400426</c:v>
                </c:pt>
                <c:pt idx="1275">
                  <c:v>25.741751104182899</c:v>
                </c:pt>
                <c:pt idx="1276">
                  <c:v>20.116593443730999</c:v>
                </c:pt>
                <c:pt idx="1277">
                  <c:v>22.699078812691901</c:v>
                </c:pt>
                <c:pt idx="1278">
                  <c:v>27.0204569606801</c:v>
                </c:pt>
                <c:pt idx="1279">
                  <c:v>30.800751879699199</c:v>
                </c:pt>
                <c:pt idx="1280">
                  <c:v>29.586359610274599</c:v>
                </c:pt>
                <c:pt idx="1281">
                  <c:v>29.314170040485816</c:v>
                </c:pt>
                <c:pt idx="1282">
                  <c:v>30.711132437620002</c:v>
                </c:pt>
                <c:pt idx="1283">
                  <c:v>28.0404653515427</c:v>
                </c:pt>
                <c:pt idx="1284">
                  <c:v>29.017695556002426</c:v>
                </c:pt>
                <c:pt idx="1285">
                  <c:v>32.238536836682137</c:v>
                </c:pt>
                <c:pt idx="1286">
                  <c:v>30.575699745547077</c:v>
                </c:pt>
                <c:pt idx="1287">
                  <c:v>27.833918611857118</c:v>
                </c:pt>
                <c:pt idx="1288">
                  <c:v>22.440526927547477</c:v>
                </c:pt>
                <c:pt idx="1289">
                  <c:v>26.51588541666673</c:v>
                </c:pt>
                <c:pt idx="1290">
                  <c:v>27.786009292720664</c:v>
                </c:pt>
                <c:pt idx="1291">
                  <c:v>27.4558760223848</c:v>
                </c:pt>
                <c:pt idx="1292">
                  <c:v>27.553877831159902</c:v>
                </c:pt>
                <c:pt idx="1293">
                  <c:v>25.083846830985863</c:v>
                </c:pt>
                <c:pt idx="1294">
                  <c:v>24.228861330326886</c:v>
                </c:pt>
                <c:pt idx="1295">
                  <c:v>22.07879924953096</c:v>
                </c:pt>
                <c:pt idx="1296">
                  <c:v>21.332526230831263</c:v>
                </c:pt>
                <c:pt idx="1297">
                  <c:v>22.344110854503487</c:v>
                </c:pt>
                <c:pt idx="1298">
                  <c:v>25.553191489361687</c:v>
                </c:pt>
                <c:pt idx="1299">
                  <c:v>23.369833212472788</c:v>
                </c:pt>
                <c:pt idx="1300">
                  <c:v>28.130122214234401</c:v>
                </c:pt>
                <c:pt idx="1301">
                  <c:v>25.379252649191287</c:v>
                </c:pt>
                <c:pt idx="1302">
                  <c:v>24.400392927308378</c:v>
                </c:pt>
                <c:pt idx="1303">
                  <c:v>21.351169064748198</c:v>
                </c:pt>
                <c:pt idx="1304">
                  <c:v>27.406686626746499</c:v>
                </c:pt>
                <c:pt idx="1305">
                  <c:v>23.526613816534489</c:v>
                </c:pt>
                <c:pt idx="1306">
                  <c:v>26.216417910447799</c:v>
                </c:pt>
                <c:pt idx="1307">
                  <c:v>25.519939804364189</c:v>
                </c:pt>
                <c:pt idx="1308">
                  <c:v>22.323609226594289</c:v>
                </c:pt>
                <c:pt idx="1309">
                  <c:v>21.247628083491499</c:v>
                </c:pt>
                <c:pt idx="1310">
                  <c:v>31.189771197846618</c:v>
                </c:pt>
                <c:pt idx="1311">
                  <c:v>23.018171806167373</c:v>
                </c:pt>
                <c:pt idx="1312">
                  <c:v>24.348113831899376</c:v>
                </c:pt>
                <c:pt idx="1313">
                  <c:v>26.350793650793687</c:v>
                </c:pt>
                <c:pt idx="1314">
                  <c:v>25.371499688861189</c:v>
                </c:pt>
                <c:pt idx="1315">
                  <c:v>26.336295769641026</c:v>
                </c:pt>
                <c:pt idx="1316">
                  <c:v>23.704980842911887</c:v>
                </c:pt>
                <c:pt idx="1317">
                  <c:v>24.722794117647087</c:v>
                </c:pt>
                <c:pt idx="1318">
                  <c:v>21.485214242607071</c:v>
                </c:pt>
                <c:pt idx="1319">
                  <c:v>25.921755725190817</c:v>
                </c:pt>
                <c:pt idx="1320">
                  <c:v>26.386449184441677</c:v>
                </c:pt>
                <c:pt idx="1321">
                  <c:v>30.946212121212099</c:v>
                </c:pt>
                <c:pt idx="1322">
                  <c:v>24.602846975088987</c:v>
                </c:pt>
                <c:pt idx="1323">
                  <c:v>29.381607530774776</c:v>
                </c:pt>
                <c:pt idx="1324">
                  <c:v>25.799907791609005</c:v>
                </c:pt>
                <c:pt idx="1325">
                  <c:v>22.937105025579299</c:v>
                </c:pt>
                <c:pt idx="1326">
                  <c:v>22.680412371133958</c:v>
                </c:pt>
                <c:pt idx="1327">
                  <c:v>27.640625</c:v>
                </c:pt>
                <c:pt idx="1328">
                  <c:v>30.482905982905976</c:v>
                </c:pt>
                <c:pt idx="1329">
                  <c:v>24.944576030317378</c:v>
                </c:pt>
                <c:pt idx="1330">
                  <c:v>25.463431786216599</c:v>
                </c:pt>
                <c:pt idx="1331">
                  <c:v>31.235554152194517</c:v>
                </c:pt>
                <c:pt idx="1332">
                  <c:v>24.079166666666701</c:v>
                </c:pt>
                <c:pt idx="1333">
                  <c:v>26.542020774315375</c:v>
                </c:pt>
                <c:pt idx="1334">
                  <c:v>25.073500967118001</c:v>
                </c:pt>
                <c:pt idx="1335">
                  <c:v>18.2352206494588</c:v>
                </c:pt>
                <c:pt idx="1336">
                  <c:v>19.441535776614302</c:v>
                </c:pt>
                <c:pt idx="1337">
                  <c:v>18.323433874709959</c:v>
                </c:pt>
                <c:pt idx="1338">
                  <c:v>21.947348340328077</c:v>
                </c:pt>
                <c:pt idx="1339">
                  <c:v>22.130455635491618</c:v>
                </c:pt>
                <c:pt idx="1340">
                  <c:v>16.871364653243798</c:v>
                </c:pt>
                <c:pt idx="1341">
                  <c:v>21.3679763413604</c:v>
                </c:pt>
                <c:pt idx="1342">
                  <c:v>20.483410331793362</c:v>
                </c:pt>
                <c:pt idx="1343">
                  <c:v>20.4470046082949</c:v>
                </c:pt>
                <c:pt idx="1344">
                  <c:v>30.706200582605089</c:v>
                </c:pt>
                <c:pt idx="1345">
                  <c:v>21.458559536735354</c:v>
                </c:pt>
                <c:pt idx="1346">
                  <c:v>25.411453320500517</c:v>
                </c:pt>
                <c:pt idx="1347">
                  <c:v>28.102017291066289</c:v>
                </c:pt>
                <c:pt idx="1348">
                  <c:v>25.718706047819989</c:v>
                </c:pt>
                <c:pt idx="1349">
                  <c:v>26.2278623801466</c:v>
                </c:pt>
                <c:pt idx="1350">
                  <c:v>25.030522088353376</c:v>
                </c:pt>
                <c:pt idx="1351">
                  <c:v>28.544283413848618</c:v>
                </c:pt>
                <c:pt idx="1352">
                  <c:v>24.216260162601618</c:v>
                </c:pt>
                <c:pt idx="1353">
                  <c:v>31.361421319797</c:v>
                </c:pt>
                <c:pt idx="1354">
                  <c:v>18.7464059804485</c:v>
                </c:pt>
                <c:pt idx="1355">
                  <c:v>21.064241486068099</c:v>
                </c:pt>
                <c:pt idx="1356">
                  <c:v>15.4949152542373</c:v>
                </c:pt>
                <c:pt idx="1357">
                  <c:v>27.443099273607675</c:v>
                </c:pt>
                <c:pt idx="1358">
                  <c:v>31.498019445444687</c:v>
                </c:pt>
                <c:pt idx="1359">
                  <c:v>28.566974088713199</c:v>
                </c:pt>
                <c:pt idx="1360">
                  <c:v>28.045895851721077</c:v>
                </c:pt>
                <c:pt idx="1361">
                  <c:v>23.519698239731778</c:v>
                </c:pt>
                <c:pt idx="1362">
                  <c:v>28.878632478632486</c:v>
                </c:pt>
                <c:pt idx="1363">
                  <c:v>25.799603174603178</c:v>
                </c:pt>
                <c:pt idx="1364">
                  <c:v>24.426936283861064</c:v>
                </c:pt>
                <c:pt idx="1365">
                  <c:v>26.237538940810001</c:v>
                </c:pt>
                <c:pt idx="1366">
                  <c:v>25.275947028025886</c:v>
                </c:pt>
                <c:pt idx="1367">
                  <c:v>24.245272825499686</c:v>
                </c:pt>
                <c:pt idx="1368">
                  <c:v>28.983926805143362</c:v>
                </c:pt>
                <c:pt idx="1369">
                  <c:v>21.821238938053099</c:v>
                </c:pt>
                <c:pt idx="1370">
                  <c:v>18.990415335463275</c:v>
                </c:pt>
                <c:pt idx="1371">
                  <c:v>15.113409678611006</c:v>
                </c:pt>
                <c:pt idx="1372">
                  <c:v>17.510423246999402</c:v>
                </c:pt>
                <c:pt idx="1373">
                  <c:v>20.472172351885089</c:v>
                </c:pt>
                <c:pt idx="1374">
                  <c:v>21.203703703703678</c:v>
                </c:pt>
                <c:pt idx="1375">
                  <c:v>27.662973222529978</c:v>
                </c:pt>
                <c:pt idx="1376">
                  <c:v>21.653806584362087</c:v>
                </c:pt>
                <c:pt idx="1377">
                  <c:v>23.843465045592701</c:v>
                </c:pt>
                <c:pt idx="1378">
                  <c:v>24.185631414547089</c:v>
                </c:pt>
                <c:pt idx="1379">
                  <c:v>22.457777777777789</c:v>
                </c:pt>
                <c:pt idx="1380">
                  <c:v>27.428196147110278</c:v>
                </c:pt>
                <c:pt idx="1381">
                  <c:v>28.074939841870087</c:v>
                </c:pt>
                <c:pt idx="1382">
                  <c:v>23.575171553337487</c:v>
                </c:pt>
                <c:pt idx="1383">
                  <c:v>27.966891891891887</c:v>
                </c:pt>
                <c:pt idx="1384">
                  <c:v>27.159550561797801</c:v>
                </c:pt>
                <c:pt idx="1385">
                  <c:v>29.067460317460299</c:v>
                </c:pt>
                <c:pt idx="1386">
                  <c:v>29.007368421052639</c:v>
                </c:pt>
                <c:pt idx="1387">
                  <c:v>26.1842338352524</c:v>
                </c:pt>
                <c:pt idx="1388">
                  <c:v>31.8041025641026</c:v>
                </c:pt>
                <c:pt idx="1389">
                  <c:v>30.509898341359001</c:v>
                </c:pt>
                <c:pt idx="1390">
                  <c:v>29.286616161616202</c:v>
                </c:pt>
                <c:pt idx="1391">
                  <c:v>19.998861047836005</c:v>
                </c:pt>
                <c:pt idx="1392">
                  <c:v>26.3845144356955</c:v>
                </c:pt>
                <c:pt idx="1393">
                  <c:v>26.7931671283472</c:v>
                </c:pt>
                <c:pt idx="1394">
                  <c:v>22.283641160949877</c:v>
                </c:pt>
                <c:pt idx="1395">
                  <c:v>24.022532188841176</c:v>
                </c:pt>
                <c:pt idx="1396">
                  <c:v>23.892648287385075</c:v>
                </c:pt>
                <c:pt idx="1397">
                  <c:v>28.275071633237786</c:v>
                </c:pt>
                <c:pt idx="1398">
                  <c:v>22.473884140550801</c:v>
                </c:pt>
                <c:pt idx="1399">
                  <c:v>24.706967213114801</c:v>
                </c:pt>
                <c:pt idx="1400">
                  <c:v>23.915984336062699</c:v>
                </c:pt>
                <c:pt idx="1401">
                  <c:v>21.629807692307701</c:v>
                </c:pt>
                <c:pt idx="1402">
                  <c:v>21.325735992402699</c:v>
                </c:pt>
                <c:pt idx="1403">
                  <c:v>25.484629294755859</c:v>
                </c:pt>
                <c:pt idx="1404">
                  <c:v>27.395943837753489</c:v>
                </c:pt>
                <c:pt idx="1405">
                  <c:v>28.0238907849829</c:v>
                </c:pt>
                <c:pt idx="1406">
                  <c:v>22.888059701492505</c:v>
                </c:pt>
                <c:pt idx="1407">
                  <c:v>24.279289283731259</c:v>
                </c:pt>
                <c:pt idx="1408">
                  <c:v>22.720617529880499</c:v>
                </c:pt>
                <c:pt idx="1409">
                  <c:v>24.2769545222279</c:v>
                </c:pt>
                <c:pt idx="1410">
                  <c:v>26.1255144032922</c:v>
                </c:pt>
                <c:pt idx="1411">
                  <c:v>24.3200757575758</c:v>
                </c:pt>
                <c:pt idx="1412">
                  <c:v>26.062499999999979</c:v>
                </c:pt>
                <c:pt idx="1413">
                  <c:v>24.758759333716277</c:v>
                </c:pt>
                <c:pt idx="1414">
                  <c:v>26.030915576694426</c:v>
                </c:pt>
                <c:pt idx="1415">
                  <c:v>27.1840157868772</c:v>
                </c:pt>
                <c:pt idx="1416">
                  <c:v>23.794007490636705</c:v>
                </c:pt>
                <c:pt idx="1417">
                  <c:v>24.389309932189864</c:v>
                </c:pt>
                <c:pt idx="1418">
                  <c:v>23.777551020408218</c:v>
                </c:pt>
                <c:pt idx="1419">
                  <c:v>25.349831271091102</c:v>
                </c:pt>
                <c:pt idx="1420">
                  <c:v>22.661052631578887</c:v>
                </c:pt>
                <c:pt idx="1421">
                  <c:v>21.897213622291005</c:v>
                </c:pt>
                <c:pt idx="1422">
                  <c:v>29.989904988123477</c:v>
                </c:pt>
                <c:pt idx="1423">
                  <c:v>29.227045908183602</c:v>
                </c:pt>
                <c:pt idx="1424">
                  <c:v>24.680952380952405</c:v>
                </c:pt>
                <c:pt idx="1425">
                  <c:v>25.831004657352018</c:v>
                </c:pt>
                <c:pt idx="1426">
                  <c:v>24.424375000000001</c:v>
                </c:pt>
                <c:pt idx="1427">
                  <c:v>31.065714285714275</c:v>
                </c:pt>
                <c:pt idx="1428">
                  <c:v>28.266386554621775</c:v>
                </c:pt>
                <c:pt idx="1429">
                  <c:v>25.313407049066999</c:v>
                </c:pt>
                <c:pt idx="1430">
                  <c:v>25.475422832980954</c:v>
                </c:pt>
                <c:pt idx="1431">
                  <c:v>28.806810880274099</c:v>
                </c:pt>
                <c:pt idx="1432">
                  <c:v>28.159525979945286</c:v>
                </c:pt>
                <c:pt idx="1433">
                  <c:v>27.006199770378878</c:v>
                </c:pt>
                <c:pt idx="1434">
                  <c:v>25.725942782834789</c:v>
                </c:pt>
                <c:pt idx="1435">
                  <c:v>25.367604267701289</c:v>
                </c:pt>
                <c:pt idx="1436">
                  <c:v>25.2016286644951</c:v>
                </c:pt>
                <c:pt idx="1437">
                  <c:v>25.846053205407799</c:v>
                </c:pt>
                <c:pt idx="1438">
                  <c:v>26.239989599584</c:v>
                </c:pt>
                <c:pt idx="1439">
                  <c:v>17.169811320754718</c:v>
                </c:pt>
                <c:pt idx="1440">
                  <c:v>26.685624012638186</c:v>
                </c:pt>
                <c:pt idx="1441">
                  <c:v>27.4371335504886</c:v>
                </c:pt>
                <c:pt idx="1442">
                  <c:v>25.636942675159187</c:v>
                </c:pt>
                <c:pt idx="1443">
                  <c:v>24.597659980897799</c:v>
                </c:pt>
                <c:pt idx="1444">
                  <c:v>23.472546544651259</c:v>
                </c:pt>
                <c:pt idx="1445">
                  <c:v>26.039845758354826</c:v>
                </c:pt>
                <c:pt idx="1446">
                  <c:v>26.516506922257701</c:v>
                </c:pt>
                <c:pt idx="1447">
                  <c:v>32.142145820984062</c:v>
                </c:pt>
                <c:pt idx="1448">
                  <c:v>29.468545751633979</c:v>
                </c:pt>
                <c:pt idx="1449">
                  <c:v>29.242424242424164</c:v>
                </c:pt>
                <c:pt idx="1450">
                  <c:v>29.496869851729777</c:v>
                </c:pt>
                <c:pt idx="1451">
                  <c:v>35.227272727272698</c:v>
                </c:pt>
                <c:pt idx="1452">
                  <c:v>28.803030303030287</c:v>
                </c:pt>
                <c:pt idx="1453">
                  <c:v>26.567708333333275</c:v>
                </c:pt>
                <c:pt idx="1454">
                  <c:v>27.6353383458647</c:v>
                </c:pt>
                <c:pt idx="1455">
                  <c:v>26.0999010880317</c:v>
                </c:pt>
                <c:pt idx="1456">
                  <c:v>24.635944700460801</c:v>
                </c:pt>
                <c:pt idx="1457">
                  <c:v>25.937321937321876</c:v>
                </c:pt>
                <c:pt idx="1458">
                  <c:v>27.102602602602602</c:v>
                </c:pt>
                <c:pt idx="1459">
                  <c:v>28.121006118286918</c:v>
                </c:pt>
                <c:pt idx="1460">
                  <c:v>28.291141621215001</c:v>
                </c:pt>
                <c:pt idx="1461">
                  <c:v>27.358106858938786</c:v>
                </c:pt>
                <c:pt idx="1462">
                  <c:v>27.111940298507498</c:v>
                </c:pt>
                <c:pt idx="1463">
                  <c:v>28.148815730671799</c:v>
                </c:pt>
                <c:pt idx="1464">
                  <c:v>27.32799558255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5253560"/>
        <c:axId val="185254736"/>
      </c:barChart>
      <c:catAx>
        <c:axId val="185253560"/>
        <c:scaling>
          <c:orientation val="minMax"/>
        </c:scaling>
        <c:delete val="0"/>
        <c:axPos val="b"/>
        <c:majorTickMark val="out"/>
        <c:minorTickMark val="none"/>
        <c:tickLblPos val="nextTo"/>
        <c:crossAx val="185254736"/>
        <c:crosses val="autoZero"/>
        <c:auto val="1"/>
        <c:lblAlgn val="ctr"/>
        <c:lblOffset val="100"/>
        <c:noMultiLvlLbl val="0"/>
      </c:catAx>
      <c:valAx>
        <c:axId val="1852547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52535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h88 depth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Sheet3!$H$2:$H$1466</c:f>
              <c:numCache>
                <c:formatCode>General</c:formatCode>
                <c:ptCount val="1465"/>
                <c:pt idx="0">
                  <c:v>25.861751152073701</c:v>
                </c:pt>
                <c:pt idx="1">
                  <c:v>31.564734895191076</c:v>
                </c:pt>
                <c:pt idx="2">
                  <c:v>32.3726098191215</c:v>
                </c:pt>
                <c:pt idx="3">
                  <c:v>34.638750000000037</c:v>
                </c:pt>
                <c:pt idx="4">
                  <c:v>29.600547195622401</c:v>
                </c:pt>
                <c:pt idx="5">
                  <c:v>34.039274025587595</c:v>
                </c:pt>
                <c:pt idx="6">
                  <c:v>35.064167267483796</c:v>
                </c:pt>
                <c:pt idx="7">
                  <c:v>30.333965844402318</c:v>
                </c:pt>
                <c:pt idx="8">
                  <c:v>31.071049840933163</c:v>
                </c:pt>
                <c:pt idx="9">
                  <c:v>29.304007231093699</c:v>
                </c:pt>
                <c:pt idx="10">
                  <c:v>28.602202868852501</c:v>
                </c:pt>
                <c:pt idx="11">
                  <c:v>30.2289623128549</c:v>
                </c:pt>
                <c:pt idx="12">
                  <c:v>28.0641918020108</c:v>
                </c:pt>
                <c:pt idx="13">
                  <c:v>31.296652110625889</c:v>
                </c:pt>
                <c:pt idx="14">
                  <c:v>35.947129611363138</c:v>
                </c:pt>
                <c:pt idx="15">
                  <c:v>35.915426781519194</c:v>
                </c:pt>
                <c:pt idx="16">
                  <c:v>33.103938286642297</c:v>
                </c:pt>
                <c:pt idx="17">
                  <c:v>34.916519694297463</c:v>
                </c:pt>
                <c:pt idx="18">
                  <c:v>24.499298081422602</c:v>
                </c:pt>
                <c:pt idx="19">
                  <c:v>28.254349338900489</c:v>
                </c:pt>
                <c:pt idx="20">
                  <c:v>28.972650567355277</c:v>
                </c:pt>
                <c:pt idx="21">
                  <c:v>30.646107178968688</c:v>
                </c:pt>
                <c:pt idx="22">
                  <c:v>53.952380952380899</c:v>
                </c:pt>
                <c:pt idx="23">
                  <c:v>34.086956521739097</c:v>
                </c:pt>
                <c:pt idx="24">
                  <c:v>31.558599695585976</c:v>
                </c:pt>
                <c:pt idx="25">
                  <c:v>28.147417840375589</c:v>
                </c:pt>
                <c:pt idx="26">
                  <c:v>25.042789223454786</c:v>
                </c:pt>
                <c:pt idx="27">
                  <c:v>36.098265895953837</c:v>
                </c:pt>
                <c:pt idx="28">
                  <c:v>29.892353134230401</c:v>
                </c:pt>
                <c:pt idx="29">
                  <c:v>33.182945736434135</c:v>
                </c:pt>
                <c:pt idx="30">
                  <c:v>26.671026653504388</c:v>
                </c:pt>
                <c:pt idx="31">
                  <c:v>28.253221288515402</c:v>
                </c:pt>
                <c:pt idx="32">
                  <c:v>26.342712842712764</c:v>
                </c:pt>
                <c:pt idx="33">
                  <c:v>25.416574990832405</c:v>
                </c:pt>
                <c:pt idx="34">
                  <c:v>30.055407565263689</c:v>
                </c:pt>
                <c:pt idx="35">
                  <c:v>28.547842401500887</c:v>
                </c:pt>
                <c:pt idx="36">
                  <c:v>31.249683944374176</c:v>
                </c:pt>
                <c:pt idx="37">
                  <c:v>29.754877438719419</c:v>
                </c:pt>
                <c:pt idx="38">
                  <c:v>25.414132379248699</c:v>
                </c:pt>
                <c:pt idx="39">
                  <c:v>30.858328721638117</c:v>
                </c:pt>
                <c:pt idx="40">
                  <c:v>35.403436426116798</c:v>
                </c:pt>
                <c:pt idx="41">
                  <c:v>18.111753371869</c:v>
                </c:pt>
                <c:pt idx="42">
                  <c:v>30.664539007092188</c:v>
                </c:pt>
                <c:pt idx="43">
                  <c:v>30.100529100529076</c:v>
                </c:pt>
                <c:pt idx="44">
                  <c:v>27.122019635343577</c:v>
                </c:pt>
                <c:pt idx="45">
                  <c:v>30.460878517501687</c:v>
                </c:pt>
                <c:pt idx="46">
                  <c:v>29.780395852968876</c:v>
                </c:pt>
                <c:pt idx="47">
                  <c:v>28.545757071547364</c:v>
                </c:pt>
                <c:pt idx="48">
                  <c:v>31.965914121292617</c:v>
                </c:pt>
                <c:pt idx="49">
                  <c:v>23.339506172839499</c:v>
                </c:pt>
                <c:pt idx="50">
                  <c:v>30.065217391304277</c:v>
                </c:pt>
                <c:pt idx="51">
                  <c:v>29.952898550724587</c:v>
                </c:pt>
                <c:pt idx="52">
                  <c:v>36.485565110565112</c:v>
                </c:pt>
                <c:pt idx="53">
                  <c:v>32.023394994559347</c:v>
                </c:pt>
                <c:pt idx="54">
                  <c:v>28.769456681350977</c:v>
                </c:pt>
                <c:pt idx="55">
                  <c:v>34.344444444444328</c:v>
                </c:pt>
                <c:pt idx="56">
                  <c:v>35.050450450450363</c:v>
                </c:pt>
                <c:pt idx="57">
                  <c:v>30.440650406504087</c:v>
                </c:pt>
                <c:pt idx="58">
                  <c:v>33.129674599320097</c:v>
                </c:pt>
                <c:pt idx="59">
                  <c:v>28.070132013201277</c:v>
                </c:pt>
                <c:pt idx="60">
                  <c:v>26.157328805885701</c:v>
                </c:pt>
                <c:pt idx="61">
                  <c:v>26.033000767459718</c:v>
                </c:pt>
                <c:pt idx="62">
                  <c:v>27.883720930232577</c:v>
                </c:pt>
                <c:pt idx="63">
                  <c:v>29.438495857233889</c:v>
                </c:pt>
                <c:pt idx="64">
                  <c:v>35.471264367816012</c:v>
                </c:pt>
                <c:pt idx="65">
                  <c:v>31.1333598726115</c:v>
                </c:pt>
                <c:pt idx="66">
                  <c:v>28.505453020134187</c:v>
                </c:pt>
                <c:pt idx="67">
                  <c:v>28.210292484265089</c:v>
                </c:pt>
                <c:pt idx="68">
                  <c:v>18.778406412069781</c:v>
                </c:pt>
                <c:pt idx="69">
                  <c:v>26.500595238095187</c:v>
                </c:pt>
                <c:pt idx="70">
                  <c:v>33.199223803363495</c:v>
                </c:pt>
                <c:pt idx="71">
                  <c:v>32.613748763600363</c:v>
                </c:pt>
                <c:pt idx="72">
                  <c:v>32.578553615960111</c:v>
                </c:pt>
                <c:pt idx="73">
                  <c:v>31.831149193548399</c:v>
                </c:pt>
                <c:pt idx="74">
                  <c:v>34.283627204030196</c:v>
                </c:pt>
                <c:pt idx="75">
                  <c:v>28.129370629370605</c:v>
                </c:pt>
                <c:pt idx="76">
                  <c:v>41.348314606741596</c:v>
                </c:pt>
                <c:pt idx="77">
                  <c:v>31.300874635568501</c:v>
                </c:pt>
                <c:pt idx="78">
                  <c:v>30.336039975015588</c:v>
                </c:pt>
                <c:pt idx="79">
                  <c:v>33.858240223463653</c:v>
                </c:pt>
                <c:pt idx="80">
                  <c:v>14.298833819242002</c:v>
                </c:pt>
                <c:pt idx="81">
                  <c:v>33.081616481774994</c:v>
                </c:pt>
                <c:pt idx="82">
                  <c:v>30.453682783551677</c:v>
                </c:pt>
                <c:pt idx="83">
                  <c:v>29.763231197771589</c:v>
                </c:pt>
                <c:pt idx="84">
                  <c:v>19.914366595895299</c:v>
                </c:pt>
                <c:pt idx="85">
                  <c:v>29.347890451517419</c:v>
                </c:pt>
                <c:pt idx="86">
                  <c:v>33.318451025056895</c:v>
                </c:pt>
                <c:pt idx="87">
                  <c:v>30.298245614035089</c:v>
                </c:pt>
                <c:pt idx="88">
                  <c:v>22.490196078431364</c:v>
                </c:pt>
                <c:pt idx="89">
                  <c:v>31.086902545003078</c:v>
                </c:pt>
                <c:pt idx="90">
                  <c:v>37.542413381123112</c:v>
                </c:pt>
                <c:pt idx="91">
                  <c:v>31.891972993248316</c:v>
                </c:pt>
                <c:pt idx="92">
                  <c:v>29.730769230769162</c:v>
                </c:pt>
                <c:pt idx="93">
                  <c:v>28.298412698412687</c:v>
                </c:pt>
                <c:pt idx="94">
                  <c:v>33.094896331738397</c:v>
                </c:pt>
                <c:pt idx="95">
                  <c:v>31.312160694896818</c:v>
                </c:pt>
                <c:pt idx="96">
                  <c:v>23.948945615982186</c:v>
                </c:pt>
                <c:pt idx="97">
                  <c:v>25.289905090595287</c:v>
                </c:pt>
                <c:pt idx="98">
                  <c:v>20.131578947368418</c:v>
                </c:pt>
                <c:pt idx="99">
                  <c:v>21.202913631633677</c:v>
                </c:pt>
                <c:pt idx="100">
                  <c:v>31.034506089309886</c:v>
                </c:pt>
                <c:pt idx="101">
                  <c:v>28.720021130480699</c:v>
                </c:pt>
                <c:pt idx="102">
                  <c:v>32.977777777777796</c:v>
                </c:pt>
                <c:pt idx="103">
                  <c:v>25.567954220314718</c:v>
                </c:pt>
                <c:pt idx="104">
                  <c:v>31.414115646258534</c:v>
                </c:pt>
                <c:pt idx="105">
                  <c:v>36.307280513918528</c:v>
                </c:pt>
                <c:pt idx="106">
                  <c:v>27.953880764904426</c:v>
                </c:pt>
                <c:pt idx="107">
                  <c:v>34.426966292134836</c:v>
                </c:pt>
                <c:pt idx="108">
                  <c:v>30.1581569115816</c:v>
                </c:pt>
                <c:pt idx="109">
                  <c:v>33.354139290407396</c:v>
                </c:pt>
                <c:pt idx="110">
                  <c:v>29.789687499999989</c:v>
                </c:pt>
                <c:pt idx="111">
                  <c:v>26.349305555555599</c:v>
                </c:pt>
                <c:pt idx="112">
                  <c:v>23.478375527426188</c:v>
                </c:pt>
                <c:pt idx="113">
                  <c:v>27.444183864915587</c:v>
                </c:pt>
                <c:pt idx="114">
                  <c:v>27.873428331936289</c:v>
                </c:pt>
                <c:pt idx="115">
                  <c:v>28.901114206128089</c:v>
                </c:pt>
                <c:pt idx="116">
                  <c:v>25.2154696132597</c:v>
                </c:pt>
                <c:pt idx="117">
                  <c:v>28.297639123102886</c:v>
                </c:pt>
                <c:pt idx="118">
                  <c:v>34.695177434030946</c:v>
                </c:pt>
                <c:pt idx="119">
                  <c:v>29.661782661782699</c:v>
                </c:pt>
                <c:pt idx="120">
                  <c:v>30.805280528052801</c:v>
                </c:pt>
                <c:pt idx="121">
                  <c:v>32.625579854208112</c:v>
                </c:pt>
                <c:pt idx="122">
                  <c:v>27.922001471670281</c:v>
                </c:pt>
                <c:pt idx="123">
                  <c:v>34.775684931506902</c:v>
                </c:pt>
                <c:pt idx="124">
                  <c:v>36.369077306733196</c:v>
                </c:pt>
                <c:pt idx="125">
                  <c:v>31.523440383905474</c:v>
                </c:pt>
                <c:pt idx="126">
                  <c:v>29.327380952380999</c:v>
                </c:pt>
                <c:pt idx="127">
                  <c:v>25.850210970464087</c:v>
                </c:pt>
                <c:pt idx="128">
                  <c:v>28.701298701298718</c:v>
                </c:pt>
                <c:pt idx="129">
                  <c:v>28.3</c:v>
                </c:pt>
                <c:pt idx="130">
                  <c:v>26.795811518324602</c:v>
                </c:pt>
                <c:pt idx="131">
                  <c:v>23.002747252747263</c:v>
                </c:pt>
                <c:pt idx="132">
                  <c:v>19.503637833468076</c:v>
                </c:pt>
                <c:pt idx="133">
                  <c:v>32.292465753424736</c:v>
                </c:pt>
                <c:pt idx="134">
                  <c:v>23.856648199445999</c:v>
                </c:pt>
                <c:pt idx="135">
                  <c:v>31.452841973766375</c:v>
                </c:pt>
                <c:pt idx="136">
                  <c:v>26.189309576837363</c:v>
                </c:pt>
                <c:pt idx="137">
                  <c:v>31.685042263873576</c:v>
                </c:pt>
                <c:pt idx="138">
                  <c:v>32.258609486679703</c:v>
                </c:pt>
                <c:pt idx="139">
                  <c:v>30.051716247139574</c:v>
                </c:pt>
                <c:pt idx="140">
                  <c:v>31.562573099415189</c:v>
                </c:pt>
                <c:pt idx="141">
                  <c:v>29.7869515011547</c:v>
                </c:pt>
                <c:pt idx="142">
                  <c:v>30.213235294117599</c:v>
                </c:pt>
                <c:pt idx="143">
                  <c:v>26.556946929039999</c:v>
                </c:pt>
                <c:pt idx="144">
                  <c:v>27.944847605224989</c:v>
                </c:pt>
                <c:pt idx="145">
                  <c:v>28.582145536384076</c:v>
                </c:pt>
                <c:pt idx="146">
                  <c:v>23.942731277532953</c:v>
                </c:pt>
                <c:pt idx="147">
                  <c:v>34.406207827260438</c:v>
                </c:pt>
                <c:pt idx="148">
                  <c:v>29.759414225941377</c:v>
                </c:pt>
                <c:pt idx="149">
                  <c:v>24.675324675324681</c:v>
                </c:pt>
                <c:pt idx="150">
                  <c:v>32.715409836065611</c:v>
                </c:pt>
                <c:pt idx="151">
                  <c:v>28.658318425760299</c:v>
                </c:pt>
                <c:pt idx="152">
                  <c:v>33.368013757523599</c:v>
                </c:pt>
                <c:pt idx="153">
                  <c:v>25.550303555940989</c:v>
                </c:pt>
                <c:pt idx="154">
                  <c:v>28.5562682215743</c:v>
                </c:pt>
                <c:pt idx="155">
                  <c:v>25.493398193189702</c:v>
                </c:pt>
                <c:pt idx="156">
                  <c:v>29.660629170638689</c:v>
                </c:pt>
                <c:pt idx="157">
                  <c:v>29.137931034482818</c:v>
                </c:pt>
                <c:pt idx="158">
                  <c:v>34.009829280910495</c:v>
                </c:pt>
                <c:pt idx="159">
                  <c:v>29.9258610624635</c:v>
                </c:pt>
                <c:pt idx="160">
                  <c:v>23.454497632824786</c:v>
                </c:pt>
                <c:pt idx="161">
                  <c:v>30.5160256410256</c:v>
                </c:pt>
                <c:pt idx="162">
                  <c:v>33.371134020618562</c:v>
                </c:pt>
                <c:pt idx="163">
                  <c:v>24.622660098522189</c:v>
                </c:pt>
                <c:pt idx="164">
                  <c:v>25.283236994219681</c:v>
                </c:pt>
                <c:pt idx="165">
                  <c:v>32.138604651162794</c:v>
                </c:pt>
                <c:pt idx="166">
                  <c:v>31.391078066914535</c:v>
                </c:pt>
                <c:pt idx="167">
                  <c:v>29.070833333333276</c:v>
                </c:pt>
                <c:pt idx="168">
                  <c:v>21.679919476597899</c:v>
                </c:pt>
                <c:pt idx="169">
                  <c:v>28.498345153664289</c:v>
                </c:pt>
                <c:pt idx="170">
                  <c:v>29.735238095238099</c:v>
                </c:pt>
                <c:pt idx="171">
                  <c:v>30.874228395061699</c:v>
                </c:pt>
                <c:pt idx="172">
                  <c:v>27.7781472684085</c:v>
                </c:pt>
                <c:pt idx="173">
                  <c:v>36.219624819624798</c:v>
                </c:pt>
                <c:pt idx="174">
                  <c:v>31.227513227513189</c:v>
                </c:pt>
                <c:pt idx="175">
                  <c:v>30.673796791443799</c:v>
                </c:pt>
                <c:pt idx="176">
                  <c:v>33.877340823970002</c:v>
                </c:pt>
                <c:pt idx="177">
                  <c:v>30.551792828685286</c:v>
                </c:pt>
                <c:pt idx="178">
                  <c:v>31.139874739039726</c:v>
                </c:pt>
                <c:pt idx="179">
                  <c:v>29.719242902208187</c:v>
                </c:pt>
                <c:pt idx="180">
                  <c:v>32.016037735849096</c:v>
                </c:pt>
                <c:pt idx="181">
                  <c:v>32.1443181818182</c:v>
                </c:pt>
                <c:pt idx="182">
                  <c:v>29.994594594594599</c:v>
                </c:pt>
                <c:pt idx="183">
                  <c:v>27.149425287356287</c:v>
                </c:pt>
                <c:pt idx="184">
                  <c:v>35.711273317112664</c:v>
                </c:pt>
                <c:pt idx="185">
                  <c:v>30.312328767123287</c:v>
                </c:pt>
                <c:pt idx="186">
                  <c:v>36.237301587301594</c:v>
                </c:pt>
                <c:pt idx="187">
                  <c:v>34.444005270092163</c:v>
                </c:pt>
                <c:pt idx="188">
                  <c:v>20.337278106508919</c:v>
                </c:pt>
                <c:pt idx="189">
                  <c:v>28.139072847682101</c:v>
                </c:pt>
                <c:pt idx="190">
                  <c:v>30.717519685039377</c:v>
                </c:pt>
                <c:pt idx="191">
                  <c:v>35.433701657458563</c:v>
                </c:pt>
                <c:pt idx="192">
                  <c:v>27.8135964912281</c:v>
                </c:pt>
                <c:pt idx="193">
                  <c:v>28.578838174273887</c:v>
                </c:pt>
                <c:pt idx="194">
                  <c:v>16.115501519756801</c:v>
                </c:pt>
                <c:pt idx="195">
                  <c:v>32.309290953545194</c:v>
                </c:pt>
                <c:pt idx="196">
                  <c:v>34.822884549503264</c:v>
                </c:pt>
                <c:pt idx="197">
                  <c:v>34.306032760687195</c:v>
                </c:pt>
                <c:pt idx="198">
                  <c:v>32.878286683630137</c:v>
                </c:pt>
                <c:pt idx="199">
                  <c:v>30.127633209417599</c:v>
                </c:pt>
                <c:pt idx="200">
                  <c:v>32.005577005577003</c:v>
                </c:pt>
                <c:pt idx="201">
                  <c:v>34.382272974442564</c:v>
                </c:pt>
                <c:pt idx="202">
                  <c:v>33.748279252704002</c:v>
                </c:pt>
                <c:pt idx="203">
                  <c:v>26.050058207217717</c:v>
                </c:pt>
                <c:pt idx="204">
                  <c:v>36.966346153846139</c:v>
                </c:pt>
                <c:pt idx="205">
                  <c:v>27.254416961130687</c:v>
                </c:pt>
                <c:pt idx="206">
                  <c:v>34.0285016286645</c:v>
                </c:pt>
                <c:pt idx="207">
                  <c:v>31.631578947368418</c:v>
                </c:pt>
                <c:pt idx="208">
                  <c:v>26.294631710361976</c:v>
                </c:pt>
                <c:pt idx="209">
                  <c:v>29.462025316455687</c:v>
                </c:pt>
                <c:pt idx="210">
                  <c:v>30.524714828897299</c:v>
                </c:pt>
                <c:pt idx="211">
                  <c:v>28.765517241379253</c:v>
                </c:pt>
                <c:pt idx="212">
                  <c:v>27.830672472181877</c:v>
                </c:pt>
                <c:pt idx="213">
                  <c:v>29.896918172157299</c:v>
                </c:pt>
                <c:pt idx="214">
                  <c:v>32.5158134985328</c:v>
                </c:pt>
                <c:pt idx="215">
                  <c:v>36.019211725094095</c:v>
                </c:pt>
                <c:pt idx="216">
                  <c:v>34.707927677329565</c:v>
                </c:pt>
                <c:pt idx="217">
                  <c:v>30.780786026200889</c:v>
                </c:pt>
                <c:pt idx="218">
                  <c:v>33.792586054722001</c:v>
                </c:pt>
                <c:pt idx="219">
                  <c:v>35.723419540229955</c:v>
                </c:pt>
                <c:pt idx="220">
                  <c:v>22.911869225302105</c:v>
                </c:pt>
                <c:pt idx="221">
                  <c:v>33.002834008097196</c:v>
                </c:pt>
                <c:pt idx="222">
                  <c:v>33.791959245490837</c:v>
                </c:pt>
                <c:pt idx="223">
                  <c:v>32.845095341065502</c:v>
                </c:pt>
                <c:pt idx="224">
                  <c:v>31.889725528297287</c:v>
                </c:pt>
                <c:pt idx="225">
                  <c:v>28.551953449709117</c:v>
                </c:pt>
                <c:pt idx="226">
                  <c:v>35.612930667800903</c:v>
                </c:pt>
                <c:pt idx="227">
                  <c:v>31.408872901678688</c:v>
                </c:pt>
                <c:pt idx="228">
                  <c:v>32.754282655246193</c:v>
                </c:pt>
                <c:pt idx="229">
                  <c:v>29.493734335839576</c:v>
                </c:pt>
                <c:pt idx="230">
                  <c:v>30.685404847859687</c:v>
                </c:pt>
                <c:pt idx="231">
                  <c:v>21.32</c:v>
                </c:pt>
                <c:pt idx="232">
                  <c:v>28.267664172901089</c:v>
                </c:pt>
                <c:pt idx="233">
                  <c:v>28.554770318021188</c:v>
                </c:pt>
                <c:pt idx="234">
                  <c:v>28.5050995628946</c:v>
                </c:pt>
                <c:pt idx="235">
                  <c:v>29.439520523065681</c:v>
                </c:pt>
                <c:pt idx="236">
                  <c:v>37.238554216867513</c:v>
                </c:pt>
                <c:pt idx="237">
                  <c:v>32.869582992641</c:v>
                </c:pt>
                <c:pt idx="238">
                  <c:v>26.405172413793089</c:v>
                </c:pt>
                <c:pt idx="239">
                  <c:v>30.345892203035078</c:v>
                </c:pt>
                <c:pt idx="240">
                  <c:v>29.821100917431199</c:v>
                </c:pt>
                <c:pt idx="241">
                  <c:v>25.134638433879299</c:v>
                </c:pt>
                <c:pt idx="242">
                  <c:v>27.117758186398035</c:v>
                </c:pt>
                <c:pt idx="243">
                  <c:v>36.622889305816095</c:v>
                </c:pt>
                <c:pt idx="244">
                  <c:v>27.5938416422287</c:v>
                </c:pt>
                <c:pt idx="245">
                  <c:v>30.288512440444674</c:v>
                </c:pt>
                <c:pt idx="246">
                  <c:v>35.383230696352364</c:v>
                </c:pt>
                <c:pt idx="247">
                  <c:v>32.924302788844599</c:v>
                </c:pt>
                <c:pt idx="248">
                  <c:v>30.8395124428644</c:v>
                </c:pt>
                <c:pt idx="249">
                  <c:v>31.560623556581962</c:v>
                </c:pt>
                <c:pt idx="250">
                  <c:v>31.654726368159199</c:v>
                </c:pt>
                <c:pt idx="251">
                  <c:v>28.975981524249399</c:v>
                </c:pt>
                <c:pt idx="252">
                  <c:v>31.376424617388501</c:v>
                </c:pt>
                <c:pt idx="253">
                  <c:v>29.148642634623855</c:v>
                </c:pt>
                <c:pt idx="254">
                  <c:v>25.675174013921087</c:v>
                </c:pt>
                <c:pt idx="255">
                  <c:v>31.799666110183587</c:v>
                </c:pt>
                <c:pt idx="256">
                  <c:v>37.438867438867348</c:v>
                </c:pt>
                <c:pt idx="257">
                  <c:v>33.072289156626447</c:v>
                </c:pt>
                <c:pt idx="258">
                  <c:v>34.851274248763794</c:v>
                </c:pt>
                <c:pt idx="259">
                  <c:v>25.290953545232288</c:v>
                </c:pt>
                <c:pt idx="260">
                  <c:v>35.598484848484937</c:v>
                </c:pt>
                <c:pt idx="261">
                  <c:v>32.345501955671395</c:v>
                </c:pt>
                <c:pt idx="262">
                  <c:v>31.729549248747855</c:v>
                </c:pt>
                <c:pt idx="263">
                  <c:v>27.182191780821881</c:v>
                </c:pt>
                <c:pt idx="264">
                  <c:v>30.695844686648517</c:v>
                </c:pt>
                <c:pt idx="265">
                  <c:v>34.331753554502363</c:v>
                </c:pt>
                <c:pt idx="266">
                  <c:v>33.023489932885937</c:v>
                </c:pt>
                <c:pt idx="267">
                  <c:v>30.995646766169163</c:v>
                </c:pt>
                <c:pt idx="268">
                  <c:v>31.009508061182299</c:v>
                </c:pt>
                <c:pt idx="269">
                  <c:v>34.668747482883596</c:v>
                </c:pt>
                <c:pt idx="270">
                  <c:v>34.695927903871855</c:v>
                </c:pt>
                <c:pt idx="271">
                  <c:v>36.5068054443555</c:v>
                </c:pt>
                <c:pt idx="272">
                  <c:v>34.191404011461294</c:v>
                </c:pt>
                <c:pt idx="273">
                  <c:v>30.88</c:v>
                </c:pt>
                <c:pt idx="274">
                  <c:v>30.226912928759887</c:v>
                </c:pt>
                <c:pt idx="275">
                  <c:v>34.250465549348164</c:v>
                </c:pt>
                <c:pt idx="276">
                  <c:v>36.605893186003698</c:v>
                </c:pt>
                <c:pt idx="277">
                  <c:v>27.249784668389289</c:v>
                </c:pt>
                <c:pt idx="278">
                  <c:v>28.794583079732178</c:v>
                </c:pt>
                <c:pt idx="279">
                  <c:v>29.0043964828137</c:v>
                </c:pt>
                <c:pt idx="280">
                  <c:v>29.973850105066518</c:v>
                </c:pt>
                <c:pt idx="281">
                  <c:v>29.637966500146916</c:v>
                </c:pt>
                <c:pt idx="282">
                  <c:v>30.651760981400901</c:v>
                </c:pt>
                <c:pt idx="283">
                  <c:v>26.402713704206189</c:v>
                </c:pt>
                <c:pt idx="284">
                  <c:v>26.358627858627877</c:v>
                </c:pt>
                <c:pt idx="285">
                  <c:v>31.282331511839676</c:v>
                </c:pt>
                <c:pt idx="286">
                  <c:v>33.005000000000003</c:v>
                </c:pt>
                <c:pt idx="287">
                  <c:v>28.770165745856431</c:v>
                </c:pt>
                <c:pt idx="288">
                  <c:v>29.280329799764363</c:v>
                </c:pt>
                <c:pt idx="289">
                  <c:v>26.199805542051518</c:v>
                </c:pt>
                <c:pt idx="290">
                  <c:v>31.708126669210188</c:v>
                </c:pt>
                <c:pt idx="291">
                  <c:v>28.112089671737376</c:v>
                </c:pt>
                <c:pt idx="292">
                  <c:v>30.162186379928276</c:v>
                </c:pt>
                <c:pt idx="293">
                  <c:v>33.257323832145737</c:v>
                </c:pt>
                <c:pt idx="294">
                  <c:v>28.261547022815787</c:v>
                </c:pt>
                <c:pt idx="295">
                  <c:v>31.2542701863354</c:v>
                </c:pt>
                <c:pt idx="296">
                  <c:v>30.138537271448687</c:v>
                </c:pt>
                <c:pt idx="297">
                  <c:v>28.653424657534199</c:v>
                </c:pt>
                <c:pt idx="298">
                  <c:v>31.194282001299516</c:v>
                </c:pt>
                <c:pt idx="299">
                  <c:v>31.981981981981978</c:v>
                </c:pt>
                <c:pt idx="300">
                  <c:v>29.162895927601816</c:v>
                </c:pt>
                <c:pt idx="301">
                  <c:v>32.582695252679912</c:v>
                </c:pt>
                <c:pt idx="302">
                  <c:v>30.330505995905199</c:v>
                </c:pt>
                <c:pt idx="303">
                  <c:v>34.313892840208595</c:v>
                </c:pt>
                <c:pt idx="304">
                  <c:v>32.277606269294644</c:v>
                </c:pt>
                <c:pt idx="305">
                  <c:v>29.705239179954376</c:v>
                </c:pt>
                <c:pt idx="306">
                  <c:v>26.545756457564586</c:v>
                </c:pt>
                <c:pt idx="307">
                  <c:v>27.947749196141476</c:v>
                </c:pt>
                <c:pt idx="308">
                  <c:v>30.776583034647587</c:v>
                </c:pt>
                <c:pt idx="309">
                  <c:v>27.988720173535754</c:v>
                </c:pt>
                <c:pt idx="310">
                  <c:v>31.777858176555718</c:v>
                </c:pt>
                <c:pt idx="311">
                  <c:v>27.163905325443817</c:v>
                </c:pt>
                <c:pt idx="312">
                  <c:v>33.688172043010837</c:v>
                </c:pt>
                <c:pt idx="313">
                  <c:v>35.814455231930999</c:v>
                </c:pt>
                <c:pt idx="314">
                  <c:v>33.950377833753194</c:v>
                </c:pt>
                <c:pt idx="315">
                  <c:v>31.569645203679379</c:v>
                </c:pt>
                <c:pt idx="316">
                  <c:v>34.484599589322329</c:v>
                </c:pt>
                <c:pt idx="317">
                  <c:v>32.9812563323202</c:v>
                </c:pt>
                <c:pt idx="318">
                  <c:v>36.269357109338301</c:v>
                </c:pt>
                <c:pt idx="319">
                  <c:v>27.231481481481516</c:v>
                </c:pt>
                <c:pt idx="320">
                  <c:v>27.1166007905138</c:v>
                </c:pt>
                <c:pt idx="321">
                  <c:v>30.345833333333264</c:v>
                </c:pt>
                <c:pt idx="322">
                  <c:v>29.121141070730786</c:v>
                </c:pt>
                <c:pt idx="323">
                  <c:v>35.266124803356099</c:v>
                </c:pt>
                <c:pt idx="324">
                  <c:v>30.495721271393563</c:v>
                </c:pt>
                <c:pt idx="325">
                  <c:v>32.674940898345199</c:v>
                </c:pt>
                <c:pt idx="326">
                  <c:v>29.554499720514301</c:v>
                </c:pt>
                <c:pt idx="327">
                  <c:v>30.556641492669886</c:v>
                </c:pt>
                <c:pt idx="328">
                  <c:v>32.186468646864697</c:v>
                </c:pt>
                <c:pt idx="329">
                  <c:v>33.097078228086737</c:v>
                </c:pt>
                <c:pt idx="330">
                  <c:v>28.327868852459034</c:v>
                </c:pt>
                <c:pt idx="331">
                  <c:v>32.939146567717962</c:v>
                </c:pt>
                <c:pt idx="332">
                  <c:v>31.554733727810618</c:v>
                </c:pt>
                <c:pt idx="333">
                  <c:v>30.492897727272705</c:v>
                </c:pt>
                <c:pt idx="334">
                  <c:v>25.072700296735864</c:v>
                </c:pt>
                <c:pt idx="335">
                  <c:v>32.052532833020635</c:v>
                </c:pt>
                <c:pt idx="336">
                  <c:v>30.662702345556681</c:v>
                </c:pt>
                <c:pt idx="337">
                  <c:v>34.482027411429975</c:v>
                </c:pt>
                <c:pt idx="338">
                  <c:v>35.690442225392296</c:v>
                </c:pt>
                <c:pt idx="339">
                  <c:v>28.046645935139864</c:v>
                </c:pt>
                <c:pt idx="340">
                  <c:v>32.244660194174813</c:v>
                </c:pt>
                <c:pt idx="341">
                  <c:v>32.368659420289902</c:v>
                </c:pt>
                <c:pt idx="342">
                  <c:v>30.262181703866688</c:v>
                </c:pt>
                <c:pt idx="343">
                  <c:v>32.810910431256865</c:v>
                </c:pt>
                <c:pt idx="344">
                  <c:v>30.691868758915835</c:v>
                </c:pt>
                <c:pt idx="345">
                  <c:v>33.7304499781564</c:v>
                </c:pt>
                <c:pt idx="346">
                  <c:v>35.239927685950398</c:v>
                </c:pt>
                <c:pt idx="347">
                  <c:v>30.580859374999989</c:v>
                </c:pt>
                <c:pt idx="348">
                  <c:v>26.900249376558577</c:v>
                </c:pt>
                <c:pt idx="349">
                  <c:v>33.6180790960452</c:v>
                </c:pt>
                <c:pt idx="350">
                  <c:v>33.241192411924111</c:v>
                </c:pt>
                <c:pt idx="351">
                  <c:v>35.929620393460802</c:v>
                </c:pt>
                <c:pt idx="352">
                  <c:v>33.9788338658147</c:v>
                </c:pt>
                <c:pt idx="353">
                  <c:v>32.8120476301658</c:v>
                </c:pt>
                <c:pt idx="354">
                  <c:v>34.789970501474912</c:v>
                </c:pt>
                <c:pt idx="355">
                  <c:v>35.932454695222347</c:v>
                </c:pt>
                <c:pt idx="356">
                  <c:v>29.908670520231176</c:v>
                </c:pt>
                <c:pt idx="357">
                  <c:v>36.195146210463513</c:v>
                </c:pt>
                <c:pt idx="358">
                  <c:v>33.624134520277003</c:v>
                </c:pt>
                <c:pt idx="359">
                  <c:v>35.233198924731255</c:v>
                </c:pt>
                <c:pt idx="360">
                  <c:v>34.481191806331495</c:v>
                </c:pt>
                <c:pt idx="361">
                  <c:v>34.295125482625537</c:v>
                </c:pt>
                <c:pt idx="362">
                  <c:v>28.9782501235788</c:v>
                </c:pt>
                <c:pt idx="363">
                  <c:v>37.615535889872213</c:v>
                </c:pt>
                <c:pt idx="364">
                  <c:v>31.992565055762089</c:v>
                </c:pt>
                <c:pt idx="365">
                  <c:v>36.183852364475236</c:v>
                </c:pt>
                <c:pt idx="366">
                  <c:v>34.288608338226737</c:v>
                </c:pt>
                <c:pt idx="367">
                  <c:v>32.914712702911601</c:v>
                </c:pt>
                <c:pt idx="368">
                  <c:v>35.243157224697597</c:v>
                </c:pt>
                <c:pt idx="369">
                  <c:v>31.215098400984001</c:v>
                </c:pt>
                <c:pt idx="370">
                  <c:v>32.884175405147765</c:v>
                </c:pt>
                <c:pt idx="371">
                  <c:v>32.400579150579112</c:v>
                </c:pt>
                <c:pt idx="372">
                  <c:v>31.297619047618987</c:v>
                </c:pt>
                <c:pt idx="373">
                  <c:v>33.030037546933698</c:v>
                </c:pt>
                <c:pt idx="374">
                  <c:v>33.806477897738795</c:v>
                </c:pt>
                <c:pt idx="375">
                  <c:v>34.650228112100812</c:v>
                </c:pt>
                <c:pt idx="376">
                  <c:v>34.758534365043197</c:v>
                </c:pt>
                <c:pt idx="377">
                  <c:v>35.913512218495413</c:v>
                </c:pt>
                <c:pt idx="378">
                  <c:v>30.4992816091954</c:v>
                </c:pt>
                <c:pt idx="379">
                  <c:v>33.533173461230994</c:v>
                </c:pt>
                <c:pt idx="380">
                  <c:v>32.674617737003096</c:v>
                </c:pt>
                <c:pt idx="381">
                  <c:v>33.379769736842064</c:v>
                </c:pt>
                <c:pt idx="382">
                  <c:v>36.0588376273218</c:v>
                </c:pt>
                <c:pt idx="383">
                  <c:v>33.140552995391737</c:v>
                </c:pt>
                <c:pt idx="384">
                  <c:v>36.486309972368801</c:v>
                </c:pt>
                <c:pt idx="385">
                  <c:v>35.17666666666662</c:v>
                </c:pt>
                <c:pt idx="386">
                  <c:v>33.514388489208528</c:v>
                </c:pt>
                <c:pt idx="387">
                  <c:v>33.157754010695164</c:v>
                </c:pt>
                <c:pt idx="388">
                  <c:v>31.771258503401388</c:v>
                </c:pt>
                <c:pt idx="389">
                  <c:v>29.171900826446318</c:v>
                </c:pt>
                <c:pt idx="390">
                  <c:v>33.618201058201095</c:v>
                </c:pt>
                <c:pt idx="391">
                  <c:v>35.595588235294102</c:v>
                </c:pt>
                <c:pt idx="392">
                  <c:v>34.912251655629063</c:v>
                </c:pt>
                <c:pt idx="393">
                  <c:v>34.312485837298894</c:v>
                </c:pt>
                <c:pt idx="394">
                  <c:v>35.777484422853448</c:v>
                </c:pt>
                <c:pt idx="395">
                  <c:v>33.422515952598054</c:v>
                </c:pt>
                <c:pt idx="396">
                  <c:v>35.863303909205499</c:v>
                </c:pt>
                <c:pt idx="397">
                  <c:v>34.870614035087655</c:v>
                </c:pt>
                <c:pt idx="398">
                  <c:v>37.838837516512463</c:v>
                </c:pt>
                <c:pt idx="399">
                  <c:v>35.807524059492494</c:v>
                </c:pt>
                <c:pt idx="400">
                  <c:v>34.109333333333311</c:v>
                </c:pt>
                <c:pt idx="401">
                  <c:v>33.476727785613427</c:v>
                </c:pt>
                <c:pt idx="402">
                  <c:v>33.990952634380037</c:v>
                </c:pt>
                <c:pt idx="403">
                  <c:v>32.759394572025101</c:v>
                </c:pt>
                <c:pt idx="404">
                  <c:v>36.330693610049195</c:v>
                </c:pt>
                <c:pt idx="405">
                  <c:v>33.984006092916964</c:v>
                </c:pt>
                <c:pt idx="406">
                  <c:v>34.150059615057096</c:v>
                </c:pt>
                <c:pt idx="407">
                  <c:v>30.665944540727864</c:v>
                </c:pt>
                <c:pt idx="408">
                  <c:v>37.268225926847535</c:v>
                </c:pt>
                <c:pt idx="409">
                  <c:v>34.276547416240795</c:v>
                </c:pt>
                <c:pt idx="410">
                  <c:v>36.190476190476211</c:v>
                </c:pt>
                <c:pt idx="411">
                  <c:v>35.670893371757899</c:v>
                </c:pt>
                <c:pt idx="412">
                  <c:v>33.817496229260847</c:v>
                </c:pt>
                <c:pt idx="413">
                  <c:v>34.687366167023548</c:v>
                </c:pt>
                <c:pt idx="414">
                  <c:v>32.238747916280836</c:v>
                </c:pt>
                <c:pt idx="415">
                  <c:v>37.171506105834496</c:v>
                </c:pt>
                <c:pt idx="416">
                  <c:v>32.51</c:v>
                </c:pt>
                <c:pt idx="417">
                  <c:v>32.178444331469201</c:v>
                </c:pt>
                <c:pt idx="418">
                  <c:v>33.214082214082197</c:v>
                </c:pt>
                <c:pt idx="419">
                  <c:v>34.111270125223555</c:v>
                </c:pt>
                <c:pt idx="420">
                  <c:v>63.839610664409598</c:v>
                </c:pt>
                <c:pt idx="421">
                  <c:v>63.241124942369837</c:v>
                </c:pt>
                <c:pt idx="422">
                  <c:v>32.464073339940498</c:v>
                </c:pt>
                <c:pt idx="423">
                  <c:v>33.059495478343528</c:v>
                </c:pt>
                <c:pt idx="424">
                  <c:v>34.813237984367163</c:v>
                </c:pt>
                <c:pt idx="425">
                  <c:v>35.856428267347738</c:v>
                </c:pt>
                <c:pt idx="426">
                  <c:v>35.238571428571454</c:v>
                </c:pt>
                <c:pt idx="427">
                  <c:v>31.058685446009399</c:v>
                </c:pt>
                <c:pt idx="428">
                  <c:v>34.261194029850699</c:v>
                </c:pt>
                <c:pt idx="429">
                  <c:v>33.151919866444096</c:v>
                </c:pt>
                <c:pt idx="430">
                  <c:v>33.449126698087099</c:v>
                </c:pt>
                <c:pt idx="431">
                  <c:v>31.118077031206116</c:v>
                </c:pt>
                <c:pt idx="432">
                  <c:v>33.803708439897648</c:v>
                </c:pt>
                <c:pt idx="433">
                  <c:v>26.815756035578087</c:v>
                </c:pt>
                <c:pt idx="434">
                  <c:v>30.001874414245535</c:v>
                </c:pt>
                <c:pt idx="435">
                  <c:v>31.135420330636688</c:v>
                </c:pt>
                <c:pt idx="436">
                  <c:v>35.941157452311636</c:v>
                </c:pt>
                <c:pt idx="437">
                  <c:v>33.585621970920812</c:v>
                </c:pt>
                <c:pt idx="438">
                  <c:v>29.528364849833089</c:v>
                </c:pt>
                <c:pt idx="439">
                  <c:v>33.0479452054795</c:v>
                </c:pt>
                <c:pt idx="440">
                  <c:v>33.855452785545296</c:v>
                </c:pt>
                <c:pt idx="441">
                  <c:v>33.403970223325103</c:v>
                </c:pt>
                <c:pt idx="442">
                  <c:v>34.63355704697998</c:v>
                </c:pt>
                <c:pt idx="443">
                  <c:v>28.184090909090905</c:v>
                </c:pt>
                <c:pt idx="444">
                  <c:v>32.5609880749574</c:v>
                </c:pt>
                <c:pt idx="445">
                  <c:v>35.197989949748703</c:v>
                </c:pt>
                <c:pt idx="446">
                  <c:v>34.045788185949</c:v>
                </c:pt>
                <c:pt idx="447">
                  <c:v>32.341546304163096</c:v>
                </c:pt>
                <c:pt idx="448">
                  <c:v>34.005046863734663</c:v>
                </c:pt>
                <c:pt idx="449">
                  <c:v>36.245846049508302</c:v>
                </c:pt>
                <c:pt idx="450">
                  <c:v>34.409536250816494</c:v>
                </c:pt>
                <c:pt idx="451">
                  <c:v>30.916316526610601</c:v>
                </c:pt>
                <c:pt idx="452">
                  <c:v>36.14230583695138</c:v>
                </c:pt>
                <c:pt idx="453">
                  <c:v>36.613331006805112</c:v>
                </c:pt>
                <c:pt idx="454">
                  <c:v>33.527821939586595</c:v>
                </c:pt>
                <c:pt idx="455">
                  <c:v>34.215271966527212</c:v>
                </c:pt>
                <c:pt idx="456">
                  <c:v>32.398727683152096</c:v>
                </c:pt>
                <c:pt idx="457">
                  <c:v>33.219850291100599</c:v>
                </c:pt>
                <c:pt idx="458">
                  <c:v>34.456701030927803</c:v>
                </c:pt>
                <c:pt idx="459">
                  <c:v>35.127344877344896</c:v>
                </c:pt>
                <c:pt idx="460">
                  <c:v>27.985014985014978</c:v>
                </c:pt>
                <c:pt idx="461">
                  <c:v>35.713030303030301</c:v>
                </c:pt>
                <c:pt idx="462">
                  <c:v>35.102777777777803</c:v>
                </c:pt>
                <c:pt idx="463">
                  <c:v>30.371440536013377</c:v>
                </c:pt>
                <c:pt idx="464">
                  <c:v>33.335925685893294</c:v>
                </c:pt>
                <c:pt idx="465">
                  <c:v>33.623840604603195</c:v>
                </c:pt>
                <c:pt idx="466">
                  <c:v>30.288667687595677</c:v>
                </c:pt>
                <c:pt idx="467">
                  <c:v>32.6823741007194</c:v>
                </c:pt>
                <c:pt idx="468">
                  <c:v>31.615763546798</c:v>
                </c:pt>
                <c:pt idx="469">
                  <c:v>32.925797503467365</c:v>
                </c:pt>
                <c:pt idx="470">
                  <c:v>35.008324924318913</c:v>
                </c:pt>
                <c:pt idx="471">
                  <c:v>33.457717698836795</c:v>
                </c:pt>
                <c:pt idx="472">
                  <c:v>32.367816091953998</c:v>
                </c:pt>
                <c:pt idx="473">
                  <c:v>35.501028806584401</c:v>
                </c:pt>
                <c:pt idx="474">
                  <c:v>33.595190380761537</c:v>
                </c:pt>
                <c:pt idx="475">
                  <c:v>35.180335296783035</c:v>
                </c:pt>
                <c:pt idx="476">
                  <c:v>34.303410427283339</c:v>
                </c:pt>
                <c:pt idx="477">
                  <c:v>33.357381077760095</c:v>
                </c:pt>
                <c:pt idx="478">
                  <c:v>32.047619047619094</c:v>
                </c:pt>
                <c:pt idx="479">
                  <c:v>34.338244197779993</c:v>
                </c:pt>
                <c:pt idx="480">
                  <c:v>33.293568464730299</c:v>
                </c:pt>
                <c:pt idx="481">
                  <c:v>34.557889209766195</c:v>
                </c:pt>
                <c:pt idx="482">
                  <c:v>34.531261038502294</c:v>
                </c:pt>
                <c:pt idx="483">
                  <c:v>32.926061493411339</c:v>
                </c:pt>
                <c:pt idx="484">
                  <c:v>31.058555997726</c:v>
                </c:pt>
                <c:pt idx="485">
                  <c:v>33.494300518134736</c:v>
                </c:pt>
                <c:pt idx="486">
                  <c:v>35.355234460196229</c:v>
                </c:pt>
                <c:pt idx="487">
                  <c:v>33.710201200141199</c:v>
                </c:pt>
                <c:pt idx="488">
                  <c:v>35.612190812720854</c:v>
                </c:pt>
                <c:pt idx="489">
                  <c:v>37.134090909090901</c:v>
                </c:pt>
                <c:pt idx="490">
                  <c:v>33.557569818716239</c:v>
                </c:pt>
                <c:pt idx="491">
                  <c:v>33.824428709365897</c:v>
                </c:pt>
                <c:pt idx="492">
                  <c:v>37.166616496086696</c:v>
                </c:pt>
                <c:pt idx="493">
                  <c:v>34.032459425717896</c:v>
                </c:pt>
                <c:pt idx="494">
                  <c:v>34.223989396951637</c:v>
                </c:pt>
                <c:pt idx="495">
                  <c:v>36.249250749250699</c:v>
                </c:pt>
                <c:pt idx="496">
                  <c:v>36.2138928742229</c:v>
                </c:pt>
                <c:pt idx="497">
                  <c:v>35.3024531024531</c:v>
                </c:pt>
                <c:pt idx="498">
                  <c:v>34.894644204174</c:v>
                </c:pt>
                <c:pt idx="499">
                  <c:v>28.278706800445864</c:v>
                </c:pt>
                <c:pt idx="500">
                  <c:v>34.1763584366063</c:v>
                </c:pt>
                <c:pt idx="501">
                  <c:v>37.489962018448196</c:v>
                </c:pt>
                <c:pt idx="502">
                  <c:v>32.965418616744699</c:v>
                </c:pt>
                <c:pt idx="503">
                  <c:v>33.096729708431837</c:v>
                </c:pt>
                <c:pt idx="504">
                  <c:v>33.174564796905202</c:v>
                </c:pt>
                <c:pt idx="505">
                  <c:v>34.321495327102802</c:v>
                </c:pt>
                <c:pt idx="506">
                  <c:v>31.952864157119517</c:v>
                </c:pt>
                <c:pt idx="507">
                  <c:v>35.682734443470601</c:v>
                </c:pt>
                <c:pt idx="508">
                  <c:v>33.957244655581839</c:v>
                </c:pt>
                <c:pt idx="509">
                  <c:v>35.204718417047197</c:v>
                </c:pt>
                <c:pt idx="510">
                  <c:v>34.041172013134599</c:v>
                </c:pt>
                <c:pt idx="511">
                  <c:v>33.589761820120913</c:v>
                </c:pt>
                <c:pt idx="512">
                  <c:v>32.625663904822602</c:v>
                </c:pt>
                <c:pt idx="513">
                  <c:v>35.451555730602564</c:v>
                </c:pt>
                <c:pt idx="514">
                  <c:v>31.774984286612217</c:v>
                </c:pt>
                <c:pt idx="515">
                  <c:v>34.623372948500382</c:v>
                </c:pt>
                <c:pt idx="516">
                  <c:v>33.826826826826803</c:v>
                </c:pt>
                <c:pt idx="517">
                  <c:v>37.109375000000036</c:v>
                </c:pt>
                <c:pt idx="518">
                  <c:v>35.305785123966899</c:v>
                </c:pt>
                <c:pt idx="519">
                  <c:v>30.810132158590299</c:v>
                </c:pt>
                <c:pt idx="520">
                  <c:v>33.678034102306903</c:v>
                </c:pt>
                <c:pt idx="521">
                  <c:v>35.292935570747936</c:v>
                </c:pt>
                <c:pt idx="522">
                  <c:v>32.322025565388394</c:v>
                </c:pt>
                <c:pt idx="523">
                  <c:v>35.766219239373612</c:v>
                </c:pt>
                <c:pt idx="524">
                  <c:v>35.006578947368403</c:v>
                </c:pt>
                <c:pt idx="525">
                  <c:v>30.957333333333263</c:v>
                </c:pt>
                <c:pt idx="526">
                  <c:v>33.519263336155845</c:v>
                </c:pt>
                <c:pt idx="527">
                  <c:v>33.1046357615894</c:v>
                </c:pt>
                <c:pt idx="528">
                  <c:v>33.6995249406176</c:v>
                </c:pt>
                <c:pt idx="529">
                  <c:v>32.793812292358879</c:v>
                </c:pt>
                <c:pt idx="530">
                  <c:v>35.419334588826104</c:v>
                </c:pt>
                <c:pt idx="531">
                  <c:v>35.912353347136012</c:v>
                </c:pt>
                <c:pt idx="532">
                  <c:v>37.825988187187598</c:v>
                </c:pt>
                <c:pt idx="533">
                  <c:v>31.365895458440431</c:v>
                </c:pt>
                <c:pt idx="534">
                  <c:v>35.179004704134698</c:v>
                </c:pt>
                <c:pt idx="535">
                  <c:v>33.628391388062312</c:v>
                </c:pt>
                <c:pt idx="536">
                  <c:v>35.472438752784001</c:v>
                </c:pt>
                <c:pt idx="537">
                  <c:v>31.830576441102799</c:v>
                </c:pt>
                <c:pt idx="538">
                  <c:v>33.151379567486863</c:v>
                </c:pt>
                <c:pt idx="539">
                  <c:v>34.714571584500597</c:v>
                </c:pt>
                <c:pt idx="540">
                  <c:v>34.400803023145997</c:v>
                </c:pt>
                <c:pt idx="541">
                  <c:v>34.665577665577736</c:v>
                </c:pt>
                <c:pt idx="542">
                  <c:v>34.429055816379879</c:v>
                </c:pt>
                <c:pt idx="543">
                  <c:v>33.945341990034699</c:v>
                </c:pt>
                <c:pt idx="544">
                  <c:v>35.932934926958872</c:v>
                </c:pt>
                <c:pt idx="545">
                  <c:v>32.522920203735111</c:v>
                </c:pt>
                <c:pt idx="546">
                  <c:v>36.280579010856499</c:v>
                </c:pt>
                <c:pt idx="547">
                  <c:v>35.808357732233198</c:v>
                </c:pt>
                <c:pt idx="548">
                  <c:v>36.073795180722911</c:v>
                </c:pt>
                <c:pt idx="549">
                  <c:v>34.329341317365298</c:v>
                </c:pt>
                <c:pt idx="550">
                  <c:v>36.755576649264398</c:v>
                </c:pt>
                <c:pt idx="551">
                  <c:v>33.587616419454996</c:v>
                </c:pt>
                <c:pt idx="552">
                  <c:v>34.657225433525994</c:v>
                </c:pt>
                <c:pt idx="553">
                  <c:v>34.744323144104854</c:v>
                </c:pt>
                <c:pt idx="554">
                  <c:v>29.167474421109301</c:v>
                </c:pt>
                <c:pt idx="555">
                  <c:v>30.105231509320486</c:v>
                </c:pt>
                <c:pt idx="556">
                  <c:v>33.853350189633339</c:v>
                </c:pt>
                <c:pt idx="557">
                  <c:v>35.721864501679647</c:v>
                </c:pt>
                <c:pt idx="558">
                  <c:v>35.193112893758645</c:v>
                </c:pt>
                <c:pt idx="559">
                  <c:v>33.914568501475898</c:v>
                </c:pt>
                <c:pt idx="560">
                  <c:v>34.818875502007998</c:v>
                </c:pt>
                <c:pt idx="561">
                  <c:v>33.686440677966047</c:v>
                </c:pt>
                <c:pt idx="562">
                  <c:v>35.423311184939145</c:v>
                </c:pt>
                <c:pt idx="563">
                  <c:v>34.989872468116964</c:v>
                </c:pt>
                <c:pt idx="564">
                  <c:v>33.356501057082411</c:v>
                </c:pt>
                <c:pt idx="565">
                  <c:v>34.326379542395699</c:v>
                </c:pt>
                <c:pt idx="566">
                  <c:v>29.689956331877699</c:v>
                </c:pt>
                <c:pt idx="567">
                  <c:v>35.943026342658811</c:v>
                </c:pt>
                <c:pt idx="568">
                  <c:v>33.023750282741503</c:v>
                </c:pt>
                <c:pt idx="569">
                  <c:v>35.160887656033239</c:v>
                </c:pt>
                <c:pt idx="570">
                  <c:v>36.714129586260647</c:v>
                </c:pt>
                <c:pt idx="571">
                  <c:v>36.817594010549563</c:v>
                </c:pt>
                <c:pt idx="572">
                  <c:v>37.154959557258337</c:v>
                </c:pt>
                <c:pt idx="573">
                  <c:v>34.775985663082395</c:v>
                </c:pt>
                <c:pt idx="574">
                  <c:v>36.547434795070195</c:v>
                </c:pt>
                <c:pt idx="575">
                  <c:v>32.4680545585068</c:v>
                </c:pt>
                <c:pt idx="576">
                  <c:v>33.215964125560497</c:v>
                </c:pt>
                <c:pt idx="577">
                  <c:v>33.631731565865799</c:v>
                </c:pt>
                <c:pt idx="578">
                  <c:v>31.540409482758587</c:v>
                </c:pt>
                <c:pt idx="579">
                  <c:v>29.594585273322974</c:v>
                </c:pt>
                <c:pt idx="580">
                  <c:v>33.181117021276563</c:v>
                </c:pt>
                <c:pt idx="581">
                  <c:v>34.121075039914835</c:v>
                </c:pt>
                <c:pt idx="582">
                  <c:v>30.7899590163934</c:v>
                </c:pt>
                <c:pt idx="583">
                  <c:v>34.854963740935197</c:v>
                </c:pt>
                <c:pt idx="584">
                  <c:v>34.875874125874098</c:v>
                </c:pt>
                <c:pt idx="585">
                  <c:v>31.747660311958388</c:v>
                </c:pt>
                <c:pt idx="586">
                  <c:v>33.666187567373264</c:v>
                </c:pt>
                <c:pt idx="587">
                  <c:v>33.616482340349599</c:v>
                </c:pt>
                <c:pt idx="588">
                  <c:v>32.746913580246897</c:v>
                </c:pt>
                <c:pt idx="589">
                  <c:v>34.185654008438803</c:v>
                </c:pt>
                <c:pt idx="590">
                  <c:v>38.103798822899954</c:v>
                </c:pt>
                <c:pt idx="591">
                  <c:v>34.954723815273155</c:v>
                </c:pt>
                <c:pt idx="592">
                  <c:v>36.632313231323145</c:v>
                </c:pt>
                <c:pt idx="593">
                  <c:v>36.665330661322599</c:v>
                </c:pt>
                <c:pt idx="594">
                  <c:v>36.744718940207754</c:v>
                </c:pt>
                <c:pt idx="595">
                  <c:v>35.414568345323701</c:v>
                </c:pt>
                <c:pt idx="596">
                  <c:v>36.841712559957394</c:v>
                </c:pt>
                <c:pt idx="597">
                  <c:v>35.161742983751836</c:v>
                </c:pt>
                <c:pt idx="598">
                  <c:v>36.149007273442038</c:v>
                </c:pt>
                <c:pt idx="599">
                  <c:v>35.827702702702702</c:v>
                </c:pt>
                <c:pt idx="600">
                  <c:v>34.213443396226396</c:v>
                </c:pt>
                <c:pt idx="601">
                  <c:v>36.267806267806264</c:v>
                </c:pt>
                <c:pt idx="602">
                  <c:v>37.01949860724222</c:v>
                </c:pt>
                <c:pt idx="603">
                  <c:v>33.2267666439446</c:v>
                </c:pt>
                <c:pt idx="604">
                  <c:v>33.908254156769594</c:v>
                </c:pt>
                <c:pt idx="605">
                  <c:v>36.244427363566437</c:v>
                </c:pt>
                <c:pt idx="606">
                  <c:v>34.125860373647996</c:v>
                </c:pt>
                <c:pt idx="607">
                  <c:v>35.642546245919512</c:v>
                </c:pt>
                <c:pt idx="608">
                  <c:v>35.542726493283794</c:v>
                </c:pt>
                <c:pt idx="609">
                  <c:v>35.648052197275035</c:v>
                </c:pt>
                <c:pt idx="610">
                  <c:v>38.369600000000005</c:v>
                </c:pt>
                <c:pt idx="611">
                  <c:v>39.720930232558196</c:v>
                </c:pt>
                <c:pt idx="612">
                  <c:v>33.5446593001842</c:v>
                </c:pt>
                <c:pt idx="613">
                  <c:v>31.590133982947577</c:v>
                </c:pt>
                <c:pt idx="614">
                  <c:v>35.744390673119199</c:v>
                </c:pt>
                <c:pt idx="615">
                  <c:v>35.0329719963866</c:v>
                </c:pt>
                <c:pt idx="616">
                  <c:v>35.337947882736138</c:v>
                </c:pt>
                <c:pt idx="617">
                  <c:v>34.258064516129011</c:v>
                </c:pt>
                <c:pt idx="618">
                  <c:v>36.831412103746338</c:v>
                </c:pt>
                <c:pt idx="619">
                  <c:v>34.807523510971812</c:v>
                </c:pt>
                <c:pt idx="620">
                  <c:v>35.053698286669494</c:v>
                </c:pt>
                <c:pt idx="621">
                  <c:v>37.063067878140004</c:v>
                </c:pt>
                <c:pt idx="622">
                  <c:v>34.331187410586537</c:v>
                </c:pt>
                <c:pt idx="623">
                  <c:v>34.623643410852701</c:v>
                </c:pt>
                <c:pt idx="624">
                  <c:v>34.913539967373595</c:v>
                </c:pt>
                <c:pt idx="625">
                  <c:v>36.920873686379601</c:v>
                </c:pt>
                <c:pt idx="626">
                  <c:v>36.752278820375345</c:v>
                </c:pt>
                <c:pt idx="627">
                  <c:v>36.1342089062179</c:v>
                </c:pt>
                <c:pt idx="628">
                  <c:v>36.6643429766469</c:v>
                </c:pt>
                <c:pt idx="629">
                  <c:v>32.827105517909011</c:v>
                </c:pt>
                <c:pt idx="630">
                  <c:v>33.9131375579598</c:v>
                </c:pt>
                <c:pt idx="631">
                  <c:v>34.435584740462801</c:v>
                </c:pt>
                <c:pt idx="632">
                  <c:v>33.730625233994836</c:v>
                </c:pt>
                <c:pt idx="633">
                  <c:v>32.495956284153046</c:v>
                </c:pt>
                <c:pt idx="634">
                  <c:v>35.133609958506199</c:v>
                </c:pt>
                <c:pt idx="635">
                  <c:v>33.652423469387763</c:v>
                </c:pt>
                <c:pt idx="636">
                  <c:v>36.644444444444339</c:v>
                </c:pt>
                <c:pt idx="637">
                  <c:v>34.805175600739403</c:v>
                </c:pt>
                <c:pt idx="638">
                  <c:v>34.255805381496494</c:v>
                </c:pt>
                <c:pt idx="639">
                  <c:v>35.962464300285596</c:v>
                </c:pt>
                <c:pt idx="640">
                  <c:v>32.924283559577653</c:v>
                </c:pt>
                <c:pt idx="641">
                  <c:v>36.248351648351772</c:v>
                </c:pt>
                <c:pt idx="642">
                  <c:v>33.3027405991077</c:v>
                </c:pt>
                <c:pt idx="643">
                  <c:v>34.113869579609329</c:v>
                </c:pt>
                <c:pt idx="644">
                  <c:v>33.743966421825803</c:v>
                </c:pt>
                <c:pt idx="645">
                  <c:v>34.133064516129011</c:v>
                </c:pt>
                <c:pt idx="646">
                  <c:v>36.148997134670502</c:v>
                </c:pt>
                <c:pt idx="647">
                  <c:v>31.868292682926775</c:v>
                </c:pt>
                <c:pt idx="648">
                  <c:v>38.736263736263702</c:v>
                </c:pt>
                <c:pt idx="649">
                  <c:v>36.341434262948155</c:v>
                </c:pt>
                <c:pt idx="650">
                  <c:v>36.479741379310248</c:v>
                </c:pt>
                <c:pt idx="651">
                  <c:v>36.407313997477935</c:v>
                </c:pt>
                <c:pt idx="652">
                  <c:v>35.624520207721837</c:v>
                </c:pt>
                <c:pt idx="653">
                  <c:v>32.447871333964095</c:v>
                </c:pt>
                <c:pt idx="654">
                  <c:v>33.768913342503481</c:v>
                </c:pt>
                <c:pt idx="655">
                  <c:v>35.463857909954598</c:v>
                </c:pt>
                <c:pt idx="656">
                  <c:v>35.419126924047397</c:v>
                </c:pt>
                <c:pt idx="657">
                  <c:v>34.615271966527203</c:v>
                </c:pt>
                <c:pt idx="658">
                  <c:v>34.453985507246294</c:v>
                </c:pt>
                <c:pt idx="659">
                  <c:v>34.602815485168399</c:v>
                </c:pt>
                <c:pt idx="660">
                  <c:v>34.286961265684653</c:v>
                </c:pt>
                <c:pt idx="661">
                  <c:v>33.660585089650802</c:v>
                </c:pt>
                <c:pt idx="662">
                  <c:v>34.563716489166396</c:v>
                </c:pt>
                <c:pt idx="663">
                  <c:v>34.779298900642999</c:v>
                </c:pt>
                <c:pt idx="664">
                  <c:v>42.415094339622563</c:v>
                </c:pt>
                <c:pt idx="665">
                  <c:v>34.717209570481394</c:v>
                </c:pt>
                <c:pt idx="666">
                  <c:v>32.316666666666585</c:v>
                </c:pt>
                <c:pt idx="667">
                  <c:v>36.526909277293647</c:v>
                </c:pt>
                <c:pt idx="668">
                  <c:v>33.995848273259099</c:v>
                </c:pt>
                <c:pt idx="669">
                  <c:v>32.969111969112006</c:v>
                </c:pt>
                <c:pt idx="670">
                  <c:v>33.672418922939663</c:v>
                </c:pt>
                <c:pt idx="671">
                  <c:v>34.663761801016648</c:v>
                </c:pt>
                <c:pt idx="672">
                  <c:v>35.0953096812989</c:v>
                </c:pt>
                <c:pt idx="673">
                  <c:v>31.592192691029876</c:v>
                </c:pt>
                <c:pt idx="674">
                  <c:v>34.372229465449763</c:v>
                </c:pt>
                <c:pt idx="675">
                  <c:v>32.791936645068411</c:v>
                </c:pt>
                <c:pt idx="676">
                  <c:v>34.605140186915946</c:v>
                </c:pt>
                <c:pt idx="677">
                  <c:v>36.256833419288263</c:v>
                </c:pt>
                <c:pt idx="678">
                  <c:v>36.603879849812294</c:v>
                </c:pt>
                <c:pt idx="679">
                  <c:v>33.715803709428101</c:v>
                </c:pt>
                <c:pt idx="680">
                  <c:v>34.245883021010798</c:v>
                </c:pt>
                <c:pt idx="681">
                  <c:v>29.605263157894719</c:v>
                </c:pt>
                <c:pt idx="682">
                  <c:v>35.493747105141296</c:v>
                </c:pt>
                <c:pt idx="683">
                  <c:v>36.634146341463399</c:v>
                </c:pt>
                <c:pt idx="684">
                  <c:v>35.136752136752136</c:v>
                </c:pt>
                <c:pt idx="685">
                  <c:v>36.409881697981895</c:v>
                </c:pt>
                <c:pt idx="686">
                  <c:v>35.957229195722839</c:v>
                </c:pt>
                <c:pt idx="687">
                  <c:v>36.138077858880813</c:v>
                </c:pt>
                <c:pt idx="688">
                  <c:v>36.205000000000013</c:v>
                </c:pt>
                <c:pt idx="689">
                  <c:v>34.738879003558736</c:v>
                </c:pt>
                <c:pt idx="690">
                  <c:v>35.404505716207098</c:v>
                </c:pt>
                <c:pt idx="691">
                  <c:v>37.243272049027411</c:v>
                </c:pt>
                <c:pt idx="692">
                  <c:v>34.021538461538498</c:v>
                </c:pt>
                <c:pt idx="693">
                  <c:v>36.492659053833563</c:v>
                </c:pt>
                <c:pt idx="694">
                  <c:v>37.742029548989137</c:v>
                </c:pt>
                <c:pt idx="695">
                  <c:v>34.824675324675312</c:v>
                </c:pt>
                <c:pt idx="696">
                  <c:v>36.260819053151302</c:v>
                </c:pt>
                <c:pt idx="697">
                  <c:v>35.134212103055745</c:v>
                </c:pt>
                <c:pt idx="698">
                  <c:v>36.091559370529346</c:v>
                </c:pt>
                <c:pt idx="699">
                  <c:v>36.155053068758697</c:v>
                </c:pt>
                <c:pt idx="700">
                  <c:v>34.932949811545299</c:v>
                </c:pt>
                <c:pt idx="701">
                  <c:v>34.645561462864464</c:v>
                </c:pt>
                <c:pt idx="702">
                  <c:v>33.532992930086436</c:v>
                </c:pt>
                <c:pt idx="703">
                  <c:v>35.923187710033595</c:v>
                </c:pt>
                <c:pt idx="704">
                  <c:v>34.080828663610028</c:v>
                </c:pt>
                <c:pt idx="705">
                  <c:v>36.456664048180194</c:v>
                </c:pt>
                <c:pt idx="706">
                  <c:v>36.275510204081662</c:v>
                </c:pt>
                <c:pt idx="707">
                  <c:v>35.927112349117962</c:v>
                </c:pt>
                <c:pt idx="708">
                  <c:v>33.167929019692636</c:v>
                </c:pt>
                <c:pt idx="709">
                  <c:v>34.541993281075001</c:v>
                </c:pt>
                <c:pt idx="710">
                  <c:v>37.598984771573598</c:v>
                </c:pt>
                <c:pt idx="711">
                  <c:v>31.154929577464799</c:v>
                </c:pt>
                <c:pt idx="712">
                  <c:v>33.257947320617546</c:v>
                </c:pt>
                <c:pt idx="713">
                  <c:v>35.197710516104046</c:v>
                </c:pt>
                <c:pt idx="714">
                  <c:v>36.787535410764903</c:v>
                </c:pt>
                <c:pt idx="715">
                  <c:v>32.644497228820299</c:v>
                </c:pt>
                <c:pt idx="716">
                  <c:v>33.510067114093964</c:v>
                </c:pt>
                <c:pt idx="717">
                  <c:v>31.426885582349886</c:v>
                </c:pt>
                <c:pt idx="718">
                  <c:v>34.717526942711302</c:v>
                </c:pt>
                <c:pt idx="719">
                  <c:v>36.903370786516902</c:v>
                </c:pt>
                <c:pt idx="720">
                  <c:v>36.65625</c:v>
                </c:pt>
                <c:pt idx="721">
                  <c:v>34.654921020656047</c:v>
                </c:pt>
                <c:pt idx="722">
                  <c:v>36.879019073569495</c:v>
                </c:pt>
                <c:pt idx="723">
                  <c:v>32.510804970286237</c:v>
                </c:pt>
                <c:pt idx="724">
                  <c:v>42.7715617715618</c:v>
                </c:pt>
                <c:pt idx="725">
                  <c:v>35.947019867549663</c:v>
                </c:pt>
                <c:pt idx="726">
                  <c:v>36.026391279403299</c:v>
                </c:pt>
                <c:pt idx="727">
                  <c:v>36.5710049423394</c:v>
                </c:pt>
                <c:pt idx="728">
                  <c:v>33.045871559632928</c:v>
                </c:pt>
                <c:pt idx="729">
                  <c:v>31.306451612903199</c:v>
                </c:pt>
                <c:pt idx="730">
                  <c:v>32.8815689261234</c:v>
                </c:pt>
                <c:pt idx="731">
                  <c:v>33.206764027670999</c:v>
                </c:pt>
                <c:pt idx="732">
                  <c:v>36.812527280663438</c:v>
                </c:pt>
                <c:pt idx="733">
                  <c:v>36.677504572241347</c:v>
                </c:pt>
                <c:pt idx="734">
                  <c:v>35.286210489753394</c:v>
                </c:pt>
                <c:pt idx="735">
                  <c:v>35.075628731680801</c:v>
                </c:pt>
                <c:pt idx="736">
                  <c:v>33.772671941570337</c:v>
                </c:pt>
                <c:pt idx="737">
                  <c:v>32.629986613119101</c:v>
                </c:pt>
                <c:pt idx="738">
                  <c:v>35.253463122426098</c:v>
                </c:pt>
                <c:pt idx="739">
                  <c:v>36.573527654999396</c:v>
                </c:pt>
                <c:pt idx="740">
                  <c:v>36.106854235258901</c:v>
                </c:pt>
                <c:pt idx="741">
                  <c:v>35.382590439276463</c:v>
                </c:pt>
                <c:pt idx="742">
                  <c:v>36.1086021505376</c:v>
                </c:pt>
                <c:pt idx="743">
                  <c:v>32.515923566879003</c:v>
                </c:pt>
                <c:pt idx="744">
                  <c:v>35.475581926061203</c:v>
                </c:pt>
                <c:pt idx="745">
                  <c:v>34.752376641014003</c:v>
                </c:pt>
                <c:pt idx="746">
                  <c:v>37.457056892779001</c:v>
                </c:pt>
                <c:pt idx="747">
                  <c:v>34.344050480769162</c:v>
                </c:pt>
                <c:pt idx="748">
                  <c:v>33.355892255892229</c:v>
                </c:pt>
                <c:pt idx="749">
                  <c:v>33.905982905982903</c:v>
                </c:pt>
                <c:pt idx="750">
                  <c:v>30.05</c:v>
                </c:pt>
                <c:pt idx="751">
                  <c:v>35.598627002288296</c:v>
                </c:pt>
                <c:pt idx="752">
                  <c:v>35.005822862396563</c:v>
                </c:pt>
                <c:pt idx="753">
                  <c:v>34.612812390003512</c:v>
                </c:pt>
                <c:pt idx="754">
                  <c:v>31.078431372548977</c:v>
                </c:pt>
                <c:pt idx="755">
                  <c:v>38.7822736030828</c:v>
                </c:pt>
                <c:pt idx="756">
                  <c:v>33.846055654837897</c:v>
                </c:pt>
                <c:pt idx="757">
                  <c:v>33.554290202238363</c:v>
                </c:pt>
                <c:pt idx="758">
                  <c:v>34.553265524625296</c:v>
                </c:pt>
                <c:pt idx="759">
                  <c:v>34.611560693641529</c:v>
                </c:pt>
                <c:pt idx="760">
                  <c:v>34.5378353376503</c:v>
                </c:pt>
                <c:pt idx="761">
                  <c:v>31.259595959595988</c:v>
                </c:pt>
                <c:pt idx="762">
                  <c:v>31.950428237736777</c:v>
                </c:pt>
                <c:pt idx="763">
                  <c:v>35.735966735966699</c:v>
                </c:pt>
                <c:pt idx="764">
                  <c:v>37.176744186046463</c:v>
                </c:pt>
                <c:pt idx="765">
                  <c:v>35.679775280898937</c:v>
                </c:pt>
                <c:pt idx="766">
                  <c:v>31.700777732296405</c:v>
                </c:pt>
                <c:pt idx="767">
                  <c:v>36.020874751491064</c:v>
                </c:pt>
                <c:pt idx="768">
                  <c:v>34.966313162819738</c:v>
                </c:pt>
                <c:pt idx="769">
                  <c:v>37.012155591572103</c:v>
                </c:pt>
                <c:pt idx="770">
                  <c:v>36.343846417552228</c:v>
                </c:pt>
                <c:pt idx="771">
                  <c:v>35.443387881468347</c:v>
                </c:pt>
                <c:pt idx="772">
                  <c:v>35.242622020431313</c:v>
                </c:pt>
                <c:pt idx="773">
                  <c:v>34.638284250960297</c:v>
                </c:pt>
                <c:pt idx="774">
                  <c:v>32.130884635281895</c:v>
                </c:pt>
                <c:pt idx="775">
                  <c:v>35.4769230769231</c:v>
                </c:pt>
                <c:pt idx="776">
                  <c:v>34.891649694500998</c:v>
                </c:pt>
                <c:pt idx="777">
                  <c:v>33.372792674951036</c:v>
                </c:pt>
                <c:pt idx="778">
                  <c:v>33.767773520647097</c:v>
                </c:pt>
                <c:pt idx="779">
                  <c:v>34.500899280575503</c:v>
                </c:pt>
                <c:pt idx="780">
                  <c:v>34.756248664815196</c:v>
                </c:pt>
                <c:pt idx="781">
                  <c:v>36.475950685882999</c:v>
                </c:pt>
                <c:pt idx="782">
                  <c:v>33.2277867528271</c:v>
                </c:pt>
                <c:pt idx="783">
                  <c:v>35.924827850038263</c:v>
                </c:pt>
                <c:pt idx="784">
                  <c:v>34.960319323784937</c:v>
                </c:pt>
                <c:pt idx="785">
                  <c:v>36.363567073170664</c:v>
                </c:pt>
                <c:pt idx="786">
                  <c:v>34.854526958290847</c:v>
                </c:pt>
                <c:pt idx="787">
                  <c:v>37.553310886644198</c:v>
                </c:pt>
                <c:pt idx="788">
                  <c:v>32.739459459459496</c:v>
                </c:pt>
                <c:pt idx="789">
                  <c:v>34.177397260273999</c:v>
                </c:pt>
                <c:pt idx="790">
                  <c:v>35.933817594834494</c:v>
                </c:pt>
                <c:pt idx="791">
                  <c:v>29.161780673181276</c:v>
                </c:pt>
                <c:pt idx="792">
                  <c:v>34.8430173292559</c:v>
                </c:pt>
                <c:pt idx="793">
                  <c:v>25.3932773109244</c:v>
                </c:pt>
                <c:pt idx="794">
                  <c:v>35.373438057836438</c:v>
                </c:pt>
                <c:pt idx="795">
                  <c:v>32.720030737704946</c:v>
                </c:pt>
                <c:pt idx="796">
                  <c:v>31.256164383561586</c:v>
                </c:pt>
                <c:pt idx="797">
                  <c:v>35.138383838383845</c:v>
                </c:pt>
                <c:pt idx="798">
                  <c:v>33.446683199008064</c:v>
                </c:pt>
                <c:pt idx="799">
                  <c:v>31.829017517136286</c:v>
                </c:pt>
                <c:pt idx="800">
                  <c:v>29.024258760107816</c:v>
                </c:pt>
                <c:pt idx="801">
                  <c:v>35.174372523117597</c:v>
                </c:pt>
                <c:pt idx="802">
                  <c:v>34.302317880794703</c:v>
                </c:pt>
                <c:pt idx="803">
                  <c:v>35.693750000000037</c:v>
                </c:pt>
                <c:pt idx="804">
                  <c:v>39.896253602305499</c:v>
                </c:pt>
                <c:pt idx="805">
                  <c:v>33.465132256956437</c:v>
                </c:pt>
                <c:pt idx="806">
                  <c:v>35.222624434389111</c:v>
                </c:pt>
                <c:pt idx="807">
                  <c:v>33.365332296929807</c:v>
                </c:pt>
                <c:pt idx="808">
                  <c:v>34.896010757507803</c:v>
                </c:pt>
                <c:pt idx="809">
                  <c:v>36.326462395543196</c:v>
                </c:pt>
                <c:pt idx="810">
                  <c:v>34.431553215494496</c:v>
                </c:pt>
                <c:pt idx="811">
                  <c:v>35.763582966226103</c:v>
                </c:pt>
                <c:pt idx="812">
                  <c:v>34.877690288713865</c:v>
                </c:pt>
                <c:pt idx="813">
                  <c:v>33.318300086730297</c:v>
                </c:pt>
                <c:pt idx="814">
                  <c:v>35.484781230183899</c:v>
                </c:pt>
                <c:pt idx="815">
                  <c:v>32.564149785144295</c:v>
                </c:pt>
                <c:pt idx="816">
                  <c:v>33.211866235167165</c:v>
                </c:pt>
                <c:pt idx="817">
                  <c:v>32.978524103267063</c:v>
                </c:pt>
                <c:pt idx="818">
                  <c:v>33.411527866073264</c:v>
                </c:pt>
                <c:pt idx="819">
                  <c:v>34.537953795379501</c:v>
                </c:pt>
                <c:pt idx="820">
                  <c:v>35.621637776449496</c:v>
                </c:pt>
                <c:pt idx="821">
                  <c:v>35.494171670787701</c:v>
                </c:pt>
                <c:pt idx="822">
                  <c:v>35.864774994458003</c:v>
                </c:pt>
                <c:pt idx="823">
                  <c:v>35.224588837961754</c:v>
                </c:pt>
                <c:pt idx="824">
                  <c:v>37.009569377990395</c:v>
                </c:pt>
                <c:pt idx="825">
                  <c:v>33.915821501014129</c:v>
                </c:pt>
                <c:pt idx="826">
                  <c:v>32.910269818029697</c:v>
                </c:pt>
                <c:pt idx="827">
                  <c:v>35.374545454545448</c:v>
                </c:pt>
                <c:pt idx="828">
                  <c:v>33.185217391304299</c:v>
                </c:pt>
                <c:pt idx="829">
                  <c:v>32.364815491413964</c:v>
                </c:pt>
                <c:pt idx="830">
                  <c:v>31.595238095238088</c:v>
                </c:pt>
                <c:pt idx="831">
                  <c:v>35.158170696184136</c:v>
                </c:pt>
                <c:pt idx="832">
                  <c:v>34.309578107183597</c:v>
                </c:pt>
                <c:pt idx="833">
                  <c:v>32.748777506112496</c:v>
                </c:pt>
                <c:pt idx="834">
                  <c:v>33.392559188275136</c:v>
                </c:pt>
                <c:pt idx="835">
                  <c:v>31.881799694966976</c:v>
                </c:pt>
                <c:pt idx="836">
                  <c:v>35.020032780914235</c:v>
                </c:pt>
                <c:pt idx="837">
                  <c:v>36.319925742574313</c:v>
                </c:pt>
                <c:pt idx="838">
                  <c:v>32.661714881417801</c:v>
                </c:pt>
                <c:pt idx="839">
                  <c:v>34.245299910474536</c:v>
                </c:pt>
                <c:pt idx="840">
                  <c:v>36.182812500000011</c:v>
                </c:pt>
                <c:pt idx="841">
                  <c:v>36.993298585256895</c:v>
                </c:pt>
                <c:pt idx="842">
                  <c:v>33.174094707520901</c:v>
                </c:pt>
                <c:pt idx="843">
                  <c:v>35.399922420481012</c:v>
                </c:pt>
                <c:pt idx="844">
                  <c:v>35.059043173862229</c:v>
                </c:pt>
                <c:pt idx="845">
                  <c:v>33.098143236074371</c:v>
                </c:pt>
                <c:pt idx="846">
                  <c:v>35.458660014255194</c:v>
                </c:pt>
                <c:pt idx="847">
                  <c:v>35.872850241545912</c:v>
                </c:pt>
                <c:pt idx="848">
                  <c:v>35.529761904761912</c:v>
                </c:pt>
                <c:pt idx="849">
                  <c:v>36.030531158511103</c:v>
                </c:pt>
                <c:pt idx="850">
                  <c:v>35.118187579214137</c:v>
                </c:pt>
                <c:pt idx="851">
                  <c:v>34.521559805024403</c:v>
                </c:pt>
                <c:pt idx="852">
                  <c:v>35.368421052631547</c:v>
                </c:pt>
                <c:pt idx="853">
                  <c:v>35.336448598130801</c:v>
                </c:pt>
                <c:pt idx="854">
                  <c:v>35.098135426889179</c:v>
                </c:pt>
                <c:pt idx="855">
                  <c:v>33.441831057157238</c:v>
                </c:pt>
                <c:pt idx="856">
                  <c:v>35.410249739854294</c:v>
                </c:pt>
                <c:pt idx="857">
                  <c:v>35.848505161549802</c:v>
                </c:pt>
                <c:pt idx="858">
                  <c:v>37.123908045977046</c:v>
                </c:pt>
                <c:pt idx="859">
                  <c:v>32.587184226740547</c:v>
                </c:pt>
                <c:pt idx="860">
                  <c:v>31.064056939501789</c:v>
                </c:pt>
                <c:pt idx="861">
                  <c:v>36.310344827586164</c:v>
                </c:pt>
                <c:pt idx="862">
                  <c:v>34.667985549630096</c:v>
                </c:pt>
                <c:pt idx="863">
                  <c:v>37.142236384704503</c:v>
                </c:pt>
                <c:pt idx="864">
                  <c:v>35.871407516580653</c:v>
                </c:pt>
                <c:pt idx="865">
                  <c:v>37.488869361452764</c:v>
                </c:pt>
                <c:pt idx="866">
                  <c:v>35.120771046420145</c:v>
                </c:pt>
                <c:pt idx="867">
                  <c:v>36.980676328502398</c:v>
                </c:pt>
                <c:pt idx="868">
                  <c:v>35.747454175152647</c:v>
                </c:pt>
                <c:pt idx="869">
                  <c:v>35.415909648907402</c:v>
                </c:pt>
                <c:pt idx="870">
                  <c:v>34.155833048238101</c:v>
                </c:pt>
                <c:pt idx="871">
                  <c:v>35.446233097231165</c:v>
                </c:pt>
                <c:pt idx="872">
                  <c:v>36.096270161290263</c:v>
                </c:pt>
                <c:pt idx="873">
                  <c:v>32.353107344632797</c:v>
                </c:pt>
                <c:pt idx="874">
                  <c:v>33.348693074642938</c:v>
                </c:pt>
                <c:pt idx="875">
                  <c:v>32.050694444444339</c:v>
                </c:pt>
                <c:pt idx="876">
                  <c:v>34.579133510168013</c:v>
                </c:pt>
                <c:pt idx="877">
                  <c:v>36.019812304483835</c:v>
                </c:pt>
                <c:pt idx="878">
                  <c:v>33.487751371115195</c:v>
                </c:pt>
                <c:pt idx="879">
                  <c:v>36.293073593073601</c:v>
                </c:pt>
                <c:pt idx="880">
                  <c:v>34.135546875000003</c:v>
                </c:pt>
                <c:pt idx="881">
                  <c:v>33.592407592407604</c:v>
                </c:pt>
                <c:pt idx="882">
                  <c:v>34.653658536585411</c:v>
                </c:pt>
                <c:pt idx="883">
                  <c:v>36.528806584362094</c:v>
                </c:pt>
                <c:pt idx="884">
                  <c:v>34.706437478935001</c:v>
                </c:pt>
                <c:pt idx="885">
                  <c:v>35.444837758112037</c:v>
                </c:pt>
                <c:pt idx="886">
                  <c:v>36.770975761342363</c:v>
                </c:pt>
                <c:pt idx="887">
                  <c:v>35.5125234815279</c:v>
                </c:pt>
                <c:pt idx="888">
                  <c:v>32.211657559198429</c:v>
                </c:pt>
                <c:pt idx="889">
                  <c:v>33.510626239727998</c:v>
                </c:pt>
                <c:pt idx="890">
                  <c:v>34.921981424148555</c:v>
                </c:pt>
                <c:pt idx="891">
                  <c:v>35.898564008554835</c:v>
                </c:pt>
                <c:pt idx="892">
                  <c:v>34.101767215112645</c:v>
                </c:pt>
                <c:pt idx="893">
                  <c:v>32.215630885122401</c:v>
                </c:pt>
                <c:pt idx="894">
                  <c:v>29.627009646302302</c:v>
                </c:pt>
                <c:pt idx="895">
                  <c:v>36.362068965517196</c:v>
                </c:pt>
                <c:pt idx="896">
                  <c:v>33.990610328638503</c:v>
                </c:pt>
                <c:pt idx="897">
                  <c:v>34.932545991369501</c:v>
                </c:pt>
                <c:pt idx="898">
                  <c:v>32.873714520773298</c:v>
                </c:pt>
                <c:pt idx="899">
                  <c:v>35.296540012736202</c:v>
                </c:pt>
                <c:pt idx="900">
                  <c:v>36.509756932557337</c:v>
                </c:pt>
                <c:pt idx="901">
                  <c:v>34.889969293756337</c:v>
                </c:pt>
                <c:pt idx="902">
                  <c:v>34.496843819995902</c:v>
                </c:pt>
                <c:pt idx="903">
                  <c:v>34.166028097062565</c:v>
                </c:pt>
                <c:pt idx="904">
                  <c:v>33.023094688221697</c:v>
                </c:pt>
                <c:pt idx="905">
                  <c:v>34.728742827334436</c:v>
                </c:pt>
                <c:pt idx="906">
                  <c:v>35.350883720930163</c:v>
                </c:pt>
                <c:pt idx="907">
                  <c:v>35.031914893616964</c:v>
                </c:pt>
                <c:pt idx="908">
                  <c:v>36.62874251497017</c:v>
                </c:pt>
                <c:pt idx="909">
                  <c:v>32.972713864306812</c:v>
                </c:pt>
                <c:pt idx="910">
                  <c:v>32.966384632975135</c:v>
                </c:pt>
                <c:pt idx="911">
                  <c:v>31.980659840728062</c:v>
                </c:pt>
                <c:pt idx="912">
                  <c:v>30.638297872340377</c:v>
                </c:pt>
                <c:pt idx="913">
                  <c:v>33.4329303396661</c:v>
                </c:pt>
                <c:pt idx="914">
                  <c:v>38.436849925705801</c:v>
                </c:pt>
                <c:pt idx="915">
                  <c:v>35.185027244728737</c:v>
                </c:pt>
                <c:pt idx="916">
                  <c:v>37.941150636802803</c:v>
                </c:pt>
                <c:pt idx="917">
                  <c:v>34.137544802867396</c:v>
                </c:pt>
                <c:pt idx="918">
                  <c:v>35.757826887661047</c:v>
                </c:pt>
                <c:pt idx="919">
                  <c:v>34.314659197012027</c:v>
                </c:pt>
                <c:pt idx="920">
                  <c:v>39.496805896805945</c:v>
                </c:pt>
                <c:pt idx="921">
                  <c:v>33.764153894275971</c:v>
                </c:pt>
                <c:pt idx="922">
                  <c:v>32.563709296838113</c:v>
                </c:pt>
                <c:pt idx="923">
                  <c:v>34.143949044586002</c:v>
                </c:pt>
                <c:pt idx="924">
                  <c:v>35.246169154228902</c:v>
                </c:pt>
                <c:pt idx="925">
                  <c:v>34.310793476268955</c:v>
                </c:pt>
                <c:pt idx="926">
                  <c:v>35.646689895470395</c:v>
                </c:pt>
                <c:pt idx="927">
                  <c:v>35.197674418604564</c:v>
                </c:pt>
                <c:pt idx="928">
                  <c:v>29.229591836734677</c:v>
                </c:pt>
                <c:pt idx="929">
                  <c:v>39.961773700305812</c:v>
                </c:pt>
                <c:pt idx="930">
                  <c:v>31.045031055900587</c:v>
                </c:pt>
                <c:pt idx="931">
                  <c:v>35.136510500807837</c:v>
                </c:pt>
                <c:pt idx="932">
                  <c:v>34.334300341296895</c:v>
                </c:pt>
                <c:pt idx="933">
                  <c:v>36.715436241610703</c:v>
                </c:pt>
                <c:pt idx="934">
                  <c:v>35.769511305616298</c:v>
                </c:pt>
                <c:pt idx="935">
                  <c:v>33.010641891891865</c:v>
                </c:pt>
                <c:pt idx="936">
                  <c:v>35.563039479269797</c:v>
                </c:pt>
                <c:pt idx="937">
                  <c:v>35.589157136806399</c:v>
                </c:pt>
                <c:pt idx="938">
                  <c:v>34.240590757503597</c:v>
                </c:pt>
                <c:pt idx="939">
                  <c:v>35.801393728222997</c:v>
                </c:pt>
                <c:pt idx="940">
                  <c:v>35.932959286433601</c:v>
                </c:pt>
                <c:pt idx="941">
                  <c:v>36.567424478355647</c:v>
                </c:pt>
                <c:pt idx="942">
                  <c:v>34.661893764434197</c:v>
                </c:pt>
                <c:pt idx="943">
                  <c:v>32.715275486638099</c:v>
                </c:pt>
                <c:pt idx="944">
                  <c:v>34.397619047618996</c:v>
                </c:pt>
                <c:pt idx="945">
                  <c:v>32.891960867715895</c:v>
                </c:pt>
                <c:pt idx="946">
                  <c:v>36.336040914560812</c:v>
                </c:pt>
                <c:pt idx="947">
                  <c:v>32.450360510260644</c:v>
                </c:pt>
                <c:pt idx="948">
                  <c:v>36.065157116451054</c:v>
                </c:pt>
                <c:pt idx="949">
                  <c:v>34.202833530106311</c:v>
                </c:pt>
                <c:pt idx="950">
                  <c:v>31.422573609596487</c:v>
                </c:pt>
                <c:pt idx="951">
                  <c:v>35.366371681415899</c:v>
                </c:pt>
                <c:pt idx="952">
                  <c:v>38.778563015312095</c:v>
                </c:pt>
                <c:pt idx="953">
                  <c:v>36.947008547008494</c:v>
                </c:pt>
                <c:pt idx="954">
                  <c:v>27.445378151260499</c:v>
                </c:pt>
                <c:pt idx="955">
                  <c:v>36.992000000000012</c:v>
                </c:pt>
                <c:pt idx="956">
                  <c:v>34.161029061457796</c:v>
                </c:pt>
                <c:pt idx="957">
                  <c:v>30.327619047618999</c:v>
                </c:pt>
                <c:pt idx="958">
                  <c:v>35.331869834710645</c:v>
                </c:pt>
                <c:pt idx="959">
                  <c:v>35.6340923466161</c:v>
                </c:pt>
                <c:pt idx="960">
                  <c:v>33.785961272475845</c:v>
                </c:pt>
                <c:pt idx="961">
                  <c:v>34.8029448621554</c:v>
                </c:pt>
                <c:pt idx="962">
                  <c:v>34.427155963302802</c:v>
                </c:pt>
                <c:pt idx="963">
                  <c:v>28.762430939226476</c:v>
                </c:pt>
                <c:pt idx="964">
                  <c:v>34.251624883936863</c:v>
                </c:pt>
                <c:pt idx="965">
                  <c:v>33.379531895364799</c:v>
                </c:pt>
                <c:pt idx="966">
                  <c:v>31.418367346938787</c:v>
                </c:pt>
                <c:pt idx="967">
                  <c:v>35.358894511483037</c:v>
                </c:pt>
                <c:pt idx="968">
                  <c:v>33.032278889606197</c:v>
                </c:pt>
                <c:pt idx="969">
                  <c:v>34.448476992871036</c:v>
                </c:pt>
                <c:pt idx="970">
                  <c:v>31.272809942406788</c:v>
                </c:pt>
                <c:pt idx="971">
                  <c:v>35.400403429147794</c:v>
                </c:pt>
                <c:pt idx="972">
                  <c:v>36.431752873563198</c:v>
                </c:pt>
                <c:pt idx="973">
                  <c:v>35.149346405228798</c:v>
                </c:pt>
                <c:pt idx="974">
                  <c:v>34.863057324840803</c:v>
                </c:pt>
                <c:pt idx="975">
                  <c:v>34.945532915360502</c:v>
                </c:pt>
                <c:pt idx="976">
                  <c:v>31.985051385861077</c:v>
                </c:pt>
                <c:pt idx="977">
                  <c:v>26.685185185185187</c:v>
                </c:pt>
                <c:pt idx="978">
                  <c:v>35.453333333333298</c:v>
                </c:pt>
                <c:pt idx="979">
                  <c:v>32.6949615289154</c:v>
                </c:pt>
                <c:pt idx="980">
                  <c:v>29.204273504273502</c:v>
                </c:pt>
                <c:pt idx="981">
                  <c:v>34.438053097345097</c:v>
                </c:pt>
                <c:pt idx="982">
                  <c:v>36.139074321317295</c:v>
                </c:pt>
                <c:pt idx="983">
                  <c:v>34.900597119775199</c:v>
                </c:pt>
                <c:pt idx="984">
                  <c:v>32.119166666666636</c:v>
                </c:pt>
                <c:pt idx="985">
                  <c:v>32.338449429358455</c:v>
                </c:pt>
                <c:pt idx="986">
                  <c:v>33.838019801980202</c:v>
                </c:pt>
                <c:pt idx="987">
                  <c:v>33.760982874162302</c:v>
                </c:pt>
                <c:pt idx="988">
                  <c:v>34.876086027631338</c:v>
                </c:pt>
                <c:pt idx="989">
                  <c:v>34.463620317709399</c:v>
                </c:pt>
                <c:pt idx="990">
                  <c:v>43.698412698412746</c:v>
                </c:pt>
                <c:pt idx="991">
                  <c:v>37.187225877192994</c:v>
                </c:pt>
                <c:pt idx="992">
                  <c:v>34.478371501272264</c:v>
                </c:pt>
                <c:pt idx="993">
                  <c:v>31.123752495009999</c:v>
                </c:pt>
                <c:pt idx="994">
                  <c:v>34.548122065727711</c:v>
                </c:pt>
                <c:pt idx="995">
                  <c:v>77.645220588235389</c:v>
                </c:pt>
                <c:pt idx="996">
                  <c:v>105.74442774856007</c:v>
                </c:pt>
                <c:pt idx="997">
                  <c:v>34.435010805804303</c:v>
                </c:pt>
                <c:pt idx="998">
                  <c:v>36.396705559368563</c:v>
                </c:pt>
                <c:pt idx="999">
                  <c:v>31.781690140845086</c:v>
                </c:pt>
                <c:pt idx="1000">
                  <c:v>35.034660504799064</c:v>
                </c:pt>
                <c:pt idx="1001">
                  <c:v>35.450653370013796</c:v>
                </c:pt>
                <c:pt idx="1002">
                  <c:v>33.306622050017538</c:v>
                </c:pt>
                <c:pt idx="1003">
                  <c:v>32.460078534031403</c:v>
                </c:pt>
                <c:pt idx="1004">
                  <c:v>33.802350427350397</c:v>
                </c:pt>
                <c:pt idx="1005">
                  <c:v>32.452743902439003</c:v>
                </c:pt>
                <c:pt idx="1006">
                  <c:v>35.914170506912363</c:v>
                </c:pt>
                <c:pt idx="1007">
                  <c:v>34.245236122618103</c:v>
                </c:pt>
                <c:pt idx="1008">
                  <c:v>32.084824387011238</c:v>
                </c:pt>
                <c:pt idx="1009">
                  <c:v>33.267119062307202</c:v>
                </c:pt>
                <c:pt idx="1010">
                  <c:v>33.633895818048401</c:v>
                </c:pt>
                <c:pt idx="1011">
                  <c:v>34.919706541675197</c:v>
                </c:pt>
                <c:pt idx="1012">
                  <c:v>34.282826177574002</c:v>
                </c:pt>
                <c:pt idx="1013">
                  <c:v>36.889027951606096</c:v>
                </c:pt>
                <c:pt idx="1014">
                  <c:v>33.559922178988302</c:v>
                </c:pt>
                <c:pt idx="1015">
                  <c:v>31.911653344552001</c:v>
                </c:pt>
                <c:pt idx="1016">
                  <c:v>33.462794918330303</c:v>
                </c:pt>
                <c:pt idx="1017">
                  <c:v>34.066547565877563</c:v>
                </c:pt>
                <c:pt idx="1018">
                  <c:v>33.440456316082397</c:v>
                </c:pt>
                <c:pt idx="1019">
                  <c:v>34.389568576947795</c:v>
                </c:pt>
                <c:pt idx="1020">
                  <c:v>36.368256450351801</c:v>
                </c:pt>
                <c:pt idx="1021">
                  <c:v>36.575994054254899</c:v>
                </c:pt>
                <c:pt idx="1022">
                  <c:v>36.598145285935146</c:v>
                </c:pt>
                <c:pt idx="1023">
                  <c:v>35.961719670200196</c:v>
                </c:pt>
                <c:pt idx="1024">
                  <c:v>31.185027647809378</c:v>
                </c:pt>
                <c:pt idx="1025">
                  <c:v>33.116933259790365</c:v>
                </c:pt>
                <c:pt idx="1026">
                  <c:v>34.497141495950494</c:v>
                </c:pt>
                <c:pt idx="1027">
                  <c:v>37.056936647955112</c:v>
                </c:pt>
                <c:pt idx="1028">
                  <c:v>37.410445891783539</c:v>
                </c:pt>
                <c:pt idx="1029">
                  <c:v>34.747567258156799</c:v>
                </c:pt>
                <c:pt idx="1030">
                  <c:v>34.562893720788502</c:v>
                </c:pt>
                <c:pt idx="1031">
                  <c:v>32.685489810950202</c:v>
                </c:pt>
                <c:pt idx="1032">
                  <c:v>31.628255722178434</c:v>
                </c:pt>
                <c:pt idx="1033">
                  <c:v>30.452573018080699</c:v>
                </c:pt>
                <c:pt idx="1034">
                  <c:v>33.720720720720763</c:v>
                </c:pt>
                <c:pt idx="1035">
                  <c:v>32.190677025527201</c:v>
                </c:pt>
                <c:pt idx="1036">
                  <c:v>37.135654261704701</c:v>
                </c:pt>
                <c:pt idx="1037">
                  <c:v>30.354292623942001</c:v>
                </c:pt>
                <c:pt idx="1038">
                  <c:v>35.052100161550911</c:v>
                </c:pt>
                <c:pt idx="1039">
                  <c:v>32.490499853843865</c:v>
                </c:pt>
                <c:pt idx="1040">
                  <c:v>32.790868596882</c:v>
                </c:pt>
                <c:pt idx="1041">
                  <c:v>33.466815809097703</c:v>
                </c:pt>
                <c:pt idx="1042">
                  <c:v>15.466666666666715</c:v>
                </c:pt>
                <c:pt idx="1043">
                  <c:v>30.489690721649499</c:v>
                </c:pt>
                <c:pt idx="1044">
                  <c:v>32.382297551789037</c:v>
                </c:pt>
                <c:pt idx="1045">
                  <c:v>31.531120331950188</c:v>
                </c:pt>
                <c:pt idx="1046">
                  <c:v>32.860086342229202</c:v>
                </c:pt>
                <c:pt idx="1047">
                  <c:v>33.570267379679095</c:v>
                </c:pt>
                <c:pt idx="1048">
                  <c:v>35.106318956870645</c:v>
                </c:pt>
                <c:pt idx="1049">
                  <c:v>37.579335793357913</c:v>
                </c:pt>
                <c:pt idx="1050">
                  <c:v>33.426900584795298</c:v>
                </c:pt>
                <c:pt idx="1051">
                  <c:v>35.004040833687796</c:v>
                </c:pt>
                <c:pt idx="1052">
                  <c:v>30.798141891891873</c:v>
                </c:pt>
                <c:pt idx="1053">
                  <c:v>35.472321784149699</c:v>
                </c:pt>
                <c:pt idx="1054">
                  <c:v>33.704652996845411</c:v>
                </c:pt>
                <c:pt idx="1055">
                  <c:v>33.6516224188791</c:v>
                </c:pt>
                <c:pt idx="1056">
                  <c:v>29.4990800367985</c:v>
                </c:pt>
                <c:pt idx="1057">
                  <c:v>35.477906976744194</c:v>
                </c:pt>
                <c:pt idx="1058">
                  <c:v>34.707650273223997</c:v>
                </c:pt>
                <c:pt idx="1059">
                  <c:v>33.057993249462996</c:v>
                </c:pt>
                <c:pt idx="1060">
                  <c:v>28.262070971495081</c:v>
                </c:pt>
                <c:pt idx="1061">
                  <c:v>25.360185902401199</c:v>
                </c:pt>
                <c:pt idx="1062">
                  <c:v>24.182363013698598</c:v>
                </c:pt>
                <c:pt idx="1063">
                  <c:v>23.032222222222178</c:v>
                </c:pt>
                <c:pt idx="1064">
                  <c:v>30.925097276264577</c:v>
                </c:pt>
                <c:pt idx="1065">
                  <c:v>23.959677419354801</c:v>
                </c:pt>
                <c:pt idx="1066">
                  <c:v>20.208860759493717</c:v>
                </c:pt>
                <c:pt idx="1067">
                  <c:v>35.515007898894197</c:v>
                </c:pt>
                <c:pt idx="1068">
                  <c:v>32.523444160272796</c:v>
                </c:pt>
                <c:pt idx="1069">
                  <c:v>24.558646267964775</c:v>
                </c:pt>
                <c:pt idx="1070">
                  <c:v>16.940568475452199</c:v>
                </c:pt>
                <c:pt idx="1071">
                  <c:v>25.298989898989873</c:v>
                </c:pt>
                <c:pt idx="1072">
                  <c:v>28.899736147757277</c:v>
                </c:pt>
                <c:pt idx="1073">
                  <c:v>27.580922242314589</c:v>
                </c:pt>
                <c:pt idx="1074">
                  <c:v>31.157001414427217</c:v>
                </c:pt>
                <c:pt idx="1075">
                  <c:v>35.446993395898495</c:v>
                </c:pt>
                <c:pt idx="1076">
                  <c:v>30.874895046179716</c:v>
                </c:pt>
                <c:pt idx="1077">
                  <c:v>33.558823529411796</c:v>
                </c:pt>
                <c:pt idx="1078">
                  <c:v>34.569252736792002</c:v>
                </c:pt>
                <c:pt idx="1079">
                  <c:v>35.299062049062101</c:v>
                </c:pt>
                <c:pt idx="1080">
                  <c:v>31.410256410256434</c:v>
                </c:pt>
                <c:pt idx="1081">
                  <c:v>28.6909827760892</c:v>
                </c:pt>
                <c:pt idx="1082">
                  <c:v>29.368253968253999</c:v>
                </c:pt>
                <c:pt idx="1083">
                  <c:v>27.694505494505517</c:v>
                </c:pt>
                <c:pt idx="1084">
                  <c:v>25.478909798831889</c:v>
                </c:pt>
                <c:pt idx="1085">
                  <c:v>23.439012814428089</c:v>
                </c:pt>
                <c:pt idx="1086">
                  <c:v>35.968999530295903</c:v>
                </c:pt>
                <c:pt idx="1087">
                  <c:v>32.832497911445294</c:v>
                </c:pt>
                <c:pt idx="1088">
                  <c:v>33.375601926163696</c:v>
                </c:pt>
                <c:pt idx="1089">
                  <c:v>28.902071563088501</c:v>
                </c:pt>
                <c:pt idx="1090">
                  <c:v>30.361304347826099</c:v>
                </c:pt>
                <c:pt idx="1091">
                  <c:v>25.894459102902399</c:v>
                </c:pt>
                <c:pt idx="1092">
                  <c:v>31.659705159705201</c:v>
                </c:pt>
                <c:pt idx="1093">
                  <c:v>34.211867630277645</c:v>
                </c:pt>
                <c:pt idx="1094">
                  <c:v>21.783291976840378</c:v>
                </c:pt>
                <c:pt idx="1095">
                  <c:v>20.2372311827957</c:v>
                </c:pt>
                <c:pt idx="1096">
                  <c:v>18.561224489795887</c:v>
                </c:pt>
                <c:pt idx="1097">
                  <c:v>36.091870215092996</c:v>
                </c:pt>
                <c:pt idx="1098">
                  <c:v>36.237951807228903</c:v>
                </c:pt>
                <c:pt idx="1099">
                  <c:v>23.284650630011502</c:v>
                </c:pt>
                <c:pt idx="1100">
                  <c:v>18.344115354637601</c:v>
                </c:pt>
                <c:pt idx="1101">
                  <c:v>22.382241215574489</c:v>
                </c:pt>
                <c:pt idx="1102">
                  <c:v>20.288062902072877</c:v>
                </c:pt>
                <c:pt idx="1103">
                  <c:v>27.383968778144698</c:v>
                </c:pt>
                <c:pt idx="1104">
                  <c:v>30.647831398900419</c:v>
                </c:pt>
                <c:pt idx="1105">
                  <c:v>31.406161137440801</c:v>
                </c:pt>
                <c:pt idx="1106">
                  <c:v>33.013031550068547</c:v>
                </c:pt>
                <c:pt idx="1107">
                  <c:v>33.523326572008102</c:v>
                </c:pt>
                <c:pt idx="1108">
                  <c:v>32.980164670658652</c:v>
                </c:pt>
                <c:pt idx="1109">
                  <c:v>34.198497429814196</c:v>
                </c:pt>
                <c:pt idx="1110">
                  <c:v>33.595981341944736</c:v>
                </c:pt>
                <c:pt idx="1111">
                  <c:v>29.477882037533487</c:v>
                </c:pt>
                <c:pt idx="1112">
                  <c:v>31.996499416569364</c:v>
                </c:pt>
                <c:pt idx="1113">
                  <c:v>28.983864620228299</c:v>
                </c:pt>
                <c:pt idx="1114">
                  <c:v>32.039233576642239</c:v>
                </c:pt>
                <c:pt idx="1115">
                  <c:v>27.2271562766866</c:v>
                </c:pt>
                <c:pt idx="1116">
                  <c:v>32.318273964668364</c:v>
                </c:pt>
                <c:pt idx="1117">
                  <c:v>32.920876085240636</c:v>
                </c:pt>
                <c:pt idx="1118">
                  <c:v>31.794755877034401</c:v>
                </c:pt>
                <c:pt idx="1119">
                  <c:v>30.263906856403587</c:v>
                </c:pt>
                <c:pt idx="1120">
                  <c:v>25.928042328042277</c:v>
                </c:pt>
                <c:pt idx="1121">
                  <c:v>30.901893821794516</c:v>
                </c:pt>
                <c:pt idx="1122">
                  <c:v>33.584846093133329</c:v>
                </c:pt>
                <c:pt idx="1123">
                  <c:v>20.380480905233402</c:v>
                </c:pt>
                <c:pt idx="1124">
                  <c:v>23.433563748079902</c:v>
                </c:pt>
                <c:pt idx="1125">
                  <c:v>34.892912571133003</c:v>
                </c:pt>
                <c:pt idx="1126">
                  <c:v>35.073622508792454</c:v>
                </c:pt>
                <c:pt idx="1127">
                  <c:v>36.027516292541613</c:v>
                </c:pt>
                <c:pt idx="1128">
                  <c:v>36.288672865595913</c:v>
                </c:pt>
                <c:pt idx="1129">
                  <c:v>29.5281501340483</c:v>
                </c:pt>
                <c:pt idx="1130">
                  <c:v>33.006958942240836</c:v>
                </c:pt>
                <c:pt idx="1131">
                  <c:v>30.364358182620201</c:v>
                </c:pt>
                <c:pt idx="1132">
                  <c:v>34.893200663349894</c:v>
                </c:pt>
                <c:pt idx="1133">
                  <c:v>33.904261890055594</c:v>
                </c:pt>
                <c:pt idx="1134">
                  <c:v>35.451345755693495</c:v>
                </c:pt>
                <c:pt idx="1135">
                  <c:v>35.366032210834611</c:v>
                </c:pt>
                <c:pt idx="1136">
                  <c:v>33.634967389017447</c:v>
                </c:pt>
                <c:pt idx="1137">
                  <c:v>34.600967351874196</c:v>
                </c:pt>
                <c:pt idx="1138">
                  <c:v>32.474245406824096</c:v>
                </c:pt>
                <c:pt idx="1139">
                  <c:v>32.183686715707438</c:v>
                </c:pt>
                <c:pt idx="1140">
                  <c:v>29.092578986039687</c:v>
                </c:pt>
                <c:pt idx="1141">
                  <c:v>23.948051948051887</c:v>
                </c:pt>
                <c:pt idx="1142">
                  <c:v>27.309302325581378</c:v>
                </c:pt>
                <c:pt idx="1143">
                  <c:v>33.883088235294039</c:v>
                </c:pt>
                <c:pt idx="1144">
                  <c:v>35.136331192005763</c:v>
                </c:pt>
                <c:pt idx="1145">
                  <c:v>33.882905982906003</c:v>
                </c:pt>
                <c:pt idx="1146">
                  <c:v>28.632739609838787</c:v>
                </c:pt>
                <c:pt idx="1147">
                  <c:v>28.503325942350287</c:v>
                </c:pt>
                <c:pt idx="1148">
                  <c:v>24.79745596868883</c:v>
                </c:pt>
                <c:pt idx="1149">
                  <c:v>28.308248914616517</c:v>
                </c:pt>
                <c:pt idx="1150">
                  <c:v>32.957492486045439</c:v>
                </c:pt>
                <c:pt idx="1151">
                  <c:v>28.584536082474177</c:v>
                </c:pt>
                <c:pt idx="1152">
                  <c:v>29.328310864393274</c:v>
                </c:pt>
                <c:pt idx="1153">
                  <c:v>30.075526506899077</c:v>
                </c:pt>
                <c:pt idx="1154">
                  <c:v>25.416455696202526</c:v>
                </c:pt>
                <c:pt idx="1155">
                  <c:v>36.996078431372496</c:v>
                </c:pt>
                <c:pt idx="1156">
                  <c:v>27.956692913385776</c:v>
                </c:pt>
                <c:pt idx="1157">
                  <c:v>28.869918699187</c:v>
                </c:pt>
                <c:pt idx="1158">
                  <c:v>26.176890156918734</c:v>
                </c:pt>
                <c:pt idx="1159">
                  <c:v>31.024344569288399</c:v>
                </c:pt>
                <c:pt idx="1160">
                  <c:v>34.6111111111111</c:v>
                </c:pt>
                <c:pt idx="1161">
                  <c:v>27.976890756302517</c:v>
                </c:pt>
                <c:pt idx="1162">
                  <c:v>27.354576271186389</c:v>
                </c:pt>
                <c:pt idx="1163">
                  <c:v>37.392332268370637</c:v>
                </c:pt>
                <c:pt idx="1164">
                  <c:v>35.279505752023937</c:v>
                </c:pt>
                <c:pt idx="1165">
                  <c:v>35.796844660194196</c:v>
                </c:pt>
                <c:pt idx="1166">
                  <c:v>20.847386759581902</c:v>
                </c:pt>
                <c:pt idx="1167">
                  <c:v>26.308596620132278</c:v>
                </c:pt>
                <c:pt idx="1168">
                  <c:v>28.671288743882535</c:v>
                </c:pt>
                <c:pt idx="1169">
                  <c:v>28.893907563025188</c:v>
                </c:pt>
                <c:pt idx="1170">
                  <c:v>35.147701149425302</c:v>
                </c:pt>
                <c:pt idx="1171">
                  <c:v>34.868016497937802</c:v>
                </c:pt>
                <c:pt idx="1172">
                  <c:v>33.483548766157497</c:v>
                </c:pt>
                <c:pt idx="1173">
                  <c:v>36.668318467129247</c:v>
                </c:pt>
                <c:pt idx="1174">
                  <c:v>34.838174273858911</c:v>
                </c:pt>
                <c:pt idx="1175">
                  <c:v>33.182608695652164</c:v>
                </c:pt>
                <c:pt idx="1176">
                  <c:v>30.022826451829488</c:v>
                </c:pt>
                <c:pt idx="1177">
                  <c:v>35.029976019184737</c:v>
                </c:pt>
                <c:pt idx="1178">
                  <c:v>32.143482064741896</c:v>
                </c:pt>
                <c:pt idx="1179">
                  <c:v>22.597938144329888</c:v>
                </c:pt>
                <c:pt idx="1180">
                  <c:v>22.995258416311</c:v>
                </c:pt>
                <c:pt idx="1181">
                  <c:v>16.619047619047617</c:v>
                </c:pt>
                <c:pt idx="1182">
                  <c:v>27.453692370460963</c:v>
                </c:pt>
                <c:pt idx="1183">
                  <c:v>27.650094398993101</c:v>
                </c:pt>
                <c:pt idx="1184">
                  <c:v>34.823404255319048</c:v>
                </c:pt>
                <c:pt idx="1185">
                  <c:v>33.635467980295594</c:v>
                </c:pt>
                <c:pt idx="1186">
                  <c:v>35.879876308277801</c:v>
                </c:pt>
                <c:pt idx="1187">
                  <c:v>35.874851013110764</c:v>
                </c:pt>
                <c:pt idx="1188">
                  <c:v>34.692542931075081</c:v>
                </c:pt>
                <c:pt idx="1189">
                  <c:v>36.016797615822263</c:v>
                </c:pt>
                <c:pt idx="1190">
                  <c:v>32.274475007394294</c:v>
                </c:pt>
                <c:pt idx="1191">
                  <c:v>33.529904539255803</c:v>
                </c:pt>
                <c:pt idx="1192">
                  <c:v>36.855013550135496</c:v>
                </c:pt>
                <c:pt idx="1193">
                  <c:v>35.442575285565937</c:v>
                </c:pt>
                <c:pt idx="1194">
                  <c:v>33.596789423984902</c:v>
                </c:pt>
                <c:pt idx="1195">
                  <c:v>34.299964119124503</c:v>
                </c:pt>
                <c:pt idx="1196">
                  <c:v>36.222679846238336</c:v>
                </c:pt>
                <c:pt idx="1197">
                  <c:v>36.429229406554498</c:v>
                </c:pt>
                <c:pt idx="1198">
                  <c:v>32.912115505335812</c:v>
                </c:pt>
                <c:pt idx="1199">
                  <c:v>34.571890145395798</c:v>
                </c:pt>
                <c:pt idx="1200">
                  <c:v>35.253559155620998</c:v>
                </c:pt>
                <c:pt idx="1201">
                  <c:v>34.376803003358994</c:v>
                </c:pt>
                <c:pt idx="1202">
                  <c:v>34.179945054945101</c:v>
                </c:pt>
                <c:pt idx="1203">
                  <c:v>34.887758248535313</c:v>
                </c:pt>
                <c:pt idx="1204">
                  <c:v>34.432134758665399</c:v>
                </c:pt>
                <c:pt idx="1205">
                  <c:v>35.078240330676103</c:v>
                </c:pt>
                <c:pt idx="1206">
                  <c:v>33.928348160615499</c:v>
                </c:pt>
                <c:pt idx="1207">
                  <c:v>34.678477306002911</c:v>
                </c:pt>
                <c:pt idx="1208">
                  <c:v>30.206236080178176</c:v>
                </c:pt>
                <c:pt idx="1209">
                  <c:v>36.100893997445702</c:v>
                </c:pt>
                <c:pt idx="1210">
                  <c:v>22.622991347342399</c:v>
                </c:pt>
                <c:pt idx="1211">
                  <c:v>25.192731605600187</c:v>
                </c:pt>
                <c:pt idx="1212">
                  <c:v>26.786067415730287</c:v>
                </c:pt>
                <c:pt idx="1213">
                  <c:v>19.398791540785489</c:v>
                </c:pt>
                <c:pt idx="1214">
                  <c:v>27.806996381182099</c:v>
                </c:pt>
                <c:pt idx="1215">
                  <c:v>24.950637825845789</c:v>
                </c:pt>
                <c:pt idx="1216">
                  <c:v>35.275784753363148</c:v>
                </c:pt>
                <c:pt idx="1217">
                  <c:v>30.903175102169087</c:v>
                </c:pt>
                <c:pt idx="1218">
                  <c:v>30.511446663419399</c:v>
                </c:pt>
                <c:pt idx="1219">
                  <c:v>31.293572496263089</c:v>
                </c:pt>
                <c:pt idx="1220">
                  <c:v>35.578718783930512</c:v>
                </c:pt>
                <c:pt idx="1221">
                  <c:v>26.334515366430317</c:v>
                </c:pt>
                <c:pt idx="1222">
                  <c:v>30.749112426035499</c:v>
                </c:pt>
                <c:pt idx="1223">
                  <c:v>35.176130895091411</c:v>
                </c:pt>
                <c:pt idx="1224">
                  <c:v>30.142857142857117</c:v>
                </c:pt>
                <c:pt idx="1225">
                  <c:v>28.865688175020789</c:v>
                </c:pt>
                <c:pt idx="1226">
                  <c:v>25.6840780365009</c:v>
                </c:pt>
                <c:pt idx="1227">
                  <c:v>25.985051140833978</c:v>
                </c:pt>
                <c:pt idx="1228">
                  <c:v>32.157303370786494</c:v>
                </c:pt>
                <c:pt idx="1229">
                  <c:v>35.9217919514047</c:v>
                </c:pt>
                <c:pt idx="1230">
                  <c:v>34.847465231045263</c:v>
                </c:pt>
                <c:pt idx="1231">
                  <c:v>34.446400988569735</c:v>
                </c:pt>
                <c:pt idx="1232">
                  <c:v>34.664206642066397</c:v>
                </c:pt>
                <c:pt idx="1233">
                  <c:v>23.633255633255626</c:v>
                </c:pt>
                <c:pt idx="1234">
                  <c:v>24.123261390887301</c:v>
                </c:pt>
                <c:pt idx="1235">
                  <c:v>34.850789096126263</c:v>
                </c:pt>
                <c:pt idx="1236">
                  <c:v>31.749019607843081</c:v>
                </c:pt>
                <c:pt idx="1237">
                  <c:v>28.365189873417677</c:v>
                </c:pt>
                <c:pt idx="1238">
                  <c:v>25.732889158086017</c:v>
                </c:pt>
                <c:pt idx="1239">
                  <c:v>27.052808610830805</c:v>
                </c:pt>
                <c:pt idx="1240">
                  <c:v>24.398505603985086</c:v>
                </c:pt>
                <c:pt idx="1241">
                  <c:v>32.947433518862063</c:v>
                </c:pt>
                <c:pt idx="1242">
                  <c:v>27.2479523454952</c:v>
                </c:pt>
                <c:pt idx="1243">
                  <c:v>29.873665016931501</c:v>
                </c:pt>
                <c:pt idx="1244">
                  <c:v>29.496449704141966</c:v>
                </c:pt>
                <c:pt idx="1245">
                  <c:v>29.712755102040816</c:v>
                </c:pt>
                <c:pt idx="1246">
                  <c:v>30.914204983303389</c:v>
                </c:pt>
                <c:pt idx="1247">
                  <c:v>28.021739130434781</c:v>
                </c:pt>
                <c:pt idx="1248">
                  <c:v>29.376252209781978</c:v>
                </c:pt>
                <c:pt idx="1249">
                  <c:v>31.466095890410987</c:v>
                </c:pt>
                <c:pt idx="1250">
                  <c:v>30.695080091533189</c:v>
                </c:pt>
                <c:pt idx="1251">
                  <c:v>30.156666666666698</c:v>
                </c:pt>
                <c:pt idx="1252">
                  <c:v>35.222666666666647</c:v>
                </c:pt>
                <c:pt idx="1253">
                  <c:v>34.869140625</c:v>
                </c:pt>
                <c:pt idx="1254">
                  <c:v>37.635000000000012</c:v>
                </c:pt>
                <c:pt idx="1255">
                  <c:v>35.5711324665536</c:v>
                </c:pt>
                <c:pt idx="1256">
                  <c:v>30.162027260510687</c:v>
                </c:pt>
                <c:pt idx="1257">
                  <c:v>32.146146616541401</c:v>
                </c:pt>
                <c:pt idx="1258">
                  <c:v>24.547709923664087</c:v>
                </c:pt>
                <c:pt idx="1259">
                  <c:v>24.387978142076534</c:v>
                </c:pt>
                <c:pt idx="1260">
                  <c:v>22.777777777777789</c:v>
                </c:pt>
                <c:pt idx="1261">
                  <c:v>33.741567202906097</c:v>
                </c:pt>
                <c:pt idx="1262">
                  <c:v>31.597898758357218</c:v>
                </c:pt>
                <c:pt idx="1263">
                  <c:v>35.210784313725497</c:v>
                </c:pt>
                <c:pt idx="1264">
                  <c:v>23.8</c:v>
                </c:pt>
                <c:pt idx="1265">
                  <c:v>31.667829119442018</c:v>
                </c:pt>
                <c:pt idx="1266">
                  <c:v>35.774866785079901</c:v>
                </c:pt>
                <c:pt idx="1267">
                  <c:v>36.083522727272701</c:v>
                </c:pt>
                <c:pt idx="1268">
                  <c:v>33.464177407126563</c:v>
                </c:pt>
                <c:pt idx="1269">
                  <c:v>34.313060005430337</c:v>
                </c:pt>
                <c:pt idx="1270">
                  <c:v>34.309500489715958</c:v>
                </c:pt>
                <c:pt idx="1271">
                  <c:v>35.269657501205998</c:v>
                </c:pt>
                <c:pt idx="1272">
                  <c:v>35.759363957597195</c:v>
                </c:pt>
                <c:pt idx="1273">
                  <c:v>35.286365016702099</c:v>
                </c:pt>
                <c:pt idx="1274">
                  <c:v>34.437029431895958</c:v>
                </c:pt>
                <c:pt idx="1275">
                  <c:v>32.581709534944096</c:v>
                </c:pt>
                <c:pt idx="1276">
                  <c:v>23.481980464803001</c:v>
                </c:pt>
                <c:pt idx="1277">
                  <c:v>29.618743615934587</c:v>
                </c:pt>
                <c:pt idx="1278">
                  <c:v>29.875398512220986</c:v>
                </c:pt>
                <c:pt idx="1279">
                  <c:v>34.106015037594013</c:v>
                </c:pt>
                <c:pt idx="1280">
                  <c:v>35.813773250664248</c:v>
                </c:pt>
                <c:pt idx="1281">
                  <c:v>36.370580296896094</c:v>
                </c:pt>
                <c:pt idx="1282">
                  <c:v>34.172744721689099</c:v>
                </c:pt>
                <c:pt idx="1283">
                  <c:v>35.694233687405202</c:v>
                </c:pt>
                <c:pt idx="1284">
                  <c:v>35.685501709229811</c:v>
                </c:pt>
                <c:pt idx="1285">
                  <c:v>38.7506439979392</c:v>
                </c:pt>
                <c:pt idx="1286">
                  <c:v>36.207061068702238</c:v>
                </c:pt>
                <c:pt idx="1287">
                  <c:v>34.436273497211239</c:v>
                </c:pt>
                <c:pt idx="1288">
                  <c:v>28.962030220844589</c:v>
                </c:pt>
                <c:pt idx="1289">
                  <c:v>33.598958333333336</c:v>
                </c:pt>
                <c:pt idx="1290">
                  <c:v>34.619772844605137</c:v>
                </c:pt>
                <c:pt idx="1291">
                  <c:v>33.991820921222548</c:v>
                </c:pt>
                <c:pt idx="1292">
                  <c:v>32.502402196293801</c:v>
                </c:pt>
                <c:pt idx="1293">
                  <c:v>32.044894366197163</c:v>
                </c:pt>
                <c:pt idx="1294">
                  <c:v>28.288212069937966</c:v>
                </c:pt>
                <c:pt idx="1295">
                  <c:v>23.318822023047399</c:v>
                </c:pt>
                <c:pt idx="1296">
                  <c:v>25.267958030669899</c:v>
                </c:pt>
                <c:pt idx="1297">
                  <c:v>27.923787528868377</c:v>
                </c:pt>
                <c:pt idx="1298">
                  <c:v>30.610763454317901</c:v>
                </c:pt>
                <c:pt idx="1299">
                  <c:v>28.2342277012328</c:v>
                </c:pt>
                <c:pt idx="1300">
                  <c:v>35.207764198418396</c:v>
                </c:pt>
                <c:pt idx="1301">
                  <c:v>34.538204127161201</c:v>
                </c:pt>
                <c:pt idx="1302">
                  <c:v>30.187426326129689</c:v>
                </c:pt>
                <c:pt idx="1303">
                  <c:v>24.699190647481988</c:v>
                </c:pt>
                <c:pt idx="1304">
                  <c:v>28.337325349301388</c:v>
                </c:pt>
                <c:pt idx="1305">
                  <c:v>29.877689694224188</c:v>
                </c:pt>
                <c:pt idx="1306">
                  <c:v>30.476616915422873</c:v>
                </c:pt>
                <c:pt idx="1307">
                  <c:v>31.931527464258817</c:v>
                </c:pt>
                <c:pt idx="1308">
                  <c:v>25.826322930800487</c:v>
                </c:pt>
                <c:pt idx="1309">
                  <c:v>25.185958254269501</c:v>
                </c:pt>
                <c:pt idx="1310">
                  <c:v>33.122476446837112</c:v>
                </c:pt>
                <c:pt idx="1311">
                  <c:v>27.75385462555073</c:v>
                </c:pt>
                <c:pt idx="1312">
                  <c:v>33.540701522170735</c:v>
                </c:pt>
                <c:pt idx="1313">
                  <c:v>30.819047619047598</c:v>
                </c:pt>
                <c:pt idx="1314">
                  <c:v>25.836963285625401</c:v>
                </c:pt>
                <c:pt idx="1315">
                  <c:v>34.410238179879101</c:v>
                </c:pt>
                <c:pt idx="1316">
                  <c:v>32.280913399396802</c:v>
                </c:pt>
                <c:pt idx="1317">
                  <c:v>30.271078431372501</c:v>
                </c:pt>
                <c:pt idx="1318">
                  <c:v>27.914906457453217</c:v>
                </c:pt>
                <c:pt idx="1319">
                  <c:v>35.127862595419799</c:v>
                </c:pt>
                <c:pt idx="1320">
                  <c:v>29.199498117942301</c:v>
                </c:pt>
                <c:pt idx="1321">
                  <c:v>31.205303030302975</c:v>
                </c:pt>
                <c:pt idx="1322">
                  <c:v>29.936298932384286</c:v>
                </c:pt>
                <c:pt idx="1323">
                  <c:v>33.178855901520613</c:v>
                </c:pt>
                <c:pt idx="1324">
                  <c:v>33.048870447210653</c:v>
                </c:pt>
                <c:pt idx="1325">
                  <c:v>28.093891062293117</c:v>
                </c:pt>
                <c:pt idx="1326">
                  <c:v>26.808419243986275</c:v>
                </c:pt>
                <c:pt idx="1327">
                  <c:v>29.467237903225776</c:v>
                </c:pt>
                <c:pt idx="1328">
                  <c:v>33.471984805318037</c:v>
                </c:pt>
                <c:pt idx="1329">
                  <c:v>32.853150165798148</c:v>
                </c:pt>
                <c:pt idx="1330">
                  <c:v>29.269338959212401</c:v>
                </c:pt>
                <c:pt idx="1331">
                  <c:v>33.433849068519095</c:v>
                </c:pt>
                <c:pt idx="1332">
                  <c:v>33.023750000000035</c:v>
                </c:pt>
                <c:pt idx="1333">
                  <c:v>27.079320113314399</c:v>
                </c:pt>
                <c:pt idx="1334">
                  <c:v>32.197292069632446</c:v>
                </c:pt>
                <c:pt idx="1335">
                  <c:v>20.630724396336401</c:v>
                </c:pt>
                <c:pt idx="1336">
                  <c:v>23.415681121331588</c:v>
                </c:pt>
                <c:pt idx="1337">
                  <c:v>19.816822429906534</c:v>
                </c:pt>
                <c:pt idx="1338">
                  <c:v>26.693628386112199</c:v>
                </c:pt>
                <c:pt idx="1339">
                  <c:v>25.130351130351105</c:v>
                </c:pt>
                <c:pt idx="1340">
                  <c:v>18.730984340044717</c:v>
                </c:pt>
                <c:pt idx="1341">
                  <c:v>26.339247993240399</c:v>
                </c:pt>
                <c:pt idx="1342">
                  <c:v>23.530290456431501</c:v>
                </c:pt>
                <c:pt idx="1343">
                  <c:v>19.447704081632686</c:v>
                </c:pt>
                <c:pt idx="1344">
                  <c:v>34.093632958801535</c:v>
                </c:pt>
                <c:pt idx="1345">
                  <c:v>25.404377466810217</c:v>
                </c:pt>
                <c:pt idx="1346">
                  <c:v>30.060635226178977</c:v>
                </c:pt>
                <c:pt idx="1347">
                  <c:v>36.458789625360147</c:v>
                </c:pt>
                <c:pt idx="1348">
                  <c:v>30.383966244725674</c:v>
                </c:pt>
                <c:pt idx="1349">
                  <c:v>32.541455160744455</c:v>
                </c:pt>
                <c:pt idx="1350">
                  <c:v>33.968406961178012</c:v>
                </c:pt>
                <c:pt idx="1351">
                  <c:v>35.812882447665046</c:v>
                </c:pt>
                <c:pt idx="1352">
                  <c:v>25.982113821138164</c:v>
                </c:pt>
                <c:pt idx="1353">
                  <c:v>38.584771573604037</c:v>
                </c:pt>
                <c:pt idx="1354">
                  <c:v>19.747527632344376</c:v>
                </c:pt>
                <c:pt idx="1355">
                  <c:v>24.221526418786699</c:v>
                </c:pt>
                <c:pt idx="1356">
                  <c:v>12.7593220338983</c:v>
                </c:pt>
                <c:pt idx="1357">
                  <c:v>32.617433414043539</c:v>
                </c:pt>
                <c:pt idx="1358">
                  <c:v>37.597407274036655</c:v>
                </c:pt>
                <c:pt idx="1359">
                  <c:v>35.751866490996846</c:v>
                </c:pt>
                <c:pt idx="1360">
                  <c:v>34.525154457193295</c:v>
                </c:pt>
                <c:pt idx="1361">
                  <c:v>33.320201173512139</c:v>
                </c:pt>
                <c:pt idx="1362">
                  <c:v>38.116239316239302</c:v>
                </c:pt>
                <c:pt idx="1363">
                  <c:v>31.1904761904762</c:v>
                </c:pt>
                <c:pt idx="1364">
                  <c:v>30.027851964898939</c:v>
                </c:pt>
                <c:pt idx="1365">
                  <c:v>31.775700934579362</c:v>
                </c:pt>
                <c:pt idx="1366">
                  <c:v>31.623960578996005</c:v>
                </c:pt>
                <c:pt idx="1367">
                  <c:v>31.575364667747188</c:v>
                </c:pt>
                <c:pt idx="1368">
                  <c:v>36.141938674579613</c:v>
                </c:pt>
                <c:pt idx="1369">
                  <c:v>27.566961651917399</c:v>
                </c:pt>
                <c:pt idx="1370">
                  <c:v>23.564365971107499</c:v>
                </c:pt>
                <c:pt idx="1371">
                  <c:v>15.690432212781715</c:v>
                </c:pt>
                <c:pt idx="1372">
                  <c:v>18.829936305732499</c:v>
                </c:pt>
                <c:pt idx="1373">
                  <c:v>33.897666068222527</c:v>
                </c:pt>
                <c:pt idx="1374">
                  <c:v>24.787037037036978</c:v>
                </c:pt>
                <c:pt idx="1375">
                  <c:v>34.422899353647239</c:v>
                </c:pt>
                <c:pt idx="1376">
                  <c:v>21.281933842239177</c:v>
                </c:pt>
                <c:pt idx="1377">
                  <c:v>30.548632218844975</c:v>
                </c:pt>
                <c:pt idx="1378">
                  <c:v>31.365908076751381</c:v>
                </c:pt>
                <c:pt idx="1379">
                  <c:v>22.093333333333263</c:v>
                </c:pt>
                <c:pt idx="1380">
                  <c:v>34.557501459427847</c:v>
                </c:pt>
                <c:pt idx="1381">
                  <c:v>34.47748367136461</c:v>
                </c:pt>
                <c:pt idx="1382">
                  <c:v>31.407985028072435</c:v>
                </c:pt>
                <c:pt idx="1383">
                  <c:v>33.909121621621594</c:v>
                </c:pt>
                <c:pt idx="1384">
                  <c:v>31.473595505618</c:v>
                </c:pt>
                <c:pt idx="1385">
                  <c:v>32.477777777777796</c:v>
                </c:pt>
                <c:pt idx="1386">
                  <c:v>34.241578947368403</c:v>
                </c:pt>
                <c:pt idx="1387">
                  <c:v>26.086802480070887</c:v>
                </c:pt>
                <c:pt idx="1388">
                  <c:v>36.252307692307703</c:v>
                </c:pt>
                <c:pt idx="1389">
                  <c:v>34.928838951310901</c:v>
                </c:pt>
                <c:pt idx="1390">
                  <c:v>33.665404040404013</c:v>
                </c:pt>
                <c:pt idx="1391">
                  <c:v>22.208074534161476</c:v>
                </c:pt>
                <c:pt idx="1392">
                  <c:v>30.4271653543307</c:v>
                </c:pt>
                <c:pt idx="1393">
                  <c:v>32.455216989842995</c:v>
                </c:pt>
                <c:pt idx="1394">
                  <c:v>31.990765171503973</c:v>
                </c:pt>
                <c:pt idx="1395">
                  <c:v>27.178648068669499</c:v>
                </c:pt>
                <c:pt idx="1396">
                  <c:v>30.6908939014202</c:v>
                </c:pt>
                <c:pt idx="1397">
                  <c:v>34.240210124164335</c:v>
                </c:pt>
                <c:pt idx="1398">
                  <c:v>32.615384615384563</c:v>
                </c:pt>
                <c:pt idx="1399">
                  <c:v>29.825819672131075</c:v>
                </c:pt>
                <c:pt idx="1400">
                  <c:v>25.212887148451419</c:v>
                </c:pt>
                <c:pt idx="1401">
                  <c:v>27.760416666666689</c:v>
                </c:pt>
                <c:pt idx="1402">
                  <c:v>28.038936372269681</c:v>
                </c:pt>
                <c:pt idx="1403">
                  <c:v>29.617239300783599</c:v>
                </c:pt>
                <c:pt idx="1404">
                  <c:v>35.235881435257348</c:v>
                </c:pt>
                <c:pt idx="1405">
                  <c:v>34.341296928327594</c:v>
                </c:pt>
                <c:pt idx="1406">
                  <c:v>25.721455457967405</c:v>
                </c:pt>
                <c:pt idx="1407">
                  <c:v>31.581343697945577</c:v>
                </c:pt>
                <c:pt idx="1408">
                  <c:v>24.307996051332701</c:v>
                </c:pt>
                <c:pt idx="1409">
                  <c:v>27.2979049565662</c:v>
                </c:pt>
                <c:pt idx="1410">
                  <c:v>29.532510288065776</c:v>
                </c:pt>
                <c:pt idx="1411">
                  <c:v>31.027462121212118</c:v>
                </c:pt>
                <c:pt idx="1412">
                  <c:v>31.28125</c:v>
                </c:pt>
                <c:pt idx="1413">
                  <c:v>31.198161975875902</c:v>
                </c:pt>
                <c:pt idx="1414">
                  <c:v>33.404280618311446</c:v>
                </c:pt>
                <c:pt idx="1415">
                  <c:v>33.005920078934402</c:v>
                </c:pt>
                <c:pt idx="1416">
                  <c:v>27.013108614232198</c:v>
                </c:pt>
                <c:pt idx="1417">
                  <c:v>33.241723175109698</c:v>
                </c:pt>
                <c:pt idx="1418">
                  <c:v>33.359693877550995</c:v>
                </c:pt>
                <c:pt idx="1419">
                  <c:v>32.169853768279012</c:v>
                </c:pt>
                <c:pt idx="1420">
                  <c:v>29.246315789473702</c:v>
                </c:pt>
                <c:pt idx="1421">
                  <c:v>34.519504643962797</c:v>
                </c:pt>
                <c:pt idx="1422">
                  <c:v>31.028503562945364</c:v>
                </c:pt>
                <c:pt idx="1423">
                  <c:v>30.327345309381187</c:v>
                </c:pt>
                <c:pt idx="1424">
                  <c:v>26.741558441558418</c:v>
                </c:pt>
                <c:pt idx="1425">
                  <c:v>29.161011310711899</c:v>
                </c:pt>
                <c:pt idx="1426">
                  <c:v>32.775000000000013</c:v>
                </c:pt>
                <c:pt idx="1427">
                  <c:v>32.975714285714297</c:v>
                </c:pt>
                <c:pt idx="1428">
                  <c:v>30.894537815125975</c:v>
                </c:pt>
                <c:pt idx="1429">
                  <c:v>27.730476848652401</c:v>
                </c:pt>
                <c:pt idx="1430">
                  <c:v>28.644820295983099</c:v>
                </c:pt>
                <c:pt idx="1431">
                  <c:v>33.446348254444196</c:v>
                </c:pt>
                <c:pt idx="1432">
                  <c:v>32.381343056821564</c:v>
                </c:pt>
                <c:pt idx="1433">
                  <c:v>33.405740528128611</c:v>
                </c:pt>
                <c:pt idx="1434">
                  <c:v>32.650845253576094</c:v>
                </c:pt>
                <c:pt idx="1435">
                  <c:v>34.349175557710964</c:v>
                </c:pt>
                <c:pt idx="1436">
                  <c:v>31.317589576547189</c:v>
                </c:pt>
                <c:pt idx="1437">
                  <c:v>34.13453990405587</c:v>
                </c:pt>
                <c:pt idx="1438">
                  <c:v>31.670046801872086</c:v>
                </c:pt>
                <c:pt idx="1439">
                  <c:v>39.094339622641499</c:v>
                </c:pt>
                <c:pt idx="1440">
                  <c:v>31.419092755585599</c:v>
                </c:pt>
                <c:pt idx="1441">
                  <c:v>30.817589576547189</c:v>
                </c:pt>
                <c:pt idx="1442">
                  <c:v>35.155414012738902</c:v>
                </c:pt>
                <c:pt idx="1443">
                  <c:v>32.611986628462247</c:v>
                </c:pt>
                <c:pt idx="1444">
                  <c:v>34.008046702429837</c:v>
                </c:pt>
                <c:pt idx="1445">
                  <c:v>33.435411311054011</c:v>
                </c:pt>
                <c:pt idx="1446">
                  <c:v>32.992190273340398</c:v>
                </c:pt>
                <c:pt idx="1447">
                  <c:v>41.677889745109702</c:v>
                </c:pt>
                <c:pt idx="1448">
                  <c:v>35.077410130719002</c:v>
                </c:pt>
                <c:pt idx="1449">
                  <c:v>33.016666666666609</c:v>
                </c:pt>
                <c:pt idx="1450">
                  <c:v>35.780889621087248</c:v>
                </c:pt>
                <c:pt idx="1451">
                  <c:v>30.727272727272705</c:v>
                </c:pt>
                <c:pt idx="1452">
                  <c:v>34.9</c:v>
                </c:pt>
                <c:pt idx="1453">
                  <c:v>34.804315476190496</c:v>
                </c:pt>
                <c:pt idx="1454">
                  <c:v>33.282372598162112</c:v>
                </c:pt>
                <c:pt idx="1455">
                  <c:v>34.804154302670597</c:v>
                </c:pt>
                <c:pt idx="1456">
                  <c:v>36.848694316436294</c:v>
                </c:pt>
                <c:pt idx="1457">
                  <c:v>36.005698005697994</c:v>
                </c:pt>
                <c:pt idx="1458">
                  <c:v>34.636886886886899</c:v>
                </c:pt>
                <c:pt idx="1459">
                  <c:v>34.712440516655299</c:v>
                </c:pt>
                <c:pt idx="1460">
                  <c:v>33.692495768290399</c:v>
                </c:pt>
                <c:pt idx="1461">
                  <c:v>32.160473285265297</c:v>
                </c:pt>
                <c:pt idx="1462">
                  <c:v>33.542910447761201</c:v>
                </c:pt>
                <c:pt idx="1463">
                  <c:v>34.650975718754736</c:v>
                </c:pt>
                <c:pt idx="1464">
                  <c:v>33.42794036443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1978872"/>
        <c:axId val="221980832"/>
      </c:barChart>
      <c:catAx>
        <c:axId val="221978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10k bin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221980832"/>
        <c:crosses val="autoZero"/>
        <c:auto val="1"/>
        <c:lblAlgn val="ctr"/>
        <c:lblOffset val="100"/>
        <c:noMultiLvlLbl val="0"/>
      </c:catAx>
      <c:valAx>
        <c:axId val="2219808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219788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h225 depth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Sheet3!$C$2:$C$1466</c:f>
              <c:numCache>
                <c:formatCode>General</c:formatCode>
                <c:ptCount val="1465"/>
                <c:pt idx="0">
                  <c:v>23.640552995391687</c:v>
                </c:pt>
                <c:pt idx="1">
                  <c:v>22.155363748458718</c:v>
                </c:pt>
                <c:pt idx="2">
                  <c:v>21.8180878552972</c:v>
                </c:pt>
                <c:pt idx="3">
                  <c:v>20.387499999999989</c:v>
                </c:pt>
                <c:pt idx="4">
                  <c:v>20.632010943912405</c:v>
                </c:pt>
                <c:pt idx="5">
                  <c:v>23.945849449568573</c:v>
                </c:pt>
                <c:pt idx="6">
                  <c:v>23.883922134102377</c:v>
                </c:pt>
                <c:pt idx="7">
                  <c:v>20.330170777988616</c:v>
                </c:pt>
                <c:pt idx="8">
                  <c:v>21.727954302034998</c:v>
                </c:pt>
                <c:pt idx="9">
                  <c:v>20.678517625790899</c:v>
                </c:pt>
                <c:pt idx="10">
                  <c:v>20.914190573770487</c:v>
                </c:pt>
                <c:pt idx="11">
                  <c:v>20.926948890036087</c:v>
                </c:pt>
                <c:pt idx="12">
                  <c:v>19.473317865429173</c:v>
                </c:pt>
                <c:pt idx="13">
                  <c:v>22.013100436681199</c:v>
                </c:pt>
                <c:pt idx="14">
                  <c:v>24.646478595383702</c:v>
                </c:pt>
                <c:pt idx="15">
                  <c:v>23.6761942051684</c:v>
                </c:pt>
                <c:pt idx="16">
                  <c:v>21.909053999188</c:v>
                </c:pt>
                <c:pt idx="17">
                  <c:v>22.999412110523163</c:v>
                </c:pt>
                <c:pt idx="18">
                  <c:v>20.254562470753378</c:v>
                </c:pt>
                <c:pt idx="19">
                  <c:v>19.887961029923517</c:v>
                </c:pt>
                <c:pt idx="20">
                  <c:v>20.788187372708776</c:v>
                </c:pt>
                <c:pt idx="21">
                  <c:v>19.473871131405399</c:v>
                </c:pt>
                <c:pt idx="22">
                  <c:v>33.387348969438463</c:v>
                </c:pt>
                <c:pt idx="23">
                  <c:v>22.9940380646641</c:v>
                </c:pt>
                <c:pt idx="24">
                  <c:v>22.6286149162861</c:v>
                </c:pt>
                <c:pt idx="25">
                  <c:v>21.004694835680802</c:v>
                </c:pt>
                <c:pt idx="26">
                  <c:v>19.472794506074976</c:v>
                </c:pt>
                <c:pt idx="27">
                  <c:v>25.439306358381486</c:v>
                </c:pt>
                <c:pt idx="28">
                  <c:v>21.318345914013801</c:v>
                </c:pt>
                <c:pt idx="29">
                  <c:v>22.268217054263577</c:v>
                </c:pt>
                <c:pt idx="30">
                  <c:v>18.850588812561273</c:v>
                </c:pt>
                <c:pt idx="31">
                  <c:v>21.572549019607774</c:v>
                </c:pt>
                <c:pt idx="32">
                  <c:v>19.399350649350598</c:v>
                </c:pt>
                <c:pt idx="33">
                  <c:v>20.108177484415101</c:v>
                </c:pt>
                <c:pt idx="34">
                  <c:v>20.537027171017598</c:v>
                </c:pt>
                <c:pt idx="35">
                  <c:v>20.707786116322687</c:v>
                </c:pt>
                <c:pt idx="36">
                  <c:v>21.533817951959517</c:v>
                </c:pt>
                <c:pt idx="37">
                  <c:v>21.077538769384716</c:v>
                </c:pt>
                <c:pt idx="38">
                  <c:v>15.627012522361399</c:v>
                </c:pt>
                <c:pt idx="39">
                  <c:v>21.273381294963976</c:v>
                </c:pt>
                <c:pt idx="40">
                  <c:v>24.870790378006902</c:v>
                </c:pt>
                <c:pt idx="41">
                  <c:v>13.098265895953798</c:v>
                </c:pt>
                <c:pt idx="42">
                  <c:v>21.5</c:v>
                </c:pt>
                <c:pt idx="43">
                  <c:v>22.694708994709</c:v>
                </c:pt>
                <c:pt idx="44">
                  <c:v>20.043478260869588</c:v>
                </c:pt>
                <c:pt idx="45">
                  <c:v>21.091969800960889</c:v>
                </c:pt>
                <c:pt idx="46">
                  <c:v>20.604775369148634</c:v>
                </c:pt>
                <c:pt idx="47">
                  <c:v>21.505823627287899</c:v>
                </c:pt>
                <c:pt idx="48">
                  <c:v>20.611775121735317</c:v>
                </c:pt>
                <c:pt idx="49">
                  <c:v>17.370370370370377</c:v>
                </c:pt>
                <c:pt idx="50">
                  <c:v>20.994632313472874</c:v>
                </c:pt>
                <c:pt idx="51">
                  <c:v>19.542572463768089</c:v>
                </c:pt>
                <c:pt idx="52">
                  <c:v>24.083845208845187</c:v>
                </c:pt>
                <c:pt idx="53">
                  <c:v>22.484221980413487</c:v>
                </c:pt>
                <c:pt idx="54">
                  <c:v>20.223935389133587</c:v>
                </c:pt>
                <c:pt idx="55">
                  <c:v>22.372839506172777</c:v>
                </c:pt>
                <c:pt idx="56">
                  <c:v>22.781621621621589</c:v>
                </c:pt>
                <c:pt idx="57">
                  <c:v>19.640650406504101</c:v>
                </c:pt>
                <c:pt idx="58">
                  <c:v>24.915978630403099</c:v>
                </c:pt>
                <c:pt idx="59">
                  <c:v>20.871699669966986</c:v>
                </c:pt>
                <c:pt idx="60">
                  <c:v>21.384236453202</c:v>
                </c:pt>
                <c:pt idx="61">
                  <c:v>20.584804297774401</c:v>
                </c:pt>
                <c:pt idx="62">
                  <c:v>19.692569483834401</c:v>
                </c:pt>
                <c:pt idx="63">
                  <c:v>19.485978330146587</c:v>
                </c:pt>
                <c:pt idx="64">
                  <c:v>23.759897828863288</c:v>
                </c:pt>
                <c:pt idx="65">
                  <c:v>20.711385350318526</c:v>
                </c:pt>
                <c:pt idx="66">
                  <c:v>20.188338926174499</c:v>
                </c:pt>
                <c:pt idx="67">
                  <c:v>19.121066271751189</c:v>
                </c:pt>
                <c:pt idx="68">
                  <c:v>13.6427915518825</c:v>
                </c:pt>
                <c:pt idx="69">
                  <c:v>18.185714285714276</c:v>
                </c:pt>
                <c:pt idx="70">
                  <c:v>23.402328589909359</c:v>
                </c:pt>
                <c:pt idx="71">
                  <c:v>22.143916913946601</c:v>
                </c:pt>
                <c:pt idx="72">
                  <c:v>21.876558603491301</c:v>
                </c:pt>
                <c:pt idx="73">
                  <c:v>22.106350806451601</c:v>
                </c:pt>
                <c:pt idx="74">
                  <c:v>23.417632241813589</c:v>
                </c:pt>
                <c:pt idx="75">
                  <c:v>21.237762237762176</c:v>
                </c:pt>
                <c:pt idx="76">
                  <c:v>30.415730337078681</c:v>
                </c:pt>
                <c:pt idx="77">
                  <c:v>22.681049562682187</c:v>
                </c:pt>
                <c:pt idx="78">
                  <c:v>21.0490318550906</c:v>
                </c:pt>
                <c:pt idx="79">
                  <c:v>21.873603351955289</c:v>
                </c:pt>
                <c:pt idx="80">
                  <c:v>14.962099125364409</c:v>
                </c:pt>
                <c:pt idx="81">
                  <c:v>22.702060221869989</c:v>
                </c:pt>
                <c:pt idx="82">
                  <c:v>19.714414821509287</c:v>
                </c:pt>
                <c:pt idx="83">
                  <c:v>19.293407613741874</c:v>
                </c:pt>
                <c:pt idx="84">
                  <c:v>16.769992922859199</c:v>
                </c:pt>
                <c:pt idx="85">
                  <c:v>21.199851961510031</c:v>
                </c:pt>
                <c:pt idx="86">
                  <c:v>22.8250569476082</c:v>
                </c:pt>
                <c:pt idx="87">
                  <c:v>21.078947368421087</c:v>
                </c:pt>
                <c:pt idx="88">
                  <c:v>18.705882352941178</c:v>
                </c:pt>
                <c:pt idx="89">
                  <c:v>19.8640595903166</c:v>
                </c:pt>
                <c:pt idx="90">
                  <c:v>24.065710872162459</c:v>
                </c:pt>
                <c:pt idx="91">
                  <c:v>21.132783195799</c:v>
                </c:pt>
                <c:pt idx="92">
                  <c:v>22.684615384615405</c:v>
                </c:pt>
                <c:pt idx="93">
                  <c:v>23.6380952380952</c:v>
                </c:pt>
                <c:pt idx="94">
                  <c:v>18.912280701754401</c:v>
                </c:pt>
                <c:pt idx="95">
                  <c:v>22.520629750271379</c:v>
                </c:pt>
                <c:pt idx="96">
                  <c:v>18.953385127636018</c:v>
                </c:pt>
                <c:pt idx="97">
                  <c:v>16.863675582398599</c:v>
                </c:pt>
                <c:pt idx="98">
                  <c:v>15.552988293284015</c:v>
                </c:pt>
                <c:pt idx="99">
                  <c:v>16.462264150943376</c:v>
                </c:pt>
                <c:pt idx="100">
                  <c:v>19.118403247631889</c:v>
                </c:pt>
                <c:pt idx="101">
                  <c:v>19.992076069730587</c:v>
                </c:pt>
                <c:pt idx="102">
                  <c:v>22.099259259259288</c:v>
                </c:pt>
                <c:pt idx="103">
                  <c:v>24.474964234620899</c:v>
                </c:pt>
                <c:pt idx="104">
                  <c:v>21.777210884353689</c:v>
                </c:pt>
                <c:pt idx="105">
                  <c:v>23.812633832976363</c:v>
                </c:pt>
                <c:pt idx="106">
                  <c:v>22.651856017997826</c:v>
                </c:pt>
                <c:pt idx="107">
                  <c:v>22.833707865168499</c:v>
                </c:pt>
                <c:pt idx="108">
                  <c:v>23.080946450809499</c:v>
                </c:pt>
                <c:pt idx="109">
                  <c:v>18.770039421813401</c:v>
                </c:pt>
                <c:pt idx="110">
                  <c:v>21.366875000000018</c:v>
                </c:pt>
                <c:pt idx="111">
                  <c:v>20.535045107564187</c:v>
                </c:pt>
                <c:pt idx="112">
                  <c:v>18.342797055730777</c:v>
                </c:pt>
                <c:pt idx="113">
                  <c:v>18.834427767354626</c:v>
                </c:pt>
                <c:pt idx="114">
                  <c:v>19.772841575859189</c:v>
                </c:pt>
                <c:pt idx="115">
                  <c:v>19.796423658872087</c:v>
                </c:pt>
                <c:pt idx="116">
                  <c:v>16.861878453038734</c:v>
                </c:pt>
                <c:pt idx="117">
                  <c:v>18.806913996627287</c:v>
                </c:pt>
                <c:pt idx="118">
                  <c:v>20.467697907188374</c:v>
                </c:pt>
                <c:pt idx="119">
                  <c:v>25.4444444444444</c:v>
                </c:pt>
                <c:pt idx="120">
                  <c:v>24.984598459846001</c:v>
                </c:pt>
                <c:pt idx="121">
                  <c:v>22.0636182902585</c:v>
                </c:pt>
                <c:pt idx="122">
                  <c:v>22.376747608535677</c:v>
                </c:pt>
                <c:pt idx="123">
                  <c:v>25.318493150684901</c:v>
                </c:pt>
                <c:pt idx="124">
                  <c:v>28.017456359102201</c:v>
                </c:pt>
                <c:pt idx="125">
                  <c:v>21.159468438538205</c:v>
                </c:pt>
                <c:pt idx="126">
                  <c:v>22.2445887445887</c:v>
                </c:pt>
                <c:pt idx="127">
                  <c:v>16.526898734177188</c:v>
                </c:pt>
                <c:pt idx="128">
                  <c:v>18.6320346320346</c:v>
                </c:pt>
                <c:pt idx="129">
                  <c:v>12.139999999999999</c:v>
                </c:pt>
                <c:pt idx="130">
                  <c:v>18.097159940209288</c:v>
                </c:pt>
                <c:pt idx="131">
                  <c:v>17.645604395604401</c:v>
                </c:pt>
                <c:pt idx="132">
                  <c:v>12.687954729183501</c:v>
                </c:pt>
                <c:pt idx="133">
                  <c:v>20.9808219178082</c:v>
                </c:pt>
                <c:pt idx="134">
                  <c:v>15.182825484764498</c:v>
                </c:pt>
                <c:pt idx="135">
                  <c:v>19.984384759525277</c:v>
                </c:pt>
                <c:pt idx="136">
                  <c:v>20.387527839643678</c:v>
                </c:pt>
                <c:pt idx="137">
                  <c:v>20.214994487320801</c:v>
                </c:pt>
                <c:pt idx="138">
                  <c:v>24.077322936972077</c:v>
                </c:pt>
                <c:pt idx="139">
                  <c:v>23.3382151029748</c:v>
                </c:pt>
                <c:pt idx="140">
                  <c:v>21.282456140350877</c:v>
                </c:pt>
                <c:pt idx="141">
                  <c:v>22.5560046189376</c:v>
                </c:pt>
                <c:pt idx="142">
                  <c:v>22.351604278074888</c:v>
                </c:pt>
                <c:pt idx="143">
                  <c:v>18.404293381037586</c:v>
                </c:pt>
                <c:pt idx="144">
                  <c:v>19.056603773584889</c:v>
                </c:pt>
                <c:pt idx="145">
                  <c:v>21.139569413511516</c:v>
                </c:pt>
                <c:pt idx="146">
                  <c:v>17.027900146842917</c:v>
                </c:pt>
                <c:pt idx="147">
                  <c:v>20.736842105263189</c:v>
                </c:pt>
                <c:pt idx="148">
                  <c:v>18.910041841004187</c:v>
                </c:pt>
                <c:pt idx="149">
                  <c:v>19.805194805194802</c:v>
                </c:pt>
                <c:pt idx="150">
                  <c:v>22.634754098360698</c:v>
                </c:pt>
                <c:pt idx="151">
                  <c:v>24.375670840787077</c:v>
                </c:pt>
                <c:pt idx="152">
                  <c:v>22.359415305245101</c:v>
                </c:pt>
                <c:pt idx="153">
                  <c:v>19.052358286456101</c:v>
                </c:pt>
                <c:pt idx="154">
                  <c:v>19.784839650145774</c:v>
                </c:pt>
                <c:pt idx="155">
                  <c:v>17.679638637942986</c:v>
                </c:pt>
                <c:pt idx="156">
                  <c:v>20.4718779790276</c:v>
                </c:pt>
                <c:pt idx="157">
                  <c:v>19.923961096374899</c:v>
                </c:pt>
                <c:pt idx="158">
                  <c:v>23.132953957578898</c:v>
                </c:pt>
                <c:pt idx="159">
                  <c:v>20.6450671336836</c:v>
                </c:pt>
                <c:pt idx="160">
                  <c:v>17.425039452919489</c:v>
                </c:pt>
                <c:pt idx="161">
                  <c:v>21.050641025640999</c:v>
                </c:pt>
                <c:pt idx="162">
                  <c:v>21.475257731958799</c:v>
                </c:pt>
                <c:pt idx="163">
                  <c:v>18.221182266009887</c:v>
                </c:pt>
                <c:pt idx="164">
                  <c:v>21.221098265896018</c:v>
                </c:pt>
                <c:pt idx="165">
                  <c:v>22.38</c:v>
                </c:pt>
                <c:pt idx="166">
                  <c:v>20.850743494423789</c:v>
                </c:pt>
                <c:pt idx="167">
                  <c:v>21.965277777777775</c:v>
                </c:pt>
                <c:pt idx="168">
                  <c:v>18.448414695520864</c:v>
                </c:pt>
                <c:pt idx="169">
                  <c:v>19.610874704491735</c:v>
                </c:pt>
                <c:pt idx="170">
                  <c:v>19.481904761904801</c:v>
                </c:pt>
                <c:pt idx="171">
                  <c:v>20.758873456790116</c:v>
                </c:pt>
                <c:pt idx="172">
                  <c:v>20.407125890736289</c:v>
                </c:pt>
                <c:pt idx="173">
                  <c:v>24.420779220779163</c:v>
                </c:pt>
                <c:pt idx="174">
                  <c:v>21.607142857142886</c:v>
                </c:pt>
                <c:pt idx="175">
                  <c:v>23.080700048614499</c:v>
                </c:pt>
                <c:pt idx="176">
                  <c:v>22.812109862671686</c:v>
                </c:pt>
                <c:pt idx="177">
                  <c:v>18.986553784860586</c:v>
                </c:pt>
                <c:pt idx="178">
                  <c:v>23.034794711203901</c:v>
                </c:pt>
                <c:pt idx="179">
                  <c:v>22.594637223974789</c:v>
                </c:pt>
                <c:pt idx="180">
                  <c:v>21.559905660377417</c:v>
                </c:pt>
                <c:pt idx="181">
                  <c:v>21.730681818181786</c:v>
                </c:pt>
                <c:pt idx="182">
                  <c:v>16.582882882882878</c:v>
                </c:pt>
                <c:pt idx="183">
                  <c:v>22.081736909323062</c:v>
                </c:pt>
                <c:pt idx="184">
                  <c:v>23.145985401459917</c:v>
                </c:pt>
                <c:pt idx="185">
                  <c:v>20.084931506849287</c:v>
                </c:pt>
                <c:pt idx="186">
                  <c:v>20.1706349206349</c:v>
                </c:pt>
                <c:pt idx="187">
                  <c:v>21.015810276679787</c:v>
                </c:pt>
                <c:pt idx="188">
                  <c:v>15.949704142011798</c:v>
                </c:pt>
                <c:pt idx="189">
                  <c:v>19.139072847682101</c:v>
                </c:pt>
                <c:pt idx="190">
                  <c:v>21.156496062992101</c:v>
                </c:pt>
                <c:pt idx="191">
                  <c:v>23.098066298342488</c:v>
                </c:pt>
                <c:pt idx="192">
                  <c:v>20.190789473684202</c:v>
                </c:pt>
                <c:pt idx="193">
                  <c:v>20.753112033194977</c:v>
                </c:pt>
                <c:pt idx="194">
                  <c:v>14.316109422492399</c:v>
                </c:pt>
                <c:pt idx="195">
                  <c:v>19.292176039119777</c:v>
                </c:pt>
                <c:pt idx="196">
                  <c:v>23.558410414525486</c:v>
                </c:pt>
                <c:pt idx="197">
                  <c:v>20.990811026767886</c:v>
                </c:pt>
                <c:pt idx="198">
                  <c:v>21.444020356234088</c:v>
                </c:pt>
                <c:pt idx="199">
                  <c:v>20.297087980173487</c:v>
                </c:pt>
                <c:pt idx="200">
                  <c:v>22.354354354354431</c:v>
                </c:pt>
                <c:pt idx="201">
                  <c:v>21.355628058727589</c:v>
                </c:pt>
                <c:pt idx="202">
                  <c:v>21.320550639134687</c:v>
                </c:pt>
                <c:pt idx="203">
                  <c:v>22.119324796274718</c:v>
                </c:pt>
                <c:pt idx="204">
                  <c:v>23.846153846153786</c:v>
                </c:pt>
                <c:pt idx="205">
                  <c:v>24.049469964664286</c:v>
                </c:pt>
                <c:pt idx="206">
                  <c:v>18.460097719869687</c:v>
                </c:pt>
                <c:pt idx="207">
                  <c:v>20.242286751361164</c:v>
                </c:pt>
                <c:pt idx="208">
                  <c:v>16.559300873907581</c:v>
                </c:pt>
                <c:pt idx="209">
                  <c:v>19.974683544303776</c:v>
                </c:pt>
                <c:pt idx="210">
                  <c:v>20.840304182509499</c:v>
                </c:pt>
                <c:pt idx="211">
                  <c:v>18.295862068965487</c:v>
                </c:pt>
                <c:pt idx="212">
                  <c:v>18.909046927914886</c:v>
                </c:pt>
                <c:pt idx="213">
                  <c:v>23.925611052072274</c:v>
                </c:pt>
                <c:pt idx="214">
                  <c:v>23.535702641017274</c:v>
                </c:pt>
                <c:pt idx="215">
                  <c:v>23.279263220439699</c:v>
                </c:pt>
                <c:pt idx="216">
                  <c:v>24.283263792304087</c:v>
                </c:pt>
                <c:pt idx="217">
                  <c:v>23.190393013100401</c:v>
                </c:pt>
                <c:pt idx="218">
                  <c:v>23.139452780229501</c:v>
                </c:pt>
                <c:pt idx="219">
                  <c:v>24.381465517241399</c:v>
                </c:pt>
                <c:pt idx="220">
                  <c:v>17.319829424307017</c:v>
                </c:pt>
                <c:pt idx="221">
                  <c:v>21.2408906882591</c:v>
                </c:pt>
                <c:pt idx="222">
                  <c:v>21.748175684978687</c:v>
                </c:pt>
                <c:pt idx="223">
                  <c:v>21.047965402005119</c:v>
                </c:pt>
                <c:pt idx="224">
                  <c:v>19.991498664075799</c:v>
                </c:pt>
                <c:pt idx="225">
                  <c:v>21.194929343308399</c:v>
                </c:pt>
                <c:pt idx="226">
                  <c:v>25.715014887281978</c:v>
                </c:pt>
                <c:pt idx="227">
                  <c:v>24.496402877697776</c:v>
                </c:pt>
                <c:pt idx="228">
                  <c:v>24.894539614560976</c:v>
                </c:pt>
                <c:pt idx="229">
                  <c:v>22.510651629072719</c:v>
                </c:pt>
                <c:pt idx="230">
                  <c:v>19.522434244455876</c:v>
                </c:pt>
                <c:pt idx="231">
                  <c:v>15.364363636363599</c:v>
                </c:pt>
                <c:pt idx="232">
                  <c:v>20.341645885286788</c:v>
                </c:pt>
                <c:pt idx="233">
                  <c:v>20.236042402826889</c:v>
                </c:pt>
                <c:pt idx="234">
                  <c:v>21.021369596891699</c:v>
                </c:pt>
                <c:pt idx="235">
                  <c:v>21.076588021778601</c:v>
                </c:pt>
                <c:pt idx="236">
                  <c:v>24.506024096385499</c:v>
                </c:pt>
                <c:pt idx="237">
                  <c:v>22.017579721995101</c:v>
                </c:pt>
                <c:pt idx="238">
                  <c:v>15.081896551724109</c:v>
                </c:pt>
                <c:pt idx="239">
                  <c:v>20.289900575614887</c:v>
                </c:pt>
                <c:pt idx="240">
                  <c:v>18.400611620795086</c:v>
                </c:pt>
                <c:pt idx="241">
                  <c:v>19.681981622053534</c:v>
                </c:pt>
                <c:pt idx="242">
                  <c:v>20.086901763224201</c:v>
                </c:pt>
                <c:pt idx="243">
                  <c:v>21.0375234521576</c:v>
                </c:pt>
                <c:pt idx="244">
                  <c:v>22.3196480938416</c:v>
                </c:pt>
                <c:pt idx="245">
                  <c:v>21.555849655902588</c:v>
                </c:pt>
                <c:pt idx="246">
                  <c:v>24.3159639981052</c:v>
                </c:pt>
                <c:pt idx="247">
                  <c:v>23.193625498008018</c:v>
                </c:pt>
                <c:pt idx="248">
                  <c:v>21.786693753174177</c:v>
                </c:pt>
                <c:pt idx="249">
                  <c:v>21.836027713625899</c:v>
                </c:pt>
                <c:pt idx="250">
                  <c:v>23.442786069651689</c:v>
                </c:pt>
                <c:pt idx="251">
                  <c:v>21.439722863741263</c:v>
                </c:pt>
                <c:pt idx="252">
                  <c:v>21.489417127971276</c:v>
                </c:pt>
                <c:pt idx="253">
                  <c:v>20.357587894971086</c:v>
                </c:pt>
                <c:pt idx="254">
                  <c:v>20.139984532095905</c:v>
                </c:pt>
                <c:pt idx="255">
                  <c:v>22.843071786310517</c:v>
                </c:pt>
                <c:pt idx="256">
                  <c:v>25.450450450450518</c:v>
                </c:pt>
                <c:pt idx="257">
                  <c:v>20.639892904953101</c:v>
                </c:pt>
                <c:pt idx="258">
                  <c:v>22.934956257132001</c:v>
                </c:pt>
                <c:pt idx="259">
                  <c:v>21.096984515077388</c:v>
                </c:pt>
                <c:pt idx="260">
                  <c:v>24.143097643097601</c:v>
                </c:pt>
                <c:pt idx="261">
                  <c:v>24.196870925684539</c:v>
                </c:pt>
                <c:pt idx="262">
                  <c:v>20.741235392320487</c:v>
                </c:pt>
                <c:pt idx="263">
                  <c:v>18.4794520547945</c:v>
                </c:pt>
                <c:pt idx="264">
                  <c:v>21.192438692098101</c:v>
                </c:pt>
                <c:pt idx="265">
                  <c:v>21.388625592417089</c:v>
                </c:pt>
                <c:pt idx="266">
                  <c:v>22.392244593586877</c:v>
                </c:pt>
                <c:pt idx="267">
                  <c:v>21.62842039801</c:v>
                </c:pt>
                <c:pt idx="268">
                  <c:v>22.303431169904901</c:v>
                </c:pt>
                <c:pt idx="269">
                  <c:v>23.930728956906989</c:v>
                </c:pt>
                <c:pt idx="270">
                  <c:v>21.940921228304401</c:v>
                </c:pt>
                <c:pt idx="271">
                  <c:v>23.590872698158517</c:v>
                </c:pt>
                <c:pt idx="272">
                  <c:v>22.928653295128871</c:v>
                </c:pt>
                <c:pt idx="273">
                  <c:v>20.236470588235289</c:v>
                </c:pt>
                <c:pt idx="274">
                  <c:v>22.989445910290186</c:v>
                </c:pt>
                <c:pt idx="275">
                  <c:v>26.331471135940419</c:v>
                </c:pt>
                <c:pt idx="276">
                  <c:v>21.683701657458617</c:v>
                </c:pt>
                <c:pt idx="277">
                  <c:v>15.839409722222209</c:v>
                </c:pt>
                <c:pt idx="278">
                  <c:v>20.708371385083687</c:v>
                </c:pt>
                <c:pt idx="279">
                  <c:v>21.0063948840927</c:v>
                </c:pt>
                <c:pt idx="280">
                  <c:v>21.246089189820189</c:v>
                </c:pt>
                <c:pt idx="281">
                  <c:v>21.066999706141587</c:v>
                </c:pt>
                <c:pt idx="282">
                  <c:v>20.666402849228277</c:v>
                </c:pt>
                <c:pt idx="283">
                  <c:v>20.677069199457318</c:v>
                </c:pt>
                <c:pt idx="284">
                  <c:v>17.792099792099787</c:v>
                </c:pt>
                <c:pt idx="285">
                  <c:v>21.551001821493617</c:v>
                </c:pt>
                <c:pt idx="286">
                  <c:v>21.41633333333326</c:v>
                </c:pt>
                <c:pt idx="287">
                  <c:v>20.632044198895017</c:v>
                </c:pt>
                <c:pt idx="288">
                  <c:v>18.735767569689799</c:v>
                </c:pt>
                <c:pt idx="289">
                  <c:v>18.686581782566087</c:v>
                </c:pt>
                <c:pt idx="290">
                  <c:v>20.999236932468477</c:v>
                </c:pt>
                <c:pt idx="291">
                  <c:v>19.756605284227376</c:v>
                </c:pt>
                <c:pt idx="292">
                  <c:v>20.940860215053799</c:v>
                </c:pt>
                <c:pt idx="293">
                  <c:v>26.787015043547086</c:v>
                </c:pt>
                <c:pt idx="294">
                  <c:v>19.998330550918176</c:v>
                </c:pt>
                <c:pt idx="295">
                  <c:v>21.461956521739086</c:v>
                </c:pt>
                <c:pt idx="296">
                  <c:v>18.417721518987289</c:v>
                </c:pt>
                <c:pt idx="297">
                  <c:v>18.568493150684887</c:v>
                </c:pt>
                <c:pt idx="298">
                  <c:v>20.764132553606181</c:v>
                </c:pt>
                <c:pt idx="299">
                  <c:v>20.872072072072086</c:v>
                </c:pt>
                <c:pt idx="300">
                  <c:v>21.199095022624434</c:v>
                </c:pt>
                <c:pt idx="301">
                  <c:v>23.726646248085764</c:v>
                </c:pt>
                <c:pt idx="302">
                  <c:v>22.301550160865801</c:v>
                </c:pt>
                <c:pt idx="303">
                  <c:v>25.254148885727776</c:v>
                </c:pt>
                <c:pt idx="304">
                  <c:v>22.023747328425589</c:v>
                </c:pt>
                <c:pt idx="305">
                  <c:v>19.240091116173087</c:v>
                </c:pt>
                <c:pt idx="306">
                  <c:v>19.882656826568276</c:v>
                </c:pt>
                <c:pt idx="307">
                  <c:v>20.9449356913183</c:v>
                </c:pt>
                <c:pt idx="308">
                  <c:v>20.273596176821979</c:v>
                </c:pt>
                <c:pt idx="309">
                  <c:v>20.358351409978301</c:v>
                </c:pt>
                <c:pt idx="310">
                  <c:v>20.7767727930535</c:v>
                </c:pt>
                <c:pt idx="311">
                  <c:v>20.659763313609517</c:v>
                </c:pt>
                <c:pt idx="312">
                  <c:v>23.767968307866418</c:v>
                </c:pt>
                <c:pt idx="313">
                  <c:v>25.516720604099199</c:v>
                </c:pt>
                <c:pt idx="314">
                  <c:v>22.629974811083098</c:v>
                </c:pt>
                <c:pt idx="315">
                  <c:v>20.631406044678101</c:v>
                </c:pt>
                <c:pt idx="316">
                  <c:v>25.642710472279276</c:v>
                </c:pt>
                <c:pt idx="317">
                  <c:v>23.201114488348505</c:v>
                </c:pt>
                <c:pt idx="318">
                  <c:v>24.124354763022126</c:v>
                </c:pt>
                <c:pt idx="319">
                  <c:v>17.592592592592577</c:v>
                </c:pt>
                <c:pt idx="320">
                  <c:v>17.696969696969699</c:v>
                </c:pt>
                <c:pt idx="321">
                  <c:v>20.493749999999959</c:v>
                </c:pt>
                <c:pt idx="322">
                  <c:v>23.598671355998388</c:v>
                </c:pt>
                <c:pt idx="323">
                  <c:v>23.771106449921277</c:v>
                </c:pt>
                <c:pt idx="324">
                  <c:v>22.052872860635699</c:v>
                </c:pt>
                <c:pt idx="325">
                  <c:v>22.959515366430299</c:v>
                </c:pt>
                <c:pt idx="326">
                  <c:v>22.680827277808799</c:v>
                </c:pt>
                <c:pt idx="327">
                  <c:v>22.0901821412705</c:v>
                </c:pt>
                <c:pt idx="328">
                  <c:v>22.678217821782187</c:v>
                </c:pt>
                <c:pt idx="329">
                  <c:v>19.674835061263018</c:v>
                </c:pt>
                <c:pt idx="330">
                  <c:v>22.717528373266099</c:v>
                </c:pt>
                <c:pt idx="331">
                  <c:v>23.217625231910887</c:v>
                </c:pt>
                <c:pt idx="332">
                  <c:v>19.418621700879786</c:v>
                </c:pt>
                <c:pt idx="333">
                  <c:v>23.072443181818187</c:v>
                </c:pt>
                <c:pt idx="334">
                  <c:v>20.252967359050398</c:v>
                </c:pt>
                <c:pt idx="335">
                  <c:v>22.163602251407077</c:v>
                </c:pt>
                <c:pt idx="336">
                  <c:v>20.240502147340589</c:v>
                </c:pt>
                <c:pt idx="337">
                  <c:v>23.757693302301487</c:v>
                </c:pt>
                <c:pt idx="338">
                  <c:v>24.204707560627689</c:v>
                </c:pt>
                <c:pt idx="339">
                  <c:v>18.159040426477105</c:v>
                </c:pt>
                <c:pt idx="340">
                  <c:v>22.724660194174799</c:v>
                </c:pt>
                <c:pt idx="341">
                  <c:v>20.651268115942031</c:v>
                </c:pt>
                <c:pt idx="342">
                  <c:v>21.318138950015701</c:v>
                </c:pt>
                <c:pt idx="343">
                  <c:v>21.605971249539287</c:v>
                </c:pt>
                <c:pt idx="344">
                  <c:v>23.251069900142699</c:v>
                </c:pt>
                <c:pt idx="345">
                  <c:v>24.314110965487117</c:v>
                </c:pt>
                <c:pt idx="346">
                  <c:v>22.250516528925576</c:v>
                </c:pt>
                <c:pt idx="347">
                  <c:v>21.359375000000018</c:v>
                </c:pt>
                <c:pt idx="348">
                  <c:v>19.419201995012518</c:v>
                </c:pt>
                <c:pt idx="349">
                  <c:v>22.206403013182687</c:v>
                </c:pt>
                <c:pt idx="350">
                  <c:v>23.325203252032502</c:v>
                </c:pt>
                <c:pt idx="351">
                  <c:v>23.380437794402887</c:v>
                </c:pt>
                <c:pt idx="352">
                  <c:v>23.3298722044728</c:v>
                </c:pt>
                <c:pt idx="353">
                  <c:v>21.044361428905017</c:v>
                </c:pt>
                <c:pt idx="354">
                  <c:v>23.152212389380502</c:v>
                </c:pt>
                <c:pt idx="355">
                  <c:v>28.920922570016486</c:v>
                </c:pt>
                <c:pt idx="356">
                  <c:v>21.491907514450901</c:v>
                </c:pt>
                <c:pt idx="357">
                  <c:v>22.955241694847789</c:v>
                </c:pt>
                <c:pt idx="358">
                  <c:v>22.309594460929802</c:v>
                </c:pt>
                <c:pt idx="359">
                  <c:v>23.365591397849499</c:v>
                </c:pt>
                <c:pt idx="360">
                  <c:v>23.986592178770859</c:v>
                </c:pt>
                <c:pt idx="361">
                  <c:v>21.702944015444</c:v>
                </c:pt>
                <c:pt idx="362">
                  <c:v>21.629757785467099</c:v>
                </c:pt>
                <c:pt idx="363">
                  <c:v>24.2659783677483</c:v>
                </c:pt>
                <c:pt idx="364">
                  <c:v>25.312267657992617</c:v>
                </c:pt>
                <c:pt idx="365">
                  <c:v>25.385928489042701</c:v>
                </c:pt>
                <c:pt idx="366">
                  <c:v>20.688197298884287</c:v>
                </c:pt>
                <c:pt idx="367">
                  <c:v>22.963153826333379</c:v>
                </c:pt>
                <c:pt idx="368">
                  <c:v>22.868236791852286</c:v>
                </c:pt>
                <c:pt idx="369">
                  <c:v>22.587330873308677</c:v>
                </c:pt>
                <c:pt idx="370">
                  <c:v>22.0781696854147</c:v>
                </c:pt>
                <c:pt idx="371">
                  <c:v>22.447876447876418</c:v>
                </c:pt>
                <c:pt idx="372">
                  <c:v>21.870039682539677</c:v>
                </c:pt>
                <c:pt idx="373">
                  <c:v>20.608886107634518</c:v>
                </c:pt>
                <c:pt idx="374">
                  <c:v>23.847830515379886</c:v>
                </c:pt>
                <c:pt idx="375">
                  <c:v>24.830545296545687</c:v>
                </c:pt>
                <c:pt idx="376">
                  <c:v>23.5109239872553</c:v>
                </c:pt>
                <c:pt idx="377">
                  <c:v>23.756588404408198</c:v>
                </c:pt>
                <c:pt idx="378">
                  <c:v>22.4788074712644</c:v>
                </c:pt>
                <c:pt idx="379">
                  <c:v>23.272182254196586</c:v>
                </c:pt>
                <c:pt idx="380">
                  <c:v>21.806727828746187</c:v>
                </c:pt>
                <c:pt idx="381">
                  <c:v>22.239802631578886</c:v>
                </c:pt>
                <c:pt idx="382">
                  <c:v>24.169802276812501</c:v>
                </c:pt>
                <c:pt idx="383">
                  <c:v>23.537524687294301</c:v>
                </c:pt>
                <c:pt idx="384">
                  <c:v>24.165536297412689</c:v>
                </c:pt>
                <c:pt idx="385">
                  <c:v>23.1781481481481</c:v>
                </c:pt>
                <c:pt idx="386">
                  <c:v>21.5368705035971</c:v>
                </c:pt>
                <c:pt idx="387">
                  <c:v>23.164884135472398</c:v>
                </c:pt>
                <c:pt idx="388">
                  <c:v>20.983843537414977</c:v>
                </c:pt>
                <c:pt idx="389">
                  <c:v>21.123966942148801</c:v>
                </c:pt>
                <c:pt idx="390">
                  <c:v>23.748359788359789</c:v>
                </c:pt>
                <c:pt idx="391">
                  <c:v>25.993872549019599</c:v>
                </c:pt>
                <c:pt idx="392">
                  <c:v>24.085540838852076</c:v>
                </c:pt>
                <c:pt idx="393">
                  <c:v>23.362111941989589</c:v>
                </c:pt>
                <c:pt idx="394">
                  <c:v>23.637131692892634</c:v>
                </c:pt>
                <c:pt idx="395">
                  <c:v>22.320647219690088</c:v>
                </c:pt>
                <c:pt idx="396">
                  <c:v>23.682723833543459</c:v>
                </c:pt>
                <c:pt idx="397">
                  <c:v>21.889912280701775</c:v>
                </c:pt>
                <c:pt idx="398">
                  <c:v>22.260237780713275</c:v>
                </c:pt>
                <c:pt idx="399">
                  <c:v>23.605132691746881</c:v>
                </c:pt>
                <c:pt idx="400">
                  <c:v>22.615333333333275</c:v>
                </c:pt>
                <c:pt idx="401">
                  <c:v>22.454563771912099</c:v>
                </c:pt>
                <c:pt idx="402">
                  <c:v>23.115220862160687</c:v>
                </c:pt>
                <c:pt idx="403">
                  <c:v>23.230167014613805</c:v>
                </c:pt>
                <c:pt idx="404">
                  <c:v>23.024576734025089</c:v>
                </c:pt>
                <c:pt idx="405">
                  <c:v>23.476389946686989</c:v>
                </c:pt>
                <c:pt idx="406">
                  <c:v>22.868335888264376</c:v>
                </c:pt>
                <c:pt idx="407">
                  <c:v>20.664644714038101</c:v>
                </c:pt>
                <c:pt idx="408">
                  <c:v>24.745459069420289</c:v>
                </c:pt>
                <c:pt idx="409">
                  <c:v>23.172345258375874</c:v>
                </c:pt>
                <c:pt idx="410">
                  <c:v>27.071428571428587</c:v>
                </c:pt>
                <c:pt idx="411">
                  <c:v>23.6175792507205</c:v>
                </c:pt>
                <c:pt idx="412">
                  <c:v>22.431875314228318</c:v>
                </c:pt>
                <c:pt idx="413">
                  <c:v>22.926610862370964</c:v>
                </c:pt>
                <c:pt idx="414">
                  <c:v>22.201704019262799</c:v>
                </c:pt>
                <c:pt idx="415">
                  <c:v>24.177204884667599</c:v>
                </c:pt>
                <c:pt idx="416">
                  <c:v>17.924999999999986</c:v>
                </c:pt>
                <c:pt idx="417">
                  <c:v>22.446365022877501</c:v>
                </c:pt>
                <c:pt idx="418">
                  <c:v>22.073260073260087</c:v>
                </c:pt>
                <c:pt idx="419">
                  <c:v>23.856171735241517</c:v>
                </c:pt>
                <c:pt idx="420">
                  <c:v>41.844646828338448</c:v>
                </c:pt>
                <c:pt idx="421">
                  <c:v>40.440064545873653</c:v>
                </c:pt>
                <c:pt idx="422">
                  <c:v>23.648909811694701</c:v>
                </c:pt>
                <c:pt idx="423">
                  <c:v>21.584483579247976</c:v>
                </c:pt>
                <c:pt idx="424">
                  <c:v>25.194744719773787</c:v>
                </c:pt>
                <c:pt idx="425">
                  <c:v>23.5750319284802</c:v>
                </c:pt>
                <c:pt idx="426">
                  <c:v>22.654285714285734</c:v>
                </c:pt>
                <c:pt idx="427">
                  <c:v>24.463028169014098</c:v>
                </c:pt>
                <c:pt idx="428">
                  <c:v>22.165578358209</c:v>
                </c:pt>
                <c:pt idx="429">
                  <c:v>23.771285475793</c:v>
                </c:pt>
                <c:pt idx="430">
                  <c:v>23.6459661768783</c:v>
                </c:pt>
                <c:pt idx="431">
                  <c:v>22.610345797020017</c:v>
                </c:pt>
                <c:pt idx="432">
                  <c:v>22.3139386189258</c:v>
                </c:pt>
                <c:pt idx="433">
                  <c:v>16.902160101651788</c:v>
                </c:pt>
                <c:pt idx="434">
                  <c:v>22.901124648547277</c:v>
                </c:pt>
                <c:pt idx="435">
                  <c:v>21.390784382694299</c:v>
                </c:pt>
                <c:pt idx="436">
                  <c:v>22.207888781118726</c:v>
                </c:pt>
                <c:pt idx="437">
                  <c:v>22.285137318255273</c:v>
                </c:pt>
                <c:pt idx="438">
                  <c:v>20.055246570263254</c:v>
                </c:pt>
                <c:pt idx="439">
                  <c:v>23.307556341140099</c:v>
                </c:pt>
                <c:pt idx="440">
                  <c:v>23.953753495375278</c:v>
                </c:pt>
                <c:pt idx="441">
                  <c:v>22.712655086848617</c:v>
                </c:pt>
                <c:pt idx="442">
                  <c:v>23.302013422818817</c:v>
                </c:pt>
                <c:pt idx="443">
                  <c:v>20.730303030302974</c:v>
                </c:pt>
                <c:pt idx="444">
                  <c:v>22.094889267461699</c:v>
                </c:pt>
                <c:pt idx="445">
                  <c:v>23.461474036850888</c:v>
                </c:pt>
                <c:pt idx="446">
                  <c:v>22.997553303040899</c:v>
                </c:pt>
                <c:pt idx="447">
                  <c:v>21.0662701784197</c:v>
                </c:pt>
                <c:pt idx="448">
                  <c:v>22.503484739245401</c:v>
                </c:pt>
                <c:pt idx="449">
                  <c:v>21.695489996608988</c:v>
                </c:pt>
                <c:pt idx="450">
                  <c:v>25.145329849771354</c:v>
                </c:pt>
                <c:pt idx="451">
                  <c:v>21.5066526610644</c:v>
                </c:pt>
                <c:pt idx="452">
                  <c:v>23.590448625180887</c:v>
                </c:pt>
                <c:pt idx="453">
                  <c:v>24.204327342523076</c:v>
                </c:pt>
                <c:pt idx="454">
                  <c:v>23.826179120296818</c:v>
                </c:pt>
                <c:pt idx="455">
                  <c:v>22.891631799163189</c:v>
                </c:pt>
                <c:pt idx="456">
                  <c:v>21.956289759901502</c:v>
                </c:pt>
                <c:pt idx="457">
                  <c:v>24.748544496811789</c:v>
                </c:pt>
                <c:pt idx="458">
                  <c:v>22.960137457044699</c:v>
                </c:pt>
                <c:pt idx="459">
                  <c:v>23.895743145743076</c:v>
                </c:pt>
                <c:pt idx="460">
                  <c:v>21.287712287712264</c:v>
                </c:pt>
                <c:pt idx="461">
                  <c:v>22.9136363636364</c:v>
                </c:pt>
                <c:pt idx="462">
                  <c:v>24.531944444444431</c:v>
                </c:pt>
                <c:pt idx="463">
                  <c:v>21.498743718592976</c:v>
                </c:pt>
                <c:pt idx="464">
                  <c:v>23.236120112335289</c:v>
                </c:pt>
                <c:pt idx="465">
                  <c:v>22.276880796977</c:v>
                </c:pt>
                <c:pt idx="466">
                  <c:v>23.8529862174579</c:v>
                </c:pt>
                <c:pt idx="467">
                  <c:v>22.457553956834516</c:v>
                </c:pt>
                <c:pt idx="468">
                  <c:v>19.988505747126379</c:v>
                </c:pt>
                <c:pt idx="469">
                  <c:v>22.674063800277388</c:v>
                </c:pt>
                <c:pt idx="470">
                  <c:v>23.197275479313817</c:v>
                </c:pt>
                <c:pt idx="471">
                  <c:v>23.135491983652901</c:v>
                </c:pt>
                <c:pt idx="472">
                  <c:v>20.194797338172989</c:v>
                </c:pt>
                <c:pt idx="473">
                  <c:v>23.279218106995899</c:v>
                </c:pt>
                <c:pt idx="474">
                  <c:v>23.080160320641287</c:v>
                </c:pt>
                <c:pt idx="475">
                  <c:v>23.824648844585376</c:v>
                </c:pt>
                <c:pt idx="476">
                  <c:v>24.157389259114101</c:v>
                </c:pt>
                <c:pt idx="477">
                  <c:v>23.556784272424089</c:v>
                </c:pt>
                <c:pt idx="478">
                  <c:v>24.328320802004978</c:v>
                </c:pt>
                <c:pt idx="479">
                  <c:v>23.232088799192717</c:v>
                </c:pt>
                <c:pt idx="480">
                  <c:v>24.251383125864518</c:v>
                </c:pt>
                <c:pt idx="481">
                  <c:v>24.187188238382799</c:v>
                </c:pt>
                <c:pt idx="482">
                  <c:v>24.324620275520964</c:v>
                </c:pt>
                <c:pt idx="483">
                  <c:v>24.669106881405586</c:v>
                </c:pt>
                <c:pt idx="484">
                  <c:v>21.293348493462187</c:v>
                </c:pt>
                <c:pt idx="485">
                  <c:v>23.145077720207301</c:v>
                </c:pt>
                <c:pt idx="486">
                  <c:v>23.418211559432887</c:v>
                </c:pt>
                <c:pt idx="487">
                  <c:v>24.367454994705302</c:v>
                </c:pt>
                <c:pt idx="488">
                  <c:v>22.762367491166081</c:v>
                </c:pt>
                <c:pt idx="489">
                  <c:v>23.235909090909086</c:v>
                </c:pt>
                <c:pt idx="490">
                  <c:v>23.459088682018617</c:v>
                </c:pt>
                <c:pt idx="491">
                  <c:v>23.021242355970376</c:v>
                </c:pt>
                <c:pt idx="492">
                  <c:v>24.652167369054826</c:v>
                </c:pt>
                <c:pt idx="493">
                  <c:v>24.363087806907973</c:v>
                </c:pt>
                <c:pt idx="494">
                  <c:v>24.230616302186878</c:v>
                </c:pt>
                <c:pt idx="495">
                  <c:v>24.744755244755186</c:v>
                </c:pt>
                <c:pt idx="496">
                  <c:v>23.353778096604518</c:v>
                </c:pt>
                <c:pt idx="497">
                  <c:v>23.492063492063487</c:v>
                </c:pt>
                <c:pt idx="498">
                  <c:v>22.721398038722686</c:v>
                </c:pt>
                <c:pt idx="499">
                  <c:v>21.451059085841699</c:v>
                </c:pt>
                <c:pt idx="500">
                  <c:v>22.709882427708905</c:v>
                </c:pt>
                <c:pt idx="501">
                  <c:v>24.940495568818999</c:v>
                </c:pt>
                <c:pt idx="502">
                  <c:v>23.394695787831498</c:v>
                </c:pt>
                <c:pt idx="503">
                  <c:v>22.885145784081978</c:v>
                </c:pt>
                <c:pt idx="504">
                  <c:v>21.529738878143064</c:v>
                </c:pt>
                <c:pt idx="505">
                  <c:v>23.567957276368499</c:v>
                </c:pt>
                <c:pt idx="506">
                  <c:v>23.091980360065516</c:v>
                </c:pt>
                <c:pt idx="507">
                  <c:v>23.421560035056999</c:v>
                </c:pt>
                <c:pt idx="508">
                  <c:v>21.576765277477886</c:v>
                </c:pt>
                <c:pt idx="509">
                  <c:v>24.212328767123289</c:v>
                </c:pt>
                <c:pt idx="510">
                  <c:v>24.175801970194517</c:v>
                </c:pt>
                <c:pt idx="511">
                  <c:v>23.118378954852535</c:v>
                </c:pt>
                <c:pt idx="512">
                  <c:v>23.329296792011899</c:v>
                </c:pt>
                <c:pt idx="513">
                  <c:v>22.218393068137086</c:v>
                </c:pt>
                <c:pt idx="514">
                  <c:v>23.770898805782501</c:v>
                </c:pt>
                <c:pt idx="515">
                  <c:v>24.239954725523518</c:v>
                </c:pt>
                <c:pt idx="516">
                  <c:v>24.938938938938886</c:v>
                </c:pt>
                <c:pt idx="517">
                  <c:v>28.557291666666718</c:v>
                </c:pt>
                <c:pt idx="518">
                  <c:v>22.103502558048</c:v>
                </c:pt>
                <c:pt idx="519">
                  <c:v>20.082819383259881</c:v>
                </c:pt>
                <c:pt idx="520">
                  <c:v>21.425777331995963</c:v>
                </c:pt>
                <c:pt idx="521">
                  <c:v>24.397555417443535</c:v>
                </c:pt>
                <c:pt idx="522">
                  <c:v>23.085054080629273</c:v>
                </c:pt>
                <c:pt idx="523">
                  <c:v>22.645786726323589</c:v>
                </c:pt>
                <c:pt idx="524">
                  <c:v>22.146929824561376</c:v>
                </c:pt>
                <c:pt idx="525">
                  <c:v>22.201142857142877</c:v>
                </c:pt>
                <c:pt idx="526">
                  <c:v>23.6704064352244</c:v>
                </c:pt>
                <c:pt idx="527">
                  <c:v>22.656291390728505</c:v>
                </c:pt>
                <c:pt idx="528">
                  <c:v>24.080760095011886</c:v>
                </c:pt>
                <c:pt idx="529">
                  <c:v>24.464285714285701</c:v>
                </c:pt>
                <c:pt idx="530">
                  <c:v>24.912534002929476</c:v>
                </c:pt>
                <c:pt idx="531">
                  <c:v>23.376811594202898</c:v>
                </c:pt>
                <c:pt idx="532">
                  <c:v>19.198091776465187</c:v>
                </c:pt>
                <c:pt idx="533">
                  <c:v>19.499571550985376</c:v>
                </c:pt>
                <c:pt idx="534">
                  <c:v>19.947759346372877</c:v>
                </c:pt>
                <c:pt idx="535">
                  <c:v>18.786977069840717</c:v>
                </c:pt>
                <c:pt idx="536">
                  <c:v>19.952115812917587</c:v>
                </c:pt>
                <c:pt idx="537">
                  <c:v>17.143358395989999</c:v>
                </c:pt>
                <c:pt idx="538">
                  <c:v>20.089485458613005</c:v>
                </c:pt>
                <c:pt idx="539">
                  <c:v>22.946516281608176</c:v>
                </c:pt>
                <c:pt idx="540">
                  <c:v>25.603212092583789</c:v>
                </c:pt>
                <c:pt idx="541">
                  <c:v>23.254529254529263</c:v>
                </c:pt>
                <c:pt idx="542">
                  <c:v>24.547991653625498</c:v>
                </c:pt>
                <c:pt idx="543">
                  <c:v>23.641250188736201</c:v>
                </c:pt>
                <c:pt idx="544">
                  <c:v>23.466135458167276</c:v>
                </c:pt>
                <c:pt idx="545">
                  <c:v>23.517543859649088</c:v>
                </c:pt>
                <c:pt idx="546">
                  <c:v>24.332689987937275</c:v>
                </c:pt>
                <c:pt idx="547">
                  <c:v>24.5501730103806</c:v>
                </c:pt>
                <c:pt idx="548">
                  <c:v>23.230421686746986</c:v>
                </c:pt>
                <c:pt idx="549">
                  <c:v>24.538922155688617</c:v>
                </c:pt>
                <c:pt idx="550">
                  <c:v>23.644043663977186</c:v>
                </c:pt>
                <c:pt idx="551">
                  <c:v>24.331493618489105</c:v>
                </c:pt>
                <c:pt idx="552">
                  <c:v>23.022543352601176</c:v>
                </c:pt>
                <c:pt idx="553">
                  <c:v>22.472052401746687</c:v>
                </c:pt>
                <c:pt idx="554">
                  <c:v>24.758750673128677</c:v>
                </c:pt>
                <c:pt idx="555">
                  <c:v>23.102224894768487</c:v>
                </c:pt>
                <c:pt idx="556">
                  <c:v>20.9393173198483</c:v>
                </c:pt>
                <c:pt idx="557">
                  <c:v>23.523236282194777</c:v>
                </c:pt>
                <c:pt idx="558">
                  <c:v>24.321267853649001</c:v>
                </c:pt>
                <c:pt idx="559">
                  <c:v>24.061121722521289</c:v>
                </c:pt>
                <c:pt idx="560">
                  <c:v>25.355823293172687</c:v>
                </c:pt>
                <c:pt idx="561">
                  <c:v>23.594279661016898</c:v>
                </c:pt>
                <c:pt idx="562">
                  <c:v>22.459856035437401</c:v>
                </c:pt>
                <c:pt idx="563">
                  <c:v>20.957239309827489</c:v>
                </c:pt>
                <c:pt idx="564">
                  <c:v>24.328224101479886</c:v>
                </c:pt>
                <c:pt idx="565">
                  <c:v>22.900628084342777</c:v>
                </c:pt>
                <c:pt idx="566">
                  <c:v>24.624454148471617</c:v>
                </c:pt>
                <c:pt idx="567">
                  <c:v>23.816826628548117</c:v>
                </c:pt>
                <c:pt idx="568">
                  <c:v>21.656864962678135</c:v>
                </c:pt>
                <c:pt idx="569">
                  <c:v>23.994729542302366</c:v>
                </c:pt>
                <c:pt idx="570">
                  <c:v>25.088524590163853</c:v>
                </c:pt>
                <c:pt idx="571">
                  <c:v>24.483750212693586</c:v>
                </c:pt>
                <c:pt idx="572">
                  <c:v>25.165176670923763</c:v>
                </c:pt>
                <c:pt idx="573">
                  <c:v>24.608124253285499</c:v>
                </c:pt>
                <c:pt idx="574">
                  <c:v>22.223273144167376</c:v>
                </c:pt>
                <c:pt idx="575">
                  <c:v>23.605168700646118</c:v>
                </c:pt>
                <c:pt idx="576">
                  <c:v>23.152466367713</c:v>
                </c:pt>
                <c:pt idx="577">
                  <c:v>23.350869925435017</c:v>
                </c:pt>
                <c:pt idx="578">
                  <c:v>23.203663793103377</c:v>
                </c:pt>
                <c:pt idx="579">
                  <c:v>22.515778582514187</c:v>
                </c:pt>
                <c:pt idx="580">
                  <c:v>21.247340425531878</c:v>
                </c:pt>
                <c:pt idx="581">
                  <c:v>21.743480574773759</c:v>
                </c:pt>
                <c:pt idx="582">
                  <c:v>23.908128415300499</c:v>
                </c:pt>
                <c:pt idx="583">
                  <c:v>23.320580145036299</c:v>
                </c:pt>
                <c:pt idx="584">
                  <c:v>22.848776223776174</c:v>
                </c:pt>
                <c:pt idx="585">
                  <c:v>22.745233968804186</c:v>
                </c:pt>
                <c:pt idx="586">
                  <c:v>23.799137621271989</c:v>
                </c:pt>
                <c:pt idx="587">
                  <c:v>22.099536211202278</c:v>
                </c:pt>
                <c:pt idx="588">
                  <c:v>23.408179012345673</c:v>
                </c:pt>
                <c:pt idx="589">
                  <c:v>23.303375527426201</c:v>
                </c:pt>
                <c:pt idx="590">
                  <c:v>23.154628143392198</c:v>
                </c:pt>
                <c:pt idx="591">
                  <c:v>25.562330214307259</c:v>
                </c:pt>
                <c:pt idx="592">
                  <c:v>24.243024302430189</c:v>
                </c:pt>
                <c:pt idx="593">
                  <c:v>24.033567134268505</c:v>
                </c:pt>
                <c:pt idx="594">
                  <c:v>24.600071607590426</c:v>
                </c:pt>
                <c:pt idx="595">
                  <c:v>25.990107913669089</c:v>
                </c:pt>
                <c:pt idx="596">
                  <c:v>24.774382661218716</c:v>
                </c:pt>
                <c:pt idx="597">
                  <c:v>24.085672082717863</c:v>
                </c:pt>
                <c:pt idx="598">
                  <c:v>23.596029093768376</c:v>
                </c:pt>
                <c:pt idx="599">
                  <c:v>23.986685214626402</c:v>
                </c:pt>
                <c:pt idx="600">
                  <c:v>22.511399371069189</c:v>
                </c:pt>
                <c:pt idx="601">
                  <c:v>24.093542260208881</c:v>
                </c:pt>
                <c:pt idx="602">
                  <c:v>23.754874651810635</c:v>
                </c:pt>
                <c:pt idx="603">
                  <c:v>24.525107930015889</c:v>
                </c:pt>
                <c:pt idx="604">
                  <c:v>23.280581947743489</c:v>
                </c:pt>
                <c:pt idx="605">
                  <c:v>23.337817063797118</c:v>
                </c:pt>
                <c:pt idx="606">
                  <c:v>23.654867256637218</c:v>
                </c:pt>
                <c:pt idx="607">
                  <c:v>25.257072905331889</c:v>
                </c:pt>
                <c:pt idx="608">
                  <c:v>25.715633038010889</c:v>
                </c:pt>
                <c:pt idx="609">
                  <c:v>24.6042985991173</c:v>
                </c:pt>
                <c:pt idx="610">
                  <c:v>24.844799999999989</c:v>
                </c:pt>
                <c:pt idx="611">
                  <c:v>25.124031007751899</c:v>
                </c:pt>
                <c:pt idx="612">
                  <c:v>23.5193370165746</c:v>
                </c:pt>
                <c:pt idx="613">
                  <c:v>23.323690621193688</c:v>
                </c:pt>
                <c:pt idx="614">
                  <c:v>25.006379234491877</c:v>
                </c:pt>
                <c:pt idx="615">
                  <c:v>21.796747967479689</c:v>
                </c:pt>
                <c:pt idx="616">
                  <c:v>23.470684039087889</c:v>
                </c:pt>
                <c:pt idx="617">
                  <c:v>31.548387096774189</c:v>
                </c:pt>
                <c:pt idx="618">
                  <c:v>25.836455331412118</c:v>
                </c:pt>
                <c:pt idx="619">
                  <c:v>22.788714733542264</c:v>
                </c:pt>
                <c:pt idx="620">
                  <c:v>23.696824070204801</c:v>
                </c:pt>
                <c:pt idx="621">
                  <c:v>25.476750400855199</c:v>
                </c:pt>
                <c:pt idx="622">
                  <c:v>23.111587982832617</c:v>
                </c:pt>
                <c:pt idx="623">
                  <c:v>25.117248062015534</c:v>
                </c:pt>
                <c:pt idx="624">
                  <c:v>24.299800616277</c:v>
                </c:pt>
                <c:pt idx="625">
                  <c:v>23.994024314856805</c:v>
                </c:pt>
                <c:pt idx="626">
                  <c:v>23.404289544235876</c:v>
                </c:pt>
                <c:pt idx="627">
                  <c:v>22.844654217114705</c:v>
                </c:pt>
                <c:pt idx="628">
                  <c:v>23.502962704775189</c:v>
                </c:pt>
                <c:pt idx="629">
                  <c:v>22.737270087124902</c:v>
                </c:pt>
                <c:pt idx="630">
                  <c:v>24.186707882534776</c:v>
                </c:pt>
                <c:pt idx="631">
                  <c:v>22.7076297686054</c:v>
                </c:pt>
                <c:pt idx="632">
                  <c:v>23.442718083114876</c:v>
                </c:pt>
                <c:pt idx="633">
                  <c:v>23.948415300546376</c:v>
                </c:pt>
                <c:pt idx="634">
                  <c:v>23.175601659750999</c:v>
                </c:pt>
                <c:pt idx="635">
                  <c:v>22.637117346938801</c:v>
                </c:pt>
                <c:pt idx="636">
                  <c:v>23.645732689210877</c:v>
                </c:pt>
                <c:pt idx="637">
                  <c:v>23.727911275415899</c:v>
                </c:pt>
                <c:pt idx="638">
                  <c:v>25.922594913379964</c:v>
                </c:pt>
                <c:pt idx="639">
                  <c:v>22.875968992248126</c:v>
                </c:pt>
                <c:pt idx="640">
                  <c:v>22.7441930618401</c:v>
                </c:pt>
                <c:pt idx="641">
                  <c:v>23.516849816849799</c:v>
                </c:pt>
                <c:pt idx="642">
                  <c:v>24.490758444869289</c:v>
                </c:pt>
                <c:pt idx="643">
                  <c:v>22.0575968222443</c:v>
                </c:pt>
                <c:pt idx="644">
                  <c:v>23.7712486883526</c:v>
                </c:pt>
                <c:pt idx="645">
                  <c:v>22.967741935483875</c:v>
                </c:pt>
                <c:pt idx="646">
                  <c:v>22.175931232091699</c:v>
                </c:pt>
                <c:pt idx="647">
                  <c:v>17.731707317073202</c:v>
                </c:pt>
                <c:pt idx="648">
                  <c:v>23.664835164835218</c:v>
                </c:pt>
                <c:pt idx="649">
                  <c:v>24.239442231075664</c:v>
                </c:pt>
                <c:pt idx="650">
                  <c:v>24.514655172413818</c:v>
                </c:pt>
                <c:pt idx="651">
                  <c:v>23.575535939470377</c:v>
                </c:pt>
                <c:pt idx="652">
                  <c:v>23.5184014450214</c:v>
                </c:pt>
                <c:pt idx="653">
                  <c:v>23.481362346262976</c:v>
                </c:pt>
                <c:pt idx="654">
                  <c:v>25.276478679504802</c:v>
                </c:pt>
                <c:pt idx="655">
                  <c:v>22.992152003304376</c:v>
                </c:pt>
                <c:pt idx="656">
                  <c:v>22.7388342165026</c:v>
                </c:pt>
                <c:pt idx="657">
                  <c:v>21.957112970711275</c:v>
                </c:pt>
                <c:pt idx="658">
                  <c:v>23.3021739130435</c:v>
                </c:pt>
                <c:pt idx="659">
                  <c:v>24.440422322775259</c:v>
                </c:pt>
                <c:pt idx="660">
                  <c:v>26.177304964539001</c:v>
                </c:pt>
                <c:pt idx="661">
                  <c:v>23.369927650204517</c:v>
                </c:pt>
                <c:pt idx="662">
                  <c:v>25.009731913330889</c:v>
                </c:pt>
                <c:pt idx="663">
                  <c:v>24.213648620618098</c:v>
                </c:pt>
                <c:pt idx="664">
                  <c:v>28.660377358490617</c:v>
                </c:pt>
                <c:pt idx="665">
                  <c:v>23.490631305851789</c:v>
                </c:pt>
                <c:pt idx="666">
                  <c:v>22.560493827160489</c:v>
                </c:pt>
                <c:pt idx="667">
                  <c:v>25.493593029215788</c:v>
                </c:pt>
                <c:pt idx="668">
                  <c:v>23.094734855633089</c:v>
                </c:pt>
                <c:pt idx="669">
                  <c:v>22.162162162162186</c:v>
                </c:pt>
                <c:pt idx="670">
                  <c:v>24.3198452841416</c:v>
                </c:pt>
                <c:pt idx="671">
                  <c:v>22.592592592592577</c:v>
                </c:pt>
                <c:pt idx="672">
                  <c:v>24.9200240529164</c:v>
                </c:pt>
                <c:pt idx="673">
                  <c:v>24.998062015503876</c:v>
                </c:pt>
                <c:pt idx="674">
                  <c:v>23.738591916558001</c:v>
                </c:pt>
                <c:pt idx="675">
                  <c:v>24.57415406767463</c:v>
                </c:pt>
                <c:pt idx="676">
                  <c:v>25.516355140186917</c:v>
                </c:pt>
                <c:pt idx="677">
                  <c:v>24.642083548220686</c:v>
                </c:pt>
                <c:pt idx="678">
                  <c:v>24.530037546933674</c:v>
                </c:pt>
                <c:pt idx="679">
                  <c:v>23.676584234930377</c:v>
                </c:pt>
                <c:pt idx="680">
                  <c:v>22.599091425326517</c:v>
                </c:pt>
                <c:pt idx="681">
                  <c:v>19.8815789473684</c:v>
                </c:pt>
                <c:pt idx="682">
                  <c:v>21.950440018527075</c:v>
                </c:pt>
                <c:pt idx="683">
                  <c:v>24.970189701896999</c:v>
                </c:pt>
                <c:pt idx="684">
                  <c:v>24.9245014245014</c:v>
                </c:pt>
                <c:pt idx="685">
                  <c:v>24.483994432846199</c:v>
                </c:pt>
                <c:pt idx="686">
                  <c:v>23.208740120873976</c:v>
                </c:pt>
                <c:pt idx="687">
                  <c:v>24.106447688564486</c:v>
                </c:pt>
                <c:pt idx="688">
                  <c:v>23.292083333333263</c:v>
                </c:pt>
                <c:pt idx="689">
                  <c:v>24.160587188612105</c:v>
                </c:pt>
                <c:pt idx="690">
                  <c:v>24.256893073301889</c:v>
                </c:pt>
                <c:pt idx="691">
                  <c:v>24.474553690380986</c:v>
                </c:pt>
                <c:pt idx="692">
                  <c:v>24.790256410256418</c:v>
                </c:pt>
                <c:pt idx="693">
                  <c:v>22.787229084129564</c:v>
                </c:pt>
                <c:pt idx="694">
                  <c:v>24.479782270606481</c:v>
                </c:pt>
                <c:pt idx="695">
                  <c:v>23.882756132756089</c:v>
                </c:pt>
                <c:pt idx="696">
                  <c:v>25.376706360731877</c:v>
                </c:pt>
                <c:pt idx="697">
                  <c:v>24.284601557819087</c:v>
                </c:pt>
                <c:pt idx="698">
                  <c:v>25.618597997138799</c:v>
                </c:pt>
                <c:pt idx="699">
                  <c:v>23.149053991693616</c:v>
                </c:pt>
                <c:pt idx="700">
                  <c:v>23.840507835746877</c:v>
                </c:pt>
                <c:pt idx="701">
                  <c:v>24.208313194780089</c:v>
                </c:pt>
                <c:pt idx="702">
                  <c:v>24.554595443833517</c:v>
                </c:pt>
                <c:pt idx="703">
                  <c:v>25.516082573211687</c:v>
                </c:pt>
                <c:pt idx="704">
                  <c:v>21.486500254712176</c:v>
                </c:pt>
                <c:pt idx="705">
                  <c:v>24.622937941869587</c:v>
                </c:pt>
                <c:pt idx="706">
                  <c:v>23.833333333333275</c:v>
                </c:pt>
                <c:pt idx="707">
                  <c:v>24.098421541318487</c:v>
                </c:pt>
                <c:pt idx="708">
                  <c:v>23.117290629733805</c:v>
                </c:pt>
                <c:pt idx="709">
                  <c:v>25.100783874580078</c:v>
                </c:pt>
                <c:pt idx="710">
                  <c:v>23.60786802030464</c:v>
                </c:pt>
                <c:pt idx="711">
                  <c:v>28.309859154929601</c:v>
                </c:pt>
                <c:pt idx="712">
                  <c:v>21.693914623069901</c:v>
                </c:pt>
                <c:pt idx="713">
                  <c:v>24.726426076833476</c:v>
                </c:pt>
                <c:pt idx="714">
                  <c:v>23.884796978281376</c:v>
                </c:pt>
                <c:pt idx="715">
                  <c:v>19.001979414093434</c:v>
                </c:pt>
                <c:pt idx="716">
                  <c:v>21.737882177479516</c:v>
                </c:pt>
                <c:pt idx="717">
                  <c:v>21.538224730631089</c:v>
                </c:pt>
                <c:pt idx="718">
                  <c:v>24.201928530913186</c:v>
                </c:pt>
                <c:pt idx="719">
                  <c:v>24.674157303370801</c:v>
                </c:pt>
                <c:pt idx="720">
                  <c:v>24.202034883720859</c:v>
                </c:pt>
                <c:pt idx="721">
                  <c:v>23.8550020251114</c:v>
                </c:pt>
                <c:pt idx="722">
                  <c:v>24.739327883742089</c:v>
                </c:pt>
                <c:pt idx="723">
                  <c:v>24.601296596434388</c:v>
                </c:pt>
                <c:pt idx="724">
                  <c:v>20.728438228438186</c:v>
                </c:pt>
                <c:pt idx="725">
                  <c:v>24.049863654070901</c:v>
                </c:pt>
                <c:pt idx="726">
                  <c:v>24.6580608146873</c:v>
                </c:pt>
                <c:pt idx="727">
                  <c:v>24.523558484349302</c:v>
                </c:pt>
                <c:pt idx="728">
                  <c:v>23.851279575084501</c:v>
                </c:pt>
                <c:pt idx="729">
                  <c:v>22.3355734767025</c:v>
                </c:pt>
                <c:pt idx="730">
                  <c:v>23.588728103579577</c:v>
                </c:pt>
                <c:pt idx="731">
                  <c:v>19.096079938508787</c:v>
                </c:pt>
                <c:pt idx="732">
                  <c:v>24.933653426451301</c:v>
                </c:pt>
                <c:pt idx="733">
                  <c:v>25.168664905506986</c:v>
                </c:pt>
                <c:pt idx="734">
                  <c:v>25.169503299756887</c:v>
                </c:pt>
                <c:pt idx="735">
                  <c:v>23.168445811470978</c:v>
                </c:pt>
                <c:pt idx="736">
                  <c:v>24.135727328058426</c:v>
                </c:pt>
                <c:pt idx="737">
                  <c:v>23.1633199464525</c:v>
                </c:pt>
                <c:pt idx="738">
                  <c:v>21.459752901534976</c:v>
                </c:pt>
                <c:pt idx="739">
                  <c:v>24.215864293393899</c:v>
                </c:pt>
                <c:pt idx="740">
                  <c:v>24.480844058665078</c:v>
                </c:pt>
                <c:pt idx="741">
                  <c:v>24.928617571059366</c:v>
                </c:pt>
                <c:pt idx="742">
                  <c:v>25.083512544802876</c:v>
                </c:pt>
                <c:pt idx="743">
                  <c:v>27.161358811040301</c:v>
                </c:pt>
                <c:pt idx="744">
                  <c:v>23.1759470561387</c:v>
                </c:pt>
                <c:pt idx="745">
                  <c:v>24.173155273879601</c:v>
                </c:pt>
                <c:pt idx="746">
                  <c:v>24.376094091903699</c:v>
                </c:pt>
                <c:pt idx="747">
                  <c:v>23.701622596153776</c:v>
                </c:pt>
                <c:pt idx="748">
                  <c:v>24.235690235690189</c:v>
                </c:pt>
                <c:pt idx="749">
                  <c:v>24.358422939068078</c:v>
                </c:pt>
                <c:pt idx="750">
                  <c:v>29.383333333333255</c:v>
                </c:pt>
                <c:pt idx="751">
                  <c:v>25.105263157894719</c:v>
                </c:pt>
                <c:pt idx="752">
                  <c:v>22.748697517621764</c:v>
                </c:pt>
                <c:pt idx="753">
                  <c:v>23.1407954945442</c:v>
                </c:pt>
                <c:pt idx="754">
                  <c:v>18.529411764705888</c:v>
                </c:pt>
                <c:pt idx="755">
                  <c:v>25.734104046242798</c:v>
                </c:pt>
                <c:pt idx="756">
                  <c:v>23.673219300485087</c:v>
                </c:pt>
                <c:pt idx="757">
                  <c:v>23.883958374239199</c:v>
                </c:pt>
                <c:pt idx="758">
                  <c:v>24.286670235545962</c:v>
                </c:pt>
                <c:pt idx="759">
                  <c:v>24.95780346820813</c:v>
                </c:pt>
                <c:pt idx="760">
                  <c:v>23.858464384828899</c:v>
                </c:pt>
                <c:pt idx="761">
                  <c:v>22.035353535353487</c:v>
                </c:pt>
                <c:pt idx="762">
                  <c:v>24.0648845055801</c:v>
                </c:pt>
                <c:pt idx="763">
                  <c:v>21.923076923076888</c:v>
                </c:pt>
                <c:pt idx="764">
                  <c:v>25.643128964059201</c:v>
                </c:pt>
                <c:pt idx="765">
                  <c:v>24.255617977528075</c:v>
                </c:pt>
                <c:pt idx="766">
                  <c:v>24.0126893164142</c:v>
                </c:pt>
                <c:pt idx="767">
                  <c:v>24.183754615166102</c:v>
                </c:pt>
                <c:pt idx="768">
                  <c:v>24.548034934497789</c:v>
                </c:pt>
                <c:pt idx="769">
                  <c:v>23.492166396542402</c:v>
                </c:pt>
                <c:pt idx="770">
                  <c:v>25.131642098045887</c:v>
                </c:pt>
                <c:pt idx="771">
                  <c:v>25.7271118973905</c:v>
                </c:pt>
                <c:pt idx="772">
                  <c:v>23.444948921679899</c:v>
                </c:pt>
                <c:pt idx="773">
                  <c:v>23.9415279556125</c:v>
                </c:pt>
                <c:pt idx="774">
                  <c:v>22.187532333160863</c:v>
                </c:pt>
                <c:pt idx="775">
                  <c:v>23.737152209492617</c:v>
                </c:pt>
                <c:pt idx="776">
                  <c:v>22.682281059063087</c:v>
                </c:pt>
                <c:pt idx="777">
                  <c:v>22.981251362546299</c:v>
                </c:pt>
                <c:pt idx="778">
                  <c:v>23.897616006811401</c:v>
                </c:pt>
                <c:pt idx="779">
                  <c:v>24.572242206234975</c:v>
                </c:pt>
                <c:pt idx="780">
                  <c:v>23.174535355693205</c:v>
                </c:pt>
                <c:pt idx="781">
                  <c:v>25.0546969960062</c:v>
                </c:pt>
                <c:pt idx="782">
                  <c:v>23.716404758408018</c:v>
                </c:pt>
                <c:pt idx="783">
                  <c:v>24.087222647283877</c:v>
                </c:pt>
                <c:pt idx="784">
                  <c:v>24.863817797605101</c:v>
                </c:pt>
                <c:pt idx="785">
                  <c:v>22.728658536585364</c:v>
                </c:pt>
                <c:pt idx="786">
                  <c:v>22.908104442183777</c:v>
                </c:pt>
                <c:pt idx="787">
                  <c:v>22.351290684624001</c:v>
                </c:pt>
                <c:pt idx="788">
                  <c:v>26.336216216216201</c:v>
                </c:pt>
                <c:pt idx="789">
                  <c:v>23.448630136986264</c:v>
                </c:pt>
                <c:pt idx="790">
                  <c:v>23.963841807909589</c:v>
                </c:pt>
                <c:pt idx="791">
                  <c:v>20.988056460369176</c:v>
                </c:pt>
                <c:pt idx="792">
                  <c:v>23.303771661569787</c:v>
                </c:pt>
                <c:pt idx="793">
                  <c:v>19.803361344537802</c:v>
                </c:pt>
                <c:pt idx="794">
                  <c:v>26.418064976794</c:v>
                </c:pt>
                <c:pt idx="795">
                  <c:v>24.497182377049189</c:v>
                </c:pt>
                <c:pt idx="796">
                  <c:v>22.0934931506849</c:v>
                </c:pt>
                <c:pt idx="797">
                  <c:v>24.495959595959587</c:v>
                </c:pt>
                <c:pt idx="798">
                  <c:v>23.1515809051457</c:v>
                </c:pt>
                <c:pt idx="799">
                  <c:v>23.480198019802</c:v>
                </c:pt>
                <c:pt idx="800">
                  <c:v>22.415094339622588</c:v>
                </c:pt>
                <c:pt idx="801">
                  <c:v>24.1246147071775</c:v>
                </c:pt>
                <c:pt idx="802">
                  <c:v>23.176158940397418</c:v>
                </c:pt>
                <c:pt idx="803">
                  <c:v>22.641477272727276</c:v>
                </c:pt>
                <c:pt idx="804">
                  <c:v>23.476464937559989</c:v>
                </c:pt>
                <c:pt idx="805">
                  <c:v>25.382686362074889</c:v>
                </c:pt>
                <c:pt idx="806">
                  <c:v>24.634932126696835</c:v>
                </c:pt>
                <c:pt idx="807">
                  <c:v>24.085114652156989</c:v>
                </c:pt>
                <c:pt idx="808">
                  <c:v>25.2115643209323</c:v>
                </c:pt>
                <c:pt idx="809">
                  <c:v>24.305292479108587</c:v>
                </c:pt>
                <c:pt idx="810">
                  <c:v>24.474614516735581</c:v>
                </c:pt>
                <c:pt idx="811">
                  <c:v>21.704845814978</c:v>
                </c:pt>
                <c:pt idx="812">
                  <c:v>24.835170603674516</c:v>
                </c:pt>
                <c:pt idx="813">
                  <c:v>23.487857762359116</c:v>
                </c:pt>
                <c:pt idx="814">
                  <c:v>24.012048192771086</c:v>
                </c:pt>
                <c:pt idx="815">
                  <c:v>22.529158993247417</c:v>
                </c:pt>
                <c:pt idx="816">
                  <c:v>22.729018338727077</c:v>
                </c:pt>
                <c:pt idx="817">
                  <c:v>24.460817911811699</c:v>
                </c:pt>
                <c:pt idx="818">
                  <c:v>25.070141979232886</c:v>
                </c:pt>
                <c:pt idx="819">
                  <c:v>23.026402640263964</c:v>
                </c:pt>
                <c:pt idx="820">
                  <c:v>22.483562462641977</c:v>
                </c:pt>
                <c:pt idx="821">
                  <c:v>26.1812080536913</c:v>
                </c:pt>
                <c:pt idx="822">
                  <c:v>24.064730658390602</c:v>
                </c:pt>
                <c:pt idx="823">
                  <c:v>23.6894041520626</c:v>
                </c:pt>
                <c:pt idx="824">
                  <c:v>21.374800637958518</c:v>
                </c:pt>
                <c:pt idx="825">
                  <c:v>22.746957403651098</c:v>
                </c:pt>
                <c:pt idx="826">
                  <c:v>23.670152687722187</c:v>
                </c:pt>
                <c:pt idx="827">
                  <c:v>24.655584415584418</c:v>
                </c:pt>
                <c:pt idx="828">
                  <c:v>26.219130434782599</c:v>
                </c:pt>
                <c:pt idx="829">
                  <c:v>23.419620021921776</c:v>
                </c:pt>
                <c:pt idx="830">
                  <c:v>23.3</c:v>
                </c:pt>
                <c:pt idx="831">
                  <c:v>23.851150597145399</c:v>
                </c:pt>
                <c:pt idx="832">
                  <c:v>23.027936145952101</c:v>
                </c:pt>
                <c:pt idx="833">
                  <c:v>24.048288508557487</c:v>
                </c:pt>
                <c:pt idx="834">
                  <c:v>23.786245772266081</c:v>
                </c:pt>
                <c:pt idx="835">
                  <c:v>24.031265887137799</c:v>
                </c:pt>
                <c:pt idx="836">
                  <c:v>23.015661992351099</c:v>
                </c:pt>
                <c:pt idx="837">
                  <c:v>22.858910891089099</c:v>
                </c:pt>
                <c:pt idx="838">
                  <c:v>21.935626791764363</c:v>
                </c:pt>
                <c:pt idx="839">
                  <c:v>23.572068039391187</c:v>
                </c:pt>
                <c:pt idx="840">
                  <c:v>24.278906249999977</c:v>
                </c:pt>
                <c:pt idx="841">
                  <c:v>24.696202531645589</c:v>
                </c:pt>
                <c:pt idx="842">
                  <c:v>23.795728876508775</c:v>
                </c:pt>
                <c:pt idx="843">
                  <c:v>23.613072148952718</c:v>
                </c:pt>
                <c:pt idx="844">
                  <c:v>22.383430571761942</c:v>
                </c:pt>
                <c:pt idx="845">
                  <c:v>20.164456233421689</c:v>
                </c:pt>
                <c:pt idx="846">
                  <c:v>23.268709907341353</c:v>
                </c:pt>
                <c:pt idx="847">
                  <c:v>25.990338164251199</c:v>
                </c:pt>
                <c:pt idx="848">
                  <c:v>24.692640692640687</c:v>
                </c:pt>
                <c:pt idx="849">
                  <c:v>24.056879966541199</c:v>
                </c:pt>
                <c:pt idx="850">
                  <c:v>24.307351077313101</c:v>
                </c:pt>
                <c:pt idx="851">
                  <c:v>24.492688413948287</c:v>
                </c:pt>
                <c:pt idx="852">
                  <c:v>24.464912280701764</c:v>
                </c:pt>
                <c:pt idx="853">
                  <c:v>23.866978193146434</c:v>
                </c:pt>
                <c:pt idx="854">
                  <c:v>23.480274779195277</c:v>
                </c:pt>
                <c:pt idx="855">
                  <c:v>24.240010116337881</c:v>
                </c:pt>
                <c:pt idx="856">
                  <c:v>25.157127991675299</c:v>
                </c:pt>
                <c:pt idx="857">
                  <c:v>23.922911918487699</c:v>
                </c:pt>
                <c:pt idx="858">
                  <c:v>24.691724137930986</c:v>
                </c:pt>
                <c:pt idx="859">
                  <c:v>22.290819470117089</c:v>
                </c:pt>
                <c:pt idx="860">
                  <c:v>22.688612099644089</c:v>
                </c:pt>
                <c:pt idx="861">
                  <c:v>24.970769582096374</c:v>
                </c:pt>
                <c:pt idx="862">
                  <c:v>24.322208842250099</c:v>
                </c:pt>
                <c:pt idx="863">
                  <c:v>24.115874855156431</c:v>
                </c:pt>
                <c:pt idx="864">
                  <c:v>25.788504053058187</c:v>
                </c:pt>
                <c:pt idx="865">
                  <c:v>24.819420035149378</c:v>
                </c:pt>
                <c:pt idx="866">
                  <c:v>25.228166797797002</c:v>
                </c:pt>
                <c:pt idx="867">
                  <c:v>23.729096989966589</c:v>
                </c:pt>
                <c:pt idx="868">
                  <c:v>23.293279022403286</c:v>
                </c:pt>
                <c:pt idx="869">
                  <c:v>22.971028725755001</c:v>
                </c:pt>
                <c:pt idx="870">
                  <c:v>24.6183715360931</c:v>
                </c:pt>
                <c:pt idx="871">
                  <c:v>23.796039922730174</c:v>
                </c:pt>
                <c:pt idx="872">
                  <c:v>22.103578629032317</c:v>
                </c:pt>
                <c:pt idx="873">
                  <c:v>24.251883239171377</c:v>
                </c:pt>
                <c:pt idx="874">
                  <c:v>23.993802209646987</c:v>
                </c:pt>
                <c:pt idx="875">
                  <c:v>22.787499999999977</c:v>
                </c:pt>
                <c:pt idx="876">
                  <c:v>25.21131741821403</c:v>
                </c:pt>
                <c:pt idx="877">
                  <c:v>24.259124087591189</c:v>
                </c:pt>
                <c:pt idx="878">
                  <c:v>23.370018281535589</c:v>
                </c:pt>
                <c:pt idx="879">
                  <c:v>22.812987012987001</c:v>
                </c:pt>
                <c:pt idx="880">
                  <c:v>23.446679687499977</c:v>
                </c:pt>
                <c:pt idx="881">
                  <c:v>26.276223776223777</c:v>
                </c:pt>
                <c:pt idx="882">
                  <c:v>25.048780487804887</c:v>
                </c:pt>
                <c:pt idx="883">
                  <c:v>23.674897119341626</c:v>
                </c:pt>
                <c:pt idx="884">
                  <c:v>21.431412200876277</c:v>
                </c:pt>
                <c:pt idx="885">
                  <c:v>22.109734513274287</c:v>
                </c:pt>
                <c:pt idx="886">
                  <c:v>22.804226227470501</c:v>
                </c:pt>
                <c:pt idx="887">
                  <c:v>22.972135253600499</c:v>
                </c:pt>
                <c:pt idx="888">
                  <c:v>20.750455373406201</c:v>
                </c:pt>
                <c:pt idx="889">
                  <c:v>22.189572116746987</c:v>
                </c:pt>
                <c:pt idx="890">
                  <c:v>24.918472652218799</c:v>
                </c:pt>
                <c:pt idx="891">
                  <c:v>25.160097769630301</c:v>
                </c:pt>
                <c:pt idx="892">
                  <c:v>24.374162096282816</c:v>
                </c:pt>
                <c:pt idx="893">
                  <c:v>23.484934086628989</c:v>
                </c:pt>
                <c:pt idx="894">
                  <c:v>21.398713826366578</c:v>
                </c:pt>
                <c:pt idx="895">
                  <c:v>25.131034482758619</c:v>
                </c:pt>
                <c:pt idx="896">
                  <c:v>23.133896713615034</c:v>
                </c:pt>
                <c:pt idx="897">
                  <c:v>24.189416307063379</c:v>
                </c:pt>
                <c:pt idx="898">
                  <c:v>22.740024681201177</c:v>
                </c:pt>
                <c:pt idx="899">
                  <c:v>23.091488006792598</c:v>
                </c:pt>
                <c:pt idx="900">
                  <c:v>24.510783978089702</c:v>
                </c:pt>
                <c:pt idx="901">
                  <c:v>20.516888433981617</c:v>
                </c:pt>
                <c:pt idx="902">
                  <c:v>24.035634290368574</c:v>
                </c:pt>
                <c:pt idx="903">
                  <c:v>22.749042145593876</c:v>
                </c:pt>
                <c:pt idx="904">
                  <c:v>22.926866820631286</c:v>
                </c:pt>
                <c:pt idx="905">
                  <c:v>23.020605112154399</c:v>
                </c:pt>
                <c:pt idx="906">
                  <c:v>24.823069767441901</c:v>
                </c:pt>
                <c:pt idx="907">
                  <c:v>23.779635258358699</c:v>
                </c:pt>
                <c:pt idx="908">
                  <c:v>22.960079840319359</c:v>
                </c:pt>
                <c:pt idx="909">
                  <c:v>23.308259587020689</c:v>
                </c:pt>
                <c:pt idx="910">
                  <c:v>24.2494854790761</c:v>
                </c:pt>
                <c:pt idx="911">
                  <c:v>24.989761092150189</c:v>
                </c:pt>
                <c:pt idx="912">
                  <c:v>20.529787234042587</c:v>
                </c:pt>
                <c:pt idx="913">
                  <c:v>24.222222222222175</c:v>
                </c:pt>
                <c:pt idx="914">
                  <c:v>23.962109955423475</c:v>
                </c:pt>
                <c:pt idx="915">
                  <c:v>24.395167022032705</c:v>
                </c:pt>
                <c:pt idx="916">
                  <c:v>24.465085638998687</c:v>
                </c:pt>
                <c:pt idx="917">
                  <c:v>23.365143369175573</c:v>
                </c:pt>
                <c:pt idx="918">
                  <c:v>22.410681399631699</c:v>
                </c:pt>
                <c:pt idx="919">
                  <c:v>26.448179271708664</c:v>
                </c:pt>
                <c:pt idx="920">
                  <c:v>23.532186732186702</c:v>
                </c:pt>
                <c:pt idx="921">
                  <c:v>24.671254300907101</c:v>
                </c:pt>
                <c:pt idx="922">
                  <c:v>22.531146767343099</c:v>
                </c:pt>
                <c:pt idx="923">
                  <c:v>23.921019108280287</c:v>
                </c:pt>
                <c:pt idx="924">
                  <c:v>26.312437810945276</c:v>
                </c:pt>
                <c:pt idx="925">
                  <c:v>23.389041597947589</c:v>
                </c:pt>
                <c:pt idx="926">
                  <c:v>23.192334494773487</c:v>
                </c:pt>
                <c:pt idx="927">
                  <c:v>23.907423971377476</c:v>
                </c:pt>
                <c:pt idx="928">
                  <c:v>21.823129251700689</c:v>
                </c:pt>
                <c:pt idx="929">
                  <c:v>21.8562691131498</c:v>
                </c:pt>
                <c:pt idx="930">
                  <c:v>18.906832298136589</c:v>
                </c:pt>
                <c:pt idx="931">
                  <c:v>24.351103931071599</c:v>
                </c:pt>
                <c:pt idx="932">
                  <c:v>24.0535836177474</c:v>
                </c:pt>
                <c:pt idx="933">
                  <c:v>24.789709172259489</c:v>
                </c:pt>
                <c:pt idx="934">
                  <c:v>22.854850474106534</c:v>
                </c:pt>
                <c:pt idx="935">
                  <c:v>23.973141891891878</c:v>
                </c:pt>
                <c:pt idx="936">
                  <c:v>23.431441913117286</c:v>
                </c:pt>
                <c:pt idx="937">
                  <c:v>24.047013977128277</c:v>
                </c:pt>
                <c:pt idx="938">
                  <c:v>25.537160552644117</c:v>
                </c:pt>
                <c:pt idx="939">
                  <c:v>24.334030197444818</c:v>
                </c:pt>
                <c:pt idx="940">
                  <c:v>24.455186304128876</c:v>
                </c:pt>
                <c:pt idx="941">
                  <c:v>23.502647150420376</c:v>
                </c:pt>
                <c:pt idx="942">
                  <c:v>23.623556581986087</c:v>
                </c:pt>
                <c:pt idx="943">
                  <c:v>22.6812933025404</c:v>
                </c:pt>
                <c:pt idx="944">
                  <c:v>25.054112554112599</c:v>
                </c:pt>
                <c:pt idx="945">
                  <c:v>24.248404934070589</c:v>
                </c:pt>
                <c:pt idx="946">
                  <c:v>24.375752105896517</c:v>
                </c:pt>
                <c:pt idx="947">
                  <c:v>23.723239046034376</c:v>
                </c:pt>
                <c:pt idx="948">
                  <c:v>23.6908502772643</c:v>
                </c:pt>
                <c:pt idx="949">
                  <c:v>23.459504132231402</c:v>
                </c:pt>
                <c:pt idx="950">
                  <c:v>23.455834242093786</c:v>
                </c:pt>
                <c:pt idx="951">
                  <c:v>24.173451327433618</c:v>
                </c:pt>
                <c:pt idx="952">
                  <c:v>22.817432273262689</c:v>
                </c:pt>
                <c:pt idx="953">
                  <c:v>26.474786324786287</c:v>
                </c:pt>
                <c:pt idx="954">
                  <c:v>18.428571428571377</c:v>
                </c:pt>
                <c:pt idx="955">
                  <c:v>23.015999999999988</c:v>
                </c:pt>
                <c:pt idx="956">
                  <c:v>23.770843258694601</c:v>
                </c:pt>
                <c:pt idx="957">
                  <c:v>19.822857142857117</c:v>
                </c:pt>
                <c:pt idx="958">
                  <c:v>22.591942148760289</c:v>
                </c:pt>
                <c:pt idx="959">
                  <c:v>24.984819734345376</c:v>
                </c:pt>
                <c:pt idx="960">
                  <c:v>23.810511756569799</c:v>
                </c:pt>
                <c:pt idx="961">
                  <c:v>25.383145363408516</c:v>
                </c:pt>
                <c:pt idx="962">
                  <c:v>21.565504587155964</c:v>
                </c:pt>
                <c:pt idx="963">
                  <c:v>21.784530386740276</c:v>
                </c:pt>
                <c:pt idx="964">
                  <c:v>25.211699164345401</c:v>
                </c:pt>
                <c:pt idx="965">
                  <c:v>24.002524093620877</c:v>
                </c:pt>
                <c:pt idx="966">
                  <c:v>20.5524781341108</c:v>
                </c:pt>
                <c:pt idx="967">
                  <c:v>22.756325418450817</c:v>
                </c:pt>
                <c:pt idx="968">
                  <c:v>22.144609425435799</c:v>
                </c:pt>
                <c:pt idx="969">
                  <c:v>23.530136098509377</c:v>
                </c:pt>
                <c:pt idx="970">
                  <c:v>22.567747802364362</c:v>
                </c:pt>
                <c:pt idx="971">
                  <c:v>24.362834089762973</c:v>
                </c:pt>
                <c:pt idx="972">
                  <c:v>22.838362068965488</c:v>
                </c:pt>
                <c:pt idx="973">
                  <c:v>25.655228758169887</c:v>
                </c:pt>
                <c:pt idx="974">
                  <c:v>25.429936305732486</c:v>
                </c:pt>
                <c:pt idx="975">
                  <c:v>22.822884012539188</c:v>
                </c:pt>
                <c:pt idx="976">
                  <c:v>22.960137028962876</c:v>
                </c:pt>
                <c:pt idx="977">
                  <c:v>17.851851851851926</c:v>
                </c:pt>
                <c:pt idx="978">
                  <c:v>23.529411764705888</c:v>
                </c:pt>
                <c:pt idx="979">
                  <c:v>22.566145445519989</c:v>
                </c:pt>
                <c:pt idx="980">
                  <c:v>24.291452991452999</c:v>
                </c:pt>
                <c:pt idx="981">
                  <c:v>23.095132743362775</c:v>
                </c:pt>
                <c:pt idx="982">
                  <c:v>23.627058299955518</c:v>
                </c:pt>
                <c:pt idx="983">
                  <c:v>23.367755532139089</c:v>
                </c:pt>
                <c:pt idx="984">
                  <c:v>24.746666666666702</c:v>
                </c:pt>
                <c:pt idx="985">
                  <c:v>24.165682802046376</c:v>
                </c:pt>
                <c:pt idx="986">
                  <c:v>24.957227722772299</c:v>
                </c:pt>
                <c:pt idx="987">
                  <c:v>23.275130305286702</c:v>
                </c:pt>
                <c:pt idx="988">
                  <c:v>23.3325737074491</c:v>
                </c:pt>
                <c:pt idx="989">
                  <c:v>24.0072563247696</c:v>
                </c:pt>
                <c:pt idx="990">
                  <c:v>20.8888888888889</c:v>
                </c:pt>
                <c:pt idx="991">
                  <c:v>24.746710526315773</c:v>
                </c:pt>
                <c:pt idx="992">
                  <c:v>18.017811704834635</c:v>
                </c:pt>
                <c:pt idx="993">
                  <c:v>21.644710578842286</c:v>
                </c:pt>
                <c:pt idx="994">
                  <c:v>23.539123630672886</c:v>
                </c:pt>
                <c:pt idx="995">
                  <c:v>47.698179142909822</c:v>
                </c:pt>
                <c:pt idx="996">
                  <c:v>67.393559704297786</c:v>
                </c:pt>
                <c:pt idx="997">
                  <c:v>23.397653596789102</c:v>
                </c:pt>
                <c:pt idx="998">
                  <c:v>23.030542210020577</c:v>
                </c:pt>
                <c:pt idx="999">
                  <c:v>23.281690140845086</c:v>
                </c:pt>
                <c:pt idx="1000">
                  <c:v>24.187166725915418</c:v>
                </c:pt>
                <c:pt idx="1001">
                  <c:v>24.625687757909187</c:v>
                </c:pt>
                <c:pt idx="1002">
                  <c:v>23.362979922507886</c:v>
                </c:pt>
                <c:pt idx="1003">
                  <c:v>21.881544502617789</c:v>
                </c:pt>
                <c:pt idx="1004">
                  <c:v>23.079059829059801</c:v>
                </c:pt>
                <c:pt idx="1005">
                  <c:v>23.873475609756117</c:v>
                </c:pt>
                <c:pt idx="1006">
                  <c:v>22.494815668202818</c:v>
                </c:pt>
                <c:pt idx="1007">
                  <c:v>24.655343827671889</c:v>
                </c:pt>
                <c:pt idx="1008">
                  <c:v>20.968190854870777</c:v>
                </c:pt>
                <c:pt idx="1009">
                  <c:v>22.164713140036987</c:v>
                </c:pt>
                <c:pt idx="1010">
                  <c:v>23.287784299339677</c:v>
                </c:pt>
                <c:pt idx="1011">
                  <c:v>24.983085388220889</c:v>
                </c:pt>
                <c:pt idx="1012">
                  <c:v>23.155689870779476</c:v>
                </c:pt>
                <c:pt idx="1013">
                  <c:v>23.912807676261973</c:v>
                </c:pt>
                <c:pt idx="1014">
                  <c:v>24.903501945525264</c:v>
                </c:pt>
                <c:pt idx="1015">
                  <c:v>24.495372318047973</c:v>
                </c:pt>
                <c:pt idx="1016">
                  <c:v>23.869328493647899</c:v>
                </c:pt>
                <c:pt idx="1017">
                  <c:v>22.262170611880286</c:v>
                </c:pt>
                <c:pt idx="1018">
                  <c:v>23.220367278797976</c:v>
                </c:pt>
                <c:pt idx="1019">
                  <c:v>24.1838377334192</c:v>
                </c:pt>
                <c:pt idx="1020">
                  <c:v>24.481626270523737</c:v>
                </c:pt>
                <c:pt idx="1021">
                  <c:v>24.120029728725378</c:v>
                </c:pt>
                <c:pt idx="1022">
                  <c:v>24.719474497681617</c:v>
                </c:pt>
                <c:pt idx="1023">
                  <c:v>22.117196702002431</c:v>
                </c:pt>
                <c:pt idx="1024">
                  <c:v>23.527647809442787</c:v>
                </c:pt>
                <c:pt idx="1025">
                  <c:v>23.526751241036987</c:v>
                </c:pt>
                <c:pt idx="1026">
                  <c:v>23.055740828966176</c:v>
                </c:pt>
                <c:pt idx="1027">
                  <c:v>24.155974338412218</c:v>
                </c:pt>
                <c:pt idx="1028">
                  <c:v>25.776678356713401</c:v>
                </c:pt>
                <c:pt idx="1029">
                  <c:v>22.895535203205487</c:v>
                </c:pt>
                <c:pt idx="1030">
                  <c:v>22.059134322292216</c:v>
                </c:pt>
                <c:pt idx="1031">
                  <c:v>22.927326295114177</c:v>
                </c:pt>
                <c:pt idx="1032">
                  <c:v>22.339767579279087</c:v>
                </c:pt>
                <c:pt idx="1033">
                  <c:v>21.734909596662</c:v>
                </c:pt>
                <c:pt idx="1034">
                  <c:v>23.853083853083888</c:v>
                </c:pt>
                <c:pt idx="1035">
                  <c:v>21.452830188679187</c:v>
                </c:pt>
                <c:pt idx="1036">
                  <c:v>22.691476590636299</c:v>
                </c:pt>
                <c:pt idx="1037">
                  <c:v>21.3440145102781</c:v>
                </c:pt>
                <c:pt idx="1038">
                  <c:v>24.056542810985476</c:v>
                </c:pt>
                <c:pt idx="1039">
                  <c:v>24.7857351651564</c:v>
                </c:pt>
                <c:pt idx="1040">
                  <c:v>22.759020044543377</c:v>
                </c:pt>
                <c:pt idx="1041">
                  <c:v>23.177479492915701</c:v>
                </c:pt>
                <c:pt idx="1042">
                  <c:v>15.095465393794704</c:v>
                </c:pt>
                <c:pt idx="1043">
                  <c:v>21.328178694158101</c:v>
                </c:pt>
                <c:pt idx="1044">
                  <c:v>19.145009416195887</c:v>
                </c:pt>
                <c:pt idx="1045">
                  <c:v>24.212655601659801</c:v>
                </c:pt>
                <c:pt idx="1046">
                  <c:v>23.524921507064388</c:v>
                </c:pt>
                <c:pt idx="1047">
                  <c:v>22.565989304812799</c:v>
                </c:pt>
                <c:pt idx="1048">
                  <c:v>23.493480441323964</c:v>
                </c:pt>
                <c:pt idx="1049">
                  <c:v>24.327358987875598</c:v>
                </c:pt>
                <c:pt idx="1050">
                  <c:v>24.089766081871275</c:v>
                </c:pt>
                <c:pt idx="1051">
                  <c:v>22.067843470863487</c:v>
                </c:pt>
                <c:pt idx="1052">
                  <c:v>21.733108108108105</c:v>
                </c:pt>
                <c:pt idx="1053">
                  <c:v>25.106730386300281</c:v>
                </c:pt>
                <c:pt idx="1054">
                  <c:v>22.929022082018889</c:v>
                </c:pt>
                <c:pt idx="1055">
                  <c:v>23.043362831858389</c:v>
                </c:pt>
                <c:pt idx="1056">
                  <c:v>23.506439742410286</c:v>
                </c:pt>
                <c:pt idx="1057">
                  <c:v>26.234883720930217</c:v>
                </c:pt>
                <c:pt idx="1058">
                  <c:v>25.259562841530077</c:v>
                </c:pt>
                <c:pt idx="1059">
                  <c:v>23.807609696225789</c:v>
                </c:pt>
                <c:pt idx="1060">
                  <c:v>18.233313987231586</c:v>
                </c:pt>
                <c:pt idx="1061">
                  <c:v>19.319907048799418</c:v>
                </c:pt>
                <c:pt idx="1062">
                  <c:v>21.150684931506799</c:v>
                </c:pt>
                <c:pt idx="1063">
                  <c:v>16.881236442516286</c:v>
                </c:pt>
                <c:pt idx="1064">
                  <c:v>21.046345811051687</c:v>
                </c:pt>
                <c:pt idx="1065">
                  <c:v>10.25</c:v>
                </c:pt>
                <c:pt idx="1066">
                  <c:v>13.132911392405099</c:v>
                </c:pt>
                <c:pt idx="1067">
                  <c:v>21.493680884676078</c:v>
                </c:pt>
                <c:pt idx="1068">
                  <c:v>23.109974424552444</c:v>
                </c:pt>
                <c:pt idx="1069">
                  <c:v>18.306444135373177</c:v>
                </c:pt>
                <c:pt idx="1070">
                  <c:v>14.4612403100775</c:v>
                </c:pt>
                <c:pt idx="1071">
                  <c:v>18.129292929292905</c:v>
                </c:pt>
                <c:pt idx="1072">
                  <c:v>17.808267370272599</c:v>
                </c:pt>
                <c:pt idx="1073">
                  <c:v>19.632911392405116</c:v>
                </c:pt>
                <c:pt idx="1074">
                  <c:v>16.8033946251768</c:v>
                </c:pt>
                <c:pt idx="1075">
                  <c:v>23.878693083072587</c:v>
                </c:pt>
                <c:pt idx="1076">
                  <c:v>22.589420654911777</c:v>
                </c:pt>
                <c:pt idx="1077">
                  <c:v>26.210784313725487</c:v>
                </c:pt>
                <c:pt idx="1078">
                  <c:v>22.157544026654026</c:v>
                </c:pt>
                <c:pt idx="1079">
                  <c:v>22.695526695526677</c:v>
                </c:pt>
                <c:pt idx="1080">
                  <c:v>23.457875457875534</c:v>
                </c:pt>
                <c:pt idx="1081">
                  <c:v>20.949341438703076</c:v>
                </c:pt>
                <c:pt idx="1082">
                  <c:v>18.839153439153399</c:v>
                </c:pt>
                <c:pt idx="1083">
                  <c:v>19.208791208791176</c:v>
                </c:pt>
                <c:pt idx="1084">
                  <c:v>17.563919532770864</c:v>
                </c:pt>
                <c:pt idx="1085">
                  <c:v>15.78832463217849</c:v>
                </c:pt>
                <c:pt idx="1086">
                  <c:v>23.620948802254617</c:v>
                </c:pt>
                <c:pt idx="1087">
                  <c:v>22.880534670008402</c:v>
                </c:pt>
                <c:pt idx="1088">
                  <c:v>21.394863563402918</c:v>
                </c:pt>
                <c:pt idx="1089">
                  <c:v>20.952919020715587</c:v>
                </c:pt>
                <c:pt idx="1090">
                  <c:v>20.85</c:v>
                </c:pt>
                <c:pt idx="1091">
                  <c:v>23.977572559366777</c:v>
                </c:pt>
                <c:pt idx="1092">
                  <c:v>20.986486486486488</c:v>
                </c:pt>
                <c:pt idx="1093">
                  <c:v>26.025865348041101</c:v>
                </c:pt>
                <c:pt idx="1094">
                  <c:v>15.799834574028109</c:v>
                </c:pt>
                <c:pt idx="1095">
                  <c:v>13.780080213903709</c:v>
                </c:pt>
                <c:pt idx="1096">
                  <c:v>16.759475218658917</c:v>
                </c:pt>
                <c:pt idx="1097">
                  <c:v>24.328837039737486</c:v>
                </c:pt>
                <c:pt idx="1098">
                  <c:v>24.229919678714889</c:v>
                </c:pt>
                <c:pt idx="1099">
                  <c:v>17.3533791523482</c:v>
                </c:pt>
                <c:pt idx="1100">
                  <c:v>14.851879699248109</c:v>
                </c:pt>
                <c:pt idx="1101">
                  <c:v>17.1994301994302</c:v>
                </c:pt>
                <c:pt idx="1102">
                  <c:v>16.471050750536101</c:v>
                </c:pt>
                <c:pt idx="1103">
                  <c:v>20.619033323326299</c:v>
                </c:pt>
                <c:pt idx="1104">
                  <c:v>21.317959682345801</c:v>
                </c:pt>
                <c:pt idx="1105">
                  <c:v>24.093838862559199</c:v>
                </c:pt>
                <c:pt idx="1106">
                  <c:v>21.6258573388203</c:v>
                </c:pt>
                <c:pt idx="1107">
                  <c:v>23.192697768762699</c:v>
                </c:pt>
                <c:pt idx="1108">
                  <c:v>23.273577844311376</c:v>
                </c:pt>
                <c:pt idx="1109">
                  <c:v>22.047844998022899</c:v>
                </c:pt>
                <c:pt idx="1110">
                  <c:v>22.695371367061401</c:v>
                </c:pt>
                <c:pt idx="1111">
                  <c:v>19.606903485254726</c:v>
                </c:pt>
                <c:pt idx="1112">
                  <c:v>22.949824970828502</c:v>
                </c:pt>
                <c:pt idx="1113">
                  <c:v>21.9846517119244</c:v>
                </c:pt>
                <c:pt idx="1114">
                  <c:v>22.820559610705587</c:v>
                </c:pt>
                <c:pt idx="1115">
                  <c:v>18.210361514375187</c:v>
                </c:pt>
                <c:pt idx="1116">
                  <c:v>24.1161309006661</c:v>
                </c:pt>
                <c:pt idx="1117">
                  <c:v>22.565114443567477</c:v>
                </c:pt>
                <c:pt idx="1118">
                  <c:v>21.188517179023489</c:v>
                </c:pt>
                <c:pt idx="1119">
                  <c:v>21.898576972833077</c:v>
                </c:pt>
                <c:pt idx="1120">
                  <c:v>17.799894403379099</c:v>
                </c:pt>
                <c:pt idx="1121">
                  <c:v>23.082583048742578</c:v>
                </c:pt>
                <c:pt idx="1122">
                  <c:v>22.124704025256534</c:v>
                </c:pt>
                <c:pt idx="1123">
                  <c:v>13.851980542043108</c:v>
                </c:pt>
                <c:pt idx="1124">
                  <c:v>16.586651917404101</c:v>
                </c:pt>
                <c:pt idx="1125">
                  <c:v>23.113295395757898</c:v>
                </c:pt>
                <c:pt idx="1126">
                  <c:v>25.790855803048117</c:v>
                </c:pt>
                <c:pt idx="1127">
                  <c:v>22.793989862418517</c:v>
                </c:pt>
                <c:pt idx="1128">
                  <c:v>24.3685545224007</c:v>
                </c:pt>
                <c:pt idx="1129">
                  <c:v>22.045576407506687</c:v>
                </c:pt>
                <c:pt idx="1130">
                  <c:v>23.774530271398689</c:v>
                </c:pt>
                <c:pt idx="1131">
                  <c:v>23.002202643171763</c:v>
                </c:pt>
                <c:pt idx="1132">
                  <c:v>23.713101160862418</c:v>
                </c:pt>
                <c:pt idx="1133">
                  <c:v>24.767757875231577</c:v>
                </c:pt>
                <c:pt idx="1134">
                  <c:v>21.9989648033126</c:v>
                </c:pt>
                <c:pt idx="1135">
                  <c:v>24.189604685212299</c:v>
                </c:pt>
                <c:pt idx="1136">
                  <c:v>23.6583210603829</c:v>
                </c:pt>
                <c:pt idx="1137">
                  <c:v>22.311970979443817</c:v>
                </c:pt>
                <c:pt idx="1138">
                  <c:v>21.508530183726975</c:v>
                </c:pt>
                <c:pt idx="1139">
                  <c:v>21.111856339247126</c:v>
                </c:pt>
                <c:pt idx="1140">
                  <c:v>19.783247612049976</c:v>
                </c:pt>
                <c:pt idx="1141">
                  <c:v>19.941558441558399</c:v>
                </c:pt>
                <c:pt idx="1142">
                  <c:v>17.350000000000001</c:v>
                </c:pt>
                <c:pt idx="1143">
                  <c:v>22.084558823529377</c:v>
                </c:pt>
                <c:pt idx="1144">
                  <c:v>25.246252676659488</c:v>
                </c:pt>
                <c:pt idx="1145">
                  <c:v>23.653846153846217</c:v>
                </c:pt>
                <c:pt idx="1146">
                  <c:v>19.927056827820188</c:v>
                </c:pt>
                <c:pt idx="1147">
                  <c:v>19.060606060606087</c:v>
                </c:pt>
                <c:pt idx="1148">
                  <c:v>19.191780821917799</c:v>
                </c:pt>
                <c:pt idx="1149">
                  <c:v>19.441389290882789</c:v>
                </c:pt>
                <c:pt idx="1150">
                  <c:v>20.623014169171299</c:v>
                </c:pt>
                <c:pt idx="1151">
                  <c:v>21.177835051546431</c:v>
                </c:pt>
                <c:pt idx="1152">
                  <c:v>20.824742268041177</c:v>
                </c:pt>
                <c:pt idx="1153">
                  <c:v>19.586056644880188</c:v>
                </c:pt>
                <c:pt idx="1154">
                  <c:v>18.0278481012658</c:v>
                </c:pt>
                <c:pt idx="1155">
                  <c:v>22.745098039215687</c:v>
                </c:pt>
                <c:pt idx="1156">
                  <c:v>20.417322834645677</c:v>
                </c:pt>
                <c:pt idx="1157">
                  <c:v>20.144124168514431</c:v>
                </c:pt>
                <c:pt idx="1158">
                  <c:v>20.582738944365154</c:v>
                </c:pt>
                <c:pt idx="1159">
                  <c:v>29.050561797752817</c:v>
                </c:pt>
                <c:pt idx="1160">
                  <c:v>23.026845637583889</c:v>
                </c:pt>
                <c:pt idx="1161">
                  <c:v>22.403361344537789</c:v>
                </c:pt>
                <c:pt idx="1162">
                  <c:v>21.749500333111264</c:v>
                </c:pt>
                <c:pt idx="1163">
                  <c:v>24.180191693290698</c:v>
                </c:pt>
                <c:pt idx="1164">
                  <c:v>25.556668086919501</c:v>
                </c:pt>
                <c:pt idx="1165">
                  <c:v>26.161407766990301</c:v>
                </c:pt>
                <c:pt idx="1166">
                  <c:v>16.979790940766573</c:v>
                </c:pt>
                <c:pt idx="1167">
                  <c:v>20.509184423218226</c:v>
                </c:pt>
                <c:pt idx="1168">
                  <c:v>19.752446982055481</c:v>
                </c:pt>
                <c:pt idx="1169">
                  <c:v>19.630252100840298</c:v>
                </c:pt>
                <c:pt idx="1170">
                  <c:v>23.3448275862069</c:v>
                </c:pt>
                <c:pt idx="1171">
                  <c:v>23.783277090363676</c:v>
                </c:pt>
                <c:pt idx="1172">
                  <c:v>23.386603995299588</c:v>
                </c:pt>
                <c:pt idx="1173">
                  <c:v>21.577799801783875</c:v>
                </c:pt>
                <c:pt idx="1174">
                  <c:v>23.695712309820173</c:v>
                </c:pt>
                <c:pt idx="1175">
                  <c:v>21.3908902691511</c:v>
                </c:pt>
                <c:pt idx="1176">
                  <c:v>20.687143336690188</c:v>
                </c:pt>
                <c:pt idx="1177">
                  <c:v>21.982414068744976</c:v>
                </c:pt>
                <c:pt idx="1178">
                  <c:v>21.402887139107602</c:v>
                </c:pt>
                <c:pt idx="1179">
                  <c:v>12.429553264604802</c:v>
                </c:pt>
                <c:pt idx="1180">
                  <c:v>19.646752015173089</c:v>
                </c:pt>
                <c:pt idx="1181">
                  <c:v>20.257142857142878</c:v>
                </c:pt>
                <c:pt idx="1182">
                  <c:v>20.613141683778199</c:v>
                </c:pt>
                <c:pt idx="1183">
                  <c:v>21.307111390811801</c:v>
                </c:pt>
                <c:pt idx="1184">
                  <c:v>25.664539007092188</c:v>
                </c:pt>
                <c:pt idx="1185">
                  <c:v>22.415089447757289</c:v>
                </c:pt>
                <c:pt idx="1186">
                  <c:v>25.212892483349187</c:v>
                </c:pt>
                <c:pt idx="1187">
                  <c:v>22.290524433849789</c:v>
                </c:pt>
                <c:pt idx="1188">
                  <c:v>24.441543166313789</c:v>
                </c:pt>
                <c:pt idx="1189">
                  <c:v>23.011649959360589</c:v>
                </c:pt>
                <c:pt idx="1190">
                  <c:v>22.536823425022217</c:v>
                </c:pt>
                <c:pt idx="1191">
                  <c:v>23.6654977595948</c:v>
                </c:pt>
                <c:pt idx="1192">
                  <c:v>24.008976964769602</c:v>
                </c:pt>
                <c:pt idx="1193">
                  <c:v>23.939148494288698</c:v>
                </c:pt>
                <c:pt idx="1194">
                  <c:v>24.088133459238289</c:v>
                </c:pt>
                <c:pt idx="1195">
                  <c:v>21.6795837818443</c:v>
                </c:pt>
                <c:pt idx="1196">
                  <c:v>23.609555189456334</c:v>
                </c:pt>
                <c:pt idx="1197">
                  <c:v>23.937998228520801</c:v>
                </c:pt>
                <c:pt idx="1198">
                  <c:v>22.992048545720859</c:v>
                </c:pt>
                <c:pt idx="1199">
                  <c:v>22.329102238633673</c:v>
                </c:pt>
                <c:pt idx="1200">
                  <c:v>24.2469317623957</c:v>
                </c:pt>
                <c:pt idx="1201">
                  <c:v>23.923335309227376</c:v>
                </c:pt>
                <c:pt idx="1202">
                  <c:v>23.910943223443187</c:v>
                </c:pt>
                <c:pt idx="1203">
                  <c:v>25.645698427382101</c:v>
                </c:pt>
                <c:pt idx="1204">
                  <c:v>22.347262714609698</c:v>
                </c:pt>
                <c:pt idx="1205">
                  <c:v>24.515500442869786</c:v>
                </c:pt>
                <c:pt idx="1206">
                  <c:v>25.550853570569789</c:v>
                </c:pt>
                <c:pt idx="1207">
                  <c:v>25.014055636896035</c:v>
                </c:pt>
                <c:pt idx="1208">
                  <c:v>21.670378619153698</c:v>
                </c:pt>
                <c:pt idx="1209">
                  <c:v>25.014687100894026</c:v>
                </c:pt>
                <c:pt idx="1210">
                  <c:v>15.351050679851706</c:v>
                </c:pt>
                <c:pt idx="1211">
                  <c:v>19.793267798629699</c:v>
                </c:pt>
                <c:pt idx="1212">
                  <c:v>19.925393258426976</c:v>
                </c:pt>
                <c:pt idx="1213">
                  <c:v>15.4266331658291</c:v>
                </c:pt>
                <c:pt idx="1214">
                  <c:v>18.791917973461977</c:v>
                </c:pt>
                <c:pt idx="1215">
                  <c:v>18.443490304709076</c:v>
                </c:pt>
                <c:pt idx="1216">
                  <c:v>22.111360239162899</c:v>
                </c:pt>
                <c:pt idx="1217">
                  <c:v>20.610185476265301</c:v>
                </c:pt>
                <c:pt idx="1218">
                  <c:v>21.292255236239686</c:v>
                </c:pt>
                <c:pt idx="1219">
                  <c:v>24.128550074738389</c:v>
                </c:pt>
                <c:pt idx="1220">
                  <c:v>22.1395222584148</c:v>
                </c:pt>
                <c:pt idx="1221">
                  <c:v>20.561465721040218</c:v>
                </c:pt>
                <c:pt idx="1222">
                  <c:v>21.8591715976331</c:v>
                </c:pt>
                <c:pt idx="1223">
                  <c:v>22.398139236445264</c:v>
                </c:pt>
                <c:pt idx="1224">
                  <c:v>20.942557442557376</c:v>
                </c:pt>
                <c:pt idx="1225">
                  <c:v>19.477707006369378</c:v>
                </c:pt>
                <c:pt idx="1226">
                  <c:v>17.347509113001188</c:v>
                </c:pt>
                <c:pt idx="1227">
                  <c:v>18.022029897718276</c:v>
                </c:pt>
                <c:pt idx="1228">
                  <c:v>20.615244457941099</c:v>
                </c:pt>
                <c:pt idx="1229">
                  <c:v>24.798025816249087</c:v>
                </c:pt>
                <c:pt idx="1230">
                  <c:v>24.313144908030505</c:v>
                </c:pt>
                <c:pt idx="1231">
                  <c:v>23.391720729070101</c:v>
                </c:pt>
                <c:pt idx="1232">
                  <c:v>21.862238622386187</c:v>
                </c:pt>
                <c:pt idx="1233">
                  <c:v>17.62587412587413</c:v>
                </c:pt>
                <c:pt idx="1234">
                  <c:v>18.373595505617999</c:v>
                </c:pt>
                <c:pt idx="1235">
                  <c:v>24.201817312290817</c:v>
                </c:pt>
                <c:pt idx="1236">
                  <c:v>20.115686274509777</c:v>
                </c:pt>
                <c:pt idx="1237">
                  <c:v>19.110759493670901</c:v>
                </c:pt>
                <c:pt idx="1238">
                  <c:v>17.6329497274379</c:v>
                </c:pt>
                <c:pt idx="1239">
                  <c:v>19.306088126471618</c:v>
                </c:pt>
                <c:pt idx="1240">
                  <c:v>18.0419261104193</c:v>
                </c:pt>
                <c:pt idx="1241">
                  <c:v>21.841063698206618</c:v>
                </c:pt>
                <c:pt idx="1242">
                  <c:v>19.8696947133284</c:v>
                </c:pt>
                <c:pt idx="1243">
                  <c:v>22.422766345402376</c:v>
                </c:pt>
                <c:pt idx="1244">
                  <c:v>22.343786982248499</c:v>
                </c:pt>
                <c:pt idx="1245">
                  <c:v>19.082142857142863</c:v>
                </c:pt>
                <c:pt idx="1246">
                  <c:v>21.322116619573578</c:v>
                </c:pt>
                <c:pt idx="1247">
                  <c:v>18.065217391304277</c:v>
                </c:pt>
                <c:pt idx="1248">
                  <c:v>20.266057748968802</c:v>
                </c:pt>
                <c:pt idx="1249">
                  <c:v>19.6345890410959</c:v>
                </c:pt>
                <c:pt idx="1250">
                  <c:v>21.565789473684177</c:v>
                </c:pt>
                <c:pt idx="1251">
                  <c:v>18.934999999999999</c:v>
                </c:pt>
                <c:pt idx="1252">
                  <c:v>20.109333333333275</c:v>
                </c:pt>
                <c:pt idx="1253">
                  <c:v>22.957868303571399</c:v>
                </c:pt>
                <c:pt idx="1254">
                  <c:v>24.045000000000002</c:v>
                </c:pt>
                <c:pt idx="1255">
                  <c:v>23.750895044281101</c:v>
                </c:pt>
                <c:pt idx="1256">
                  <c:v>21.617187500000018</c:v>
                </c:pt>
                <c:pt idx="1257">
                  <c:v>20.895206766917287</c:v>
                </c:pt>
                <c:pt idx="1258">
                  <c:v>15.004366812227104</c:v>
                </c:pt>
                <c:pt idx="1259">
                  <c:v>18.179644808743173</c:v>
                </c:pt>
                <c:pt idx="1260">
                  <c:v>22.8526077097506</c:v>
                </c:pt>
                <c:pt idx="1261">
                  <c:v>20.715101193565086</c:v>
                </c:pt>
                <c:pt idx="1262">
                  <c:v>22.0993314231137</c:v>
                </c:pt>
                <c:pt idx="1263">
                  <c:v>19.593137254901976</c:v>
                </c:pt>
                <c:pt idx="1264">
                  <c:v>16.653968253968301</c:v>
                </c:pt>
                <c:pt idx="1265">
                  <c:v>22.707061900610316</c:v>
                </c:pt>
                <c:pt idx="1266">
                  <c:v>23.5377442273535</c:v>
                </c:pt>
                <c:pt idx="1267">
                  <c:v>25.623863636363588</c:v>
                </c:pt>
                <c:pt idx="1268">
                  <c:v>23.942191053828687</c:v>
                </c:pt>
                <c:pt idx="1269">
                  <c:v>22.622454520771086</c:v>
                </c:pt>
                <c:pt idx="1270">
                  <c:v>22.801175318315426</c:v>
                </c:pt>
                <c:pt idx="1271">
                  <c:v>23.550892426435105</c:v>
                </c:pt>
                <c:pt idx="1272">
                  <c:v>25.257597173144902</c:v>
                </c:pt>
                <c:pt idx="1273">
                  <c:v>24.127543273610687</c:v>
                </c:pt>
                <c:pt idx="1274">
                  <c:v>22.701232032854186</c:v>
                </c:pt>
                <c:pt idx="1275">
                  <c:v>21.339568719147817</c:v>
                </c:pt>
                <c:pt idx="1276">
                  <c:v>19.923206466823789</c:v>
                </c:pt>
                <c:pt idx="1277">
                  <c:v>20.013789581205277</c:v>
                </c:pt>
                <c:pt idx="1278">
                  <c:v>22.952178533474989</c:v>
                </c:pt>
                <c:pt idx="1279">
                  <c:v>24.282706766917276</c:v>
                </c:pt>
                <c:pt idx="1280">
                  <c:v>23.651904340123988</c:v>
                </c:pt>
                <c:pt idx="1281">
                  <c:v>24.614035087719301</c:v>
                </c:pt>
                <c:pt idx="1282">
                  <c:v>26.320537428022988</c:v>
                </c:pt>
                <c:pt idx="1283">
                  <c:v>25.7744056651492</c:v>
                </c:pt>
                <c:pt idx="1284">
                  <c:v>24.363161069776801</c:v>
                </c:pt>
                <c:pt idx="1285">
                  <c:v>27.754250386398805</c:v>
                </c:pt>
                <c:pt idx="1286">
                  <c:v>23.402035623409699</c:v>
                </c:pt>
                <c:pt idx="1287">
                  <c:v>24.0780830406941</c:v>
                </c:pt>
                <c:pt idx="1288">
                  <c:v>19.722588144130189</c:v>
                </c:pt>
                <c:pt idx="1289">
                  <c:v>24.232031249999977</c:v>
                </c:pt>
                <c:pt idx="1290">
                  <c:v>22.0162622612287</c:v>
                </c:pt>
                <c:pt idx="1291">
                  <c:v>21.9939733103745</c:v>
                </c:pt>
                <c:pt idx="1292">
                  <c:v>21.281400137268378</c:v>
                </c:pt>
                <c:pt idx="1293">
                  <c:v>20.635123239436599</c:v>
                </c:pt>
                <c:pt idx="1294">
                  <c:v>18.436230248306977</c:v>
                </c:pt>
                <c:pt idx="1295">
                  <c:v>18.283302063789876</c:v>
                </c:pt>
                <c:pt idx="1296">
                  <c:v>16.956416464890999</c:v>
                </c:pt>
                <c:pt idx="1297">
                  <c:v>22.775981524249399</c:v>
                </c:pt>
                <c:pt idx="1298">
                  <c:v>19.503546099290787</c:v>
                </c:pt>
                <c:pt idx="1299">
                  <c:v>22.400290065264699</c:v>
                </c:pt>
                <c:pt idx="1300">
                  <c:v>23.992092020129366</c:v>
                </c:pt>
                <c:pt idx="1301">
                  <c:v>21.857222532069176</c:v>
                </c:pt>
                <c:pt idx="1302">
                  <c:v>21.984675834970481</c:v>
                </c:pt>
                <c:pt idx="1303">
                  <c:v>17.914568345323687</c:v>
                </c:pt>
                <c:pt idx="1304">
                  <c:v>22.850299401197599</c:v>
                </c:pt>
                <c:pt idx="1305">
                  <c:v>19.6070215175538</c:v>
                </c:pt>
                <c:pt idx="1306">
                  <c:v>23.347263681592</c:v>
                </c:pt>
                <c:pt idx="1307">
                  <c:v>22.0353649360421</c:v>
                </c:pt>
                <c:pt idx="1308">
                  <c:v>18.068521031207577</c:v>
                </c:pt>
                <c:pt idx="1309">
                  <c:v>18.422201138519878</c:v>
                </c:pt>
                <c:pt idx="1310">
                  <c:v>26.417227456258431</c:v>
                </c:pt>
                <c:pt idx="1311">
                  <c:v>19.199889867841399</c:v>
                </c:pt>
                <c:pt idx="1312">
                  <c:v>19.7028457974851</c:v>
                </c:pt>
                <c:pt idx="1313">
                  <c:v>21.562962962962978</c:v>
                </c:pt>
                <c:pt idx="1314">
                  <c:v>18.263223397635276</c:v>
                </c:pt>
                <c:pt idx="1315">
                  <c:v>21.435833629576987</c:v>
                </c:pt>
                <c:pt idx="1316">
                  <c:v>20.614457831325289</c:v>
                </c:pt>
                <c:pt idx="1317">
                  <c:v>20.8698529411765</c:v>
                </c:pt>
                <c:pt idx="1318">
                  <c:v>21.075437537718773</c:v>
                </c:pt>
                <c:pt idx="1319">
                  <c:v>23.357960741548535</c:v>
                </c:pt>
                <c:pt idx="1320">
                  <c:v>21.622961104140519</c:v>
                </c:pt>
                <c:pt idx="1321">
                  <c:v>21.241666666666699</c:v>
                </c:pt>
                <c:pt idx="1322">
                  <c:v>21.567615658362989</c:v>
                </c:pt>
                <c:pt idx="1323">
                  <c:v>24.578566256335979</c:v>
                </c:pt>
                <c:pt idx="1324">
                  <c:v>22.512217611802701</c:v>
                </c:pt>
                <c:pt idx="1325">
                  <c:v>20.420704182967164</c:v>
                </c:pt>
                <c:pt idx="1326">
                  <c:v>22.324742268041177</c:v>
                </c:pt>
                <c:pt idx="1327">
                  <c:v>23.758064516128989</c:v>
                </c:pt>
                <c:pt idx="1328">
                  <c:v>23.250237416904099</c:v>
                </c:pt>
                <c:pt idx="1329">
                  <c:v>22.216485078161973</c:v>
                </c:pt>
                <c:pt idx="1330">
                  <c:v>21.420534458509081</c:v>
                </c:pt>
                <c:pt idx="1331">
                  <c:v>24.655825702557618</c:v>
                </c:pt>
                <c:pt idx="1332">
                  <c:v>21.247083333333276</c:v>
                </c:pt>
                <c:pt idx="1333">
                  <c:v>20.163361661945199</c:v>
                </c:pt>
                <c:pt idx="1334">
                  <c:v>20.1914893617021</c:v>
                </c:pt>
                <c:pt idx="1335">
                  <c:v>14.500416319733612</c:v>
                </c:pt>
                <c:pt idx="1336">
                  <c:v>18.236157718120801</c:v>
                </c:pt>
                <c:pt idx="1337">
                  <c:v>13.702552204176309</c:v>
                </c:pt>
                <c:pt idx="1338">
                  <c:v>16.985883250667676</c:v>
                </c:pt>
                <c:pt idx="1339">
                  <c:v>18.875240847784177</c:v>
                </c:pt>
                <c:pt idx="1340">
                  <c:v>15.687466087900209</c:v>
                </c:pt>
                <c:pt idx="1341">
                  <c:v>16.803126320236601</c:v>
                </c:pt>
                <c:pt idx="1342">
                  <c:v>18.217102532170976</c:v>
                </c:pt>
                <c:pt idx="1343">
                  <c:v>13.439374735952699</c:v>
                </c:pt>
                <c:pt idx="1344">
                  <c:v>22.577195172700801</c:v>
                </c:pt>
                <c:pt idx="1345">
                  <c:v>17.358844765343001</c:v>
                </c:pt>
                <c:pt idx="1346">
                  <c:v>20.953801732435</c:v>
                </c:pt>
                <c:pt idx="1347">
                  <c:v>23.416138328530302</c:v>
                </c:pt>
                <c:pt idx="1348">
                  <c:v>22.522503516174371</c:v>
                </c:pt>
                <c:pt idx="1349">
                  <c:v>24.479977439368302</c:v>
                </c:pt>
                <c:pt idx="1350">
                  <c:v>21.861311914323974</c:v>
                </c:pt>
                <c:pt idx="1351">
                  <c:v>22.745571658615088</c:v>
                </c:pt>
                <c:pt idx="1352">
                  <c:v>21.728455284552787</c:v>
                </c:pt>
                <c:pt idx="1353">
                  <c:v>24.109644670050788</c:v>
                </c:pt>
                <c:pt idx="1354">
                  <c:v>16.170632617527573</c:v>
                </c:pt>
                <c:pt idx="1355">
                  <c:v>17.380422264875175</c:v>
                </c:pt>
                <c:pt idx="1356">
                  <c:v>11.789830508474608</c:v>
                </c:pt>
                <c:pt idx="1357">
                  <c:v>23.391041162227605</c:v>
                </c:pt>
                <c:pt idx="1358">
                  <c:v>25.394670507742202</c:v>
                </c:pt>
                <c:pt idx="1359">
                  <c:v>23.498462889767154</c:v>
                </c:pt>
                <c:pt idx="1360">
                  <c:v>22.660194174757287</c:v>
                </c:pt>
                <c:pt idx="1361">
                  <c:v>19.937971500419117</c:v>
                </c:pt>
                <c:pt idx="1362">
                  <c:v>24.996581196581189</c:v>
                </c:pt>
                <c:pt idx="1363">
                  <c:v>23.709325396825378</c:v>
                </c:pt>
                <c:pt idx="1364">
                  <c:v>20.7733689431515</c:v>
                </c:pt>
                <c:pt idx="1365">
                  <c:v>22.913551401869199</c:v>
                </c:pt>
                <c:pt idx="1366">
                  <c:v>22.248845087773276</c:v>
                </c:pt>
                <c:pt idx="1367">
                  <c:v>20.259859535386287</c:v>
                </c:pt>
                <c:pt idx="1368">
                  <c:v>23.861275964391705</c:v>
                </c:pt>
                <c:pt idx="1369">
                  <c:v>18.463126843657776</c:v>
                </c:pt>
                <c:pt idx="1370">
                  <c:v>17.309265175718817</c:v>
                </c:pt>
                <c:pt idx="1371">
                  <c:v>13.495012929442215</c:v>
                </c:pt>
                <c:pt idx="1372">
                  <c:v>15.675555555555615</c:v>
                </c:pt>
                <c:pt idx="1373">
                  <c:v>18.264512268102877</c:v>
                </c:pt>
                <c:pt idx="1374">
                  <c:v>15.287037037037004</c:v>
                </c:pt>
                <c:pt idx="1375">
                  <c:v>21.763157894736789</c:v>
                </c:pt>
                <c:pt idx="1376">
                  <c:v>18.033889731917</c:v>
                </c:pt>
                <c:pt idx="1377">
                  <c:v>20.301418439716301</c:v>
                </c:pt>
                <c:pt idx="1378">
                  <c:v>20.330655957162001</c:v>
                </c:pt>
                <c:pt idx="1379">
                  <c:v>18.688888888888901</c:v>
                </c:pt>
                <c:pt idx="1380">
                  <c:v>22.029480443666099</c:v>
                </c:pt>
                <c:pt idx="1381">
                  <c:v>24.719491234101081</c:v>
                </c:pt>
                <c:pt idx="1382">
                  <c:v>19.460386774797275</c:v>
                </c:pt>
                <c:pt idx="1383">
                  <c:v>22.395945945945886</c:v>
                </c:pt>
                <c:pt idx="1384">
                  <c:v>24.011235955056218</c:v>
                </c:pt>
                <c:pt idx="1385">
                  <c:v>23.885714285714275</c:v>
                </c:pt>
                <c:pt idx="1386">
                  <c:v>22.794210526315787</c:v>
                </c:pt>
                <c:pt idx="1387">
                  <c:v>19.824623560673189</c:v>
                </c:pt>
                <c:pt idx="1388">
                  <c:v>24.957606837606789</c:v>
                </c:pt>
                <c:pt idx="1389">
                  <c:v>22.097913322632426</c:v>
                </c:pt>
                <c:pt idx="1390">
                  <c:v>25.915404040403978</c:v>
                </c:pt>
                <c:pt idx="1391">
                  <c:v>14.770661157024801</c:v>
                </c:pt>
                <c:pt idx="1392">
                  <c:v>22.083333333333254</c:v>
                </c:pt>
                <c:pt idx="1393">
                  <c:v>22.640504770698701</c:v>
                </c:pt>
                <c:pt idx="1394">
                  <c:v>21.555408970976274</c:v>
                </c:pt>
                <c:pt idx="1395">
                  <c:v>19.8261802575107</c:v>
                </c:pt>
                <c:pt idx="1396">
                  <c:v>20.722222222222175</c:v>
                </c:pt>
                <c:pt idx="1397">
                  <c:v>22.533906399235899</c:v>
                </c:pt>
                <c:pt idx="1398">
                  <c:v>20.632478632478598</c:v>
                </c:pt>
                <c:pt idx="1399">
                  <c:v>20.714139344262289</c:v>
                </c:pt>
                <c:pt idx="1400">
                  <c:v>18.534353862584517</c:v>
                </c:pt>
                <c:pt idx="1401">
                  <c:v>19.068108974358989</c:v>
                </c:pt>
                <c:pt idx="1402">
                  <c:v>20.826685660019017</c:v>
                </c:pt>
                <c:pt idx="1403">
                  <c:v>21.5822784810127</c:v>
                </c:pt>
                <c:pt idx="1404">
                  <c:v>24.7419656786271</c:v>
                </c:pt>
                <c:pt idx="1405">
                  <c:v>24.6040955631399</c:v>
                </c:pt>
                <c:pt idx="1406">
                  <c:v>17.952595014303181</c:v>
                </c:pt>
                <c:pt idx="1407">
                  <c:v>18.088284286507474</c:v>
                </c:pt>
                <c:pt idx="1408">
                  <c:v>18.960499999999971</c:v>
                </c:pt>
                <c:pt idx="1409">
                  <c:v>20.206949412365876</c:v>
                </c:pt>
                <c:pt idx="1410">
                  <c:v>22.7740740740741</c:v>
                </c:pt>
                <c:pt idx="1411">
                  <c:v>22.142992424242419</c:v>
                </c:pt>
                <c:pt idx="1412">
                  <c:v>17.34375</c:v>
                </c:pt>
                <c:pt idx="1413">
                  <c:v>24.739230327398001</c:v>
                </c:pt>
                <c:pt idx="1414">
                  <c:v>21.970868014268717</c:v>
                </c:pt>
                <c:pt idx="1415">
                  <c:v>21.948199309324064</c:v>
                </c:pt>
                <c:pt idx="1416">
                  <c:v>18.628589263420686</c:v>
                </c:pt>
                <c:pt idx="1417">
                  <c:v>22.773833266852801</c:v>
                </c:pt>
                <c:pt idx="1418">
                  <c:v>20.916326530612189</c:v>
                </c:pt>
                <c:pt idx="1419">
                  <c:v>21.413948256467886</c:v>
                </c:pt>
                <c:pt idx="1420">
                  <c:v>15.082105263157899</c:v>
                </c:pt>
                <c:pt idx="1421">
                  <c:v>21.910835913312717</c:v>
                </c:pt>
                <c:pt idx="1422">
                  <c:v>21.296912114014301</c:v>
                </c:pt>
                <c:pt idx="1423">
                  <c:v>21.3208582834331</c:v>
                </c:pt>
                <c:pt idx="1424">
                  <c:v>20.454978354978426</c:v>
                </c:pt>
                <c:pt idx="1425">
                  <c:v>21.282102461743175</c:v>
                </c:pt>
                <c:pt idx="1426">
                  <c:v>25.047499999999989</c:v>
                </c:pt>
                <c:pt idx="1427">
                  <c:v>25.737857142857134</c:v>
                </c:pt>
                <c:pt idx="1428">
                  <c:v>24.1596638655462</c:v>
                </c:pt>
                <c:pt idx="1429">
                  <c:v>19.795093296475489</c:v>
                </c:pt>
                <c:pt idx="1430">
                  <c:v>21.308139534883676</c:v>
                </c:pt>
                <c:pt idx="1431">
                  <c:v>24.738916256157587</c:v>
                </c:pt>
                <c:pt idx="1432">
                  <c:v>23.008811911273199</c:v>
                </c:pt>
                <c:pt idx="1433">
                  <c:v>20.8939150401837</c:v>
                </c:pt>
                <c:pt idx="1434">
                  <c:v>23.480169050715176</c:v>
                </c:pt>
                <c:pt idx="1435">
                  <c:v>22.322987390882616</c:v>
                </c:pt>
                <c:pt idx="1436">
                  <c:v>21.314657980456026</c:v>
                </c:pt>
                <c:pt idx="1437">
                  <c:v>22.786524204099376</c:v>
                </c:pt>
                <c:pt idx="1438">
                  <c:v>22.647945917836726</c:v>
                </c:pt>
                <c:pt idx="1439">
                  <c:v>30.216981132075517</c:v>
                </c:pt>
                <c:pt idx="1440">
                  <c:v>23.314150304671617</c:v>
                </c:pt>
                <c:pt idx="1441">
                  <c:v>23.114006514658026</c:v>
                </c:pt>
                <c:pt idx="1442">
                  <c:v>23.052866242038199</c:v>
                </c:pt>
                <c:pt idx="1443">
                  <c:v>22.758834765998117</c:v>
                </c:pt>
                <c:pt idx="1444">
                  <c:v>20.907857368255033</c:v>
                </c:pt>
                <c:pt idx="1445">
                  <c:v>22.146850899742901</c:v>
                </c:pt>
                <c:pt idx="1446">
                  <c:v>22.510117145899901</c:v>
                </c:pt>
                <c:pt idx="1447">
                  <c:v>29.8098399525785</c:v>
                </c:pt>
                <c:pt idx="1448">
                  <c:v>22.5792483660131</c:v>
                </c:pt>
                <c:pt idx="1449">
                  <c:v>24.9136363636364</c:v>
                </c:pt>
                <c:pt idx="1450">
                  <c:v>23.525864909390418</c:v>
                </c:pt>
                <c:pt idx="1451">
                  <c:v>25.363636363636378</c:v>
                </c:pt>
                <c:pt idx="1452">
                  <c:v>20.18484848484853</c:v>
                </c:pt>
                <c:pt idx="1453">
                  <c:v>23.140625</c:v>
                </c:pt>
                <c:pt idx="1454">
                  <c:v>24.743943191311587</c:v>
                </c:pt>
                <c:pt idx="1455">
                  <c:v>22.000989119683517</c:v>
                </c:pt>
                <c:pt idx="1456">
                  <c:v>22.913978494623716</c:v>
                </c:pt>
                <c:pt idx="1457">
                  <c:v>20.366571699904988</c:v>
                </c:pt>
                <c:pt idx="1458">
                  <c:v>22.795795795795787</c:v>
                </c:pt>
                <c:pt idx="1459">
                  <c:v>23.980058916836601</c:v>
                </c:pt>
                <c:pt idx="1460">
                  <c:v>23.793116419033289</c:v>
                </c:pt>
                <c:pt idx="1461">
                  <c:v>22.235348493252001</c:v>
                </c:pt>
                <c:pt idx="1462">
                  <c:v>21.823227611940286</c:v>
                </c:pt>
                <c:pt idx="1463">
                  <c:v>23.053478325636817</c:v>
                </c:pt>
                <c:pt idx="1464">
                  <c:v>23.59690778575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1981224"/>
        <c:axId val="221984360"/>
      </c:barChart>
      <c:catAx>
        <c:axId val="2219812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10k bin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221984360"/>
        <c:crosses val="autoZero"/>
        <c:auto val="1"/>
        <c:lblAlgn val="ctr"/>
        <c:lblOffset val="100"/>
        <c:noMultiLvlLbl val="0"/>
      </c:catAx>
      <c:valAx>
        <c:axId val="2219843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219812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h144 depth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Sheet3!$C$2:$C$1466</c:f>
              <c:numCache>
                <c:formatCode>General</c:formatCode>
                <c:ptCount val="1465"/>
                <c:pt idx="0">
                  <c:v>18.992319508448489</c:v>
                </c:pt>
                <c:pt idx="1">
                  <c:v>17.404438964241699</c:v>
                </c:pt>
                <c:pt idx="2">
                  <c:v>16.724547803617586</c:v>
                </c:pt>
                <c:pt idx="3">
                  <c:v>16.096250000000001</c:v>
                </c:pt>
                <c:pt idx="4">
                  <c:v>17.406976744186</c:v>
                </c:pt>
                <c:pt idx="5">
                  <c:v>18.777149657839889</c:v>
                </c:pt>
                <c:pt idx="6">
                  <c:v>19.599855803893298</c:v>
                </c:pt>
                <c:pt idx="7">
                  <c:v>17.071473750790616</c:v>
                </c:pt>
                <c:pt idx="8">
                  <c:v>17.908801696712601</c:v>
                </c:pt>
                <c:pt idx="9">
                  <c:v>17.475444410967164</c:v>
                </c:pt>
                <c:pt idx="10">
                  <c:v>16.694415983606618</c:v>
                </c:pt>
                <c:pt idx="11">
                  <c:v>17.610738255033599</c:v>
                </c:pt>
                <c:pt idx="12">
                  <c:v>15.464810518174804</c:v>
                </c:pt>
                <c:pt idx="13">
                  <c:v>18.2393013100437</c:v>
                </c:pt>
                <c:pt idx="14">
                  <c:v>19.699743539159577</c:v>
                </c:pt>
                <c:pt idx="15">
                  <c:v>19.813234142521502</c:v>
                </c:pt>
                <c:pt idx="16">
                  <c:v>18.1173365814048</c:v>
                </c:pt>
                <c:pt idx="17">
                  <c:v>19.4162257495591</c:v>
                </c:pt>
                <c:pt idx="18">
                  <c:v>14.579784744969615</c:v>
                </c:pt>
                <c:pt idx="19">
                  <c:v>16.265483646485674</c:v>
                </c:pt>
                <c:pt idx="20">
                  <c:v>16.226069246435777</c:v>
                </c:pt>
                <c:pt idx="21">
                  <c:v>14.391809908999004</c:v>
                </c:pt>
                <c:pt idx="22">
                  <c:v>26.972281449893401</c:v>
                </c:pt>
                <c:pt idx="23">
                  <c:v>18.789702517162464</c:v>
                </c:pt>
                <c:pt idx="24">
                  <c:v>17.6773211567732</c:v>
                </c:pt>
                <c:pt idx="25">
                  <c:v>15.6009389671362</c:v>
                </c:pt>
                <c:pt idx="26">
                  <c:v>14.109350237717909</c:v>
                </c:pt>
                <c:pt idx="27">
                  <c:v>21.236994219653205</c:v>
                </c:pt>
                <c:pt idx="28">
                  <c:v>17.429274696422699</c:v>
                </c:pt>
                <c:pt idx="29">
                  <c:v>18.630749354005189</c:v>
                </c:pt>
                <c:pt idx="30">
                  <c:v>15.484052993130501</c:v>
                </c:pt>
                <c:pt idx="31">
                  <c:v>15.645938375350099</c:v>
                </c:pt>
                <c:pt idx="32">
                  <c:v>15.046176046176001</c:v>
                </c:pt>
                <c:pt idx="33">
                  <c:v>14.443711037770401</c:v>
                </c:pt>
                <c:pt idx="34">
                  <c:v>16.3249866808737</c:v>
                </c:pt>
                <c:pt idx="35">
                  <c:v>16.9174484052533</c:v>
                </c:pt>
                <c:pt idx="36">
                  <c:v>16.9393173198483</c:v>
                </c:pt>
                <c:pt idx="37">
                  <c:v>16.8364182091046</c:v>
                </c:pt>
                <c:pt idx="38">
                  <c:v>14.788014311270098</c:v>
                </c:pt>
                <c:pt idx="39">
                  <c:v>18.345877144438301</c:v>
                </c:pt>
                <c:pt idx="40">
                  <c:v>18.147766323024101</c:v>
                </c:pt>
                <c:pt idx="41">
                  <c:v>8.6801541425818804</c:v>
                </c:pt>
                <c:pt idx="42">
                  <c:v>17.069503546099273</c:v>
                </c:pt>
                <c:pt idx="43">
                  <c:v>18.347089947089888</c:v>
                </c:pt>
                <c:pt idx="44">
                  <c:v>17.889200561009787</c:v>
                </c:pt>
                <c:pt idx="45">
                  <c:v>16.867536032944376</c:v>
                </c:pt>
                <c:pt idx="46">
                  <c:v>18.042098649073189</c:v>
                </c:pt>
                <c:pt idx="47">
                  <c:v>17.5</c:v>
                </c:pt>
                <c:pt idx="48">
                  <c:v>17.978308986277089</c:v>
                </c:pt>
                <c:pt idx="49">
                  <c:v>13.746913580246892</c:v>
                </c:pt>
                <c:pt idx="50">
                  <c:v>16.221148684916788</c:v>
                </c:pt>
                <c:pt idx="51">
                  <c:v>16.2454710144928</c:v>
                </c:pt>
                <c:pt idx="52">
                  <c:v>18.693181818181799</c:v>
                </c:pt>
                <c:pt idx="53">
                  <c:v>17.362350380848699</c:v>
                </c:pt>
                <c:pt idx="54">
                  <c:v>16.341409691629973</c:v>
                </c:pt>
                <c:pt idx="55">
                  <c:v>18.901234567901177</c:v>
                </c:pt>
                <c:pt idx="56">
                  <c:v>17.576576576576581</c:v>
                </c:pt>
                <c:pt idx="57">
                  <c:v>16.610840108401117</c:v>
                </c:pt>
                <c:pt idx="58">
                  <c:v>19.602234094220499</c:v>
                </c:pt>
                <c:pt idx="59">
                  <c:v>17.509900990098998</c:v>
                </c:pt>
                <c:pt idx="60">
                  <c:v>15.803503010399609</c:v>
                </c:pt>
                <c:pt idx="61">
                  <c:v>15.851880276285515</c:v>
                </c:pt>
                <c:pt idx="62">
                  <c:v>15.435621100397098</c:v>
                </c:pt>
                <c:pt idx="63">
                  <c:v>17.412683237730963</c:v>
                </c:pt>
                <c:pt idx="64">
                  <c:v>20.628352490421499</c:v>
                </c:pt>
                <c:pt idx="65">
                  <c:v>17.601114649681517</c:v>
                </c:pt>
                <c:pt idx="66">
                  <c:v>16.858221476510099</c:v>
                </c:pt>
                <c:pt idx="67">
                  <c:v>17.260644205849676</c:v>
                </c:pt>
                <c:pt idx="68">
                  <c:v>12.4341983317887</c:v>
                </c:pt>
                <c:pt idx="69">
                  <c:v>13.581547619047615</c:v>
                </c:pt>
                <c:pt idx="70">
                  <c:v>19.218197498921889</c:v>
                </c:pt>
                <c:pt idx="71">
                  <c:v>17.410484668644905</c:v>
                </c:pt>
                <c:pt idx="72">
                  <c:v>17.319825436409026</c:v>
                </c:pt>
                <c:pt idx="73">
                  <c:v>17.454637096774189</c:v>
                </c:pt>
                <c:pt idx="74">
                  <c:v>18.473047858942078</c:v>
                </c:pt>
                <c:pt idx="75">
                  <c:v>18.269230769230788</c:v>
                </c:pt>
                <c:pt idx="76">
                  <c:v>16.915730337078681</c:v>
                </c:pt>
                <c:pt idx="77">
                  <c:v>17.647813411078726</c:v>
                </c:pt>
                <c:pt idx="78">
                  <c:v>18.056839475327877</c:v>
                </c:pt>
                <c:pt idx="79">
                  <c:v>18.7870111731844</c:v>
                </c:pt>
                <c:pt idx="80">
                  <c:v>10.976676384839609</c:v>
                </c:pt>
                <c:pt idx="81">
                  <c:v>18.007923930269389</c:v>
                </c:pt>
                <c:pt idx="82">
                  <c:v>16.164030727519201</c:v>
                </c:pt>
                <c:pt idx="83">
                  <c:v>17.865366759517187</c:v>
                </c:pt>
                <c:pt idx="84">
                  <c:v>11.885350318471309</c:v>
                </c:pt>
                <c:pt idx="85">
                  <c:v>15.259807549963009</c:v>
                </c:pt>
                <c:pt idx="86">
                  <c:v>18.5940774487472</c:v>
                </c:pt>
                <c:pt idx="87">
                  <c:v>19.947368421052634</c:v>
                </c:pt>
                <c:pt idx="88">
                  <c:v>26.941176470588189</c:v>
                </c:pt>
                <c:pt idx="89">
                  <c:v>17.781812538795776</c:v>
                </c:pt>
                <c:pt idx="90">
                  <c:v>17.774193548387089</c:v>
                </c:pt>
                <c:pt idx="91">
                  <c:v>17.54688672168043</c:v>
                </c:pt>
                <c:pt idx="92">
                  <c:v>16.771794871794889</c:v>
                </c:pt>
                <c:pt idx="93">
                  <c:v>21.266666666666687</c:v>
                </c:pt>
                <c:pt idx="94">
                  <c:v>18.744816586921775</c:v>
                </c:pt>
                <c:pt idx="95">
                  <c:v>17.679153094462517</c:v>
                </c:pt>
                <c:pt idx="96">
                  <c:v>14.2824639289678</c:v>
                </c:pt>
                <c:pt idx="97">
                  <c:v>14.844693701466801</c:v>
                </c:pt>
                <c:pt idx="98">
                  <c:v>11.248933577087101</c:v>
                </c:pt>
                <c:pt idx="99">
                  <c:v>13.9953149401353</c:v>
                </c:pt>
                <c:pt idx="100">
                  <c:v>17.208389715832187</c:v>
                </c:pt>
                <c:pt idx="101">
                  <c:v>16.595879556259899</c:v>
                </c:pt>
                <c:pt idx="102">
                  <c:v>16.906666666666688</c:v>
                </c:pt>
                <c:pt idx="103">
                  <c:v>17.426323319027176</c:v>
                </c:pt>
                <c:pt idx="104">
                  <c:v>18.550170068027199</c:v>
                </c:pt>
                <c:pt idx="105">
                  <c:v>18.411134903640299</c:v>
                </c:pt>
                <c:pt idx="106">
                  <c:v>16.713723284589364</c:v>
                </c:pt>
                <c:pt idx="107">
                  <c:v>15.119101123595492</c:v>
                </c:pt>
                <c:pt idx="108">
                  <c:v>19.268991282689889</c:v>
                </c:pt>
                <c:pt idx="109">
                  <c:v>18.7023653088042</c:v>
                </c:pt>
                <c:pt idx="110">
                  <c:v>17.474999999999987</c:v>
                </c:pt>
                <c:pt idx="111">
                  <c:v>15.909784871616917</c:v>
                </c:pt>
                <c:pt idx="112">
                  <c:v>16.861788617886205</c:v>
                </c:pt>
                <c:pt idx="113">
                  <c:v>16.084896810506599</c:v>
                </c:pt>
                <c:pt idx="114">
                  <c:v>15.643755238893499</c:v>
                </c:pt>
                <c:pt idx="115">
                  <c:v>14.910591471801904</c:v>
                </c:pt>
                <c:pt idx="116">
                  <c:v>15.174033149171301</c:v>
                </c:pt>
                <c:pt idx="117">
                  <c:v>15.070826306914</c:v>
                </c:pt>
                <c:pt idx="118">
                  <c:v>19.179253867151999</c:v>
                </c:pt>
                <c:pt idx="119">
                  <c:v>19.5054945054945</c:v>
                </c:pt>
                <c:pt idx="120">
                  <c:v>18.965896589658989</c:v>
                </c:pt>
                <c:pt idx="121">
                  <c:v>17.880053015241899</c:v>
                </c:pt>
                <c:pt idx="122">
                  <c:v>14.4701986754967</c:v>
                </c:pt>
                <c:pt idx="123">
                  <c:v>18.166095890411</c:v>
                </c:pt>
                <c:pt idx="124">
                  <c:v>19.952618453865274</c:v>
                </c:pt>
                <c:pt idx="125">
                  <c:v>17.655223329641899</c:v>
                </c:pt>
                <c:pt idx="126">
                  <c:v>17.862554112554101</c:v>
                </c:pt>
                <c:pt idx="127">
                  <c:v>14.370780590717315</c:v>
                </c:pt>
                <c:pt idx="128">
                  <c:v>16.081385281385277</c:v>
                </c:pt>
                <c:pt idx="129">
                  <c:v>11.360000000000008</c:v>
                </c:pt>
                <c:pt idx="130">
                  <c:v>17.624065769805735</c:v>
                </c:pt>
                <c:pt idx="131">
                  <c:v>12.410714285714302</c:v>
                </c:pt>
                <c:pt idx="132">
                  <c:v>11.696847210994306</c:v>
                </c:pt>
                <c:pt idx="133">
                  <c:v>17.154794520547899</c:v>
                </c:pt>
                <c:pt idx="134">
                  <c:v>12.376731301939104</c:v>
                </c:pt>
                <c:pt idx="135">
                  <c:v>15.650843222985609</c:v>
                </c:pt>
                <c:pt idx="136">
                  <c:v>12.004454342984404</c:v>
                </c:pt>
                <c:pt idx="137">
                  <c:v>16.850422638735775</c:v>
                </c:pt>
                <c:pt idx="138">
                  <c:v>17.823911630929189</c:v>
                </c:pt>
                <c:pt idx="139">
                  <c:v>17.760183066361574</c:v>
                </c:pt>
                <c:pt idx="140">
                  <c:v>17.5894736842105</c:v>
                </c:pt>
                <c:pt idx="141">
                  <c:v>15.730369515011498</c:v>
                </c:pt>
                <c:pt idx="142">
                  <c:v>17.790775401069499</c:v>
                </c:pt>
                <c:pt idx="143">
                  <c:v>16.777579010137089</c:v>
                </c:pt>
                <c:pt idx="144">
                  <c:v>16.111272375423287</c:v>
                </c:pt>
                <c:pt idx="145">
                  <c:v>16.569413511507076</c:v>
                </c:pt>
                <c:pt idx="146">
                  <c:v>12.587371512481598</c:v>
                </c:pt>
                <c:pt idx="147">
                  <c:v>16.408906882591076</c:v>
                </c:pt>
                <c:pt idx="148">
                  <c:v>15.3333333333333</c:v>
                </c:pt>
                <c:pt idx="149">
                  <c:v>15.753246753246804</c:v>
                </c:pt>
                <c:pt idx="150">
                  <c:v>17.440655737704887</c:v>
                </c:pt>
                <c:pt idx="151">
                  <c:v>14.8085867620751</c:v>
                </c:pt>
                <c:pt idx="152">
                  <c:v>15.1573516766982</c:v>
                </c:pt>
                <c:pt idx="153">
                  <c:v>14.80960623106882</c:v>
                </c:pt>
                <c:pt idx="154">
                  <c:v>17.406997084548099</c:v>
                </c:pt>
                <c:pt idx="155">
                  <c:v>15.349548297428809</c:v>
                </c:pt>
                <c:pt idx="156">
                  <c:v>14.740705433746401</c:v>
                </c:pt>
                <c:pt idx="157">
                  <c:v>17.321544356027086</c:v>
                </c:pt>
                <c:pt idx="158">
                  <c:v>17.936885669943116</c:v>
                </c:pt>
                <c:pt idx="159">
                  <c:v>19.159953298307101</c:v>
                </c:pt>
                <c:pt idx="160">
                  <c:v>12.974224092582904</c:v>
                </c:pt>
                <c:pt idx="161">
                  <c:v>19.687820512820501</c:v>
                </c:pt>
                <c:pt idx="162">
                  <c:v>16.995876288659787</c:v>
                </c:pt>
                <c:pt idx="163">
                  <c:v>14.415270935960599</c:v>
                </c:pt>
                <c:pt idx="164">
                  <c:v>16.078034682080887</c:v>
                </c:pt>
                <c:pt idx="165">
                  <c:v>18.575348837209276</c:v>
                </c:pt>
                <c:pt idx="166">
                  <c:v>18.578066914498098</c:v>
                </c:pt>
                <c:pt idx="167">
                  <c:v>16.234027777777786</c:v>
                </c:pt>
                <c:pt idx="168">
                  <c:v>14.0125817815803</c:v>
                </c:pt>
                <c:pt idx="169">
                  <c:v>14.805108798486309</c:v>
                </c:pt>
                <c:pt idx="170">
                  <c:v>16.163809523809501</c:v>
                </c:pt>
                <c:pt idx="171">
                  <c:v>18.128472222222189</c:v>
                </c:pt>
                <c:pt idx="172">
                  <c:v>15.373396674584315</c:v>
                </c:pt>
                <c:pt idx="173">
                  <c:v>19.557287157287217</c:v>
                </c:pt>
                <c:pt idx="174">
                  <c:v>18.926917989418001</c:v>
                </c:pt>
                <c:pt idx="175">
                  <c:v>16.267379679144376</c:v>
                </c:pt>
                <c:pt idx="176">
                  <c:v>19.640137328339588</c:v>
                </c:pt>
                <c:pt idx="177">
                  <c:v>16.572709163346602</c:v>
                </c:pt>
                <c:pt idx="178">
                  <c:v>17.326374391092617</c:v>
                </c:pt>
                <c:pt idx="179">
                  <c:v>16.626182965299705</c:v>
                </c:pt>
                <c:pt idx="180">
                  <c:v>18.5877358490566</c:v>
                </c:pt>
                <c:pt idx="181">
                  <c:v>15.935227272727309</c:v>
                </c:pt>
                <c:pt idx="182">
                  <c:v>15.805405405405409</c:v>
                </c:pt>
                <c:pt idx="183">
                  <c:v>16.554278416347426</c:v>
                </c:pt>
                <c:pt idx="184">
                  <c:v>17.815896188159005</c:v>
                </c:pt>
                <c:pt idx="185">
                  <c:v>18.963470319634688</c:v>
                </c:pt>
                <c:pt idx="186">
                  <c:v>16.642857142857117</c:v>
                </c:pt>
                <c:pt idx="187">
                  <c:v>20.349143610013186</c:v>
                </c:pt>
                <c:pt idx="188">
                  <c:v>12.374753451676501</c:v>
                </c:pt>
                <c:pt idx="189">
                  <c:v>16.711920529801301</c:v>
                </c:pt>
                <c:pt idx="190">
                  <c:v>13.11712598425199</c:v>
                </c:pt>
                <c:pt idx="191">
                  <c:v>20.940607734806587</c:v>
                </c:pt>
                <c:pt idx="192">
                  <c:v>16.2923976608187</c:v>
                </c:pt>
                <c:pt idx="193">
                  <c:v>16.582987551867173</c:v>
                </c:pt>
                <c:pt idx="194">
                  <c:v>10.173252279635308</c:v>
                </c:pt>
                <c:pt idx="195">
                  <c:v>14.8178484107579</c:v>
                </c:pt>
                <c:pt idx="196">
                  <c:v>19.3905447070915</c:v>
                </c:pt>
                <c:pt idx="197">
                  <c:v>18.900119856172577</c:v>
                </c:pt>
                <c:pt idx="198">
                  <c:v>19.767175572519086</c:v>
                </c:pt>
                <c:pt idx="199">
                  <c:v>16.905514250309764</c:v>
                </c:pt>
                <c:pt idx="200">
                  <c:v>19.605748605748602</c:v>
                </c:pt>
                <c:pt idx="201">
                  <c:v>16.651984774333901</c:v>
                </c:pt>
                <c:pt idx="202">
                  <c:v>17.559488692232101</c:v>
                </c:pt>
                <c:pt idx="203">
                  <c:v>17.780558789289888</c:v>
                </c:pt>
                <c:pt idx="204">
                  <c:v>19.130769230769175</c:v>
                </c:pt>
                <c:pt idx="205">
                  <c:v>19.526501766784516</c:v>
                </c:pt>
                <c:pt idx="206">
                  <c:v>16.342833876221476</c:v>
                </c:pt>
                <c:pt idx="207">
                  <c:v>16.109800362976419</c:v>
                </c:pt>
                <c:pt idx="208">
                  <c:v>13.294631710361999</c:v>
                </c:pt>
                <c:pt idx="209">
                  <c:v>14.483122362869199</c:v>
                </c:pt>
                <c:pt idx="210">
                  <c:v>15.064638783269999</c:v>
                </c:pt>
                <c:pt idx="211">
                  <c:v>14.146896551724106</c:v>
                </c:pt>
                <c:pt idx="212">
                  <c:v>16.0807934204161</c:v>
                </c:pt>
                <c:pt idx="213">
                  <c:v>15.475026567481409</c:v>
                </c:pt>
                <c:pt idx="214">
                  <c:v>19.704597326377588</c:v>
                </c:pt>
                <c:pt idx="215">
                  <c:v>19.259853436324001</c:v>
                </c:pt>
                <c:pt idx="216">
                  <c:v>17.786740843764459</c:v>
                </c:pt>
                <c:pt idx="217">
                  <c:v>19.1592430858806</c:v>
                </c:pt>
                <c:pt idx="218">
                  <c:v>18.313327449249801</c:v>
                </c:pt>
                <c:pt idx="219">
                  <c:v>19.365660919540186</c:v>
                </c:pt>
                <c:pt idx="220">
                  <c:v>11.072494669509624</c:v>
                </c:pt>
                <c:pt idx="221">
                  <c:v>18.105263157894719</c:v>
                </c:pt>
                <c:pt idx="222">
                  <c:v>18.481894533939077</c:v>
                </c:pt>
                <c:pt idx="223">
                  <c:v>17.540200511106686</c:v>
                </c:pt>
                <c:pt idx="224">
                  <c:v>17.010687393733289</c:v>
                </c:pt>
                <c:pt idx="225">
                  <c:v>15.459684123025811</c:v>
                </c:pt>
                <c:pt idx="226">
                  <c:v>17.659719268396401</c:v>
                </c:pt>
                <c:pt idx="227">
                  <c:v>17.203836930455587</c:v>
                </c:pt>
                <c:pt idx="228">
                  <c:v>17.858672376873677</c:v>
                </c:pt>
                <c:pt idx="229">
                  <c:v>17.322055137844618</c:v>
                </c:pt>
                <c:pt idx="230">
                  <c:v>16.847859721505898</c:v>
                </c:pt>
                <c:pt idx="231">
                  <c:v>11.965090909090909</c:v>
                </c:pt>
                <c:pt idx="232">
                  <c:v>14.624688279301704</c:v>
                </c:pt>
                <c:pt idx="233">
                  <c:v>19.537102473498205</c:v>
                </c:pt>
                <c:pt idx="234">
                  <c:v>16.847498785818431</c:v>
                </c:pt>
                <c:pt idx="235">
                  <c:v>15.4392014519056</c:v>
                </c:pt>
                <c:pt idx="236">
                  <c:v>21.5506024096386</c:v>
                </c:pt>
                <c:pt idx="237">
                  <c:v>17.407604251839686</c:v>
                </c:pt>
                <c:pt idx="238">
                  <c:v>15.63362068965519</c:v>
                </c:pt>
                <c:pt idx="239">
                  <c:v>17.228152799581402</c:v>
                </c:pt>
                <c:pt idx="240">
                  <c:v>14.9587155963303</c:v>
                </c:pt>
                <c:pt idx="241">
                  <c:v>15.768677586895699</c:v>
                </c:pt>
                <c:pt idx="242">
                  <c:v>15.751259445843798</c:v>
                </c:pt>
                <c:pt idx="243">
                  <c:v>16.472795497185686</c:v>
                </c:pt>
                <c:pt idx="244">
                  <c:v>17.6920821114369</c:v>
                </c:pt>
                <c:pt idx="245">
                  <c:v>17.363155108522999</c:v>
                </c:pt>
                <c:pt idx="246">
                  <c:v>18.151586925627701</c:v>
                </c:pt>
                <c:pt idx="247">
                  <c:v>17.774501992031887</c:v>
                </c:pt>
                <c:pt idx="248">
                  <c:v>20.156932453021799</c:v>
                </c:pt>
                <c:pt idx="249">
                  <c:v>17.516743648960674</c:v>
                </c:pt>
                <c:pt idx="250">
                  <c:v>19.525373134328376</c:v>
                </c:pt>
                <c:pt idx="251">
                  <c:v>16.637875288683635</c:v>
                </c:pt>
                <c:pt idx="252">
                  <c:v>18.096059915336987</c:v>
                </c:pt>
                <c:pt idx="253">
                  <c:v>16.7714730752114</c:v>
                </c:pt>
                <c:pt idx="254">
                  <c:v>14.4740912606342</c:v>
                </c:pt>
                <c:pt idx="255">
                  <c:v>19.920979410128002</c:v>
                </c:pt>
                <c:pt idx="256">
                  <c:v>17.447876447876418</c:v>
                </c:pt>
                <c:pt idx="257">
                  <c:v>19.556894243641199</c:v>
                </c:pt>
                <c:pt idx="258">
                  <c:v>18.487257512362078</c:v>
                </c:pt>
                <c:pt idx="259">
                  <c:v>16.572127139364277</c:v>
                </c:pt>
                <c:pt idx="260">
                  <c:v>19.430134680134689</c:v>
                </c:pt>
                <c:pt idx="261">
                  <c:v>18.493481095175976</c:v>
                </c:pt>
                <c:pt idx="262">
                  <c:v>17.196994991652826</c:v>
                </c:pt>
                <c:pt idx="263">
                  <c:v>14.999543378995408</c:v>
                </c:pt>
                <c:pt idx="264">
                  <c:v>17.050068119891034</c:v>
                </c:pt>
                <c:pt idx="265">
                  <c:v>13.739336492891001</c:v>
                </c:pt>
                <c:pt idx="266">
                  <c:v>19.9753914988814</c:v>
                </c:pt>
                <c:pt idx="267">
                  <c:v>17.478855721393018</c:v>
                </c:pt>
                <c:pt idx="268">
                  <c:v>17.202563042579577</c:v>
                </c:pt>
                <c:pt idx="269">
                  <c:v>19.4079742247282</c:v>
                </c:pt>
                <c:pt idx="270">
                  <c:v>20.182576769025378</c:v>
                </c:pt>
                <c:pt idx="271">
                  <c:v>18.971577261809401</c:v>
                </c:pt>
                <c:pt idx="272">
                  <c:v>17.792263610315189</c:v>
                </c:pt>
                <c:pt idx="273">
                  <c:v>16.855294117647105</c:v>
                </c:pt>
                <c:pt idx="274">
                  <c:v>18.110817941952519</c:v>
                </c:pt>
                <c:pt idx="275">
                  <c:v>21.922718808193675</c:v>
                </c:pt>
                <c:pt idx="276">
                  <c:v>19.858655616942901</c:v>
                </c:pt>
                <c:pt idx="277">
                  <c:v>14.3540051679587</c:v>
                </c:pt>
                <c:pt idx="278">
                  <c:v>15.929504709814609</c:v>
                </c:pt>
                <c:pt idx="279">
                  <c:v>17.430055955235801</c:v>
                </c:pt>
                <c:pt idx="280">
                  <c:v>17.957973383142701</c:v>
                </c:pt>
                <c:pt idx="281">
                  <c:v>17.895680282103964</c:v>
                </c:pt>
                <c:pt idx="282">
                  <c:v>15.430945785516398</c:v>
                </c:pt>
                <c:pt idx="283">
                  <c:v>16.594029850746281</c:v>
                </c:pt>
                <c:pt idx="284">
                  <c:v>15.45374220374222</c:v>
                </c:pt>
                <c:pt idx="285">
                  <c:v>18.1475409836066</c:v>
                </c:pt>
                <c:pt idx="286">
                  <c:v>19.555333333333259</c:v>
                </c:pt>
                <c:pt idx="287">
                  <c:v>15.579005524861909</c:v>
                </c:pt>
                <c:pt idx="288">
                  <c:v>17.691009030231587</c:v>
                </c:pt>
                <c:pt idx="289">
                  <c:v>15.73009708737859</c:v>
                </c:pt>
                <c:pt idx="290">
                  <c:v>18.282716520412077</c:v>
                </c:pt>
                <c:pt idx="291">
                  <c:v>16.8038430744596</c:v>
                </c:pt>
                <c:pt idx="292">
                  <c:v>17.061827956989202</c:v>
                </c:pt>
                <c:pt idx="293">
                  <c:v>18.529691211401389</c:v>
                </c:pt>
                <c:pt idx="294">
                  <c:v>15.6588759042849</c:v>
                </c:pt>
                <c:pt idx="295">
                  <c:v>17.991459627329181</c:v>
                </c:pt>
                <c:pt idx="296">
                  <c:v>15.770745428973299</c:v>
                </c:pt>
                <c:pt idx="297">
                  <c:v>12.4041095890411</c:v>
                </c:pt>
                <c:pt idx="298">
                  <c:v>16.159763313609517</c:v>
                </c:pt>
                <c:pt idx="299">
                  <c:v>19.241441441441378</c:v>
                </c:pt>
                <c:pt idx="300">
                  <c:v>17.227752639517274</c:v>
                </c:pt>
                <c:pt idx="301">
                  <c:v>18.078101071975489</c:v>
                </c:pt>
                <c:pt idx="302">
                  <c:v>18.229014331675877</c:v>
                </c:pt>
                <c:pt idx="303">
                  <c:v>18.616880037932717</c:v>
                </c:pt>
                <c:pt idx="304">
                  <c:v>17.572548088340081</c:v>
                </c:pt>
                <c:pt idx="305">
                  <c:v>16.537585421412334</c:v>
                </c:pt>
                <c:pt idx="306">
                  <c:v>16.971955719557219</c:v>
                </c:pt>
                <c:pt idx="307">
                  <c:v>15.655144694533806</c:v>
                </c:pt>
                <c:pt idx="308">
                  <c:v>17.303464755077705</c:v>
                </c:pt>
                <c:pt idx="309">
                  <c:v>16.992624728850299</c:v>
                </c:pt>
                <c:pt idx="310">
                  <c:v>16.709840810419699</c:v>
                </c:pt>
                <c:pt idx="311">
                  <c:v>15.610650887574</c:v>
                </c:pt>
                <c:pt idx="312">
                  <c:v>17.688172043010788</c:v>
                </c:pt>
                <c:pt idx="313">
                  <c:v>17.908306364616987</c:v>
                </c:pt>
                <c:pt idx="314">
                  <c:v>19.210831234256901</c:v>
                </c:pt>
                <c:pt idx="315">
                  <c:v>19.080814717477001</c:v>
                </c:pt>
                <c:pt idx="316">
                  <c:v>16.783367556468189</c:v>
                </c:pt>
                <c:pt idx="317">
                  <c:v>18.731003039513688</c:v>
                </c:pt>
                <c:pt idx="318">
                  <c:v>19.647583294228099</c:v>
                </c:pt>
                <c:pt idx="319">
                  <c:v>17.0246913580247</c:v>
                </c:pt>
                <c:pt idx="320">
                  <c:v>14.835968379446609</c:v>
                </c:pt>
                <c:pt idx="321">
                  <c:v>12.485416666666717</c:v>
                </c:pt>
                <c:pt idx="322">
                  <c:v>17.896053145760099</c:v>
                </c:pt>
                <c:pt idx="323">
                  <c:v>20.041688515993702</c:v>
                </c:pt>
                <c:pt idx="324">
                  <c:v>17.492053789731077</c:v>
                </c:pt>
                <c:pt idx="325">
                  <c:v>17.806146572103966</c:v>
                </c:pt>
                <c:pt idx="326">
                  <c:v>16.923420905533764</c:v>
                </c:pt>
                <c:pt idx="327">
                  <c:v>17.3651710350955</c:v>
                </c:pt>
                <c:pt idx="328">
                  <c:v>16.638613861386087</c:v>
                </c:pt>
                <c:pt idx="329">
                  <c:v>16.287464655984888</c:v>
                </c:pt>
                <c:pt idx="330">
                  <c:v>16.465321563682178</c:v>
                </c:pt>
                <c:pt idx="331">
                  <c:v>18.4736549165121</c:v>
                </c:pt>
                <c:pt idx="332">
                  <c:v>16.981125092524081</c:v>
                </c:pt>
                <c:pt idx="333">
                  <c:v>17.098366477272702</c:v>
                </c:pt>
                <c:pt idx="334">
                  <c:v>15.237759643916901</c:v>
                </c:pt>
                <c:pt idx="335">
                  <c:v>18.256285178236418</c:v>
                </c:pt>
                <c:pt idx="336">
                  <c:v>16.173439048562877</c:v>
                </c:pt>
                <c:pt idx="337">
                  <c:v>18.567882079131078</c:v>
                </c:pt>
                <c:pt idx="338">
                  <c:v>18.210413694721776</c:v>
                </c:pt>
                <c:pt idx="339">
                  <c:v>16.022212350066589</c:v>
                </c:pt>
                <c:pt idx="340">
                  <c:v>17.443883495145599</c:v>
                </c:pt>
                <c:pt idx="341">
                  <c:v>18.1838768115942</c:v>
                </c:pt>
                <c:pt idx="342">
                  <c:v>18.648223828984602</c:v>
                </c:pt>
                <c:pt idx="343">
                  <c:v>19.715075562108417</c:v>
                </c:pt>
                <c:pt idx="344">
                  <c:v>17.704232049453189</c:v>
                </c:pt>
                <c:pt idx="345">
                  <c:v>18.494102228047186</c:v>
                </c:pt>
                <c:pt idx="346">
                  <c:v>18.122933884297499</c:v>
                </c:pt>
                <c:pt idx="347">
                  <c:v>18.13320312500003</c:v>
                </c:pt>
                <c:pt idx="348">
                  <c:v>15.4588528678304</c:v>
                </c:pt>
                <c:pt idx="349">
                  <c:v>18.232391713747599</c:v>
                </c:pt>
                <c:pt idx="350">
                  <c:v>18.698283649503189</c:v>
                </c:pt>
                <c:pt idx="351">
                  <c:v>18.973399833748964</c:v>
                </c:pt>
                <c:pt idx="352">
                  <c:v>15.983226837060709</c:v>
                </c:pt>
                <c:pt idx="353">
                  <c:v>17.470231146392699</c:v>
                </c:pt>
                <c:pt idx="354">
                  <c:v>18.357522123893801</c:v>
                </c:pt>
                <c:pt idx="355">
                  <c:v>20.574958813838535</c:v>
                </c:pt>
                <c:pt idx="356">
                  <c:v>17.6384393063584</c:v>
                </c:pt>
                <c:pt idx="357">
                  <c:v>18.926198527949087</c:v>
                </c:pt>
                <c:pt idx="358">
                  <c:v>21.618199802176086</c:v>
                </c:pt>
                <c:pt idx="359">
                  <c:v>18.481630824372775</c:v>
                </c:pt>
                <c:pt idx="360">
                  <c:v>17.722532588454364</c:v>
                </c:pt>
                <c:pt idx="361">
                  <c:v>18.060328185328189</c:v>
                </c:pt>
                <c:pt idx="362">
                  <c:v>16.738012852199677</c:v>
                </c:pt>
                <c:pt idx="363">
                  <c:v>18.329400196656817</c:v>
                </c:pt>
                <c:pt idx="364">
                  <c:v>14.721189591078099</c:v>
                </c:pt>
                <c:pt idx="365">
                  <c:v>18.7658592848904</c:v>
                </c:pt>
                <c:pt idx="366">
                  <c:v>17.556958308866726</c:v>
                </c:pt>
                <c:pt idx="367">
                  <c:v>18.656274156145301</c:v>
                </c:pt>
                <c:pt idx="368">
                  <c:v>17.196690006365376</c:v>
                </c:pt>
                <c:pt idx="369">
                  <c:v>18.6522140221402</c:v>
                </c:pt>
                <c:pt idx="370">
                  <c:v>16.3651096282174</c:v>
                </c:pt>
                <c:pt idx="371">
                  <c:v>17.163127413127373</c:v>
                </c:pt>
                <c:pt idx="372">
                  <c:v>17.503968253968299</c:v>
                </c:pt>
                <c:pt idx="373">
                  <c:v>18.804130162703405</c:v>
                </c:pt>
                <c:pt idx="374">
                  <c:v>18.445915665104899</c:v>
                </c:pt>
                <c:pt idx="375">
                  <c:v>19.129480773408616</c:v>
                </c:pt>
                <c:pt idx="376">
                  <c:v>19.1720527992717</c:v>
                </c:pt>
                <c:pt idx="377">
                  <c:v>18.956396741734487</c:v>
                </c:pt>
                <c:pt idx="378">
                  <c:v>18.952227011494287</c:v>
                </c:pt>
                <c:pt idx="379">
                  <c:v>18.2294164668265</c:v>
                </c:pt>
                <c:pt idx="380">
                  <c:v>16.400305810397587</c:v>
                </c:pt>
                <c:pt idx="381">
                  <c:v>18.888651315789499</c:v>
                </c:pt>
                <c:pt idx="382">
                  <c:v>19.106291192330701</c:v>
                </c:pt>
                <c:pt idx="383">
                  <c:v>19.101382488479299</c:v>
                </c:pt>
                <c:pt idx="384">
                  <c:v>16.8731474503894</c:v>
                </c:pt>
                <c:pt idx="385">
                  <c:v>18.220740740740673</c:v>
                </c:pt>
                <c:pt idx="386">
                  <c:v>19.415767386091087</c:v>
                </c:pt>
                <c:pt idx="387">
                  <c:v>18.303030303030287</c:v>
                </c:pt>
                <c:pt idx="388">
                  <c:v>17.360119047618987</c:v>
                </c:pt>
                <c:pt idx="389">
                  <c:v>17.633057851239698</c:v>
                </c:pt>
                <c:pt idx="390">
                  <c:v>18.569100529100499</c:v>
                </c:pt>
                <c:pt idx="391">
                  <c:v>16.067401960784299</c:v>
                </c:pt>
                <c:pt idx="392">
                  <c:v>18.2555187637969</c:v>
                </c:pt>
                <c:pt idx="393">
                  <c:v>19.580104237480189</c:v>
                </c:pt>
                <c:pt idx="394">
                  <c:v>19.369415989016801</c:v>
                </c:pt>
                <c:pt idx="395">
                  <c:v>19.115998176845917</c:v>
                </c:pt>
                <c:pt idx="396">
                  <c:v>17.652206809583877</c:v>
                </c:pt>
                <c:pt idx="397">
                  <c:v>19.355701754386001</c:v>
                </c:pt>
                <c:pt idx="398">
                  <c:v>19.835314839277881</c:v>
                </c:pt>
                <c:pt idx="399">
                  <c:v>17.932050160396617</c:v>
                </c:pt>
                <c:pt idx="400">
                  <c:v>19.364000000000001</c:v>
                </c:pt>
                <c:pt idx="401">
                  <c:v>18.032641547451089</c:v>
                </c:pt>
                <c:pt idx="402">
                  <c:v>17.473922299095289</c:v>
                </c:pt>
                <c:pt idx="403">
                  <c:v>17.713987473904005</c:v>
                </c:pt>
                <c:pt idx="404">
                  <c:v>17.092026215182976</c:v>
                </c:pt>
                <c:pt idx="405">
                  <c:v>18.7368621477532</c:v>
                </c:pt>
                <c:pt idx="406">
                  <c:v>18.160790325327874</c:v>
                </c:pt>
                <c:pt idx="407">
                  <c:v>17.183708838821477</c:v>
                </c:pt>
                <c:pt idx="408">
                  <c:v>19.210997760637017</c:v>
                </c:pt>
                <c:pt idx="409">
                  <c:v>18.341567291311787</c:v>
                </c:pt>
                <c:pt idx="410">
                  <c:v>11.821428571428608</c:v>
                </c:pt>
                <c:pt idx="411">
                  <c:v>18.892507204610986</c:v>
                </c:pt>
                <c:pt idx="412">
                  <c:v>17.016591251885401</c:v>
                </c:pt>
                <c:pt idx="413">
                  <c:v>18.678022191940787</c:v>
                </c:pt>
                <c:pt idx="414">
                  <c:v>18.080570476014099</c:v>
                </c:pt>
                <c:pt idx="415">
                  <c:v>18.305563093622787</c:v>
                </c:pt>
                <c:pt idx="416">
                  <c:v>12.465000000000009</c:v>
                </c:pt>
                <c:pt idx="417">
                  <c:v>19.052364006100699</c:v>
                </c:pt>
                <c:pt idx="418">
                  <c:v>17.664631664631699</c:v>
                </c:pt>
                <c:pt idx="419">
                  <c:v>18.994991055456218</c:v>
                </c:pt>
                <c:pt idx="420">
                  <c:v>38.972580986661001</c:v>
                </c:pt>
                <c:pt idx="421">
                  <c:v>37.332987551867127</c:v>
                </c:pt>
                <c:pt idx="422">
                  <c:v>18.653369672943487</c:v>
                </c:pt>
                <c:pt idx="423">
                  <c:v>17.1406473108044</c:v>
                </c:pt>
                <c:pt idx="424">
                  <c:v>19.432562780641877</c:v>
                </c:pt>
                <c:pt idx="425">
                  <c:v>19.991166453810116</c:v>
                </c:pt>
                <c:pt idx="426">
                  <c:v>18.272857142857116</c:v>
                </c:pt>
                <c:pt idx="427">
                  <c:v>16.751760563380302</c:v>
                </c:pt>
                <c:pt idx="428">
                  <c:v>17.749533582089576</c:v>
                </c:pt>
                <c:pt idx="429">
                  <c:v>18.5984974958264</c:v>
                </c:pt>
                <c:pt idx="430">
                  <c:v>17.258386470751276</c:v>
                </c:pt>
                <c:pt idx="431">
                  <c:v>16.243463592915376</c:v>
                </c:pt>
                <c:pt idx="432">
                  <c:v>18.1246803069054</c:v>
                </c:pt>
                <c:pt idx="433">
                  <c:v>11.813214739517209</c:v>
                </c:pt>
                <c:pt idx="434">
                  <c:v>19.075913776944699</c:v>
                </c:pt>
                <c:pt idx="435">
                  <c:v>17.789658811114986</c:v>
                </c:pt>
                <c:pt idx="436">
                  <c:v>18.076624636275486</c:v>
                </c:pt>
                <c:pt idx="437">
                  <c:v>19.579159935379586</c:v>
                </c:pt>
                <c:pt idx="438">
                  <c:v>16.702632554690378</c:v>
                </c:pt>
                <c:pt idx="439">
                  <c:v>19.668802474591189</c:v>
                </c:pt>
                <c:pt idx="440">
                  <c:v>17.289954828995501</c:v>
                </c:pt>
                <c:pt idx="441">
                  <c:v>19.599007444168699</c:v>
                </c:pt>
                <c:pt idx="442">
                  <c:v>19.763534675615176</c:v>
                </c:pt>
                <c:pt idx="443">
                  <c:v>15.025</c:v>
                </c:pt>
                <c:pt idx="444">
                  <c:v>17.336286201022087</c:v>
                </c:pt>
                <c:pt idx="445">
                  <c:v>19.0383584589615</c:v>
                </c:pt>
                <c:pt idx="446">
                  <c:v>18.055574973785376</c:v>
                </c:pt>
                <c:pt idx="447">
                  <c:v>17.050127442650801</c:v>
                </c:pt>
                <c:pt idx="448">
                  <c:v>17.419610670511876</c:v>
                </c:pt>
                <c:pt idx="449">
                  <c:v>19.337402509325177</c:v>
                </c:pt>
                <c:pt idx="450">
                  <c:v>20.248203788373576</c:v>
                </c:pt>
                <c:pt idx="451">
                  <c:v>17.467086834733863</c:v>
                </c:pt>
                <c:pt idx="452">
                  <c:v>19.252291365171189</c:v>
                </c:pt>
                <c:pt idx="453">
                  <c:v>18.61420345489444</c:v>
                </c:pt>
                <c:pt idx="454">
                  <c:v>16.703232644409074</c:v>
                </c:pt>
                <c:pt idx="455">
                  <c:v>18.082426778242677</c:v>
                </c:pt>
                <c:pt idx="456">
                  <c:v>18.328134619330989</c:v>
                </c:pt>
                <c:pt idx="457">
                  <c:v>18.7776545605767</c:v>
                </c:pt>
                <c:pt idx="458">
                  <c:v>19.452577319587586</c:v>
                </c:pt>
                <c:pt idx="459">
                  <c:v>19.687229437229377</c:v>
                </c:pt>
                <c:pt idx="460">
                  <c:v>17.233100233100178</c:v>
                </c:pt>
                <c:pt idx="461">
                  <c:v>18.269393939393876</c:v>
                </c:pt>
                <c:pt idx="462">
                  <c:v>21.016666666666701</c:v>
                </c:pt>
                <c:pt idx="463">
                  <c:v>17.508375209380187</c:v>
                </c:pt>
                <c:pt idx="464">
                  <c:v>18.284294664074299</c:v>
                </c:pt>
                <c:pt idx="465">
                  <c:v>15.943562014194002</c:v>
                </c:pt>
                <c:pt idx="466">
                  <c:v>16.993108728943302</c:v>
                </c:pt>
                <c:pt idx="467">
                  <c:v>18.021942446043202</c:v>
                </c:pt>
                <c:pt idx="468">
                  <c:v>16.576354679803</c:v>
                </c:pt>
                <c:pt idx="469">
                  <c:v>17.142857142857117</c:v>
                </c:pt>
                <c:pt idx="470">
                  <c:v>18.413975782038317</c:v>
                </c:pt>
                <c:pt idx="471">
                  <c:v>18.188305564288001</c:v>
                </c:pt>
                <c:pt idx="472">
                  <c:v>16.281911675741089</c:v>
                </c:pt>
                <c:pt idx="473">
                  <c:v>18.109465020576117</c:v>
                </c:pt>
                <c:pt idx="474">
                  <c:v>18.615230460921786</c:v>
                </c:pt>
                <c:pt idx="475">
                  <c:v>18.157000453103805</c:v>
                </c:pt>
                <c:pt idx="476">
                  <c:v>18.186593492747889</c:v>
                </c:pt>
                <c:pt idx="477">
                  <c:v>18.274354923644026</c:v>
                </c:pt>
                <c:pt idx="478">
                  <c:v>20.289473684210499</c:v>
                </c:pt>
                <c:pt idx="479">
                  <c:v>19.492431886982775</c:v>
                </c:pt>
                <c:pt idx="480">
                  <c:v>17.469571230981966</c:v>
                </c:pt>
                <c:pt idx="481">
                  <c:v>17.796534523497002</c:v>
                </c:pt>
                <c:pt idx="482">
                  <c:v>18.181561285764687</c:v>
                </c:pt>
                <c:pt idx="483">
                  <c:v>17.352855051244539</c:v>
                </c:pt>
                <c:pt idx="484">
                  <c:v>15.463899943149508</c:v>
                </c:pt>
                <c:pt idx="485">
                  <c:v>18.170639032815178</c:v>
                </c:pt>
                <c:pt idx="486">
                  <c:v>19.413849509269376</c:v>
                </c:pt>
                <c:pt idx="487">
                  <c:v>17.543240381221263</c:v>
                </c:pt>
                <c:pt idx="488">
                  <c:v>16.972173144876287</c:v>
                </c:pt>
                <c:pt idx="489">
                  <c:v>17.804090909090917</c:v>
                </c:pt>
                <c:pt idx="490">
                  <c:v>17.800261309815518</c:v>
                </c:pt>
                <c:pt idx="491">
                  <c:v>19.861924686192516</c:v>
                </c:pt>
                <c:pt idx="492">
                  <c:v>19.219295605057201</c:v>
                </c:pt>
                <c:pt idx="493">
                  <c:v>19.7213899292551</c:v>
                </c:pt>
                <c:pt idx="494">
                  <c:v>17.779324055665978</c:v>
                </c:pt>
                <c:pt idx="495">
                  <c:v>19.383616383616378</c:v>
                </c:pt>
                <c:pt idx="496">
                  <c:v>19.813127690100401</c:v>
                </c:pt>
                <c:pt idx="497">
                  <c:v>19.513275613275617</c:v>
                </c:pt>
                <c:pt idx="498">
                  <c:v>20.029419160170978</c:v>
                </c:pt>
                <c:pt idx="499">
                  <c:v>16.003344481605289</c:v>
                </c:pt>
                <c:pt idx="500">
                  <c:v>17.4061010486177</c:v>
                </c:pt>
                <c:pt idx="501">
                  <c:v>18.028757460662</c:v>
                </c:pt>
                <c:pt idx="502">
                  <c:v>19.000260010400417</c:v>
                </c:pt>
                <c:pt idx="503">
                  <c:v>17.668833727344399</c:v>
                </c:pt>
                <c:pt idx="504">
                  <c:v>17.979690522243686</c:v>
                </c:pt>
                <c:pt idx="505">
                  <c:v>17.351668891855805</c:v>
                </c:pt>
                <c:pt idx="506">
                  <c:v>16.886743044189863</c:v>
                </c:pt>
                <c:pt idx="507">
                  <c:v>17.049079754601188</c:v>
                </c:pt>
                <c:pt idx="508">
                  <c:v>19.969984884474187</c:v>
                </c:pt>
                <c:pt idx="509">
                  <c:v>18.645738203957379</c:v>
                </c:pt>
                <c:pt idx="510">
                  <c:v>19.037888355645435</c:v>
                </c:pt>
                <c:pt idx="511">
                  <c:v>18.960540348382477</c:v>
                </c:pt>
                <c:pt idx="512">
                  <c:v>18.792861695347401</c:v>
                </c:pt>
                <c:pt idx="513">
                  <c:v>17.898188263095701</c:v>
                </c:pt>
                <c:pt idx="514">
                  <c:v>17.736957888120699</c:v>
                </c:pt>
                <c:pt idx="515">
                  <c:v>18.404074702886216</c:v>
                </c:pt>
                <c:pt idx="516">
                  <c:v>18.869869869869888</c:v>
                </c:pt>
                <c:pt idx="517">
                  <c:v>17.651041666666718</c:v>
                </c:pt>
                <c:pt idx="518">
                  <c:v>17.376229830775259</c:v>
                </c:pt>
                <c:pt idx="519">
                  <c:v>17.654185022026439</c:v>
                </c:pt>
                <c:pt idx="520">
                  <c:v>18.2520060180542</c:v>
                </c:pt>
                <c:pt idx="521">
                  <c:v>17.796975347006398</c:v>
                </c:pt>
                <c:pt idx="522">
                  <c:v>17.433628318584088</c:v>
                </c:pt>
                <c:pt idx="523">
                  <c:v>18.711409395973178</c:v>
                </c:pt>
                <c:pt idx="524">
                  <c:v>20.212719298245577</c:v>
                </c:pt>
                <c:pt idx="525">
                  <c:v>17.744761904761877</c:v>
                </c:pt>
                <c:pt idx="526">
                  <c:v>18.28683319221</c:v>
                </c:pt>
                <c:pt idx="527">
                  <c:v>19.692052980132502</c:v>
                </c:pt>
                <c:pt idx="528">
                  <c:v>18.060570071258887</c:v>
                </c:pt>
                <c:pt idx="529">
                  <c:v>19.332848837209287</c:v>
                </c:pt>
                <c:pt idx="530">
                  <c:v>19.348189997907486</c:v>
                </c:pt>
                <c:pt idx="531">
                  <c:v>20.344375431332001</c:v>
                </c:pt>
                <c:pt idx="532">
                  <c:v>18.129486597001389</c:v>
                </c:pt>
                <c:pt idx="533">
                  <c:v>19.121679520137089</c:v>
                </c:pt>
                <c:pt idx="534">
                  <c:v>19.019064124783434</c:v>
                </c:pt>
                <c:pt idx="535">
                  <c:v>18.530719411867686</c:v>
                </c:pt>
                <c:pt idx="536">
                  <c:v>19.389198218262788</c:v>
                </c:pt>
                <c:pt idx="537">
                  <c:v>16.097243107769376</c:v>
                </c:pt>
                <c:pt idx="538">
                  <c:v>16.863534675615178</c:v>
                </c:pt>
                <c:pt idx="539">
                  <c:v>18.028924868109886</c:v>
                </c:pt>
                <c:pt idx="540">
                  <c:v>18.200047236655589</c:v>
                </c:pt>
                <c:pt idx="541">
                  <c:v>17.061479061479087</c:v>
                </c:pt>
                <c:pt idx="542">
                  <c:v>18.009650495566</c:v>
                </c:pt>
                <c:pt idx="543">
                  <c:v>18.556696361165589</c:v>
                </c:pt>
                <c:pt idx="544">
                  <c:v>18.951084550686101</c:v>
                </c:pt>
                <c:pt idx="545">
                  <c:v>19.049518958686999</c:v>
                </c:pt>
                <c:pt idx="546">
                  <c:v>17.910977080820299</c:v>
                </c:pt>
                <c:pt idx="547">
                  <c:v>18.352142667021589</c:v>
                </c:pt>
                <c:pt idx="548">
                  <c:v>17.845381526104401</c:v>
                </c:pt>
                <c:pt idx="549">
                  <c:v>17.652694610778401</c:v>
                </c:pt>
                <c:pt idx="550">
                  <c:v>19.579496915045102</c:v>
                </c:pt>
                <c:pt idx="551">
                  <c:v>19.783201103828887</c:v>
                </c:pt>
                <c:pt idx="552">
                  <c:v>17.894508670520189</c:v>
                </c:pt>
                <c:pt idx="553">
                  <c:v>18.673362445414817</c:v>
                </c:pt>
                <c:pt idx="554">
                  <c:v>17.314485729671535</c:v>
                </c:pt>
                <c:pt idx="555">
                  <c:v>18.585087191822002</c:v>
                </c:pt>
                <c:pt idx="556">
                  <c:v>17.816687737041701</c:v>
                </c:pt>
                <c:pt idx="557">
                  <c:v>19.9490481522956</c:v>
                </c:pt>
                <c:pt idx="558">
                  <c:v>20.380943063979689</c:v>
                </c:pt>
                <c:pt idx="559">
                  <c:v>17.973953811425599</c:v>
                </c:pt>
                <c:pt idx="560">
                  <c:v>18.405622489959775</c:v>
                </c:pt>
                <c:pt idx="561">
                  <c:v>18.893714689265487</c:v>
                </c:pt>
                <c:pt idx="562">
                  <c:v>17.021040974529264</c:v>
                </c:pt>
                <c:pt idx="563">
                  <c:v>18.292573143285789</c:v>
                </c:pt>
                <c:pt idx="564">
                  <c:v>19.905126849894277</c:v>
                </c:pt>
                <c:pt idx="565">
                  <c:v>18.750112157918299</c:v>
                </c:pt>
                <c:pt idx="566">
                  <c:v>17.231441048034899</c:v>
                </c:pt>
                <c:pt idx="567">
                  <c:v>18.368184602818101</c:v>
                </c:pt>
                <c:pt idx="568">
                  <c:v>16.849129156299501</c:v>
                </c:pt>
                <c:pt idx="569">
                  <c:v>16.718723994452187</c:v>
                </c:pt>
                <c:pt idx="570">
                  <c:v>19.770491803278688</c:v>
                </c:pt>
                <c:pt idx="571">
                  <c:v>19.260847371107676</c:v>
                </c:pt>
                <c:pt idx="572">
                  <c:v>18.990634312473379</c:v>
                </c:pt>
                <c:pt idx="573">
                  <c:v>17.949223416965363</c:v>
                </c:pt>
                <c:pt idx="574">
                  <c:v>18.45113212955</c:v>
                </c:pt>
                <c:pt idx="575">
                  <c:v>19.109834888729377</c:v>
                </c:pt>
                <c:pt idx="576">
                  <c:v>17.950313901345275</c:v>
                </c:pt>
                <c:pt idx="577">
                  <c:v>18.716238608119287</c:v>
                </c:pt>
                <c:pt idx="578">
                  <c:v>14.734374999999995</c:v>
                </c:pt>
                <c:pt idx="579">
                  <c:v>16.9394723228143</c:v>
                </c:pt>
                <c:pt idx="580">
                  <c:v>17.627659574468087</c:v>
                </c:pt>
                <c:pt idx="581">
                  <c:v>18.398350186269287</c:v>
                </c:pt>
                <c:pt idx="582">
                  <c:v>19.215846994535486</c:v>
                </c:pt>
                <c:pt idx="583">
                  <c:v>18.257814453613431</c:v>
                </c:pt>
                <c:pt idx="584">
                  <c:v>17.970935314685299</c:v>
                </c:pt>
                <c:pt idx="585">
                  <c:v>16.840901213171588</c:v>
                </c:pt>
                <c:pt idx="586">
                  <c:v>19.090549766439089</c:v>
                </c:pt>
                <c:pt idx="587">
                  <c:v>17.027470567249399</c:v>
                </c:pt>
                <c:pt idx="588">
                  <c:v>17.3822016460905</c:v>
                </c:pt>
                <c:pt idx="589">
                  <c:v>17.190295358649816</c:v>
                </c:pt>
                <c:pt idx="590">
                  <c:v>15.498662386302801</c:v>
                </c:pt>
                <c:pt idx="591">
                  <c:v>17.877754301237498</c:v>
                </c:pt>
                <c:pt idx="592">
                  <c:v>19.527677767776801</c:v>
                </c:pt>
                <c:pt idx="593">
                  <c:v>19.593687374749489</c:v>
                </c:pt>
                <c:pt idx="594">
                  <c:v>18.1263873970641</c:v>
                </c:pt>
                <c:pt idx="595">
                  <c:v>18.705035971222976</c:v>
                </c:pt>
                <c:pt idx="596">
                  <c:v>18.984189021140502</c:v>
                </c:pt>
                <c:pt idx="597">
                  <c:v>18.655834564254118</c:v>
                </c:pt>
                <c:pt idx="598">
                  <c:v>18.6331826223708</c:v>
                </c:pt>
                <c:pt idx="599">
                  <c:v>19.704491255961774</c:v>
                </c:pt>
                <c:pt idx="600">
                  <c:v>19.869103773584889</c:v>
                </c:pt>
                <c:pt idx="601">
                  <c:v>18.241215574548889</c:v>
                </c:pt>
                <c:pt idx="602">
                  <c:v>19.658681522748399</c:v>
                </c:pt>
                <c:pt idx="603">
                  <c:v>18.591002044989789</c:v>
                </c:pt>
                <c:pt idx="604">
                  <c:v>18.008313539192375</c:v>
                </c:pt>
                <c:pt idx="605">
                  <c:v>16.544965411222126</c:v>
                </c:pt>
                <c:pt idx="606">
                  <c:v>19.889872173057999</c:v>
                </c:pt>
                <c:pt idx="607">
                  <c:v>18.186615886833486</c:v>
                </c:pt>
                <c:pt idx="608">
                  <c:v>20.032580737353499</c:v>
                </c:pt>
                <c:pt idx="609">
                  <c:v>19.114949146037201</c:v>
                </c:pt>
                <c:pt idx="610">
                  <c:v>16.856533333333264</c:v>
                </c:pt>
                <c:pt idx="611">
                  <c:v>15.5193798449612</c:v>
                </c:pt>
                <c:pt idx="612">
                  <c:v>17.734346224677687</c:v>
                </c:pt>
                <c:pt idx="613">
                  <c:v>18.391595615103501</c:v>
                </c:pt>
                <c:pt idx="614">
                  <c:v>18.362296524417086</c:v>
                </c:pt>
                <c:pt idx="615">
                  <c:v>18.453929539295402</c:v>
                </c:pt>
                <c:pt idx="616">
                  <c:v>18.313517915309401</c:v>
                </c:pt>
                <c:pt idx="617">
                  <c:v>13.4086021505376</c:v>
                </c:pt>
                <c:pt idx="618">
                  <c:v>18.568804034582087</c:v>
                </c:pt>
                <c:pt idx="619">
                  <c:v>16.517241379310299</c:v>
                </c:pt>
                <c:pt idx="620">
                  <c:v>17.870037609694901</c:v>
                </c:pt>
                <c:pt idx="621">
                  <c:v>19.250133618385878</c:v>
                </c:pt>
                <c:pt idx="622">
                  <c:v>19.666309012875502</c:v>
                </c:pt>
                <c:pt idx="623">
                  <c:v>19.388565891472886</c:v>
                </c:pt>
                <c:pt idx="624">
                  <c:v>18.985499365597164</c:v>
                </c:pt>
                <c:pt idx="625">
                  <c:v>21.406964764063517</c:v>
                </c:pt>
                <c:pt idx="626">
                  <c:v>18.550402144772089</c:v>
                </c:pt>
                <c:pt idx="627">
                  <c:v>18.237020316027099</c:v>
                </c:pt>
                <c:pt idx="628">
                  <c:v>17.002091321017801</c:v>
                </c:pt>
                <c:pt idx="629">
                  <c:v>19.255759922555686</c:v>
                </c:pt>
                <c:pt idx="630">
                  <c:v>18.245440494590376</c:v>
                </c:pt>
                <c:pt idx="631">
                  <c:v>17.252970606629088</c:v>
                </c:pt>
                <c:pt idx="632">
                  <c:v>18.945526020217073</c:v>
                </c:pt>
                <c:pt idx="633">
                  <c:v>17.784043715847002</c:v>
                </c:pt>
                <c:pt idx="634">
                  <c:v>19.145228215767577</c:v>
                </c:pt>
                <c:pt idx="635">
                  <c:v>16.524234693877599</c:v>
                </c:pt>
                <c:pt idx="636">
                  <c:v>18.139130434782601</c:v>
                </c:pt>
                <c:pt idx="637">
                  <c:v>19.247689463955599</c:v>
                </c:pt>
                <c:pt idx="638">
                  <c:v>19.7578326575746</c:v>
                </c:pt>
                <c:pt idx="639">
                  <c:v>17.943696450428376</c:v>
                </c:pt>
                <c:pt idx="640">
                  <c:v>17.812368024132716</c:v>
                </c:pt>
                <c:pt idx="641">
                  <c:v>20.437728937728878</c:v>
                </c:pt>
                <c:pt idx="642">
                  <c:v>16.509878903760399</c:v>
                </c:pt>
                <c:pt idx="643">
                  <c:v>17.412115193644517</c:v>
                </c:pt>
                <c:pt idx="644">
                  <c:v>17.908919202518376</c:v>
                </c:pt>
                <c:pt idx="645">
                  <c:v>21.338709677419377</c:v>
                </c:pt>
                <c:pt idx="646">
                  <c:v>19.483094555873876</c:v>
                </c:pt>
                <c:pt idx="647">
                  <c:v>20.756097560975586</c:v>
                </c:pt>
                <c:pt idx="648">
                  <c:v>18.298534798534789</c:v>
                </c:pt>
                <c:pt idx="649">
                  <c:v>18.105179282868502</c:v>
                </c:pt>
                <c:pt idx="650">
                  <c:v>18.600000000000001</c:v>
                </c:pt>
                <c:pt idx="651">
                  <c:v>18.7240857503153</c:v>
                </c:pt>
                <c:pt idx="652">
                  <c:v>17.312711673063877</c:v>
                </c:pt>
                <c:pt idx="653">
                  <c:v>18.110122989593187</c:v>
                </c:pt>
                <c:pt idx="654">
                  <c:v>17.844566712517199</c:v>
                </c:pt>
                <c:pt idx="655">
                  <c:v>19.0185873605948</c:v>
                </c:pt>
                <c:pt idx="656">
                  <c:v>17.879636638909876</c:v>
                </c:pt>
                <c:pt idx="657">
                  <c:v>17.607531380753102</c:v>
                </c:pt>
                <c:pt idx="658">
                  <c:v>18.343840579710086</c:v>
                </c:pt>
                <c:pt idx="659">
                  <c:v>17.246857717446034</c:v>
                </c:pt>
                <c:pt idx="660">
                  <c:v>18.025641025640986</c:v>
                </c:pt>
                <c:pt idx="661">
                  <c:v>18.65114815979873</c:v>
                </c:pt>
                <c:pt idx="662">
                  <c:v>18.922511935365353</c:v>
                </c:pt>
                <c:pt idx="663">
                  <c:v>19.305745695913689</c:v>
                </c:pt>
                <c:pt idx="664">
                  <c:v>20.044025157232717</c:v>
                </c:pt>
                <c:pt idx="665">
                  <c:v>17.884692995099499</c:v>
                </c:pt>
                <c:pt idx="666">
                  <c:v>17.319753086419801</c:v>
                </c:pt>
                <c:pt idx="667">
                  <c:v>20.211173757047717</c:v>
                </c:pt>
                <c:pt idx="668">
                  <c:v>17.410077373089287</c:v>
                </c:pt>
                <c:pt idx="669">
                  <c:v>18.166988416988431</c:v>
                </c:pt>
                <c:pt idx="670">
                  <c:v>18.867301398393288</c:v>
                </c:pt>
                <c:pt idx="671">
                  <c:v>17.239651416122001</c:v>
                </c:pt>
                <c:pt idx="672">
                  <c:v>18.262477450390886</c:v>
                </c:pt>
                <c:pt idx="673">
                  <c:v>17.5681063122924</c:v>
                </c:pt>
                <c:pt idx="674">
                  <c:v>17.476531942633589</c:v>
                </c:pt>
                <c:pt idx="675">
                  <c:v>18.093952483801299</c:v>
                </c:pt>
                <c:pt idx="676">
                  <c:v>20.247663551401889</c:v>
                </c:pt>
                <c:pt idx="677">
                  <c:v>18.203713254254787</c:v>
                </c:pt>
                <c:pt idx="678">
                  <c:v>19.525031289111379</c:v>
                </c:pt>
                <c:pt idx="679">
                  <c:v>18.314914992272026</c:v>
                </c:pt>
                <c:pt idx="680">
                  <c:v>16.622373651334499</c:v>
                </c:pt>
                <c:pt idx="681">
                  <c:v>7.0131578947368398</c:v>
                </c:pt>
                <c:pt idx="682">
                  <c:v>17.231588698471501</c:v>
                </c:pt>
                <c:pt idx="683">
                  <c:v>19.210365853658534</c:v>
                </c:pt>
                <c:pt idx="684">
                  <c:v>19.650522317188987</c:v>
                </c:pt>
                <c:pt idx="685">
                  <c:v>27.910925539318001</c:v>
                </c:pt>
                <c:pt idx="686">
                  <c:v>23.483496048349576</c:v>
                </c:pt>
                <c:pt idx="687">
                  <c:v>19.487023519870181</c:v>
                </c:pt>
                <c:pt idx="688">
                  <c:v>18.215</c:v>
                </c:pt>
                <c:pt idx="689">
                  <c:v>18.562277580071175</c:v>
                </c:pt>
                <c:pt idx="690">
                  <c:v>18.490585070611989</c:v>
                </c:pt>
                <c:pt idx="691">
                  <c:v>19.307220889954699</c:v>
                </c:pt>
                <c:pt idx="692">
                  <c:v>16.125641025640999</c:v>
                </c:pt>
                <c:pt idx="693">
                  <c:v>18.257748776508986</c:v>
                </c:pt>
                <c:pt idx="694">
                  <c:v>19.555793157076199</c:v>
                </c:pt>
                <c:pt idx="695">
                  <c:v>17.754329004328977</c:v>
                </c:pt>
                <c:pt idx="696">
                  <c:v>18.0121986639559</c:v>
                </c:pt>
                <c:pt idx="697">
                  <c:v>17.562013181545776</c:v>
                </c:pt>
                <c:pt idx="698">
                  <c:v>18.9519313304721</c:v>
                </c:pt>
                <c:pt idx="699">
                  <c:v>16.959852330410701</c:v>
                </c:pt>
                <c:pt idx="700">
                  <c:v>19.031739734179673</c:v>
                </c:pt>
                <c:pt idx="701">
                  <c:v>18.891090704043801</c:v>
                </c:pt>
                <c:pt idx="702">
                  <c:v>19.746857816182199</c:v>
                </c:pt>
                <c:pt idx="703">
                  <c:v>20.809409505520875</c:v>
                </c:pt>
                <c:pt idx="704">
                  <c:v>17.380370181694701</c:v>
                </c:pt>
                <c:pt idx="705">
                  <c:v>18.443047918303176</c:v>
                </c:pt>
                <c:pt idx="706">
                  <c:v>18.494557823129274</c:v>
                </c:pt>
                <c:pt idx="707">
                  <c:v>18.531569173630501</c:v>
                </c:pt>
                <c:pt idx="708">
                  <c:v>17.364639688379075</c:v>
                </c:pt>
                <c:pt idx="709">
                  <c:v>19.070548712206001</c:v>
                </c:pt>
                <c:pt idx="710">
                  <c:v>16.703045685279189</c:v>
                </c:pt>
                <c:pt idx="711">
                  <c:v>28.619718309859216</c:v>
                </c:pt>
                <c:pt idx="712">
                  <c:v>18.329700272479577</c:v>
                </c:pt>
                <c:pt idx="713">
                  <c:v>17.409778812572789</c:v>
                </c:pt>
                <c:pt idx="714">
                  <c:v>17.323890462700717</c:v>
                </c:pt>
                <c:pt idx="715">
                  <c:v>18.209422011084687</c:v>
                </c:pt>
                <c:pt idx="716">
                  <c:v>18.817673378076101</c:v>
                </c:pt>
                <c:pt idx="717">
                  <c:v>17.215495125705498</c:v>
                </c:pt>
                <c:pt idx="718">
                  <c:v>17.995745887691363</c:v>
                </c:pt>
                <c:pt idx="719">
                  <c:v>17.071910112359618</c:v>
                </c:pt>
                <c:pt idx="720">
                  <c:v>17.370639534883676</c:v>
                </c:pt>
                <c:pt idx="721">
                  <c:v>19.554880518428519</c:v>
                </c:pt>
                <c:pt idx="722">
                  <c:v>19.940054495912801</c:v>
                </c:pt>
                <c:pt idx="723">
                  <c:v>18.347649918962674</c:v>
                </c:pt>
                <c:pt idx="724">
                  <c:v>18.198135198135187</c:v>
                </c:pt>
                <c:pt idx="725">
                  <c:v>19.200038955979689</c:v>
                </c:pt>
                <c:pt idx="726">
                  <c:v>19.919487473704287</c:v>
                </c:pt>
                <c:pt idx="727">
                  <c:v>20.754530477759499</c:v>
                </c:pt>
                <c:pt idx="728">
                  <c:v>19.154031868662518</c:v>
                </c:pt>
                <c:pt idx="729">
                  <c:v>19.666218637992799</c:v>
                </c:pt>
                <c:pt idx="730">
                  <c:v>17.449733434881864</c:v>
                </c:pt>
                <c:pt idx="731">
                  <c:v>17.699461952344418</c:v>
                </c:pt>
                <c:pt idx="732">
                  <c:v>20.452204277607976</c:v>
                </c:pt>
                <c:pt idx="733">
                  <c:v>18.629750050802716</c:v>
                </c:pt>
                <c:pt idx="734">
                  <c:v>18.216047238624487</c:v>
                </c:pt>
                <c:pt idx="735">
                  <c:v>18.8031481816537</c:v>
                </c:pt>
                <c:pt idx="736">
                  <c:v>18.654595252586716</c:v>
                </c:pt>
                <c:pt idx="737">
                  <c:v>18.076037483266401</c:v>
                </c:pt>
                <c:pt idx="738">
                  <c:v>17.7472856608012</c:v>
                </c:pt>
                <c:pt idx="739">
                  <c:v>18.682953052203999</c:v>
                </c:pt>
                <c:pt idx="740">
                  <c:v>19.2506734510626</c:v>
                </c:pt>
                <c:pt idx="741">
                  <c:v>17.8305878552972</c:v>
                </c:pt>
                <c:pt idx="742">
                  <c:v>19.527419354838699</c:v>
                </c:pt>
                <c:pt idx="743">
                  <c:v>17.333333333333275</c:v>
                </c:pt>
                <c:pt idx="744">
                  <c:v>18.996576905522573</c:v>
                </c:pt>
                <c:pt idx="745">
                  <c:v>19.280217292892686</c:v>
                </c:pt>
                <c:pt idx="746">
                  <c:v>18.907275711159716</c:v>
                </c:pt>
                <c:pt idx="747">
                  <c:v>19.590144230769162</c:v>
                </c:pt>
                <c:pt idx="748">
                  <c:v>16.689562289562275</c:v>
                </c:pt>
                <c:pt idx="749">
                  <c:v>18.237937689550598</c:v>
                </c:pt>
                <c:pt idx="750">
                  <c:v>19.238888888888901</c:v>
                </c:pt>
                <c:pt idx="751">
                  <c:v>18.001372997711702</c:v>
                </c:pt>
                <c:pt idx="752">
                  <c:v>17.1412810297272</c:v>
                </c:pt>
                <c:pt idx="753">
                  <c:v>19.077789510735673</c:v>
                </c:pt>
                <c:pt idx="754">
                  <c:v>8.3137254901960809</c:v>
                </c:pt>
                <c:pt idx="755">
                  <c:v>17.8323699421965</c:v>
                </c:pt>
                <c:pt idx="756">
                  <c:v>17.799591524125589</c:v>
                </c:pt>
                <c:pt idx="757">
                  <c:v>19.127626153544099</c:v>
                </c:pt>
                <c:pt idx="758">
                  <c:v>19.801659528907887</c:v>
                </c:pt>
                <c:pt idx="759">
                  <c:v>18.708670520231173</c:v>
                </c:pt>
                <c:pt idx="760">
                  <c:v>18.702497687326478</c:v>
                </c:pt>
                <c:pt idx="761">
                  <c:v>17.354545454545505</c:v>
                </c:pt>
                <c:pt idx="762">
                  <c:v>17.529717103555686</c:v>
                </c:pt>
                <c:pt idx="763">
                  <c:v>15.979209979210006</c:v>
                </c:pt>
                <c:pt idx="764">
                  <c:v>18.015644820296</c:v>
                </c:pt>
                <c:pt idx="765">
                  <c:v>17.796548956661276</c:v>
                </c:pt>
                <c:pt idx="766">
                  <c:v>18.085550552599276</c:v>
                </c:pt>
                <c:pt idx="767">
                  <c:v>19.403294518602699</c:v>
                </c:pt>
                <c:pt idx="768">
                  <c:v>18.481752963193976</c:v>
                </c:pt>
                <c:pt idx="769">
                  <c:v>17.738519719070787</c:v>
                </c:pt>
                <c:pt idx="770">
                  <c:v>19.016798080219399</c:v>
                </c:pt>
                <c:pt idx="771">
                  <c:v>20.255196815568276</c:v>
                </c:pt>
                <c:pt idx="772">
                  <c:v>18.232406356413186</c:v>
                </c:pt>
                <c:pt idx="773">
                  <c:v>18.782543747332475</c:v>
                </c:pt>
                <c:pt idx="774">
                  <c:v>18.226332126228687</c:v>
                </c:pt>
                <c:pt idx="775">
                  <c:v>20.010801963993526</c:v>
                </c:pt>
                <c:pt idx="776">
                  <c:v>17.989002036659876</c:v>
                </c:pt>
                <c:pt idx="777">
                  <c:v>18.4988009592326</c:v>
                </c:pt>
                <c:pt idx="778">
                  <c:v>18.792464878671776</c:v>
                </c:pt>
                <c:pt idx="779">
                  <c:v>19.035971223021601</c:v>
                </c:pt>
                <c:pt idx="780">
                  <c:v>17.729544969023689</c:v>
                </c:pt>
                <c:pt idx="781">
                  <c:v>18.757944087515199</c:v>
                </c:pt>
                <c:pt idx="782">
                  <c:v>18.919077691290905</c:v>
                </c:pt>
                <c:pt idx="783">
                  <c:v>19.832823259372599</c:v>
                </c:pt>
                <c:pt idx="784">
                  <c:v>19.318149800422589</c:v>
                </c:pt>
                <c:pt idx="785">
                  <c:v>19.142022357723576</c:v>
                </c:pt>
                <c:pt idx="786">
                  <c:v>17.639877924720217</c:v>
                </c:pt>
                <c:pt idx="787">
                  <c:v>18.093153759820417</c:v>
                </c:pt>
                <c:pt idx="788">
                  <c:v>17.011891891891917</c:v>
                </c:pt>
                <c:pt idx="789">
                  <c:v>16.280136986301354</c:v>
                </c:pt>
                <c:pt idx="790">
                  <c:v>18.624213075060499</c:v>
                </c:pt>
                <c:pt idx="791">
                  <c:v>17.321389793702501</c:v>
                </c:pt>
                <c:pt idx="792">
                  <c:v>18.091743119266088</c:v>
                </c:pt>
                <c:pt idx="793">
                  <c:v>15.835294117647109</c:v>
                </c:pt>
                <c:pt idx="794">
                  <c:v>18.742591931453077</c:v>
                </c:pt>
                <c:pt idx="795">
                  <c:v>17.286885245901587</c:v>
                </c:pt>
                <c:pt idx="796">
                  <c:v>17.875</c:v>
                </c:pt>
                <c:pt idx="797">
                  <c:v>16.880303030302976</c:v>
                </c:pt>
                <c:pt idx="798">
                  <c:v>17.069745815251089</c:v>
                </c:pt>
                <c:pt idx="799">
                  <c:v>18.153084539223187</c:v>
                </c:pt>
                <c:pt idx="800">
                  <c:v>16.746630727762778</c:v>
                </c:pt>
                <c:pt idx="801">
                  <c:v>18.634081902245718</c:v>
                </c:pt>
                <c:pt idx="802">
                  <c:v>18.018874172185399</c:v>
                </c:pt>
                <c:pt idx="803">
                  <c:v>18.633143939393889</c:v>
                </c:pt>
                <c:pt idx="804">
                  <c:v>19.968299711815586</c:v>
                </c:pt>
                <c:pt idx="805">
                  <c:v>18.785640673308063</c:v>
                </c:pt>
                <c:pt idx="806">
                  <c:v>17.865339366515776</c:v>
                </c:pt>
                <c:pt idx="807">
                  <c:v>17.025262339681277</c:v>
                </c:pt>
                <c:pt idx="808">
                  <c:v>17.560286866875789</c:v>
                </c:pt>
                <c:pt idx="809">
                  <c:v>19.970473537604502</c:v>
                </c:pt>
                <c:pt idx="810">
                  <c:v>19.093268145919517</c:v>
                </c:pt>
                <c:pt idx="811">
                  <c:v>17.571218795888431</c:v>
                </c:pt>
                <c:pt idx="812">
                  <c:v>17.153805774278226</c:v>
                </c:pt>
                <c:pt idx="813">
                  <c:v>18.320901994796198</c:v>
                </c:pt>
                <c:pt idx="814">
                  <c:v>18.069752694990488</c:v>
                </c:pt>
                <c:pt idx="815">
                  <c:v>18.062922038060176</c:v>
                </c:pt>
                <c:pt idx="816">
                  <c:v>17.884358144552301</c:v>
                </c:pt>
                <c:pt idx="817">
                  <c:v>17.969156956819699</c:v>
                </c:pt>
                <c:pt idx="818">
                  <c:v>18.924136469590987</c:v>
                </c:pt>
                <c:pt idx="819">
                  <c:v>17.455445544554486</c:v>
                </c:pt>
                <c:pt idx="820">
                  <c:v>17.342199641362775</c:v>
                </c:pt>
                <c:pt idx="821">
                  <c:v>19.71706110914873</c:v>
                </c:pt>
                <c:pt idx="822">
                  <c:v>18.862558191088418</c:v>
                </c:pt>
                <c:pt idx="823">
                  <c:v>18.483418711242887</c:v>
                </c:pt>
                <c:pt idx="824">
                  <c:v>16.947368421052634</c:v>
                </c:pt>
                <c:pt idx="825">
                  <c:v>17.275608519269777</c:v>
                </c:pt>
                <c:pt idx="826">
                  <c:v>18.287387575820976</c:v>
                </c:pt>
                <c:pt idx="827">
                  <c:v>16.692987012987</c:v>
                </c:pt>
                <c:pt idx="828">
                  <c:v>18.1069565217391</c:v>
                </c:pt>
                <c:pt idx="829">
                  <c:v>18.982279868469064</c:v>
                </c:pt>
                <c:pt idx="830">
                  <c:v>20.6904761904762</c:v>
                </c:pt>
                <c:pt idx="831">
                  <c:v>18.634139236819099</c:v>
                </c:pt>
                <c:pt idx="832">
                  <c:v>18.808437856328379</c:v>
                </c:pt>
                <c:pt idx="833">
                  <c:v>19.046251018744901</c:v>
                </c:pt>
                <c:pt idx="834">
                  <c:v>17.126719278466677</c:v>
                </c:pt>
                <c:pt idx="835">
                  <c:v>17.665480427046301</c:v>
                </c:pt>
                <c:pt idx="836">
                  <c:v>19.586414132216401</c:v>
                </c:pt>
                <c:pt idx="837">
                  <c:v>18.447710396039589</c:v>
                </c:pt>
                <c:pt idx="838">
                  <c:v>17.916340891321259</c:v>
                </c:pt>
                <c:pt idx="839">
                  <c:v>18.086839749328586</c:v>
                </c:pt>
                <c:pt idx="840">
                  <c:v>18.513476562499999</c:v>
                </c:pt>
                <c:pt idx="841">
                  <c:v>18.199925539836201</c:v>
                </c:pt>
                <c:pt idx="842">
                  <c:v>18.383008356546</c:v>
                </c:pt>
                <c:pt idx="843">
                  <c:v>18.548875096974399</c:v>
                </c:pt>
                <c:pt idx="844">
                  <c:v>17.459509918319689</c:v>
                </c:pt>
                <c:pt idx="845">
                  <c:v>18.525198938991974</c:v>
                </c:pt>
                <c:pt idx="846">
                  <c:v>18.125801853171787</c:v>
                </c:pt>
                <c:pt idx="847">
                  <c:v>19.3540096618358</c:v>
                </c:pt>
                <c:pt idx="848">
                  <c:v>19.114448051948116</c:v>
                </c:pt>
                <c:pt idx="849">
                  <c:v>18.942283563362576</c:v>
                </c:pt>
                <c:pt idx="850">
                  <c:v>17.768060836501864</c:v>
                </c:pt>
                <c:pt idx="851">
                  <c:v>18.705661792276</c:v>
                </c:pt>
                <c:pt idx="852">
                  <c:v>17.037719298245602</c:v>
                </c:pt>
                <c:pt idx="853">
                  <c:v>18.176947040498426</c:v>
                </c:pt>
                <c:pt idx="854">
                  <c:v>18.7419038272817</c:v>
                </c:pt>
                <c:pt idx="855">
                  <c:v>17.405918057663087</c:v>
                </c:pt>
                <c:pt idx="856">
                  <c:v>18.6222684703434</c:v>
                </c:pt>
                <c:pt idx="857">
                  <c:v>18.995173615766173</c:v>
                </c:pt>
                <c:pt idx="858">
                  <c:v>18.1124137931034</c:v>
                </c:pt>
                <c:pt idx="859">
                  <c:v>18.890942698706102</c:v>
                </c:pt>
                <c:pt idx="860">
                  <c:v>18.973309608540877</c:v>
                </c:pt>
                <c:pt idx="861">
                  <c:v>18.984242977848776</c:v>
                </c:pt>
                <c:pt idx="862">
                  <c:v>18.691553414760001</c:v>
                </c:pt>
                <c:pt idx="863">
                  <c:v>17.097045191193505</c:v>
                </c:pt>
                <c:pt idx="864">
                  <c:v>19.135224760501099</c:v>
                </c:pt>
                <c:pt idx="865">
                  <c:v>18.551552431165781</c:v>
                </c:pt>
                <c:pt idx="866">
                  <c:v>19.747442958300489</c:v>
                </c:pt>
                <c:pt idx="867">
                  <c:v>18.536231884058001</c:v>
                </c:pt>
                <c:pt idx="868">
                  <c:v>17.549083503055002</c:v>
                </c:pt>
                <c:pt idx="869">
                  <c:v>18.037809968082534</c:v>
                </c:pt>
                <c:pt idx="870">
                  <c:v>18.617174136161498</c:v>
                </c:pt>
                <c:pt idx="871">
                  <c:v>18.079201545396</c:v>
                </c:pt>
                <c:pt idx="872">
                  <c:v>19.035786290322577</c:v>
                </c:pt>
                <c:pt idx="873">
                  <c:v>18.141713747646001</c:v>
                </c:pt>
                <c:pt idx="874">
                  <c:v>17.392077607114</c:v>
                </c:pt>
                <c:pt idx="875">
                  <c:v>18.761574074074087</c:v>
                </c:pt>
                <c:pt idx="876">
                  <c:v>19.540819333922776</c:v>
                </c:pt>
                <c:pt idx="877">
                  <c:v>19.124087591240901</c:v>
                </c:pt>
                <c:pt idx="878">
                  <c:v>18.148446069469777</c:v>
                </c:pt>
                <c:pt idx="879">
                  <c:v>19.481818181818198</c:v>
                </c:pt>
                <c:pt idx="880">
                  <c:v>18.123437499999987</c:v>
                </c:pt>
                <c:pt idx="881">
                  <c:v>17.504995004995017</c:v>
                </c:pt>
                <c:pt idx="882">
                  <c:v>19.195121951219505</c:v>
                </c:pt>
                <c:pt idx="883">
                  <c:v>18.0174897119342</c:v>
                </c:pt>
                <c:pt idx="884">
                  <c:v>16.634310751600918</c:v>
                </c:pt>
                <c:pt idx="885">
                  <c:v>19.436578171091401</c:v>
                </c:pt>
                <c:pt idx="886">
                  <c:v>18.5602858918583</c:v>
                </c:pt>
                <c:pt idx="887">
                  <c:v>17.657795867251117</c:v>
                </c:pt>
                <c:pt idx="888">
                  <c:v>17.783242258652074</c:v>
                </c:pt>
                <c:pt idx="889">
                  <c:v>20.873051856049901</c:v>
                </c:pt>
                <c:pt idx="890">
                  <c:v>17.330237358101087</c:v>
                </c:pt>
                <c:pt idx="891">
                  <c:v>19.668805377329686</c:v>
                </c:pt>
                <c:pt idx="892">
                  <c:v>17.740402193784274</c:v>
                </c:pt>
                <c:pt idx="893">
                  <c:v>16.911487758945388</c:v>
                </c:pt>
                <c:pt idx="894">
                  <c:v>18.090032154340786</c:v>
                </c:pt>
                <c:pt idx="895">
                  <c:v>19.705172413793086</c:v>
                </c:pt>
                <c:pt idx="896">
                  <c:v>17.283755868544599</c:v>
                </c:pt>
                <c:pt idx="897">
                  <c:v>18.673631614808105</c:v>
                </c:pt>
                <c:pt idx="898">
                  <c:v>17.768819415878188</c:v>
                </c:pt>
                <c:pt idx="899">
                  <c:v>18.859690087030401</c:v>
                </c:pt>
                <c:pt idx="900">
                  <c:v>18.0482711400205</c:v>
                </c:pt>
                <c:pt idx="901">
                  <c:v>17.628966223132</c:v>
                </c:pt>
                <c:pt idx="902">
                  <c:v>18.534514355528401</c:v>
                </c:pt>
                <c:pt idx="903">
                  <c:v>20.2100893997446</c:v>
                </c:pt>
                <c:pt idx="904">
                  <c:v>17.137798306389517</c:v>
                </c:pt>
                <c:pt idx="905">
                  <c:v>18.438184663536799</c:v>
                </c:pt>
                <c:pt idx="906">
                  <c:v>19.158883720930216</c:v>
                </c:pt>
                <c:pt idx="907">
                  <c:v>18.15425531914893</c:v>
                </c:pt>
                <c:pt idx="908">
                  <c:v>17.338323353293401</c:v>
                </c:pt>
                <c:pt idx="909">
                  <c:v>18.646386430678501</c:v>
                </c:pt>
                <c:pt idx="910">
                  <c:v>19.202606906014189</c:v>
                </c:pt>
                <c:pt idx="911">
                  <c:v>17.891922639362889</c:v>
                </c:pt>
                <c:pt idx="912">
                  <c:v>14.457446808510618</c:v>
                </c:pt>
                <c:pt idx="913">
                  <c:v>18.477259643062787</c:v>
                </c:pt>
                <c:pt idx="914">
                  <c:v>18.349925705794917</c:v>
                </c:pt>
                <c:pt idx="915">
                  <c:v>17.947168917318201</c:v>
                </c:pt>
                <c:pt idx="916">
                  <c:v>18.984628897672376</c:v>
                </c:pt>
                <c:pt idx="917">
                  <c:v>18.372759856630786</c:v>
                </c:pt>
                <c:pt idx="918">
                  <c:v>17.418968692449418</c:v>
                </c:pt>
                <c:pt idx="919">
                  <c:v>17.028011204481789</c:v>
                </c:pt>
                <c:pt idx="920">
                  <c:v>21.904176904176889</c:v>
                </c:pt>
                <c:pt idx="921">
                  <c:v>18.272442915232975</c:v>
                </c:pt>
                <c:pt idx="922">
                  <c:v>17.438414346389774</c:v>
                </c:pt>
                <c:pt idx="923">
                  <c:v>17.925477707006401</c:v>
                </c:pt>
                <c:pt idx="924">
                  <c:v>19.473830845771076</c:v>
                </c:pt>
                <c:pt idx="925">
                  <c:v>18.374564779182698</c:v>
                </c:pt>
                <c:pt idx="926">
                  <c:v>17.441114982578402</c:v>
                </c:pt>
                <c:pt idx="927">
                  <c:v>19.223166368515187</c:v>
                </c:pt>
                <c:pt idx="928">
                  <c:v>19.008503401360489</c:v>
                </c:pt>
                <c:pt idx="929">
                  <c:v>17.616207951070301</c:v>
                </c:pt>
                <c:pt idx="930">
                  <c:v>15.9347826086957</c:v>
                </c:pt>
                <c:pt idx="931">
                  <c:v>18.072428648357587</c:v>
                </c:pt>
                <c:pt idx="932">
                  <c:v>17.977303754266199</c:v>
                </c:pt>
                <c:pt idx="933">
                  <c:v>19.187472035794187</c:v>
                </c:pt>
                <c:pt idx="934">
                  <c:v>16.668854850474101</c:v>
                </c:pt>
                <c:pt idx="935">
                  <c:v>19.025506756756787</c:v>
                </c:pt>
                <c:pt idx="936">
                  <c:v>18.379227394934187</c:v>
                </c:pt>
                <c:pt idx="937">
                  <c:v>18.483269800931755</c:v>
                </c:pt>
                <c:pt idx="938">
                  <c:v>19.222248689852286</c:v>
                </c:pt>
                <c:pt idx="939">
                  <c:v>18.857142857142886</c:v>
                </c:pt>
                <c:pt idx="940">
                  <c:v>18.695151776722799</c:v>
                </c:pt>
                <c:pt idx="941">
                  <c:v>18.771410775459401</c:v>
                </c:pt>
                <c:pt idx="942">
                  <c:v>19.737644341801381</c:v>
                </c:pt>
                <c:pt idx="943">
                  <c:v>17.627845595513001</c:v>
                </c:pt>
                <c:pt idx="944">
                  <c:v>18.662554112554101</c:v>
                </c:pt>
                <c:pt idx="945">
                  <c:v>18.018290089323678</c:v>
                </c:pt>
                <c:pt idx="946">
                  <c:v>18.756317689530686</c:v>
                </c:pt>
                <c:pt idx="947">
                  <c:v>19.956184137548501</c:v>
                </c:pt>
                <c:pt idx="948">
                  <c:v>17.2231977818854</c:v>
                </c:pt>
                <c:pt idx="949">
                  <c:v>18.5940968122786</c:v>
                </c:pt>
                <c:pt idx="950">
                  <c:v>18.031624863685899</c:v>
                </c:pt>
                <c:pt idx="951">
                  <c:v>17.520943952802401</c:v>
                </c:pt>
                <c:pt idx="952">
                  <c:v>17.495877502944602</c:v>
                </c:pt>
                <c:pt idx="953">
                  <c:v>17.943589743589676</c:v>
                </c:pt>
                <c:pt idx="954">
                  <c:v>21.689075630252098</c:v>
                </c:pt>
                <c:pt idx="955">
                  <c:v>16.244</c:v>
                </c:pt>
                <c:pt idx="956">
                  <c:v>19.578370652691799</c:v>
                </c:pt>
                <c:pt idx="957">
                  <c:v>18.382857142857105</c:v>
                </c:pt>
                <c:pt idx="958">
                  <c:v>18.750774793388388</c:v>
                </c:pt>
                <c:pt idx="959">
                  <c:v>18.902909550917077</c:v>
                </c:pt>
                <c:pt idx="960">
                  <c:v>18.973720608575366</c:v>
                </c:pt>
                <c:pt idx="961">
                  <c:v>18.114974937343426</c:v>
                </c:pt>
                <c:pt idx="962">
                  <c:v>17.546788990825689</c:v>
                </c:pt>
                <c:pt idx="963">
                  <c:v>16.917127071823177</c:v>
                </c:pt>
                <c:pt idx="964">
                  <c:v>18.333333333333275</c:v>
                </c:pt>
                <c:pt idx="965">
                  <c:v>17.4396512161542</c:v>
                </c:pt>
                <c:pt idx="966">
                  <c:v>20.138483965014618</c:v>
                </c:pt>
                <c:pt idx="967">
                  <c:v>20.702413390424276</c:v>
                </c:pt>
                <c:pt idx="968">
                  <c:v>18.479664299548102</c:v>
                </c:pt>
                <c:pt idx="969">
                  <c:v>20.312162454093805</c:v>
                </c:pt>
                <c:pt idx="970">
                  <c:v>17.290694149742286</c:v>
                </c:pt>
                <c:pt idx="971">
                  <c:v>18.798285426122</c:v>
                </c:pt>
                <c:pt idx="972">
                  <c:v>17.977011494252917</c:v>
                </c:pt>
                <c:pt idx="973">
                  <c:v>19.102941176470601</c:v>
                </c:pt>
                <c:pt idx="974">
                  <c:v>17.579617834394877</c:v>
                </c:pt>
                <c:pt idx="975">
                  <c:v>19.817006269592518</c:v>
                </c:pt>
                <c:pt idx="976">
                  <c:v>17.531610090314501</c:v>
                </c:pt>
                <c:pt idx="977">
                  <c:v>19.027777777777789</c:v>
                </c:pt>
                <c:pt idx="978">
                  <c:v>18.170196078431378</c:v>
                </c:pt>
                <c:pt idx="979">
                  <c:v>18.281459419210705</c:v>
                </c:pt>
                <c:pt idx="980">
                  <c:v>16.892307692307689</c:v>
                </c:pt>
                <c:pt idx="981">
                  <c:v>17.157079646017717</c:v>
                </c:pt>
                <c:pt idx="982">
                  <c:v>18.143747218513589</c:v>
                </c:pt>
                <c:pt idx="983">
                  <c:v>17.630136986301402</c:v>
                </c:pt>
                <c:pt idx="984">
                  <c:v>15.370833333333309</c:v>
                </c:pt>
                <c:pt idx="985">
                  <c:v>17.282565918929578</c:v>
                </c:pt>
                <c:pt idx="986">
                  <c:v>16.767128712871287</c:v>
                </c:pt>
                <c:pt idx="987">
                  <c:v>19.173119880863673</c:v>
                </c:pt>
                <c:pt idx="988">
                  <c:v>18.4442387124341</c:v>
                </c:pt>
                <c:pt idx="989">
                  <c:v>19.226515002941778</c:v>
                </c:pt>
                <c:pt idx="990">
                  <c:v>19.269841269841287</c:v>
                </c:pt>
                <c:pt idx="991">
                  <c:v>20.130756578947373</c:v>
                </c:pt>
                <c:pt idx="992">
                  <c:v>17.860050890585189</c:v>
                </c:pt>
                <c:pt idx="993">
                  <c:v>17.2155688622755</c:v>
                </c:pt>
                <c:pt idx="994">
                  <c:v>17.944053208137689</c:v>
                </c:pt>
                <c:pt idx="995">
                  <c:v>39.979315394471982</c:v>
                </c:pt>
                <c:pt idx="996">
                  <c:v>61.619834710743795</c:v>
                </c:pt>
                <c:pt idx="997">
                  <c:v>17.247916023464001</c:v>
                </c:pt>
                <c:pt idx="998">
                  <c:v>18.6743308167467</c:v>
                </c:pt>
                <c:pt idx="999">
                  <c:v>17.471830985915499</c:v>
                </c:pt>
                <c:pt idx="1000">
                  <c:v>17.915748311411289</c:v>
                </c:pt>
                <c:pt idx="1001">
                  <c:v>18.728679504814274</c:v>
                </c:pt>
                <c:pt idx="1002">
                  <c:v>18.754843254667087</c:v>
                </c:pt>
                <c:pt idx="1003">
                  <c:v>18.956806282722489</c:v>
                </c:pt>
                <c:pt idx="1004">
                  <c:v>17.661324786324787</c:v>
                </c:pt>
                <c:pt idx="1005">
                  <c:v>18.108612804877978</c:v>
                </c:pt>
                <c:pt idx="1006">
                  <c:v>18.3845046082949</c:v>
                </c:pt>
                <c:pt idx="1007">
                  <c:v>18.987572493786189</c:v>
                </c:pt>
                <c:pt idx="1008">
                  <c:v>17.616302186878698</c:v>
                </c:pt>
                <c:pt idx="1009">
                  <c:v>18.891425046267699</c:v>
                </c:pt>
                <c:pt idx="1010">
                  <c:v>18.870322817314687</c:v>
                </c:pt>
                <c:pt idx="1011">
                  <c:v>19.565926227837789</c:v>
                </c:pt>
                <c:pt idx="1012">
                  <c:v>18.566069195498098</c:v>
                </c:pt>
                <c:pt idx="1013">
                  <c:v>20.047142261159777</c:v>
                </c:pt>
                <c:pt idx="1014">
                  <c:v>18.680933852140086</c:v>
                </c:pt>
                <c:pt idx="1015">
                  <c:v>18.220235591081178</c:v>
                </c:pt>
                <c:pt idx="1016">
                  <c:v>18.650246305418701</c:v>
                </c:pt>
                <c:pt idx="1017">
                  <c:v>17.416703885663171</c:v>
                </c:pt>
                <c:pt idx="1018">
                  <c:v>18.690317195325488</c:v>
                </c:pt>
                <c:pt idx="1019">
                  <c:v>17.386349001931659</c:v>
                </c:pt>
                <c:pt idx="1020">
                  <c:v>16.406567630961664</c:v>
                </c:pt>
                <c:pt idx="1021">
                  <c:v>17.522110739501976</c:v>
                </c:pt>
                <c:pt idx="1022">
                  <c:v>19.314786192684217</c:v>
                </c:pt>
                <c:pt idx="1023">
                  <c:v>17.760011778562976</c:v>
                </c:pt>
                <c:pt idx="1024">
                  <c:v>18.728626116546089</c:v>
                </c:pt>
                <c:pt idx="1025">
                  <c:v>15.672917815775008</c:v>
                </c:pt>
                <c:pt idx="1026">
                  <c:v>18.939971414959526</c:v>
                </c:pt>
                <c:pt idx="1027">
                  <c:v>18.441058540497199</c:v>
                </c:pt>
                <c:pt idx="1028">
                  <c:v>20.222820641282599</c:v>
                </c:pt>
                <c:pt idx="1029">
                  <c:v>17.555809959931278</c:v>
                </c:pt>
                <c:pt idx="1030">
                  <c:v>19.473684210526276</c:v>
                </c:pt>
                <c:pt idx="1031">
                  <c:v>19.759636631475576</c:v>
                </c:pt>
                <c:pt idx="1032">
                  <c:v>17.219175379759299</c:v>
                </c:pt>
                <c:pt idx="1033">
                  <c:v>16.932236475181259</c:v>
                </c:pt>
                <c:pt idx="1034">
                  <c:v>19.262878262878299</c:v>
                </c:pt>
                <c:pt idx="1035">
                  <c:v>18.0031076581576</c:v>
                </c:pt>
                <c:pt idx="1036">
                  <c:v>17.887154861944801</c:v>
                </c:pt>
                <c:pt idx="1037">
                  <c:v>16.5550181378476</c:v>
                </c:pt>
                <c:pt idx="1038">
                  <c:v>19.255654281098501</c:v>
                </c:pt>
                <c:pt idx="1039">
                  <c:v>18.752411575562675</c:v>
                </c:pt>
                <c:pt idx="1040">
                  <c:v>16.717149220490001</c:v>
                </c:pt>
                <c:pt idx="1041">
                  <c:v>17.921700223713589</c:v>
                </c:pt>
                <c:pt idx="1042">
                  <c:v>10.968824940048</c:v>
                </c:pt>
                <c:pt idx="1043">
                  <c:v>15.063573883161499</c:v>
                </c:pt>
                <c:pt idx="1044">
                  <c:v>16.356559949780287</c:v>
                </c:pt>
                <c:pt idx="1045">
                  <c:v>18.1016597510373</c:v>
                </c:pt>
                <c:pt idx="1046">
                  <c:v>17.6593406593407</c:v>
                </c:pt>
                <c:pt idx="1047">
                  <c:v>16.697326203208601</c:v>
                </c:pt>
                <c:pt idx="1048">
                  <c:v>18.024072216649888</c:v>
                </c:pt>
                <c:pt idx="1049">
                  <c:v>18.488666315234589</c:v>
                </c:pt>
                <c:pt idx="1050">
                  <c:v>20.803216374268978</c:v>
                </c:pt>
                <c:pt idx="1051">
                  <c:v>19.17715865589113</c:v>
                </c:pt>
                <c:pt idx="1052">
                  <c:v>16.510135135135087</c:v>
                </c:pt>
                <c:pt idx="1053">
                  <c:v>20.344484269215517</c:v>
                </c:pt>
                <c:pt idx="1054">
                  <c:v>18.368690851734975</c:v>
                </c:pt>
                <c:pt idx="1055">
                  <c:v>19.682153392330378</c:v>
                </c:pt>
                <c:pt idx="1056">
                  <c:v>17.080496780128776</c:v>
                </c:pt>
                <c:pt idx="1057">
                  <c:v>19.5170542635659</c:v>
                </c:pt>
                <c:pt idx="1058">
                  <c:v>19.952641165755889</c:v>
                </c:pt>
                <c:pt idx="1059">
                  <c:v>18.254065664314219</c:v>
                </c:pt>
                <c:pt idx="1060">
                  <c:v>14.743909512761</c:v>
                </c:pt>
                <c:pt idx="1061">
                  <c:v>14.9271882261813</c:v>
                </c:pt>
                <c:pt idx="1062">
                  <c:v>13.909638554216915</c:v>
                </c:pt>
                <c:pt idx="1063">
                  <c:v>12.0883947939262</c:v>
                </c:pt>
                <c:pt idx="1064">
                  <c:v>15.420677361853798</c:v>
                </c:pt>
                <c:pt idx="1065">
                  <c:v>8.9193548387096957</c:v>
                </c:pt>
                <c:pt idx="1066">
                  <c:v>19.443037974683477</c:v>
                </c:pt>
                <c:pt idx="1067">
                  <c:v>18.1477093206951</c:v>
                </c:pt>
                <c:pt idx="1068">
                  <c:v>19.260017050298401</c:v>
                </c:pt>
                <c:pt idx="1069">
                  <c:v>13.4014835419564</c:v>
                </c:pt>
                <c:pt idx="1070">
                  <c:v>10.785058977719499</c:v>
                </c:pt>
                <c:pt idx="1071">
                  <c:v>11.234343434343398</c:v>
                </c:pt>
                <c:pt idx="1072">
                  <c:v>16.832014072119588</c:v>
                </c:pt>
                <c:pt idx="1073">
                  <c:v>15.904611211573204</c:v>
                </c:pt>
                <c:pt idx="1074">
                  <c:v>16.701555869872717</c:v>
                </c:pt>
                <c:pt idx="1075">
                  <c:v>17.869655891553688</c:v>
                </c:pt>
                <c:pt idx="1076">
                  <c:v>18.611670864819533</c:v>
                </c:pt>
                <c:pt idx="1077">
                  <c:v>14.857843137254909</c:v>
                </c:pt>
                <c:pt idx="1078">
                  <c:v>17.456449309852488</c:v>
                </c:pt>
                <c:pt idx="1079">
                  <c:v>17.675685425685426</c:v>
                </c:pt>
                <c:pt idx="1080">
                  <c:v>19.384615384615401</c:v>
                </c:pt>
                <c:pt idx="1081">
                  <c:v>17.157041540020288</c:v>
                </c:pt>
                <c:pt idx="1082">
                  <c:v>17.373544973544973</c:v>
                </c:pt>
                <c:pt idx="1083">
                  <c:v>15.967032967033004</c:v>
                </c:pt>
                <c:pt idx="1084">
                  <c:v>15.046073977936398</c:v>
                </c:pt>
                <c:pt idx="1085">
                  <c:v>13.665401044138608</c:v>
                </c:pt>
                <c:pt idx="1086">
                  <c:v>19.1615782057304</c:v>
                </c:pt>
                <c:pt idx="1087">
                  <c:v>17.812865497076039</c:v>
                </c:pt>
                <c:pt idx="1088">
                  <c:v>15.002675227394302</c:v>
                </c:pt>
                <c:pt idx="1089">
                  <c:v>19.676082862523486</c:v>
                </c:pt>
                <c:pt idx="1090">
                  <c:v>15.4347826086957</c:v>
                </c:pt>
                <c:pt idx="1091">
                  <c:v>15.8509234828496</c:v>
                </c:pt>
                <c:pt idx="1092">
                  <c:v>16.9074529074529</c:v>
                </c:pt>
                <c:pt idx="1093">
                  <c:v>19.529478889311488</c:v>
                </c:pt>
                <c:pt idx="1094">
                  <c:v>12.967741935483909</c:v>
                </c:pt>
                <c:pt idx="1095">
                  <c:v>12.362683438155109</c:v>
                </c:pt>
                <c:pt idx="1096">
                  <c:v>14.3002915451895</c:v>
                </c:pt>
                <c:pt idx="1097">
                  <c:v>19.2216551221291</c:v>
                </c:pt>
                <c:pt idx="1098">
                  <c:v>20.119477911646634</c:v>
                </c:pt>
                <c:pt idx="1099">
                  <c:v>15.2919975565058</c:v>
                </c:pt>
                <c:pt idx="1100">
                  <c:v>10.5139153640869</c:v>
                </c:pt>
                <c:pt idx="1101">
                  <c:v>11.394112060778699</c:v>
                </c:pt>
                <c:pt idx="1102">
                  <c:v>11.771265189420998</c:v>
                </c:pt>
                <c:pt idx="1103">
                  <c:v>15.606724707295101</c:v>
                </c:pt>
                <c:pt idx="1104">
                  <c:v>16.1261453879047</c:v>
                </c:pt>
                <c:pt idx="1105">
                  <c:v>17.204739336492889</c:v>
                </c:pt>
                <c:pt idx="1106">
                  <c:v>16.4341563786008</c:v>
                </c:pt>
                <c:pt idx="1107">
                  <c:v>13.65314401622722</c:v>
                </c:pt>
                <c:pt idx="1108">
                  <c:v>19.508982035928089</c:v>
                </c:pt>
                <c:pt idx="1109">
                  <c:v>20.132463424278431</c:v>
                </c:pt>
                <c:pt idx="1110">
                  <c:v>18.052386078220277</c:v>
                </c:pt>
                <c:pt idx="1111">
                  <c:v>15.107238605898099</c:v>
                </c:pt>
                <c:pt idx="1112">
                  <c:v>18.275379229871589</c:v>
                </c:pt>
                <c:pt idx="1113">
                  <c:v>18.933884297520699</c:v>
                </c:pt>
                <c:pt idx="1114">
                  <c:v>17.691909975669088</c:v>
                </c:pt>
                <c:pt idx="1115">
                  <c:v>15.4281241104469</c:v>
                </c:pt>
                <c:pt idx="1116">
                  <c:v>17.370112945264989</c:v>
                </c:pt>
                <c:pt idx="1117">
                  <c:v>17.428176795580089</c:v>
                </c:pt>
                <c:pt idx="1118">
                  <c:v>17.416365280289288</c:v>
                </c:pt>
                <c:pt idx="1119">
                  <c:v>19.591979301422999</c:v>
                </c:pt>
                <c:pt idx="1120">
                  <c:v>13.6663146779303</c:v>
                </c:pt>
                <c:pt idx="1121">
                  <c:v>19.086619062402978</c:v>
                </c:pt>
                <c:pt idx="1122">
                  <c:v>19.606156274664599</c:v>
                </c:pt>
                <c:pt idx="1123">
                  <c:v>11.480537862703509</c:v>
                </c:pt>
                <c:pt idx="1124">
                  <c:v>13.095681310498909</c:v>
                </c:pt>
                <c:pt idx="1125">
                  <c:v>20.440765649249887</c:v>
                </c:pt>
                <c:pt idx="1126">
                  <c:v>20.1946072684642</c:v>
                </c:pt>
                <c:pt idx="1127">
                  <c:v>19.440984793627788</c:v>
                </c:pt>
                <c:pt idx="1128">
                  <c:v>19.081994928148816</c:v>
                </c:pt>
                <c:pt idx="1129">
                  <c:v>17.142627345844499</c:v>
                </c:pt>
                <c:pt idx="1130">
                  <c:v>18.183716075156589</c:v>
                </c:pt>
                <c:pt idx="1131">
                  <c:v>16.083185840707976</c:v>
                </c:pt>
                <c:pt idx="1132">
                  <c:v>17.752238805970077</c:v>
                </c:pt>
                <c:pt idx="1133">
                  <c:v>17.119827053736898</c:v>
                </c:pt>
                <c:pt idx="1134">
                  <c:v>19.607660455486535</c:v>
                </c:pt>
                <c:pt idx="1135">
                  <c:v>21.196925329429018</c:v>
                </c:pt>
                <c:pt idx="1136">
                  <c:v>19.424784346728377</c:v>
                </c:pt>
                <c:pt idx="1137">
                  <c:v>18.236396614268401</c:v>
                </c:pt>
                <c:pt idx="1138">
                  <c:v>18.954888451443626</c:v>
                </c:pt>
                <c:pt idx="1139">
                  <c:v>18.320640415404601</c:v>
                </c:pt>
                <c:pt idx="1140">
                  <c:v>19.545187362233687</c:v>
                </c:pt>
                <c:pt idx="1141">
                  <c:v>13.591991341991298</c:v>
                </c:pt>
                <c:pt idx="1142">
                  <c:v>15.0837209302326</c:v>
                </c:pt>
                <c:pt idx="1143">
                  <c:v>18.595220588235275</c:v>
                </c:pt>
                <c:pt idx="1144">
                  <c:v>19.541755888651</c:v>
                </c:pt>
                <c:pt idx="1145">
                  <c:v>18.947008547008501</c:v>
                </c:pt>
                <c:pt idx="1146">
                  <c:v>17.535199321458901</c:v>
                </c:pt>
                <c:pt idx="1147">
                  <c:v>13.623798965262401</c:v>
                </c:pt>
                <c:pt idx="1148">
                  <c:v>12.783268101761298</c:v>
                </c:pt>
                <c:pt idx="1149">
                  <c:v>17.551374819102801</c:v>
                </c:pt>
                <c:pt idx="1150">
                  <c:v>16.063117217689989</c:v>
                </c:pt>
                <c:pt idx="1151">
                  <c:v>16.577061855670117</c:v>
                </c:pt>
                <c:pt idx="1152">
                  <c:v>15.370605339677509</c:v>
                </c:pt>
                <c:pt idx="1153">
                  <c:v>16.080246913580176</c:v>
                </c:pt>
                <c:pt idx="1154">
                  <c:v>14.718143459915591</c:v>
                </c:pt>
                <c:pt idx="1155">
                  <c:v>19.035294117647101</c:v>
                </c:pt>
                <c:pt idx="1156">
                  <c:v>19.594488188976399</c:v>
                </c:pt>
                <c:pt idx="1157">
                  <c:v>16.6330376940133</c:v>
                </c:pt>
                <c:pt idx="1158">
                  <c:v>13.011412268188309</c:v>
                </c:pt>
                <c:pt idx="1159">
                  <c:v>18.720973782771502</c:v>
                </c:pt>
                <c:pt idx="1160">
                  <c:v>18.374720357941786</c:v>
                </c:pt>
                <c:pt idx="1161">
                  <c:v>18.911764705882426</c:v>
                </c:pt>
                <c:pt idx="1162">
                  <c:v>16.379196840026289</c:v>
                </c:pt>
                <c:pt idx="1163">
                  <c:v>19.984451544195974</c:v>
                </c:pt>
                <c:pt idx="1164">
                  <c:v>20.524286322965487</c:v>
                </c:pt>
                <c:pt idx="1165">
                  <c:v>20.625</c:v>
                </c:pt>
                <c:pt idx="1166">
                  <c:v>12.990243902439</c:v>
                </c:pt>
                <c:pt idx="1167">
                  <c:v>16.423218221895699</c:v>
                </c:pt>
                <c:pt idx="1168">
                  <c:v>14.4017128874388</c:v>
                </c:pt>
                <c:pt idx="1169">
                  <c:v>15.014705882352898</c:v>
                </c:pt>
                <c:pt idx="1170">
                  <c:v>18.488218390804587</c:v>
                </c:pt>
                <c:pt idx="1171">
                  <c:v>20.599925009373788</c:v>
                </c:pt>
                <c:pt idx="1172">
                  <c:v>16.876028202115187</c:v>
                </c:pt>
                <c:pt idx="1173">
                  <c:v>19.575156921043899</c:v>
                </c:pt>
                <c:pt idx="1174">
                  <c:v>18.305670816044302</c:v>
                </c:pt>
                <c:pt idx="1175">
                  <c:v>18.096480331262889</c:v>
                </c:pt>
                <c:pt idx="1176">
                  <c:v>18.624034911043999</c:v>
                </c:pt>
                <c:pt idx="1177">
                  <c:v>19.309752198241405</c:v>
                </c:pt>
                <c:pt idx="1178">
                  <c:v>18.2239720034996</c:v>
                </c:pt>
                <c:pt idx="1179">
                  <c:v>15.738831615120301</c:v>
                </c:pt>
                <c:pt idx="1180">
                  <c:v>13.9691797060218</c:v>
                </c:pt>
                <c:pt idx="1181">
                  <c:v>11.647619047618999</c:v>
                </c:pt>
                <c:pt idx="1182">
                  <c:v>15.692589576547224</c:v>
                </c:pt>
                <c:pt idx="1183">
                  <c:v>14.392070484581501</c:v>
                </c:pt>
                <c:pt idx="1184">
                  <c:v>19.368085106382999</c:v>
                </c:pt>
                <c:pt idx="1185">
                  <c:v>18.737619911848601</c:v>
                </c:pt>
                <c:pt idx="1186">
                  <c:v>20.099666983824889</c:v>
                </c:pt>
                <c:pt idx="1187">
                  <c:v>18.8799165673421</c:v>
                </c:pt>
                <c:pt idx="1188">
                  <c:v>18.832274758880317</c:v>
                </c:pt>
                <c:pt idx="1189">
                  <c:v>20.15686805743703</c:v>
                </c:pt>
                <c:pt idx="1190">
                  <c:v>18.371191955042917</c:v>
                </c:pt>
                <c:pt idx="1191">
                  <c:v>19.000974089226617</c:v>
                </c:pt>
                <c:pt idx="1192">
                  <c:v>19.221375338753401</c:v>
                </c:pt>
                <c:pt idx="1193">
                  <c:v>19.618899273104887</c:v>
                </c:pt>
                <c:pt idx="1194">
                  <c:v>19.095058231035587</c:v>
                </c:pt>
                <c:pt idx="1195">
                  <c:v>19.669178327951201</c:v>
                </c:pt>
                <c:pt idx="1196">
                  <c:v>19.3736957715541</c:v>
                </c:pt>
                <c:pt idx="1197">
                  <c:v>19.880425155004399</c:v>
                </c:pt>
                <c:pt idx="1198">
                  <c:v>18.428332287089358</c:v>
                </c:pt>
                <c:pt idx="1199">
                  <c:v>19.834064158781398</c:v>
                </c:pt>
                <c:pt idx="1200">
                  <c:v>19.267795778105089</c:v>
                </c:pt>
                <c:pt idx="1201">
                  <c:v>18.058684054534702</c:v>
                </c:pt>
                <c:pt idx="1202">
                  <c:v>19.895146520146486</c:v>
                </c:pt>
                <c:pt idx="1203">
                  <c:v>19.829787234042588</c:v>
                </c:pt>
                <c:pt idx="1204">
                  <c:v>18.873987690314198</c:v>
                </c:pt>
                <c:pt idx="1205">
                  <c:v>18.985828166518999</c:v>
                </c:pt>
                <c:pt idx="1206">
                  <c:v>20.103149795623889</c:v>
                </c:pt>
                <c:pt idx="1207">
                  <c:v>18.426939970717363</c:v>
                </c:pt>
                <c:pt idx="1208">
                  <c:v>16.606236080178189</c:v>
                </c:pt>
                <c:pt idx="1209">
                  <c:v>18.685504469987187</c:v>
                </c:pt>
                <c:pt idx="1210">
                  <c:v>12.116810877626706</c:v>
                </c:pt>
                <c:pt idx="1211">
                  <c:v>14.974084003574609</c:v>
                </c:pt>
                <c:pt idx="1212">
                  <c:v>16.462022471910064</c:v>
                </c:pt>
                <c:pt idx="1213">
                  <c:v>11.431852986217498</c:v>
                </c:pt>
                <c:pt idx="1214">
                  <c:v>16.569360675512687</c:v>
                </c:pt>
                <c:pt idx="1215">
                  <c:v>14.454268292682899</c:v>
                </c:pt>
                <c:pt idx="1216">
                  <c:v>18.368460388639789</c:v>
                </c:pt>
                <c:pt idx="1217">
                  <c:v>16.994655768626217</c:v>
                </c:pt>
                <c:pt idx="1218">
                  <c:v>19.317584023380434</c:v>
                </c:pt>
                <c:pt idx="1219">
                  <c:v>17.649925261584517</c:v>
                </c:pt>
                <c:pt idx="1220">
                  <c:v>20.460912052117276</c:v>
                </c:pt>
                <c:pt idx="1221">
                  <c:v>17.562647754137064</c:v>
                </c:pt>
                <c:pt idx="1222">
                  <c:v>18.413806706114418</c:v>
                </c:pt>
                <c:pt idx="1223">
                  <c:v>16.530959255694619</c:v>
                </c:pt>
                <c:pt idx="1224">
                  <c:v>16.267732267732264</c:v>
                </c:pt>
                <c:pt idx="1225">
                  <c:v>14.579894765992799</c:v>
                </c:pt>
                <c:pt idx="1226">
                  <c:v>14.3803159173755</c:v>
                </c:pt>
                <c:pt idx="1227">
                  <c:v>13.608182533438208</c:v>
                </c:pt>
                <c:pt idx="1228">
                  <c:v>16.907379289401781</c:v>
                </c:pt>
                <c:pt idx="1229">
                  <c:v>20.480637813211775</c:v>
                </c:pt>
                <c:pt idx="1230">
                  <c:v>18.375504710632601</c:v>
                </c:pt>
                <c:pt idx="1231">
                  <c:v>17.776645041705276</c:v>
                </c:pt>
                <c:pt idx="1232">
                  <c:v>17.952952029520286</c:v>
                </c:pt>
                <c:pt idx="1233">
                  <c:v>13.913752913752909</c:v>
                </c:pt>
                <c:pt idx="1234">
                  <c:v>11.7003745318352</c:v>
                </c:pt>
                <c:pt idx="1235">
                  <c:v>17.548541367766589</c:v>
                </c:pt>
                <c:pt idx="1236">
                  <c:v>17.3460784313726</c:v>
                </c:pt>
                <c:pt idx="1237">
                  <c:v>15.570886075949417</c:v>
                </c:pt>
                <c:pt idx="1238">
                  <c:v>15.322834645669317</c:v>
                </c:pt>
                <c:pt idx="1239">
                  <c:v>15.7299024554322</c:v>
                </c:pt>
                <c:pt idx="1240">
                  <c:v>12.951017019510209</c:v>
                </c:pt>
                <c:pt idx="1241">
                  <c:v>16.661719233147764</c:v>
                </c:pt>
                <c:pt idx="1242">
                  <c:v>15.639612807148209</c:v>
                </c:pt>
                <c:pt idx="1243">
                  <c:v>17.609533732742889</c:v>
                </c:pt>
                <c:pt idx="1244">
                  <c:v>18.2153846153846</c:v>
                </c:pt>
                <c:pt idx="1245">
                  <c:v>16.2780612244898</c:v>
                </c:pt>
                <c:pt idx="1246">
                  <c:v>17.093065222995605</c:v>
                </c:pt>
                <c:pt idx="1247">
                  <c:v>13.369565217391315</c:v>
                </c:pt>
                <c:pt idx="1248">
                  <c:v>15.7059516794343</c:v>
                </c:pt>
                <c:pt idx="1249">
                  <c:v>17.223287671232889</c:v>
                </c:pt>
                <c:pt idx="1250">
                  <c:v>17.911327231121263</c:v>
                </c:pt>
                <c:pt idx="1251">
                  <c:v>16.404999999999987</c:v>
                </c:pt>
                <c:pt idx="1252">
                  <c:v>17.3786666666667</c:v>
                </c:pt>
                <c:pt idx="1253">
                  <c:v>18.380022321428587</c:v>
                </c:pt>
                <c:pt idx="1254">
                  <c:v>19.166956521739099</c:v>
                </c:pt>
                <c:pt idx="1255">
                  <c:v>20.115884680610534</c:v>
                </c:pt>
                <c:pt idx="1256">
                  <c:v>15.597100343380401</c:v>
                </c:pt>
                <c:pt idx="1257">
                  <c:v>18.068139097744371</c:v>
                </c:pt>
                <c:pt idx="1258">
                  <c:v>13.2464129756706</c:v>
                </c:pt>
                <c:pt idx="1259">
                  <c:v>15.496584699453615</c:v>
                </c:pt>
                <c:pt idx="1260">
                  <c:v>15.253968253968306</c:v>
                </c:pt>
                <c:pt idx="1261">
                  <c:v>17.012973533990699</c:v>
                </c:pt>
                <c:pt idx="1262">
                  <c:v>15.151862464183401</c:v>
                </c:pt>
                <c:pt idx="1263">
                  <c:v>18.137254901960805</c:v>
                </c:pt>
                <c:pt idx="1264">
                  <c:v>12.160317460317492</c:v>
                </c:pt>
                <c:pt idx="1265">
                  <c:v>17.695727986050599</c:v>
                </c:pt>
                <c:pt idx="1266">
                  <c:v>18.045293072824176</c:v>
                </c:pt>
                <c:pt idx="1267">
                  <c:v>16.2715909090909</c:v>
                </c:pt>
                <c:pt idx="1268">
                  <c:v>17.418309325246401</c:v>
                </c:pt>
                <c:pt idx="1269">
                  <c:v>18.625712734184074</c:v>
                </c:pt>
                <c:pt idx="1270">
                  <c:v>17.505713352921962</c:v>
                </c:pt>
                <c:pt idx="1271">
                  <c:v>19.487698986975364</c:v>
                </c:pt>
                <c:pt idx="1272">
                  <c:v>20.2809187279152</c:v>
                </c:pt>
                <c:pt idx="1273">
                  <c:v>19.3470999088977</c:v>
                </c:pt>
                <c:pt idx="1274">
                  <c:v>19.180355920602317</c:v>
                </c:pt>
                <c:pt idx="1275">
                  <c:v>18.830085736554917</c:v>
                </c:pt>
                <c:pt idx="1276">
                  <c:v>14.245620061834398</c:v>
                </c:pt>
                <c:pt idx="1277">
                  <c:v>16.086567926455601</c:v>
                </c:pt>
                <c:pt idx="1278">
                  <c:v>17.728480340063776</c:v>
                </c:pt>
                <c:pt idx="1279">
                  <c:v>18.997243107769378</c:v>
                </c:pt>
                <c:pt idx="1280">
                  <c:v>18.919397697077088</c:v>
                </c:pt>
                <c:pt idx="1281">
                  <c:v>19.515519568151078</c:v>
                </c:pt>
                <c:pt idx="1282">
                  <c:v>19.795585412667887</c:v>
                </c:pt>
                <c:pt idx="1283">
                  <c:v>18.999494183105689</c:v>
                </c:pt>
                <c:pt idx="1284">
                  <c:v>20.256183390307687</c:v>
                </c:pt>
                <c:pt idx="1285">
                  <c:v>19.884595569294198</c:v>
                </c:pt>
                <c:pt idx="1286">
                  <c:v>20.338104325699717</c:v>
                </c:pt>
                <c:pt idx="1287">
                  <c:v>18.201817806238399</c:v>
                </c:pt>
                <c:pt idx="1288">
                  <c:v>15.384347152266599</c:v>
                </c:pt>
                <c:pt idx="1289">
                  <c:v>18.180208333333276</c:v>
                </c:pt>
                <c:pt idx="1290">
                  <c:v>18.502065049044901</c:v>
                </c:pt>
                <c:pt idx="1291">
                  <c:v>19.327163151097718</c:v>
                </c:pt>
                <c:pt idx="1292">
                  <c:v>20.838023335621077</c:v>
                </c:pt>
                <c:pt idx="1293">
                  <c:v>16.715228873239376</c:v>
                </c:pt>
                <c:pt idx="1294">
                  <c:v>16.053551296505088</c:v>
                </c:pt>
                <c:pt idx="1295">
                  <c:v>14.077548467792401</c:v>
                </c:pt>
                <c:pt idx="1296">
                  <c:v>13.314769975786909</c:v>
                </c:pt>
                <c:pt idx="1297">
                  <c:v>15.163972286374101</c:v>
                </c:pt>
                <c:pt idx="1298">
                  <c:v>16.224864413850639</c:v>
                </c:pt>
                <c:pt idx="1299">
                  <c:v>18.825960841189289</c:v>
                </c:pt>
                <c:pt idx="1300">
                  <c:v>17.839683680805202</c:v>
                </c:pt>
                <c:pt idx="1301">
                  <c:v>17.329615170105981</c:v>
                </c:pt>
                <c:pt idx="1302">
                  <c:v>15.850294695481315</c:v>
                </c:pt>
                <c:pt idx="1303">
                  <c:v>16.362410071942364</c:v>
                </c:pt>
                <c:pt idx="1304">
                  <c:v>16.447604790419199</c:v>
                </c:pt>
                <c:pt idx="1305">
                  <c:v>17.062287655719089</c:v>
                </c:pt>
                <c:pt idx="1306">
                  <c:v>18.723383084577076</c:v>
                </c:pt>
                <c:pt idx="1307">
                  <c:v>17.112114371708099</c:v>
                </c:pt>
                <c:pt idx="1308">
                  <c:v>13.852781546811409</c:v>
                </c:pt>
                <c:pt idx="1309">
                  <c:v>12.989563567362406</c:v>
                </c:pt>
                <c:pt idx="1310">
                  <c:v>17.6433378196501</c:v>
                </c:pt>
                <c:pt idx="1311">
                  <c:v>15.8116740088106</c:v>
                </c:pt>
                <c:pt idx="1312">
                  <c:v>17.680344142951689</c:v>
                </c:pt>
                <c:pt idx="1313">
                  <c:v>16.306349206349175</c:v>
                </c:pt>
                <c:pt idx="1314">
                  <c:v>15.436216552582502</c:v>
                </c:pt>
                <c:pt idx="1315">
                  <c:v>18.218627799502286</c:v>
                </c:pt>
                <c:pt idx="1316">
                  <c:v>16.624521072796899</c:v>
                </c:pt>
                <c:pt idx="1317">
                  <c:v>16.676854818831718</c:v>
                </c:pt>
                <c:pt idx="1318">
                  <c:v>15.7006638503319</c:v>
                </c:pt>
                <c:pt idx="1319">
                  <c:v>18.7764449291167</c:v>
                </c:pt>
                <c:pt idx="1320">
                  <c:v>15.856649937264724</c:v>
                </c:pt>
                <c:pt idx="1321">
                  <c:v>17.4992424242424</c:v>
                </c:pt>
                <c:pt idx="1322">
                  <c:v>14.909608540925309</c:v>
                </c:pt>
                <c:pt idx="1323">
                  <c:v>19.2671976828385</c:v>
                </c:pt>
                <c:pt idx="1324">
                  <c:v>16.575380359612701</c:v>
                </c:pt>
                <c:pt idx="1325">
                  <c:v>16.399337947637687</c:v>
                </c:pt>
                <c:pt idx="1326">
                  <c:v>15.637457044673498</c:v>
                </c:pt>
                <c:pt idx="1327">
                  <c:v>18.708669354838687</c:v>
                </c:pt>
                <c:pt idx="1328">
                  <c:v>18.547958214624916</c:v>
                </c:pt>
                <c:pt idx="1329">
                  <c:v>17.788015158692598</c:v>
                </c:pt>
                <c:pt idx="1330">
                  <c:v>15.843881856540104</c:v>
                </c:pt>
                <c:pt idx="1331">
                  <c:v>17.193558572781789</c:v>
                </c:pt>
                <c:pt idx="1332">
                  <c:v>17.742083333333259</c:v>
                </c:pt>
                <c:pt idx="1333">
                  <c:v>15.607176581680799</c:v>
                </c:pt>
                <c:pt idx="1334">
                  <c:v>22.384912959380987</c:v>
                </c:pt>
                <c:pt idx="1335">
                  <c:v>11.319317235637008</c:v>
                </c:pt>
                <c:pt idx="1336">
                  <c:v>13.361828184511191</c:v>
                </c:pt>
                <c:pt idx="1337">
                  <c:v>13.127992183683398</c:v>
                </c:pt>
                <c:pt idx="1338">
                  <c:v>15.202594429607009</c:v>
                </c:pt>
                <c:pt idx="1339">
                  <c:v>14.569784172661915</c:v>
                </c:pt>
                <c:pt idx="1340">
                  <c:v>12.017038777908304</c:v>
                </c:pt>
                <c:pt idx="1341">
                  <c:v>13.894465894465915</c:v>
                </c:pt>
                <c:pt idx="1342">
                  <c:v>14.662321278385209</c:v>
                </c:pt>
                <c:pt idx="1343">
                  <c:v>13.006347862886209</c:v>
                </c:pt>
                <c:pt idx="1344">
                  <c:v>18.816063254265501</c:v>
                </c:pt>
                <c:pt idx="1345">
                  <c:v>14.1740861382555</c:v>
                </c:pt>
                <c:pt idx="1346">
                  <c:v>17.425409047160663</c:v>
                </c:pt>
                <c:pt idx="1347">
                  <c:v>17.956772334293873</c:v>
                </c:pt>
                <c:pt idx="1348">
                  <c:v>14.424753867791798</c:v>
                </c:pt>
                <c:pt idx="1349">
                  <c:v>19.659898477157434</c:v>
                </c:pt>
                <c:pt idx="1350">
                  <c:v>18.306827309236901</c:v>
                </c:pt>
                <c:pt idx="1351">
                  <c:v>19.618357487922701</c:v>
                </c:pt>
                <c:pt idx="1352">
                  <c:v>16.284552845528474</c:v>
                </c:pt>
                <c:pt idx="1353">
                  <c:v>20.703553299492388</c:v>
                </c:pt>
                <c:pt idx="1354">
                  <c:v>12.288641686182698</c:v>
                </c:pt>
                <c:pt idx="1355">
                  <c:v>14.515174798309609</c:v>
                </c:pt>
                <c:pt idx="1356">
                  <c:v>8.1288135593220279</c:v>
                </c:pt>
                <c:pt idx="1357">
                  <c:v>18.198547215496401</c:v>
                </c:pt>
                <c:pt idx="1358">
                  <c:v>21.729564277997778</c:v>
                </c:pt>
                <c:pt idx="1359">
                  <c:v>19.006587615283287</c:v>
                </c:pt>
                <c:pt idx="1360">
                  <c:v>17.028243601059089</c:v>
                </c:pt>
                <c:pt idx="1361">
                  <c:v>17.335289186923681</c:v>
                </c:pt>
                <c:pt idx="1362">
                  <c:v>20.169230769230801</c:v>
                </c:pt>
                <c:pt idx="1363">
                  <c:v>17.866071428571399</c:v>
                </c:pt>
                <c:pt idx="1364">
                  <c:v>17.9057611598626</c:v>
                </c:pt>
                <c:pt idx="1365">
                  <c:v>20.963395638629276</c:v>
                </c:pt>
                <c:pt idx="1366">
                  <c:v>18.6134893748075</c:v>
                </c:pt>
                <c:pt idx="1367">
                  <c:v>18.070772555375473</c:v>
                </c:pt>
                <c:pt idx="1368">
                  <c:v>18.237636003956499</c:v>
                </c:pt>
                <c:pt idx="1369">
                  <c:v>16.408849557522064</c:v>
                </c:pt>
                <c:pt idx="1370">
                  <c:v>13.749840255591099</c:v>
                </c:pt>
                <c:pt idx="1371">
                  <c:v>9.7898042113040393</c:v>
                </c:pt>
                <c:pt idx="1372">
                  <c:v>11.184508816120909</c:v>
                </c:pt>
                <c:pt idx="1373">
                  <c:v>18.270496708557786</c:v>
                </c:pt>
                <c:pt idx="1374">
                  <c:v>18.268518518518487</c:v>
                </c:pt>
                <c:pt idx="1375">
                  <c:v>19.360572483841189</c:v>
                </c:pt>
                <c:pt idx="1376">
                  <c:v>13.8245253976398</c:v>
                </c:pt>
                <c:pt idx="1377">
                  <c:v>17.5374873353597</c:v>
                </c:pt>
                <c:pt idx="1378">
                  <c:v>16.702365015618017</c:v>
                </c:pt>
                <c:pt idx="1379">
                  <c:v>16.173333333333275</c:v>
                </c:pt>
                <c:pt idx="1380">
                  <c:v>18.885580852305864</c:v>
                </c:pt>
                <c:pt idx="1381">
                  <c:v>20.148848401512517</c:v>
                </c:pt>
                <c:pt idx="1382">
                  <c:v>15.985028072364306</c:v>
                </c:pt>
                <c:pt idx="1383">
                  <c:v>19.080067567567589</c:v>
                </c:pt>
                <c:pt idx="1384">
                  <c:v>17.031460674157302</c:v>
                </c:pt>
                <c:pt idx="1385">
                  <c:v>20.521825396825399</c:v>
                </c:pt>
                <c:pt idx="1386">
                  <c:v>18.664210526315799</c:v>
                </c:pt>
                <c:pt idx="1387">
                  <c:v>17.035429583702363</c:v>
                </c:pt>
                <c:pt idx="1388">
                  <c:v>19.855042735042687</c:v>
                </c:pt>
                <c:pt idx="1389">
                  <c:v>16.895666131621176</c:v>
                </c:pt>
                <c:pt idx="1390">
                  <c:v>16.516414141414117</c:v>
                </c:pt>
                <c:pt idx="1391">
                  <c:v>15.743792325056399</c:v>
                </c:pt>
                <c:pt idx="1392">
                  <c:v>17.841207349081401</c:v>
                </c:pt>
                <c:pt idx="1393">
                  <c:v>17.094182825484801</c:v>
                </c:pt>
                <c:pt idx="1394">
                  <c:v>17.6530343007916</c:v>
                </c:pt>
                <c:pt idx="1395">
                  <c:v>14.450107296137311</c:v>
                </c:pt>
                <c:pt idx="1396">
                  <c:v>16.524227234753489</c:v>
                </c:pt>
                <c:pt idx="1397">
                  <c:v>17.104106972301789</c:v>
                </c:pt>
                <c:pt idx="1398">
                  <c:v>16.336182336182286</c:v>
                </c:pt>
                <c:pt idx="1399">
                  <c:v>17.745560109289599</c:v>
                </c:pt>
                <c:pt idx="1400">
                  <c:v>14.549305802776798</c:v>
                </c:pt>
                <c:pt idx="1401">
                  <c:v>13.659455128205106</c:v>
                </c:pt>
                <c:pt idx="1402">
                  <c:v>15.262583095916408</c:v>
                </c:pt>
                <c:pt idx="1403">
                  <c:v>17.480409885473154</c:v>
                </c:pt>
                <c:pt idx="1404">
                  <c:v>18.780343213728475</c:v>
                </c:pt>
                <c:pt idx="1405">
                  <c:v>15.7337883959044</c:v>
                </c:pt>
                <c:pt idx="1406">
                  <c:v>15.8013109381401</c:v>
                </c:pt>
                <c:pt idx="1407">
                  <c:v>14.418101054969499</c:v>
                </c:pt>
                <c:pt idx="1408">
                  <c:v>14.490029910269209</c:v>
                </c:pt>
                <c:pt idx="1409">
                  <c:v>19.059785385794601</c:v>
                </c:pt>
                <c:pt idx="1410">
                  <c:v>17.893004115226301</c:v>
                </c:pt>
                <c:pt idx="1411">
                  <c:v>15.486742424242404</c:v>
                </c:pt>
                <c:pt idx="1412">
                  <c:v>9.052083333333341</c:v>
                </c:pt>
                <c:pt idx="1413">
                  <c:v>15.518134715025909</c:v>
                </c:pt>
                <c:pt idx="1414">
                  <c:v>18.394173602853705</c:v>
                </c:pt>
                <c:pt idx="1415">
                  <c:v>18.628021706956101</c:v>
                </c:pt>
                <c:pt idx="1416">
                  <c:v>14.786516853932609</c:v>
                </c:pt>
                <c:pt idx="1417">
                  <c:v>18.217790187475099</c:v>
                </c:pt>
                <c:pt idx="1418">
                  <c:v>18.458673469387787</c:v>
                </c:pt>
                <c:pt idx="1419">
                  <c:v>17.735658042744699</c:v>
                </c:pt>
                <c:pt idx="1420">
                  <c:v>13.962105263157909</c:v>
                </c:pt>
                <c:pt idx="1421">
                  <c:v>18.118885448916448</c:v>
                </c:pt>
                <c:pt idx="1422">
                  <c:v>18.2036817102138</c:v>
                </c:pt>
                <c:pt idx="1423">
                  <c:v>17.794411177644701</c:v>
                </c:pt>
                <c:pt idx="1424">
                  <c:v>17.086580086580089</c:v>
                </c:pt>
                <c:pt idx="1425">
                  <c:v>17.0006653359947</c:v>
                </c:pt>
                <c:pt idx="1426">
                  <c:v>19.54</c:v>
                </c:pt>
                <c:pt idx="1427">
                  <c:v>20.128571428571401</c:v>
                </c:pt>
                <c:pt idx="1428">
                  <c:v>20.138235294117599</c:v>
                </c:pt>
                <c:pt idx="1429">
                  <c:v>16.1575673807878</c:v>
                </c:pt>
                <c:pt idx="1430">
                  <c:v>17.856765327695634</c:v>
                </c:pt>
                <c:pt idx="1431">
                  <c:v>19.999143285500075</c:v>
                </c:pt>
                <c:pt idx="1432">
                  <c:v>20.035855363111533</c:v>
                </c:pt>
                <c:pt idx="1433">
                  <c:v>16.417680826636101</c:v>
                </c:pt>
                <c:pt idx="1434">
                  <c:v>17.977243172951876</c:v>
                </c:pt>
                <c:pt idx="1435">
                  <c:v>18.798254122211418</c:v>
                </c:pt>
                <c:pt idx="1436">
                  <c:v>18.053420195439699</c:v>
                </c:pt>
                <c:pt idx="1437">
                  <c:v>19.8068033144352</c:v>
                </c:pt>
                <c:pt idx="1438">
                  <c:v>18.594123764950616</c:v>
                </c:pt>
                <c:pt idx="1439">
                  <c:v>11.556603773584909</c:v>
                </c:pt>
                <c:pt idx="1440">
                  <c:v>18.512299706612517</c:v>
                </c:pt>
                <c:pt idx="1441">
                  <c:v>17.557003257328986</c:v>
                </c:pt>
                <c:pt idx="1442">
                  <c:v>18.2331210191083</c:v>
                </c:pt>
                <c:pt idx="1443">
                  <c:v>17.311843361986618</c:v>
                </c:pt>
                <c:pt idx="1444">
                  <c:v>40.232723256547835</c:v>
                </c:pt>
                <c:pt idx="1445">
                  <c:v>18.226221079691499</c:v>
                </c:pt>
                <c:pt idx="1446">
                  <c:v>19.029463968761089</c:v>
                </c:pt>
                <c:pt idx="1447">
                  <c:v>24.078363959691799</c:v>
                </c:pt>
                <c:pt idx="1448">
                  <c:v>19.320465686274517</c:v>
                </c:pt>
                <c:pt idx="1449">
                  <c:v>19.960606060606089</c:v>
                </c:pt>
                <c:pt idx="1450">
                  <c:v>18.715650741350899</c:v>
                </c:pt>
                <c:pt idx="1451">
                  <c:v>15.909090909090899</c:v>
                </c:pt>
                <c:pt idx="1452">
                  <c:v>16.727272727272705</c:v>
                </c:pt>
                <c:pt idx="1453">
                  <c:v>16.891369047619001</c:v>
                </c:pt>
                <c:pt idx="1454">
                  <c:v>16.908521303258102</c:v>
                </c:pt>
                <c:pt idx="1455">
                  <c:v>15.6716122650841</c:v>
                </c:pt>
                <c:pt idx="1456">
                  <c:v>16.019969278033788</c:v>
                </c:pt>
                <c:pt idx="1457">
                  <c:v>20.109211775878418</c:v>
                </c:pt>
                <c:pt idx="1458">
                  <c:v>18.736986986986999</c:v>
                </c:pt>
                <c:pt idx="1459">
                  <c:v>19.417403127124388</c:v>
                </c:pt>
                <c:pt idx="1460">
                  <c:v>20.863832988527363</c:v>
                </c:pt>
                <c:pt idx="1461">
                  <c:v>17.499352930301264</c:v>
                </c:pt>
                <c:pt idx="1462">
                  <c:v>18.451026119403</c:v>
                </c:pt>
                <c:pt idx="1463">
                  <c:v>19.029792939073364</c:v>
                </c:pt>
                <c:pt idx="1464">
                  <c:v>19.4124792932081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1979264"/>
        <c:axId val="221984752"/>
      </c:barChart>
      <c:catAx>
        <c:axId val="2219792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10k bin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221984752"/>
        <c:crosses val="autoZero"/>
        <c:auto val="1"/>
        <c:lblAlgn val="ctr"/>
        <c:lblOffset val="100"/>
        <c:noMultiLvlLbl val="0"/>
      </c:catAx>
      <c:valAx>
        <c:axId val="2219847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219792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362270"/>
            <a:ext cx="7772400" cy="78401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0726400"/>
            <a:ext cx="6400800" cy="9347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7814739"/>
            <a:ext cx="2057400" cy="1664377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7814739"/>
            <a:ext cx="6019800" cy="1664377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23503469"/>
            <a:ext cx="7772400" cy="72644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15502472"/>
            <a:ext cx="7772400" cy="800099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45516800"/>
            <a:ext cx="4038600" cy="12873566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45516800"/>
            <a:ext cx="4038600" cy="12873566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464736"/>
            <a:ext cx="8229600" cy="6096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8187269"/>
            <a:ext cx="4040188" cy="3412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1599333"/>
            <a:ext cx="4040188" cy="210735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8187269"/>
            <a:ext cx="4041775" cy="3412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1599333"/>
            <a:ext cx="4041775" cy="210735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1456267"/>
            <a:ext cx="3008313" cy="61976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1456269"/>
            <a:ext cx="5111750" cy="3121660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7653869"/>
            <a:ext cx="3008313" cy="2501900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25603200"/>
            <a:ext cx="5486400" cy="30226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3268133"/>
            <a:ext cx="5486400" cy="21945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28625803"/>
            <a:ext cx="5486400" cy="42925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1464736"/>
            <a:ext cx="8229600" cy="6096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8534403"/>
            <a:ext cx="8229600" cy="241384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33900536"/>
            <a:ext cx="21336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8E9476-20DB-45C1-99F9-1A851F2CAE37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33900536"/>
            <a:ext cx="28956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33900536"/>
            <a:ext cx="21336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2717E-FE49-4E08-A62C-D65731498E4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3835952158"/>
              </p:ext>
            </p:extLst>
          </p:nvPr>
        </p:nvGraphicFramePr>
        <p:xfrm>
          <a:off x="1981200" y="5486400"/>
          <a:ext cx="4572000" cy="2362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3621995383"/>
              </p:ext>
            </p:extLst>
          </p:nvPr>
        </p:nvGraphicFramePr>
        <p:xfrm>
          <a:off x="1981200" y="78486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3439318393"/>
              </p:ext>
            </p:extLst>
          </p:nvPr>
        </p:nvGraphicFramePr>
        <p:xfrm>
          <a:off x="1981200" y="10439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Chart 12"/>
          <p:cNvGraphicFramePr/>
          <p:nvPr>
            <p:extLst>
              <p:ext uri="{D42A27DB-BD31-4B8C-83A1-F6EECF244321}">
                <p14:modId xmlns:p14="http://schemas.microsoft.com/office/powerpoint/2010/main" val="3114948831"/>
              </p:ext>
            </p:extLst>
          </p:nvPr>
        </p:nvGraphicFramePr>
        <p:xfrm>
          <a:off x="1981200" y="130302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0" y="16002000"/>
            <a:ext cx="91440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dirty="0" smtClean="0"/>
              <a:t>Figure </a:t>
            </a:r>
            <a:r>
              <a:rPr lang="en-US" dirty="0"/>
              <a:t>1</a:t>
            </a:r>
            <a:r>
              <a:rPr lang="en-US" dirty="0" smtClean="0"/>
              <a:t>. </a:t>
            </a:r>
            <a:r>
              <a:rPr lang="en-US" dirty="0" smtClean="0"/>
              <a:t>Comparison of genomes missing dpy-5 and/or unc-13 markers. A. The distribution of EMS mutations are plotted along the length of chromosome I. The genomes missing markers have more EMS mutation in the first 7Mbp of chromosome I when compared to a control genome (h706). B.   The average read depth per 10Kbp of coding element is plotted along the length of chromosome I. The x-axis shows the coordinate in 10K units. The y-axis shows the number of reads. The control genome show 33% more reads in the first 7Mbp while the genome with missing markers shows a flat distribution.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</TotalTime>
  <Words>129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iggy</dc:creator>
  <cp:lastModifiedBy>Jeff Chu</cp:lastModifiedBy>
  <cp:revision>6</cp:revision>
  <dcterms:created xsi:type="dcterms:W3CDTF">2012-12-20T23:32:42Z</dcterms:created>
  <dcterms:modified xsi:type="dcterms:W3CDTF">2013-07-17T03:54:10Z</dcterms:modified>
</cp:coreProperties>
</file>